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7559675" cy="10691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29000"/>
    <a:srgbClr val="FF7E79"/>
    <a:srgbClr val="B41A00"/>
    <a:srgbClr val="FF2600"/>
    <a:srgbClr val="00FDFF"/>
    <a:srgbClr val="00FA00"/>
    <a:srgbClr val="780000"/>
    <a:srgbClr val="DF0000"/>
    <a:srgbClr val="9437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88"/>
    <p:restoredTop sz="94700"/>
  </p:normalViewPr>
  <p:slideViewPr>
    <p:cSldViewPr snapToGrid="0" snapToObjects="1">
      <p:cViewPr>
        <p:scale>
          <a:sx n="285" d="100"/>
          <a:sy n="285" d="100"/>
        </p:scale>
        <p:origin x="-808" y="-87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4281488" y="0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9057D7-9CD4-A24B-A1B3-0FFEA8D6A4D4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30475" y="1336675"/>
            <a:ext cx="2498725" cy="36083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755650" y="5145088"/>
            <a:ext cx="6048375" cy="42100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10155238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4281488" y="10155238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8BAF7A-1CD9-4846-B2E4-EC7F272701F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36980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8BAF7A-1CD9-4846-B2E4-EC7F272701F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8301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98EAC450-8038-4162-B42A-E462F87377B1}" type="slidenum">
              <a:t>‹#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370FAA6F-07ED-4546-B376-87446DC4C01D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696B1A59-89FE-4671-8262-7412198F8F9B}" type="slidenum">
              <a:t>‹#›</a:t>
            </a:fld>
            <a:endParaRPr/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756F6178-D755-4CF0-8AC1-3D0E680B3C25}" type="slidenum">
              <a:t>‹#›</a:t>
            </a:fld>
            <a:endParaRPr/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s-E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2" name="PlaceHolder 4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B6265F4A-8814-4D1F-8C74-55DDB6D8759D}" type="slidenum">
              <a:t>‹#›</a:t>
            </a:fld>
            <a:endParaRPr/>
          </a:p>
        </p:txBody>
      </p:sp>
      <p:sp>
        <p:nvSpPr>
          <p:cNvPr id="3" name="PlaceHolder 5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2AE25788-D584-47DC-8224-388AD8766CC7}" type="slidenum">
              <a:t>‹#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7C12DBE0-CA6C-4BD5-9F08-77E815F9FBAE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5AEB9A6E-D483-45DA-8A92-0E4839A1405D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1621080"/>
            <a:ext cx="5829120" cy="15986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s-E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31583CA6-222E-4202-8646-D98D33C53B26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618F2074-C219-4044-94DE-C040D5B6DFA6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1DFC1F9D-81A7-4FA9-B9E4-5573EA7CD153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F851E50F-A5E0-443D-BB8C-649FB32C67D8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/>
          <a:p>
            <a:pPr algn="ctr">
              <a:lnSpc>
                <a:spcPct val="90000"/>
              </a:lnSpc>
              <a:buNone/>
            </a:pPr>
            <a:r>
              <a:rPr lang="en-GB" sz="4500" b="0" strike="noStrike" spc="-1">
                <a:solidFill>
                  <a:srgbClr val="000000"/>
                </a:solidFill>
                <a:latin typeface="Calibri Light"/>
              </a:rPr>
              <a:t>Click to edit Master title style</a:t>
            </a:r>
            <a:endParaRPr lang="en-US" sz="45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dt" idx="1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>
              <a:lnSpc>
                <a:spcPct val="100000"/>
              </a:lnSpc>
              <a:buNone/>
              <a:defRPr lang="en-ES" sz="900" b="0" strike="noStrike" spc="-1">
                <a:solidFill>
                  <a:srgbClr val="8B8B8B"/>
                </a:solidFill>
                <a:latin typeface="Calibri"/>
              </a:defRPr>
            </a:lvl1pPr>
          </a:lstStyle>
          <a:p>
            <a:pPr>
              <a:lnSpc>
                <a:spcPct val="100000"/>
              </a:lnSpc>
              <a:buNone/>
            </a:pPr>
            <a:r>
              <a:rPr lang="en-ES" sz="900" b="0" strike="noStrike" spc="-1">
                <a:solidFill>
                  <a:srgbClr val="8B8B8B"/>
                </a:solidFill>
                <a:latin typeface="Calibri"/>
              </a:rPr>
              <a:t>&lt;date/time&gt;</a:t>
            </a:r>
            <a:endParaRPr lang="es-ES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 idx="2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ctr">
              <a:buNone/>
              <a:defRPr lang="es-ES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algn="ctr">
              <a:buNone/>
            </a:pPr>
            <a:r>
              <a:rPr lang="es-ES" sz="1400" b="0" strike="noStrike" spc="-1">
                <a:solidFill>
                  <a:srgbClr val="000000"/>
                </a:solidFill>
                <a:latin typeface="Calibri"/>
              </a:rPr>
              <a:t>&lt;footer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sldNum" idx="3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r">
              <a:lnSpc>
                <a:spcPct val="100000"/>
              </a:lnSpc>
              <a:buNone/>
              <a:defRPr lang="en-ES" sz="900" b="0" strike="noStrike" spc="-1">
                <a:solidFill>
                  <a:srgbClr val="8B8B8B"/>
                </a:solidFill>
                <a:latin typeface="Calibri"/>
              </a:defRPr>
            </a:lvl1pPr>
          </a:lstStyle>
          <a:p>
            <a:pPr algn="r">
              <a:lnSpc>
                <a:spcPct val="100000"/>
              </a:lnSpc>
              <a:buNone/>
            </a:pPr>
            <a:fld id="{5FFCE3FD-062B-4470-8A07-CA2137CC5636}" type="slidenum">
              <a:rPr lang="en-ES" sz="9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s-ES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lnSpc>
                <a:spcPct val="90000"/>
              </a:lnSpc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10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lnSpc>
                <a:spcPct val="90000"/>
              </a:lnSpc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5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35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lnSpc>
                <a:spcPct val="90000"/>
              </a:lnSpc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35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lnSpc>
                <a:spcPct val="90000"/>
              </a:lnSpc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lnSpc>
                <a:spcPct val="90000"/>
              </a:lnSpc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lnSpc>
                <a:spcPct val="90000"/>
              </a:lnSpc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8B8646A-F906-90D5-BFC1-CB0DBA07681C}"/>
              </a:ext>
            </a:extLst>
          </p:cNvPr>
          <p:cNvGrpSpPr/>
          <p:nvPr/>
        </p:nvGrpSpPr>
        <p:grpSpPr>
          <a:xfrm>
            <a:off x="957698" y="890006"/>
            <a:ext cx="5055644" cy="2996790"/>
            <a:chOff x="957698" y="890006"/>
            <a:chExt cx="3804941" cy="2996790"/>
          </a:xfrm>
        </p:grpSpPr>
        <p:sp>
          <p:nvSpPr>
            <p:cNvPr id="42" name="Rectangle 6"/>
            <p:cNvSpPr/>
            <p:nvPr/>
          </p:nvSpPr>
          <p:spPr>
            <a:xfrm>
              <a:off x="957698" y="890006"/>
              <a:ext cx="3804941" cy="1112215"/>
            </a:xfrm>
            <a:prstGeom prst="rect">
              <a:avLst/>
            </a:prstGeom>
            <a:gradFill rotWithShape="0">
              <a:gsLst>
                <a:gs pos="0">
                  <a:srgbClr val="E0E5F6"/>
                </a:gs>
                <a:gs pos="100000">
                  <a:schemeClr val="accent5">
                    <a:lumMod val="40000"/>
                    <a:lumOff val="60000"/>
                  </a:schemeClr>
                </a:gs>
              </a:gsLst>
              <a:lin ang="2700000"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43" name="Rectangle 7"/>
            <p:cNvSpPr/>
            <p:nvPr/>
          </p:nvSpPr>
          <p:spPr>
            <a:xfrm>
              <a:off x="957698" y="2489125"/>
              <a:ext cx="3804941" cy="1397671"/>
            </a:xfrm>
            <a:prstGeom prst="rect">
              <a:avLst/>
            </a:prstGeom>
            <a:gradFill rotWithShape="0">
              <a:gsLst>
                <a:gs pos="0">
                  <a:srgbClr val="E2F0D9"/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44" name="Rectangle 8"/>
            <p:cNvSpPr/>
            <p:nvPr/>
          </p:nvSpPr>
          <p:spPr>
            <a:xfrm>
              <a:off x="957698" y="1905566"/>
              <a:ext cx="3804941" cy="585720"/>
            </a:xfrm>
            <a:prstGeom prst="rect">
              <a:avLst/>
            </a:prstGeom>
            <a:gradFill rotWithShape="0">
              <a:gsLst>
                <a:gs pos="100000">
                  <a:schemeClr val="accent2">
                    <a:lumMod val="20000"/>
                    <a:lumOff val="80000"/>
                  </a:schemeClr>
                </a:gs>
                <a:gs pos="0">
                  <a:schemeClr val="bg1"/>
                </a:gs>
              </a:gsLst>
              <a:lin ang="2700000"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 dirty="0">
                <a:solidFill>
                  <a:schemeClr val="lt1"/>
                </a:solidFill>
                <a:latin typeface="Calibri"/>
              </a:endParaRPr>
            </a:p>
          </p:txBody>
        </p:sp>
        <p:cxnSp>
          <p:nvCxnSpPr>
            <p:cNvPr id="215" name="Conector recto 214">
              <a:extLst>
                <a:ext uri="{FF2B5EF4-FFF2-40B4-BE49-F238E27FC236}">
                  <a16:creationId xmlns:a16="http://schemas.microsoft.com/office/drawing/2014/main" id="{E9D20D7B-9152-E849-9997-C5662429F939}"/>
                </a:ext>
              </a:extLst>
            </p:cNvPr>
            <p:cNvCxnSpPr/>
            <p:nvPr/>
          </p:nvCxnSpPr>
          <p:spPr>
            <a:xfrm>
              <a:off x="968805" y="1904966"/>
              <a:ext cx="3776542" cy="0"/>
            </a:xfrm>
            <a:prstGeom prst="line">
              <a:avLst/>
            </a:prstGeom>
            <a:ln w="76200" cmpd="thickThin">
              <a:solidFill>
                <a:schemeClr val="accent4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Conector recto 215">
              <a:extLst>
                <a:ext uri="{FF2B5EF4-FFF2-40B4-BE49-F238E27FC236}">
                  <a16:creationId xmlns:a16="http://schemas.microsoft.com/office/drawing/2014/main" id="{80053DFB-4442-6C44-A66F-E5AAC1163620}"/>
                </a:ext>
              </a:extLst>
            </p:cNvPr>
            <p:cNvCxnSpPr/>
            <p:nvPr/>
          </p:nvCxnSpPr>
          <p:spPr>
            <a:xfrm>
              <a:off x="968805" y="2476822"/>
              <a:ext cx="3776542" cy="0"/>
            </a:xfrm>
            <a:prstGeom prst="line">
              <a:avLst/>
            </a:prstGeom>
            <a:ln w="76200" cmpd="dbl">
              <a:solidFill>
                <a:schemeClr val="accent4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upo 11">
            <a:extLst>
              <a:ext uri="{FF2B5EF4-FFF2-40B4-BE49-F238E27FC236}">
                <a16:creationId xmlns:a16="http://schemas.microsoft.com/office/drawing/2014/main" id="{FB97C84D-CF10-1248-98C6-2E06A860565E}"/>
              </a:ext>
            </a:extLst>
          </p:cNvPr>
          <p:cNvGrpSpPr/>
          <p:nvPr/>
        </p:nvGrpSpPr>
        <p:grpSpPr>
          <a:xfrm>
            <a:off x="1563488" y="3000277"/>
            <a:ext cx="1668434" cy="867985"/>
            <a:chOff x="1157581" y="4856395"/>
            <a:chExt cx="1944608" cy="1011661"/>
          </a:xfrm>
        </p:grpSpPr>
        <p:grpSp>
          <p:nvGrpSpPr>
            <p:cNvPr id="7" name="Grupo 6">
              <a:extLst>
                <a:ext uri="{FF2B5EF4-FFF2-40B4-BE49-F238E27FC236}">
                  <a16:creationId xmlns:a16="http://schemas.microsoft.com/office/drawing/2014/main" id="{0F1D9B62-3E6D-5840-A9D7-79DE5FF40A5E}"/>
                </a:ext>
              </a:extLst>
            </p:cNvPr>
            <p:cNvGrpSpPr/>
            <p:nvPr/>
          </p:nvGrpSpPr>
          <p:grpSpPr>
            <a:xfrm>
              <a:off x="1157581" y="5139533"/>
              <a:ext cx="1944608" cy="728523"/>
              <a:chOff x="1370183" y="5193338"/>
              <a:chExt cx="2442083" cy="914896"/>
            </a:xfrm>
          </p:grpSpPr>
          <p:sp>
            <p:nvSpPr>
              <p:cNvPr id="45" name="Flecha derecha 86"/>
              <p:cNvSpPr/>
              <p:nvPr/>
            </p:nvSpPr>
            <p:spPr>
              <a:xfrm>
                <a:off x="2428583" y="5372993"/>
                <a:ext cx="654840" cy="24300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C00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_tradnl" sz="1800" b="0" strike="noStrike" spc="-1" dirty="0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46" name="CuadroTexto 87"/>
              <p:cNvSpPr/>
              <p:nvPr/>
            </p:nvSpPr>
            <p:spPr>
              <a:xfrm>
                <a:off x="2401393" y="5505833"/>
                <a:ext cx="757556" cy="268167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square" lIns="90000" tIns="45000" rIns="90000" bIns="45000" anchor="t">
                <a:spAutoFit/>
              </a:bodyPr>
              <a:lstStyle/>
              <a:p>
                <a:pPr>
                  <a:lnSpc>
                    <a:spcPct val="100000"/>
                  </a:lnSpc>
                  <a:buNone/>
                </a:pPr>
                <a:r>
                  <a:rPr lang="es-ES_tradnl" sz="600" i="1" spc="-1" dirty="0" err="1">
                    <a:solidFill>
                      <a:srgbClr val="000000"/>
                    </a:solidFill>
                    <a:latin typeface="Arial"/>
                  </a:rPr>
                  <a:t>z</a:t>
                </a:r>
                <a:r>
                  <a:rPr lang="es-ES_tradnl" sz="600" b="0" i="1" strike="noStrike" spc="-1" dirty="0" err="1">
                    <a:solidFill>
                      <a:srgbClr val="000000"/>
                    </a:solidFill>
                    <a:latin typeface="Arial"/>
                  </a:rPr>
                  <a:t>epA</a:t>
                </a:r>
                <a:endParaRPr lang="es-ES" sz="600" b="0" strike="noStrike" spc="-1" dirty="0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Conector recto 88"/>
              <p:cNvSpPr/>
              <p:nvPr/>
            </p:nvSpPr>
            <p:spPr>
              <a:xfrm flipH="1" flipV="1">
                <a:off x="1370183" y="5489633"/>
                <a:ext cx="1058400" cy="468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-40320" rIns="90000" bIns="-40320" anchor="t" anchorCtr="1">
                <a:noAutofit/>
              </a:bodyPr>
              <a:lstStyle/>
              <a:p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Flecha derecha 107"/>
              <p:cNvSpPr/>
              <p:nvPr/>
            </p:nvSpPr>
            <p:spPr>
              <a:xfrm>
                <a:off x="2093063" y="5372993"/>
                <a:ext cx="325440" cy="24300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FF6666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_tradnl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grpSp>
            <p:nvGrpSpPr>
              <p:cNvPr id="49" name="Agrupar 100"/>
              <p:cNvGrpSpPr/>
              <p:nvPr/>
            </p:nvGrpSpPr>
            <p:grpSpPr>
              <a:xfrm>
                <a:off x="2322023" y="5301353"/>
                <a:ext cx="252720" cy="187920"/>
                <a:chOff x="2332800" y="5909760"/>
                <a:chExt cx="252720" cy="187920"/>
              </a:xfrm>
            </p:grpSpPr>
            <p:sp>
              <p:nvSpPr>
                <p:cNvPr id="50" name="Conector recto 89"/>
                <p:cNvSpPr/>
                <p:nvPr/>
              </p:nvSpPr>
              <p:spPr>
                <a:xfrm flipV="1">
                  <a:off x="2335680" y="5909760"/>
                  <a:ext cx="1440" cy="187920"/>
                </a:xfrm>
                <a:prstGeom prst="line">
                  <a:avLst/>
                </a:prstGeom>
                <a:ln w="9525">
                  <a:solidFill>
                    <a:srgbClr val="000000"/>
                  </a:solidFill>
                  <a:round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/>
              </p:style>
              <p:txBody>
                <a:bodyPr lIns="90000" tIns="45000" rIns="90000" bIns="45000" anchor="t" anchorCtr="1">
                  <a:noAutofit/>
                </a:bodyPr>
                <a:lstStyle/>
                <a:p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" name="Conector recto de flecha 90"/>
                <p:cNvSpPr/>
                <p:nvPr/>
              </p:nvSpPr>
              <p:spPr>
                <a:xfrm>
                  <a:off x="2332800" y="5910120"/>
                  <a:ext cx="25272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21600" h="21600">
                      <a:moveTo>
                        <a:pt x="0" y="0"/>
                      </a:moveTo>
                      <a:lnTo>
                        <a:pt x="21600" y="2160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round/>
                  <a:tailEnd type="triangle" w="med" len="med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/>
              </p:style>
              <p:txBody>
                <a:bodyPr lIns="90000" tIns="-44280" rIns="90000" bIns="-44280" anchor="t">
                  <a:noAutofit/>
                </a:bodyPr>
                <a:lstStyle/>
                <a:p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Conector recto 108"/>
                <p:cNvSpPr/>
                <p:nvPr/>
              </p:nvSpPr>
              <p:spPr>
                <a:xfrm flipV="1">
                  <a:off x="2365560" y="5909760"/>
                  <a:ext cx="1080" cy="187920"/>
                </a:xfrm>
                <a:prstGeom prst="line">
                  <a:avLst/>
                </a:prstGeom>
                <a:ln w="9525">
                  <a:solidFill>
                    <a:srgbClr val="000000"/>
                  </a:solidFill>
                  <a:round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/>
              </p:style>
              <p:txBody>
                <a:bodyPr lIns="90000" tIns="45000" rIns="90000" bIns="45000" anchor="t" anchorCtr="1">
                  <a:noAutofit/>
                </a:bodyPr>
                <a:lstStyle/>
                <a:p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53" name="Flecha derecha 111"/>
              <p:cNvSpPr/>
              <p:nvPr/>
            </p:nvSpPr>
            <p:spPr>
              <a:xfrm>
                <a:off x="1370183" y="5367953"/>
                <a:ext cx="525240" cy="24300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_tradnl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grpSp>
            <p:nvGrpSpPr>
              <p:cNvPr id="54" name="Agrupar 122"/>
              <p:cNvGrpSpPr/>
              <p:nvPr/>
            </p:nvGrpSpPr>
            <p:grpSpPr>
              <a:xfrm>
                <a:off x="1555943" y="5243753"/>
                <a:ext cx="252720" cy="187920"/>
                <a:chOff x="1566720" y="5852160"/>
                <a:chExt cx="252720" cy="187920"/>
              </a:xfrm>
            </p:grpSpPr>
            <p:sp>
              <p:nvSpPr>
                <p:cNvPr id="55" name="Conector recto 123"/>
                <p:cNvSpPr/>
                <p:nvPr/>
              </p:nvSpPr>
              <p:spPr>
                <a:xfrm flipV="1">
                  <a:off x="1569960" y="5852160"/>
                  <a:ext cx="1080" cy="187920"/>
                </a:xfrm>
                <a:prstGeom prst="line">
                  <a:avLst/>
                </a:prstGeom>
                <a:ln w="9525">
                  <a:solidFill>
                    <a:srgbClr val="000000"/>
                  </a:solidFill>
                  <a:round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/>
              </p:style>
              <p:txBody>
                <a:bodyPr lIns="90000" tIns="45000" rIns="90000" bIns="45000" anchor="t" anchorCtr="1">
                  <a:noAutofit/>
                </a:bodyPr>
                <a:lstStyle/>
                <a:p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Conector recto de flecha 124"/>
                <p:cNvSpPr/>
                <p:nvPr/>
              </p:nvSpPr>
              <p:spPr>
                <a:xfrm>
                  <a:off x="1566720" y="5858640"/>
                  <a:ext cx="252720" cy="7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21600" h="21600">
                      <a:moveTo>
                        <a:pt x="0" y="0"/>
                      </a:moveTo>
                      <a:lnTo>
                        <a:pt x="21600" y="2160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round/>
                  <a:tailEnd type="triangle" w="med" len="med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/>
              </p:style>
              <p:txBody>
                <a:bodyPr lIns="90000" tIns="-44280" rIns="90000" bIns="-44280" anchor="t">
                  <a:noAutofit/>
                </a:bodyPr>
                <a:lstStyle/>
                <a:p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7" name="Agrupar 151"/>
              <p:cNvGrpSpPr/>
              <p:nvPr/>
            </p:nvGrpSpPr>
            <p:grpSpPr>
              <a:xfrm>
                <a:off x="1555583" y="5943233"/>
                <a:ext cx="1569600" cy="51480"/>
                <a:chOff x="1566360" y="6551640"/>
                <a:chExt cx="1569600" cy="51480"/>
              </a:xfrm>
            </p:grpSpPr>
            <p:grpSp>
              <p:nvGrpSpPr>
                <p:cNvPr id="58" name="Agrupar 145"/>
                <p:cNvGrpSpPr/>
                <p:nvPr/>
              </p:nvGrpSpPr>
              <p:grpSpPr>
                <a:xfrm>
                  <a:off x="1566360" y="6555600"/>
                  <a:ext cx="632520" cy="47520"/>
                  <a:chOff x="1566360" y="6555600"/>
                  <a:chExt cx="632520" cy="47520"/>
                </a:xfrm>
              </p:grpSpPr>
              <p:sp>
                <p:nvSpPr>
                  <p:cNvPr id="59" name="Forma libre 149"/>
                  <p:cNvSpPr/>
                  <p:nvPr/>
                </p:nvSpPr>
                <p:spPr>
                  <a:xfrm>
                    <a:off x="1566360" y="6557400"/>
                    <a:ext cx="318600" cy="45720"/>
                  </a:xfrm>
                  <a:custGeom>
                    <a:avLst/>
                    <a:gdLst>
                      <a:gd name="textAreaLeft" fmla="*/ 0 w 318600"/>
                      <a:gd name="textAreaRight" fmla="*/ 318960 w 318600"/>
                      <a:gd name="textAreaTop" fmla="*/ 0 h 45720"/>
                      <a:gd name="textAreaBottom" fmla="*/ 46080 h 45720"/>
                    </a:gdLst>
                    <a:ahLst/>
                    <a:cxnLst/>
                    <a:rect l="textAreaLeft" t="textAreaTop" r="textAreaRight" b="textAreaBottom"/>
                    <a:pathLst>
                      <a:path w="336550" h="77381">
                        <a:moveTo>
                          <a:pt x="0" y="39049"/>
                        </a:moveTo>
                        <a:cubicBezTo>
                          <a:pt x="15081" y="17088"/>
                          <a:pt x="30163" y="-4872"/>
                          <a:pt x="50800" y="949"/>
                        </a:cubicBezTo>
                        <a:cubicBezTo>
                          <a:pt x="71437" y="6770"/>
                          <a:pt x="100013" y="73974"/>
                          <a:pt x="123825" y="73974"/>
                        </a:cubicBezTo>
                        <a:cubicBezTo>
                          <a:pt x="147637" y="73974"/>
                          <a:pt x="168275" y="420"/>
                          <a:pt x="193675" y="949"/>
                        </a:cubicBezTo>
                        <a:cubicBezTo>
                          <a:pt x="219075" y="1478"/>
                          <a:pt x="252413" y="72916"/>
                          <a:pt x="276225" y="77149"/>
                        </a:cubicBezTo>
                        <a:cubicBezTo>
                          <a:pt x="300037" y="81382"/>
                          <a:pt x="336550" y="26349"/>
                          <a:pt x="336550" y="26349"/>
                        </a:cubicBezTo>
                      </a:path>
                    </a:pathLst>
                  </a:custGeom>
                  <a:noFill/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/>
                </p:style>
                <p:txBody>
                  <a:bodyPr lIns="90000" tIns="1080" rIns="90000" bIns="108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s-ES" sz="1800" b="0" strike="noStrike" spc="-1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" name="Forma libre 150"/>
                  <p:cNvSpPr/>
                  <p:nvPr/>
                </p:nvSpPr>
                <p:spPr>
                  <a:xfrm>
                    <a:off x="1880280" y="6555600"/>
                    <a:ext cx="318600" cy="45720"/>
                  </a:xfrm>
                  <a:custGeom>
                    <a:avLst/>
                    <a:gdLst>
                      <a:gd name="textAreaLeft" fmla="*/ 0 w 318600"/>
                      <a:gd name="textAreaRight" fmla="*/ 318960 w 318600"/>
                      <a:gd name="textAreaTop" fmla="*/ 0 h 45720"/>
                      <a:gd name="textAreaBottom" fmla="*/ 46080 h 45720"/>
                    </a:gdLst>
                    <a:ahLst/>
                    <a:cxnLst/>
                    <a:rect l="textAreaLeft" t="textAreaTop" r="textAreaRight" b="textAreaBottom"/>
                    <a:pathLst>
                      <a:path w="336550" h="77381">
                        <a:moveTo>
                          <a:pt x="0" y="39049"/>
                        </a:moveTo>
                        <a:cubicBezTo>
                          <a:pt x="15081" y="17088"/>
                          <a:pt x="30163" y="-4872"/>
                          <a:pt x="50800" y="949"/>
                        </a:cubicBezTo>
                        <a:cubicBezTo>
                          <a:pt x="71437" y="6770"/>
                          <a:pt x="100013" y="73974"/>
                          <a:pt x="123825" y="73974"/>
                        </a:cubicBezTo>
                        <a:cubicBezTo>
                          <a:pt x="147637" y="73974"/>
                          <a:pt x="168275" y="420"/>
                          <a:pt x="193675" y="949"/>
                        </a:cubicBezTo>
                        <a:cubicBezTo>
                          <a:pt x="219075" y="1478"/>
                          <a:pt x="252413" y="72916"/>
                          <a:pt x="276225" y="77149"/>
                        </a:cubicBezTo>
                        <a:cubicBezTo>
                          <a:pt x="300037" y="81382"/>
                          <a:pt x="336550" y="26349"/>
                          <a:pt x="336550" y="26349"/>
                        </a:cubicBezTo>
                      </a:path>
                    </a:pathLst>
                  </a:custGeom>
                  <a:noFill/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/>
                </p:style>
                <p:txBody>
                  <a:bodyPr lIns="90000" tIns="1080" rIns="90000" bIns="108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s-ES" sz="1800" b="0" strike="noStrike" spc="-1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61" name="Forma libre 146"/>
                <p:cNvSpPr/>
                <p:nvPr/>
              </p:nvSpPr>
              <p:spPr>
                <a:xfrm>
                  <a:off x="2190240" y="6555600"/>
                  <a:ext cx="318600" cy="45720"/>
                </a:xfrm>
                <a:custGeom>
                  <a:avLst/>
                  <a:gdLst>
                    <a:gd name="textAreaLeft" fmla="*/ 0 w 318600"/>
                    <a:gd name="textAreaRight" fmla="*/ 318960 w 318600"/>
                    <a:gd name="textAreaTop" fmla="*/ 0 h 45720"/>
                    <a:gd name="textAreaBottom" fmla="*/ 46080 h 45720"/>
                  </a:gdLst>
                  <a:ahLst/>
                  <a:cxnLst/>
                  <a:rect l="textAreaLeft" t="textAreaTop" r="textAreaRight" b="textAreaBottom"/>
                  <a:pathLst>
                    <a:path w="336550" h="77381">
                      <a:moveTo>
                        <a:pt x="0" y="39049"/>
                      </a:moveTo>
                      <a:cubicBezTo>
                        <a:pt x="15081" y="17088"/>
                        <a:pt x="30163" y="-4872"/>
                        <a:pt x="50800" y="949"/>
                      </a:cubicBezTo>
                      <a:cubicBezTo>
                        <a:pt x="71437" y="6770"/>
                        <a:pt x="100013" y="73974"/>
                        <a:pt x="123825" y="73974"/>
                      </a:cubicBezTo>
                      <a:cubicBezTo>
                        <a:pt x="147637" y="73974"/>
                        <a:pt x="168275" y="420"/>
                        <a:pt x="193675" y="949"/>
                      </a:cubicBezTo>
                      <a:cubicBezTo>
                        <a:pt x="219075" y="1478"/>
                        <a:pt x="252413" y="72916"/>
                        <a:pt x="276225" y="77149"/>
                      </a:cubicBezTo>
                      <a:cubicBezTo>
                        <a:pt x="300037" y="81382"/>
                        <a:pt x="336550" y="26349"/>
                        <a:pt x="336550" y="26349"/>
                      </a:cubicBezTo>
                    </a:path>
                  </a:pathLst>
                </a:custGeom>
                <a:noFill/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/>
              </p:style>
              <p:txBody>
                <a:bodyPr lIns="90000" tIns="1080" rIns="90000" bIns="1080" anchor="ctr">
                  <a:noAutofit/>
                </a:bodyPr>
                <a:lstStyle/>
                <a:p>
                  <a:pPr algn="ctr">
                    <a:lnSpc>
                      <a:spcPct val="100000"/>
                    </a:lnSpc>
                    <a:buNone/>
                  </a:pPr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" name="Forma libre 147"/>
                <p:cNvSpPr/>
                <p:nvPr/>
              </p:nvSpPr>
              <p:spPr>
                <a:xfrm>
                  <a:off x="2503800" y="6553800"/>
                  <a:ext cx="318600" cy="45720"/>
                </a:xfrm>
                <a:custGeom>
                  <a:avLst/>
                  <a:gdLst>
                    <a:gd name="textAreaLeft" fmla="*/ 0 w 318600"/>
                    <a:gd name="textAreaRight" fmla="*/ 318960 w 318600"/>
                    <a:gd name="textAreaTop" fmla="*/ 0 h 45720"/>
                    <a:gd name="textAreaBottom" fmla="*/ 46080 h 45720"/>
                  </a:gdLst>
                  <a:ahLst/>
                  <a:cxnLst/>
                  <a:rect l="textAreaLeft" t="textAreaTop" r="textAreaRight" b="textAreaBottom"/>
                  <a:pathLst>
                    <a:path w="336550" h="77381">
                      <a:moveTo>
                        <a:pt x="0" y="39049"/>
                      </a:moveTo>
                      <a:cubicBezTo>
                        <a:pt x="15081" y="17088"/>
                        <a:pt x="30163" y="-4872"/>
                        <a:pt x="50800" y="949"/>
                      </a:cubicBezTo>
                      <a:cubicBezTo>
                        <a:pt x="71437" y="6770"/>
                        <a:pt x="100013" y="73974"/>
                        <a:pt x="123825" y="73974"/>
                      </a:cubicBezTo>
                      <a:cubicBezTo>
                        <a:pt x="147637" y="73974"/>
                        <a:pt x="168275" y="420"/>
                        <a:pt x="193675" y="949"/>
                      </a:cubicBezTo>
                      <a:cubicBezTo>
                        <a:pt x="219075" y="1478"/>
                        <a:pt x="252413" y="72916"/>
                        <a:pt x="276225" y="77149"/>
                      </a:cubicBezTo>
                      <a:cubicBezTo>
                        <a:pt x="300037" y="81382"/>
                        <a:pt x="336550" y="26349"/>
                        <a:pt x="336550" y="26349"/>
                      </a:cubicBezTo>
                    </a:path>
                  </a:pathLst>
                </a:custGeom>
                <a:noFill/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/>
              </p:style>
              <p:txBody>
                <a:bodyPr lIns="90000" tIns="1080" rIns="90000" bIns="1080" anchor="ctr">
                  <a:noAutofit/>
                </a:bodyPr>
                <a:lstStyle/>
                <a:p>
                  <a:pPr algn="ctr">
                    <a:lnSpc>
                      <a:spcPct val="100000"/>
                    </a:lnSpc>
                    <a:buNone/>
                  </a:pPr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" name="Forma libre 148"/>
                <p:cNvSpPr/>
                <p:nvPr/>
              </p:nvSpPr>
              <p:spPr>
                <a:xfrm>
                  <a:off x="2817360" y="6551640"/>
                  <a:ext cx="318600" cy="45720"/>
                </a:xfrm>
                <a:custGeom>
                  <a:avLst/>
                  <a:gdLst>
                    <a:gd name="textAreaLeft" fmla="*/ 0 w 318600"/>
                    <a:gd name="textAreaRight" fmla="*/ 318960 w 318600"/>
                    <a:gd name="textAreaTop" fmla="*/ 0 h 45720"/>
                    <a:gd name="textAreaBottom" fmla="*/ 46080 h 45720"/>
                  </a:gdLst>
                  <a:ahLst/>
                  <a:cxnLst/>
                  <a:rect l="textAreaLeft" t="textAreaTop" r="textAreaRight" b="textAreaBottom"/>
                  <a:pathLst>
                    <a:path w="336550" h="77381">
                      <a:moveTo>
                        <a:pt x="0" y="39049"/>
                      </a:moveTo>
                      <a:cubicBezTo>
                        <a:pt x="15081" y="17088"/>
                        <a:pt x="30163" y="-4872"/>
                        <a:pt x="50800" y="949"/>
                      </a:cubicBezTo>
                      <a:cubicBezTo>
                        <a:pt x="71437" y="6770"/>
                        <a:pt x="100013" y="73974"/>
                        <a:pt x="123825" y="73974"/>
                      </a:cubicBezTo>
                      <a:cubicBezTo>
                        <a:pt x="147637" y="73974"/>
                        <a:pt x="168275" y="420"/>
                        <a:pt x="193675" y="949"/>
                      </a:cubicBezTo>
                      <a:cubicBezTo>
                        <a:pt x="219075" y="1478"/>
                        <a:pt x="252413" y="72916"/>
                        <a:pt x="276225" y="77149"/>
                      </a:cubicBezTo>
                      <a:cubicBezTo>
                        <a:pt x="300037" y="81382"/>
                        <a:pt x="336550" y="26349"/>
                        <a:pt x="336550" y="26349"/>
                      </a:cubicBezTo>
                    </a:path>
                  </a:pathLst>
                </a:custGeom>
                <a:noFill/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/>
              </p:style>
              <p:txBody>
                <a:bodyPr lIns="90000" tIns="1080" rIns="90000" bIns="1080" anchor="ctr">
                  <a:noAutofit/>
                </a:bodyPr>
                <a:lstStyle/>
                <a:p>
                  <a:pPr algn="ctr">
                    <a:lnSpc>
                      <a:spcPct val="100000"/>
                    </a:lnSpc>
                    <a:buNone/>
                  </a:pPr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4" name="Conector recto 153"/>
              <p:cNvSpPr/>
              <p:nvPr/>
            </p:nvSpPr>
            <p:spPr>
              <a:xfrm>
                <a:off x="1555943" y="5431673"/>
                <a:ext cx="360" cy="557640"/>
              </a:xfrm>
              <a:prstGeom prst="line">
                <a:avLst/>
              </a:prstGeom>
              <a:ln w="6350">
                <a:solidFill>
                  <a:srgbClr val="000000"/>
                </a:solidFill>
                <a:prstDash val="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45000" rIns="90000" bIns="45000" anchor="t" anchorCtr="1">
                <a:noAutofit/>
              </a:bodyPr>
              <a:lstStyle/>
              <a:p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CuadroTexto 158"/>
              <p:cNvSpPr/>
              <p:nvPr/>
            </p:nvSpPr>
            <p:spPr>
              <a:xfrm>
                <a:off x="3083424" y="5862592"/>
                <a:ext cx="728842" cy="245642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square" lIns="90000" tIns="45000" rIns="90000" bIns="45000" anchor="t">
                <a:spAutoFit/>
              </a:bodyPr>
              <a:lstStyle/>
              <a:p>
                <a:pPr>
                  <a:lnSpc>
                    <a:spcPct val="100000"/>
                  </a:lnSpc>
                  <a:buNone/>
                </a:pPr>
                <a:r>
                  <a:rPr lang="es-ES_tradnl" sz="500" b="0" strike="noStrike" spc="-1" dirty="0">
                    <a:solidFill>
                      <a:srgbClr val="000000"/>
                    </a:solidFill>
                    <a:latin typeface="Arial"/>
                  </a:rPr>
                  <a:t>2.1 Kb</a:t>
                </a:r>
                <a:endParaRPr lang="es-ES" sz="500" b="0" strike="noStrike" spc="-1" dirty="0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3" name="Grupo 2">
                <a:extLst>
                  <a:ext uri="{FF2B5EF4-FFF2-40B4-BE49-F238E27FC236}">
                    <a16:creationId xmlns:a16="http://schemas.microsoft.com/office/drawing/2014/main" id="{9493B4EE-B7D3-FA4D-AE24-9BB4C21C8697}"/>
                  </a:ext>
                </a:extLst>
              </p:cNvPr>
              <p:cNvGrpSpPr/>
              <p:nvPr/>
            </p:nvGrpSpPr>
            <p:grpSpPr>
              <a:xfrm>
                <a:off x="2166464" y="5345287"/>
                <a:ext cx="204699" cy="254866"/>
                <a:chOff x="3289320" y="4782960"/>
                <a:chExt cx="292320" cy="363960"/>
              </a:xfrm>
            </p:grpSpPr>
            <p:grpSp>
              <p:nvGrpSpPr>
                <p:cNvPr id="76" name="Group 79"/>
                <p:cNvGrpSpPr/>
                <p:nvPr/>
              </p:nvGrpSpPr>
              <p:grpSpPr>
                <a:xfrm>
                  <a:off x="3289320" y="4782960"/>
                  <a:ext cx="194040" cy="361440"/>
                  <a:chOff x="3289320" y="4782960"/>
                  <a:chExt cx="194040" cy="361440"/>
                </a:xfrm>
              </p:grpSpPr>
              <p:sp>
                <p:nvSpPr>
                  <p:cNvPr id="77" name="Oval 57"/>
                  <p:cNvSpPr/>
                  <p:nvPr/>
                </p:nvSpPr>
                <p:spPr>
                  <a:xfrm rot="16200000">
                    <a:off x="3248640" y="5026320"/>
                    <a:ext cx="158760" cy="77400"/>
                  </a:xfrm>
                  <a:prstGeom prst="ellipse">
                    <a:avLst/>
                  </a:prstGeom>
                  <a:solidFill>
                    <a:srgbClr val="9B24F4"/>
                  </a:solidFill>
                  <a:ln>
                    <a:solidFill>
                      <a:srgbClr val="1D3155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  <p:txBody>
                  <a:bodyPr lIns="90000" tIns="10080" rIns="90000" bIns="1008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n-ES" sz="1800" b="0" strike="noStrike" spc="-1">
                      <a:solidFill>
                        <a:schemeClr val="lt1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" name="Oval 59"/>
                  <p:cNvSpPr/>
                  <p:nvPr/>
                </p:nvSpPr>
                <p:spPr>
                  <a:xfrm rot="17726400">
                    <a:off x="3334680" y="4832280"/>
                    <a:ext cx="158760" cy="77400"/>
                  </a:xfrm>
                  <a:prstGeom prst="ellipse">
                    <a:avLst/>
                  </a:prstGeom>
                  <a:solidFill>
                    <a:srgbClr val="9B24F4"/>
                  </a:solidFill>
                  <a:ln>
                    <a:solidFill>
                      <a:srgbClr val="1D3155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  <p:txBody>
                  <a:bodyPr lIns="90000" tIns="10080" rIns="90000" bIns="1008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n-ES" sz="1800" b="0" strike="noStrike" spc="-1">
                      <a:solidFill>
                        <a:schemeClr val="lt1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" name="Freeform 62"/>
                  <p:cNvSpPr/>
                  <p:nvPr/>
                </p:nvSpPr>
                <p:spPr>
                  <a:xfrm>
                    <a:off x="3315240" y="4938840"/>
                    <a:ext cx="48600" cy="45720"/>
                  </a:xfrm>
                  <a:custGeom>
                    <a:avLst/>
                    <a:gdLst>
                      <a:gd name="textAreaLeft" fmla="*/ 0 w 48600"/>
                      <a:gd name="textAreaRight" fmla="*/ 48960 w 48600"/>
                      <a:gd name="textAreaTop" fmla="*/ 0 h 45720"/>
                      <a:gd name="textAreaBottom" fmla="*/ 46080 h 45720"/>
                    </a:gdLst>
                    <a:ahLst/>
                    <a:cxnLst/>
                    <a:rect l="textAreaLeft" t="textAreaTop" r="textAreaRight" b="textAreaBottom"/>
                    <a:pathLst>
                      <a:path w="92279" h="109207">
                        <a:moveTo>
                          <a:pt x="29362" y="109207"/>
                        </a:moveTo>
                        <a:cubicBezTo>
                          <a:pt x="23769" y="99420"/>
                          <a:pt x="18384" y="89512"/>
                          <a:pt x="12584" y="79846"/>
                        </a:cubicBezTo>
                        <a:cubicBezTo>
                          <a:pt x="9990" y="75523"/>
                          <a:pt x="6450" y="71771"/>
                          <a:pt x="4195" y="67262"/>
                        </a:cubicBezTo>
                        <a:cubicBezTo>
                          <a:pt x="2218" y="63308"/>
                          <a:pt x="1398" y="58873"/>
                          <a:pt x="0" y="54679"/>
                        </a:cubicBezTo>
                        <a:cubicBezTo>
                          <a:pt x="1398" y="46290"/>
                          <a:pt x="-24" y="36896"/>
                          <a:pt x="4195" y="29512"/>
                        </a:cubicBezTo>
                        <a:cubicBezTo>
                          <a:pt x="6389" y="25673"/>
                          <a:pt x="12513" y="26480"/>
                          <a:pt x="16778" y="25317"/>
                        </a:cubicBezTo>
                        <a:cubicBezTo>
                          <a:pt x="68840" y="11118"/>
                          <a:pt x="33944" y="22390"/>
                          <a:pt x="62918" y="12734"/>
                        </a:cubicBezTo>
                        <a:cubicBezTo>
                          <a:pt x="75220" y="4532"/>
                          <a:pt x="74192" y="3624"/>
                          <a:pt x="88085" y="150"/>
                        </a:cubicBezTo>
                        <a:cubicBezTo>
                          <a:pt x="89441" y="-189"/>
                          <a:pt x="90881" y="150"/>
                          <a:pt x="92279" y="150"/>
                        </a:cubicBezTo>
                      </a:path>
                    </a:pathLst>
                  </a:custGeom>
                  <a:noFill/>
                  <a:ln>
                    <a:solidFill>
                      <a:srgbClr val="1D3155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  <p:txBody>
                  <a:bodyPr lIns="90000" tIns="1080" rIns="90000" bIns="108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n-ES" sz="1800" b="0" strike="noStrike" spc="-1">
                      <a:solidFill>
                        <a:schemeClr val="lt1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" name="Oval 63"/>
                  <p:cNvSpPr/>
                  <p:nvPr/>
                </p:nvSpPr>
                <p:spPr>
                  <a:xfrm>
                    <a:off x="3302640" y="4923360"/>
                    <a:ext cx="105120" cy="86400"/>
                  </a:xfrm>
                  <a:prstGeom prst="ellipse">
                    <a:avLst/>
                  </a:prstGeom>
                  <a:solidFill>
                    <a:schemeClr val="accent4"/>
                  </a:solidFill>
                  <a:ln w="12700">
                    <a:solidFill>
                      <a:srgbClr val="1D3155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  <p:txBody>
                  <a:bodyPr lIns="90000" tIns="16200" rIns="90000" bIns="1620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n-ES" sz="1800" b="0" strike="noStrike" spc="-1">
                      <a:solidFill>
                        <a:schemeClr val="lt1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81" name="Group 80"/>
                <p:cNvGrpSpPr/>
                <p:nvPr/>
              </p:nvGrpSpPr>
              <p:grpSpPr>
                <a:xfrm>
                  <a:off x="3388320" y="4785480"/>
                  <a:ext cx="193320" cy="361440"/>
                  <a:chOff x="3388320" y="4785480"/>
                  <a:chExt cx="193320" cy="361440"/>
                </a:xfrm>
              </p:grpSpPr>
              <p:sp>
                <p:nvSpPr>
                  <p:cNvPr id="82" name="Oval 81"/>
                  <p:cNvSpPr/>
                  <p:nvPr/>
                </p:nvSpPr>
                <p:spPr>
                  <a:xfrm rot="5400000" flipH="1">
                    <a:off x="3463200" y="5028840"/>
                    <a:ext cx="158760" cy="77400"/>
                  </a:xfrm>
                  <a:prstGeom prst="ellipse">
                    <a:avLst/>
                  </a:prstGeom>
                  <a:solidFill>
                    <a:srgbClr val="9B24F4"/>
                  </a:solidFill>
                  <a:ln>
                    <a:solidFill>
                      <a:srgbClr val="1D3155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  <p:txBody>
                  <a:bodyPr lIns="90000" tIns="10080" rIns="90000" bIns="1008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n-ES" sz="1800" b="0" strike="noStrike" spc="-1">
                      <a:solidFill>
                        <a:schemeClr val="lt1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" name="Oval 82"/>
                  <p:cNvSpPr/>
                  <p:nvPr/>
                </p:nvSpPr>
                <p:spPr>
                  <a:xfrm rot="3873600" flipH="1">
                    <a:off x="3377880" y="4834800"/>
                    <a:ext cx="158760" cy="77760"/>
                  </a:xfrm>
                  <a:prstGeom prst="ellipse">
                    <a:avLst/>
                  </a:prstGeom>
                  <a:solidFill>
                    <a:srgbClr val="9B24F4"/>
                  </a:solidFill>
                  <a:ln>
                    <a:solidFill>
                      <a:srgbClr val="1D3155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  <p:txBody>
                  <a:bodyPr lIns="90000" tIns="10440" rIns="90000" bIns="1044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n-ES" sz="1800" b="0" strike="noStrike" spc="-1">
                      <a:solidFill>
                        <a:schemeClr val="lt1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" name="Freeform 83"/>
                  <p:cNvSpPr/>
                  <p:nvPr/>
                </p:nvSpPr>
                <p:spPr>
                  <a:xfrm flipH="1">
                    <a:off x="3506760" y="4941360"/>
                    <a:ext cx="48600" cy="45720"/>
                  </a:xfrm>
                  <a:custGeom>
                    <a:avLst/>
                    <a:gdLst>
                      <a:gd name="textAreaLeft" fmla="*/ -360 w 48600"/>
                      <a:gd name="textAreaRight" fmla="*/ 48600 w 48600"/>
                      <a:gd name="textAreaTop" fmla="*/ 0 h 45720"/>
                      <a:gd name="textAreaBottom" fmla="*/ 46080 h 45720"/>
                    </a:gdLst>
                    <a:ahLst/>
                    <a:cxnLst/>
                    <a:rect l="textAreaLeft" t="textAreaTop" r="textAreaRight" b="textAreaBottom"/>
                    <a:pathLst>
                      <a:path w="92279" h="109207">
                        <a:moveTo>
                          <a:pt x="29362" y="109207"/>
                        </a:moveTo>
                        <a:cubicBezTo>
                          <a:pt x="23769" y="99420"/>
                          <a:pt x="18384" y="89512"/>
                          <a:pt x="12584" y="79846"/>
                        </a:cubicBezTo>
                        <a:cubicBezTo>
                          <a:pt x="9990" y="75523"/>
                          <a:pt x="6450" y="71771"/>
                          <a:pt x="4195" y="67262"/>
                        </a:cubicBezTo>
                        <a:cubicBezTo>
                          <a:pt x="2218" y="63308"/>
                          <a:pt x="1398" y="58873"/>
                          <a:pt x="0" y="54679"/>
                        </a:cubicBezTo>
                        <a:cubicBezTo>
                          <a:pt x="1398" y="46290"/>
                          <a:pt x="-24" y="36896"/>
                          <a:pt x="4195" y="29512"/>
                        </a:cubicBezTo>
                        <a:cubicBezTo>
                          <a:pt x="6389" y="25673"/>
                          <a:pt x="12513" y="26480"/>
                          <a:pt x="16778" y="25317"/>
                        </a:cubicBezTo>
                        <a:cubicBezTo>
                          <a:pt x="68840" y="11118"/>
                          <a:pt x="33944" y="22390"/>
                          <a:pt x="62918" y="12734"/>
                        </a:cubicBezTo>
                        <a:cubicBezTo>
                          <a:pt x="75220" y="4532"/>
                          <a:pt x="74192" y="3624"/>
                          <a:pt x="88085" y="150"/>
                        </a:cubicBezTo>
                        <a:cubicBezTo>
                          <a:pt x="89441" y="-189"/>
                          <a:pt x="90881" y="150"/>
                          <a:pt x="92279" y="150"/>
                        </a:cubicBezTo>
                      </a:path>
                    </a:pathLst>
                  </a:custGeom>
                  <a:noFill/>
                  <a:ln>
                    <a:solidFill>
                      <a:srgbClr val="1D3155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  <p:txBody>
                  <a:bodyPr lIns="90000" tIns="1080" rIns="90000" bIns="108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n-ES" sz="1800" b="0" strike="noStrike" spc="-1">
                      <a:solidFill>
                        <a:schemeClr val="lt1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" name="Oval 84"/>
                  <p:cNvSpPr/>
                  <p:nvPr/>
                </p:nvSpPr>
                <p:spPr>
                  <a:xfrm flipH="1">
                    <a:off x="3463200" y="4926240"/>
                    <a:ext cx="105120" cy="86400"/>
                  </a:xfrm>
                  <a:prstGeom prst="ellipse">
                    <a:avLst/>
                  </a:prstGeom>
                  <a:solidFill>
                    <a:schemeClr val="accent4"/>
                  </a:solidFill>
                  <a:ln w="12700">
                    <a:solidFill>
                      <a:srgbClr val="1D3155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  <p:txBody>
                  <a:bodyPr lIns="90000" tIns="16200" rIns="90000" bIns="16200" anchor="ctr">
                    <a:noAutofit/>
                  </a:bodyPr>
                  <a:lstStyle/>
                  <a:p>
                    <a:pPr algn="ctr">
                      <a:lnSpc>
                        <a:spcPct val="100000"/>
                      </a:lnSpc>
                      <a:buNone/>
                    </a:pPr>
                    <a:endParaRPr lang="en-ES" sz="1800" b="0" strike="noStrike" spc="-1">
                      <a:solidFill>
                        <a:schemeClr val="lt1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114" name="Group 129"/>
              <p:cNvGrpSpPr/>
              <p:nvPr/>
            </p:nvGrpSpPr>
            <p:grpSpPr>
              <a:xfrm>
                <a:off x="2325808" y="5193338"/>
                <a:ext cx="244615" cy="209670"/>
                <a:chOff x="2447640" y="5841720"/>
                <a:chExt cx="133560" cy="114480"/>
              </a:xfrm>
            </p:grpSpPr>
            <p:sp>
              <p:nvSpPr>
                <p:cNvPr id="115" name="Straight Connector 127"/>
                <p:cNvSpPr/>
                <p:nvPr/>
              </p:nvSpPr>
              <p:spPr>
                <a:xfrm>
                  <a:off x="2447640" y="5841720"/>
                  <a:ext cx="133560" cy="114480"/>
                </a:xfrm>
                <a:prstGeom prst="line">
                  <a:avLst/>
                </a:prstGeom>
                <a:ln w="381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  <p:txBody>
                <a:bodyPr lIns="90000" tIns="45000" rIns="90000" bIns="45000" anchor="t" anchorCtr="1">
                  <a:noAutofit/>
                </a:bodyPr>
                <a:lstStyle/>
                <a:p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6" name="Straight Connector 128"/>
                <p:cNvSpPr/>
                <p:nvPr/>
              </p:nvSpPr>
              <p:spPr>
                <a:xfrm flipH="1">
                  <a:off x="2447640" y="5841720"/>
                  <a:ext cx="133560" cy="114480"/>
                </a:xfrm>
                <a:prstGeom prst="line">
                  <a:avLst/>
                </a:prstGeom>
                <a:ln w="381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  <p:txBody>
                <a:bodyPr lIns="90000" tIns="45000" rIns="90000" bIns="45000" anchor="t" anchorCtr="1">
                  <a:noAutofit/>
                </a:bodyPr>
                <a:lstStyle/>
                <a:p>
                  <a:endParaRPr lang="es-ES" sz="1800" b="0" strike="noStrike" spc="-1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120" name="CuadroTexto 119">
              <a:extLst>
                <a:ext uri="{FF2B5EF4-FFF2-40B4-BE49-F238E27FC236}">
                  <a16:creationId xmlns:a16="http://schemas.microsoft.com/office/drawing/2014/main" id="{402DAC8C-5C20-FD47-978B-97B885E13DBF}"/>
                </a:ext>
              </a:extLst>
            </p:cNvPr>
            <p:cNvSpPr txBox="1"/>
            <p:nvPr/>
          </p:nvSpPr>
          <p:spPr>
            <a:xfrm>
              <a:off x="1554798" y="4856395"/>
              <a:ext cx="566482" cy="2152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Holo-</a:t>
              </a:r>
              <a:r>
                <a:rPr lang="es-ES" sz="600" dirty="0" err="1"/>
                <a:t>Zur</a:t>
              </a:r>
              <a:endParaRPr lang="es-ES" sz="600" dirty="0"/>
            </a:p>
          </p:txBody>
        </p:sp>
        <p:cxnSp>
          <p:nvCxnSpPr>
            <p:cNvPr id="11" name="Conector recto 10">
              <a:extLst>
                <a:ext uri="{FF2B5EF4-FFF2-40B4-BE49-F238E27FC236}">
                  <a16:creationId xmlns:a16="http://schemas.microsoft.com/office/drawing/2014/main" id="{617E4A11-CDFA-BD41-A4E1-5968959DB1CE}"/>
                </a:ext>
              </a:extLst>
            </p:cNvPr>
            <p:cNvCxnSpPr/>
            <p:nvPr/>
          </p:nvCxnSpPr>
          <p:spPr>
            <a:xfrm>
              <a:off x="1733204" y="5042684"/>
              <a:ext cx="86451" cy="219147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upo 23">
            <a:extLst>
              <a:ext uri="{FF2B5EF4-FFF2-40B4-BE49-F238E27FC236}">
                <a16:creationId xmlns:a16="http://schemas.microsoft.com/office/drawing/2014/main" id="{11CFAD72-C838-EE45-91CF-8F92BD636EA0}"/>
              </a:ext>
            </a:extLst>
          </p:cNvPr>
          <p:cNvGrpSpPr/>
          <p:nvPr/>
        </p:nvGrpSpPr>
        <p:grpSpPr>
          <a:xfrm>
            <a:off x="3628661" y="3074448"/>
            <a:ext cx="306071" cy="499332"/>
            <a:chOff x="2297505" y="4099104"/>
            <a:chExt cx="306071" cy="499332"/>
          </a:xfrm>
        </p:grpSpPr>
        <p:grpSp>
          <p:nvGrpSpPr>
            <p:cNvPr id="23" name="Grupo 22">
              <a:extLst>
                <a:ext uri="{FF2B5EF4-FFF2-40B4-BE49-F238E27FC236}">
                  <a16:creationId xmlns:a16="http://schemas.microsoft.com/office/drawing/2014/main" id="{35840FF0-B8B9-5E43-99B2-7505ACCF036F}"/>
                </a:ext>
              </a:extLst>
            </p:cNvPr>
            <p:cNvGrpSpPr/>
            <p:nvPr/>
          </p:nvGrpSpPr>
          <p:grpSpPr>
            <a:xfrm>
              <a:off x="2297505" y="4239577"/>
              <a:ext cx="205948" cy="358859"/>
              <a:chOff x="3021023" y="4132290"/>
              <a:chExt cx="205948" cy="358859"/>
            </a:xfrm>
          </p:grpSpPr>
          <p:sp>
            <p:nvSpPr>
              <p:cNvPr id="19" name="Forma libre 18">
                <a:extLst>
                  <a:ext uri="{FF2B5EF4-FFF2-40B4-BE49-F238E27FC236}">
                    <a16:creationId xmlns:a16="http://schemas.microsoft.com/office/drawing/2014/main" id="{DE466031-000C-DB4E-836C-0B5CB52B029A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C0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22" name="Forma libre 21">
                <a:extLst>
                  <a:ext uri="{FF2B5EF4-FFF2-40B4-BE49-F238E27FC236}">
                    <a16:creationId xmlns:a16="http://schemas.microsoft.com/office/drawing/2014/main" id="{71D3B4D5-2CD3-A746-A98D-12CD1F8F2E5A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33" name="Grupo 132">
              <a:extLst>
                <a:ext uri="{FF2B5EF4-FFF2-40B4-BE49-F238E27FC236}">
                  <a16:creationId xmlns:a16="http://schemas.microsoft.com/office/drawing/2014/main" id="{640047B2-48A4-5E41-B842-B0F63FFF4CCE}"/>
                </a:ext>
              </a:extLst>
            </p:cNvPr>
            <p:cNvGrpSpPr/>
            <p:nvPr/>
          </p:nvGrpSpPr>
          <p:grpSpPr>
            <a:xfrm>
              <a:off x="2488818" y="4099104"/>
              <a:ext cx="114758" cy="152400"/>
              <a:chOff x="3021023" y="4132290"/>
              <a:chExt cx="205948" cy="358859"/>
            </a:xfrm>
          </p:grpSpPr>
          <p:sp>
            <p:nvSpPr>
              <p:cNvPr id="134" name="Forma libre 133">
                <a:extLst>
                  <a:ext uri="{FF2B5EF4-FFF2-40B4-BE49-F238E27FC236}">
                    <a16:creationId xmlns:a16="http://schemas.microsoft.com/office/drawing/2014/main" id="{594E3525-2729-1442-8000-4166007C2F8B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0070C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35" name="Forma libre 134">
                <a:extLst>
                  <a:ext uri="{FF2B5EF4-FFF2-40B4-BE49-F238E27FC236}">
                    <a16:creationId xmlns:a16="http://schemas.microsoft.com/office/drawing/2014/main" id="{37B58A9F-CAED-9641-96D7-2525D75D6B53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grpSp>
        <p:nvGrpSpPr>
          <p:cNvPr id="18" name="Grupo 17">
            <a:extLst>
              <a:ext uri="{FF2B5EF4-FFF2-40B4-BE49-F238E27FC236}">
                <a16:creationId xmlns:a16="http://schemas.microsoft.com/office/drawing/2014/main" id="{736C222D-2C59-2B46-BF71-DFFAFC61FAA5}"/>
              </a:ext>
            </a:extLst>
          </p:cNvPr>
          <p:cNvGrpSpPr/>
          <p:nvPr/>
        </p:nvGrpSpPr>
        <p:grpSpPr>
          <a:xfrm>
            <a:off x="3231922" y="3402534"/>
            <a:ext cx="655321" cy="310465"/>
            <a:chOff x="1869721" y="4434816"/>
            <a:chExt cx="835035" cy="395606"/>
          </a:xfrm>
        </p:grpSpPr>
        <p:grpSp>
          <p:nvGrpSpPr>
            <p:cNvPr id="17" name="Grupo 16">
              <a:extLst>
                <a:ext uri="{FF2B5EF4-FFF2-40B4-BE49-F238E27FC236}">
                  <a16:creationId xmlns:a16="http://schemas.microsoft.com/office/drawing/2014/main" id="{47F1611E-A209-614F-870E-F6300718F397}"/>
                </a:ext>
              </a:extLst>
            </p:cNvPr>
            <p:cNvGrpSpPr/>
            <p:nvPr/>
          </p:nvGrpSpPr>
          <p:grpSpPr>
            <a:xfrm rot="20543507">
              <a:off x="1869721" y="4797956"/>
              <a:ext cx="432139" cy="32466"/>
              <a:chOff x="1849246" y="4735547"/>
              <a:chExt cx="432139" cy="32466"/>
            </a:xfrm>
          </p:grpSpPr>
          <p:sp>
            <p:nvSpPr>
              <p:cNvPr id="125" name="Forma libre 149">
                <a:extLst>
                  <a:ext uri="{FF2B5EF4-FFF2-40B4-BE49-F238E27FC236}">
                    <a16:creationId xmlns:a16="http://schemas.microsoft.com/office/drawing/2014/main" id="{9054B73F-9BC1-8242-89F2-DEE4938BCD4E}"/>
                  </a:ext>
                </a:extLst>
              </p:cNvPr>
              <p:cNvSpPr/>
              <p:nvPr/>
            </p:nvSpPr>
            <p:spPr>
              <a:xfrm>
                <a:off x="1849246" y="4736777"/>
                <a:ext cx="217668" cy="31236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Forma libre 150">
                <a:extLst>
                  <a:ext uri="{FF2B5EF4-FFF2-40B4-BE49-F238E27FC236}">
                    <a16:creationId xmlns:a16="http://schemas.microsoft.com/office/drawing/2014/main" id="{272055DC-941D-9041-8441-98F0E9B9DF1F}"/>
                  </a:ext>
                </a:extLst>
              </p:cNvPr>
              <p:cNvSpPr/>
              <p:nvPr/>
            </p:nvSpPr>
            <p:spPr>
              <a:xfrm>
                <a:off x="2063717" y="4735547"/>
                <a:ext cx="217668" cy="31236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" name="Grupo 15">
              <a:extLst>
                <a:ext uri="{FF2B5EF4-FFF2-40B4-BE49-F238E27FC236}">
                  <a16:creationId xmlns:a16="http://schemas.microsoft.com/office/drawing/2014/main" id="{CF68FAB9-B45A-BB41-9C53-1C11CE30F2D0}"/>
                </a:ext>
              </a:extLst>
            </p:cNvPr>
            <p:cNvGrpSpPr/>
            <p:nvPr/>
          </p:nvGrpSpPr>
          <p:grpSpPr>
            <a:xfrm>
              <a:off x="2335809" y="4543813"/>
              <a:ext cx="368947" cy="236552"/>
              <a:chOff x="3539379" y="4188715"/>
              <a:chExt cx="368947" cy="236552"/>
            </a:xfrm>
          </p:grpSpPr>
          <p:sp>
            <p:nvSpPr>
              <p:cNvPr id="127" name="Forma libre 146">
                <a:extLst>
                  <a:ext uri="{FF2B5EF4-FFF2-40B4-BE49-F238E27FC236}">
                    <a16:creationId xmlns:a16="http://schemas.microsoft.com/office/drawing/2014/main" id="{3A8F39E5-427B-DE45-A79B-4840C167C88C}"/>
                  </a:ext>
                </a:extLst>
              </p:cNvPr>
              <p:cNvSpPr/>
              <p:nvPr/>
            </p:nvSpPr>
            <p:spPr>
              <a:xfrm rot="18409375">
                <a:off x="3446163" y="4300815"/>
                <a:ext cx="217668" cy="31236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Forma libre 147">
                <a:extLst>
                  <a:ext uri="{FF2B5EF4-FFF2-40B4-BE49-F238E27FC236}">
                    <a16:creationId xmlns:a16="http://schemas.microsoft.com/office/drawing/2014/main" id="{203497E1-4202-6943-8220-E7148209F087}"/>
                  </a:ext>
                </a:extLst>
              </p:cNvPr>
              <p:cNvSpPr/>
              <p:nvPr/>
            </p:nvSpPr>
            <p:spPr>
              <a:xfrm rot="20444268" flipV="1">
                <a:off x="3540884" y="4219888"/>
                <a:ext cx="217668" cy="45719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Forma libre 148">
                <a:extLst>
                  <a:ext uri="{FF2B5EF4-FFF2-40B4-BE49-F238E27FC236}">
                    <a16:creationId xmlns:a16="http://schemas.microsoft.com/office/drawing/2014/main" id="{10A36641-1250-904F-A4C2-5CBDC49C4E17}"/>
                  </a:ext>
                </a:extLst>
              </p:cNvPr>
              <p:cNvSpPr/>
              <p:nvPr/>
            </p:nvSpPr>
            <p:spPr>
              <a:xfrm>
                <a:off x="3690658" y="4188715"/>
                <a:ext cx="217668" cy="31236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5" name="Grupo 14">
              <a:extLst>
                <a:ext uri="{FF2B5EF4-FFF2-40B4-BE49-F238E27FC236}">
                  <a16:creationId xmlns:a16="http://schemas.microsoft.com/office/drawing/2014/main" id="{E5917D17-8C21-7741-9279-202B689E63A6}"/>
                </a:ext>
              </a:extLst>
            </p:cNvPr>
            <p:cNvGrpSpPr/>
            <p:nvPr/>
          </p:nvGrpSpPr>
          <p:grpSpPr>
            <a:xfrm rot="21011966">
              <a:off x="2332135" y="4434816"/>
              <a:ext cx="192907" cy="208024"/>
              <a:chOff x="2399355" y="4434815"/>
              <a:chExt cx="216810" cy="233801"/>
            </a:xfrm>
            <a:solidFill>
              <a:schemeClr val="accent6">
                <a:lumMod val="75000"/>
              </a:schemeClr>
            </a:solidFill>
          </p:grpSpPr>
          <p:sp>
            <p:nvSpPr>
              <p:cNvPr id="14" name="Elipse 13">
                <a:extLst>
                  <a:ext uri="{FF2B5EF4-FFF2-40B4-BE49-F238E27FC236}">
                    <a16:creationId xmlns:a16="http://schemas.microsoft.com/office/drawing/2014/main" id="{ABF827BC-49E8-EE4E-9541-DAC1EE7FAD8A}"/>
                  </a:ext>
                </a:extLst>
              </p:cNvPr>
              <p:cNvSpPr/>
              <p:nvPr/>
            </p:nvSpPr>
            <p:spPr>
              <a:xfrm>
                <a:off x="2418847" y="4582352"/>
                <a:ext cx="184729" cy="86264"/>
              </a:xfrm>
              <a:prstGeom prst="ellipse">
                <a:avLst/>
              </a:prstGeom>
              <a:grpFill/>
              <a:ln w="19050"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24" name="Elipse 123">
                <a:extLst>
                  <a:ext uri="{FF2B5EF4-FFF2-40B4-BE49-F238E27FC236}">
                    <a16:creationId xmlns:a16="http://schemas.microsoft.com/office/drawing/2014/main" id="{B4B4702A-D0A8-3741-A1AC-FD6BCCA2B014}"/>
                  </a:ext>
                </a:extLst>
              </p:cNvPr>
              <p:cNvSpPr/>
              <p:nvPr/>
            </p:nvSpPr>
            <p:spPr>
              <a:xfrm>
                <a:off x="2399355" y="4434815"/>
                <a:ext cx="216810" cy="144348"/>
              </a:xfrm>
              <a:prstGeom prst="ellipse">
                <a:avLst/>
              </a:prstGeom>
              <a:grpFill/>
              <a:ln w="19050"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grpSp>
        <p:nvGrpSpPr>
          <p:cNvPr id="29" name="Grupo 28">
            <a:extLst>
              <a:ext uri="{FF2B5EF4-FFF2-40B4-BE49-F238E27FC236}">
                <a16:creationId xmlns:a16="http://schemas.microsoft.com/office/drawing/2014/main" id="{70288D59-DFBF-664A-9996-D17301CD762B}"/>
              </a:ext>
            </a:extLst>
          </p:cNvPr>
          <p:cNvGrpSpPr/>
          <p:nvPr/>
        </p:nvGrpSpPr>
        <p:grpSpPr>
          <a:xfrm>
            <a:off x="4577661" y="3082012"/>
            <a:ext cx="481779" cy="423731"/>
            <a:chOff x="3657484" y="2834955"/>
            <a:chExt cx="481779" cy="423731"/>
          </a:xfrm>
        </p:grpSpPr>
        <p:grpSp>
          <p:nvGrpSpPr>
            <p:cNvPr id="136" name="Grupo 135">
              <a:extLst>
                <a:ext uri="{FF2B5EF4-FFF2-40B4-BE49-F238E27FC236}">
                  <a16:creationId xmlns:a16="http://schemas.microsoft.com/office/drawing/2014/main" id="{64377789-6B09-3E46-B605-58153A60120F}"/>
                </a:ext>
              </a:extLst>
            </p:cNvPr>
            <p:cNvGrpSpPr/>
            <p:nvPr/>
          </p:nvGrpSpPr>
          <p:grpSpPr>
            <a:xfrm rot="12974753">
              <a:off x="4024505" y="3106286"/>
              <a:ext cx="114758" cy="152400"/>
              <a:chOff x="3021023" y="4132290"/>
              <a:chExt cx="205948" cy="358859"/>
            </a:xfrm>
          </p:grpSpPr>
          <p:sp>
            <p:nvSpPr>
              <p:cNvPr id="137" name="Forma libre 136">
                <a:extLst>
                  <a:ext uri="{FF2B5EF4-FFF2-40B4-BE49-F238E27FC236}">
                    <a16:creationId xmlns:a16="http://schemas.microsoft.com/office/drawing/2014/main" id="{F7EC1A47-F408-1940-9A1A-75D78CFE3057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00FDFF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38" name="Forma libre 137">
                <a:extLst>
                  <a:ext uri="{FF2B5EF4-FFF2-40B4-BE49-F238E27FC236}">
                    <a16:creationId xmlns:a16="http://schemas.microsoft.com/office/drawing/2014/main" id="{0AB825F8-1342-0444-8EB9-E3673356665C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00FD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40" name="Grupo 139">
              <a:extLst>
                <a:ext uri="{FF2B5EF4-FFF2-40B4-BE49-F238E27FC236}">
                  <a16:creationId xmlns:a16="http://schemas.microsoft.com/office/drawing/2014/main" id="{6034EE0E-7E45-AE47-9D12-23D0403CE294}"/>
                </a:ext>
              </a:extLst>
            </p:cNvPr>
            <p:cNvGrpSpPr/>
            <p:nvPr/>
          </p:nvGrpSpPr>
          <p:grpSpPr>
            <a:xfrm rot="16598938">
              <a:off x="3733940" y="2917027"/>
              <a:ext cx="205948" cy="358859"/>
              <a:chOff x="3021023" y="4132290"/>
              <a:chExt cx="205948" cy="358859"/>
            </a:xfrm>
          </p:grpSpPr>
          <p:sp>
            <p:nvSpPr>
              <p:cNvPr id="144" name="Forma libre 143">
                <a:extLst>
                  <a:ext uri="{FF2B5EF4-FFF2-40B4-BE49-F238E27FC236}">
                    <a16:creationId xmlns:a16="http://schemas.microsoft.com/office/drawing/2014/main" id="{65E6BBAD-11F4-2E47-A562-83DACCC16CC1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C0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45" name="Forma libre 144">
                <a:extLst>
                  <a:ext uri="{FF2B5EF4-FFF2-40B4-BE49-F238E27FC236}">
                    <a16:creationId xmlns:a16="http://schemas.microsoft.com/office/drawing/2014/main" id="{300262AB-505A-3247-97D6-C3E7034EDDBD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41" name="Grupo 140">
              <a:extLst>
                <a:ext uri="{FF2B5EF4-FFF2-40B4-BE49-F238E27FC236}">
                  <a16:creationId xmlns:a16="http://schemas.microsoft.com/office/drawing/2014/main" id="{E3B03790-A858-4C42-A0C5-B72CF6B484D0}"/>
                </a:ext>
              </a:extLst>
            </p:cNvPr>
            <p:cNvGrpSpPr/>
            <p:nvPr/>
          </p:nvGrpSpPr>
          <p:grpSpPr>
            <a:xfrm rot="19980196">
              <a:off x="3662833" y="2834955"/>
              <a:ext cx="114758" cy="152400"/>
              <a:chOff x="3021023" y="4132290"/>
              <a:chExt cx="205948" cy="358859"/>
            </a:xfrm>
          </p:grpSpPr>
          <p:sp>
            <p:nvSpPr>
              <p:cNvPr id="142" name="Forma libre 141">
                <a:extLst>
                  <a:ext uri="{FF2B5EF4-FFF2-40B4-BE49-F238E27FC236}">
                    <a16:creationId xmlns:a16="http://schemas.microsoft.com/office/drawing/2014/main" id="{ECB291FB-BEF6-4840-804A-1A9CEE33AD11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0070C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43" name="Forma libre 142">
                <a:extLst>
                  <a:ext uri="{FF2B5EF4-FFF2-40B4-BE49-F238E27FC236}">
                    <a16:creationId xmlns:a16="http://schemas.microsoft.com/office/drawing/2014/main" id="{09A93B7D-763F-8049-8562-AF410DC8BE98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sp>
        <p:nvSpPr>
          <p:cNvPr id="26" name="CuadroTexto 25">
            <a:extLst>
              <a:ext uri="{FF2B5EF4-FFF2-40B4-BE49-F238E27FC236}">
                <a16:creationId xmlns:a16="http://schemas.microsoft.com/office/drawing/2014/main" id="{B364A5A3-D25F-D64C-9087-EB4C5A05776A}"/>
              </a:ext>
            </a:extLst>
          </p:cNvPr>
          <p:cNvSpPr txBox="1"/>
          <p:nvPr/>
        </p:nvSpPr>
        <p:spPr>
          <a:xfrm>
            <a:off x="4792373" y="3457155"/>
            <a:ext cx="562975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/>
              <a:t>PEP-CTERM</a:t>
            </a:r>
          </a:p>
        </p:txBody>
      </p:sp>
      <p:sp>
        <p:nvSpPr>
          <p:cNvPr id="146" name="CuadroTexto 145">
            <a:extLst>
              <a:ext uri="{FF2B5EF4-FFF2-40B4-BE49-F238E27FC236}">
                <a16:creationId xmlns:a16="http://schemas.microsoft.com/office/drawing/2014/main" id="{FAA980B2-760F-694F-8990-72201EEDE417}"/>
              </a:ext>
            </a:extLst>
          </p:cNvPr>
          <p:cNvSpPr txBox="1"/>
          <p:nvPr/>
        </p:nvSpPr>
        <p:spPr>
          <a:xfrm>
            <a:off x="4608742" y="3073573"/>
            <a:ext cx="58862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Signal</a:t>
            </a:r>
            <a:r>
              <a:rPr lang="es-ES" sz="500" dirty="0"/>
              <a:t> </a:t>
            </a:r>
            <a:r>
              <a:rPr lang="es-ES" sz="500" dirty="0" err="1"/>
              <a:t>peptide</a:t>
            </a:r>
            <a:endParaRPr lang="es-ES" sz="500" dirty="0"/>
          </a:p>
        </p:txBody>
      </p:sp>
      <p:grpSp>
        <p:nvGrpSpPr>
          <p:cNvPr id="161" name="Grupo 160">
            <a:extLst>
              <a:ext uri="{FF2B5EF4-FFF2-40B4-BE49-F238E27FC236}">
                <a16:creationId xmlns:a16="http://schemas.microsoft.com/office/drawing/2014/main" id="{B404AABB-5230-3749-A2DC-BC182A5C4729}"/>
              </a:ext>
            </a:extLst>
          </p:cNvPr>
          <p:cNvGrpSpPr/>
          <p:nvPr/>
        </p:nvGrpSpPr>
        <p:grpSpPr>
          <a:xfrm>
            <a:off x="1539146" y="1252449"/>
            <a:ext cx="195908" cy="255927"/>
            <a:chOff x="3552654" y="5162545"/>
            <a:chExt cx="195908" cy="255927"/>
          </a:xfrm>
        </p:grpSpPr>
        <p:sp>
          <p:nvSpPr>
            <p:cNvPr id="162" name="Forma libre 161">
              <a:extLst>
                <a:ext uri="{FF2B5EF4-FFF2-40B4-BE49-F238E27FC236}">
                  <a16:creationId xmlns:a16="http://schemas.microsoft.com/office/drawing/2014/main" id="{77D03F2E-CB33-9C48-AAF3-BCD5C3DD2419}"/>
                </a:ext>
              </a:extLst>
            </p:cNvPr>
            <p:cNvSpPr/>
            <p:nvPr/>
          </p:nvSpPr>
          <p:spPr>
            <a:xfrm>
              <a:off x="3564469" y="5197645"/>
              <a:ext cx="184093" cy="220827"/>
            </a:xfrm>
            <a:custGeom>
              <a:avLst/>
              <a:gdLst>
                <a:gd name="connsiteX0" fmla="*/ 234987 w 535666"/>
                <a:gd name="connsiteY0" fmla="*/ 0 h 642553"/>
                <a:gd name="connsiteX1" fmla="*/ 193580 w 535666"/>
                <a:gd name="connsiteY1" fmla="*/ 62110 h 642553"/>
                <a:gd name="connsiteX2" fmla="*/ 131470 w 535666"/>
                <a:gd name="connsiteY2" fmla="*/ 72462 h 642553"/>
                <a:gd name="connsiteX3" fmla="*/ 38305 w 535666"/>
                <a:gd name="connsiteY3" fmla="*/ 131121 h 642553"/>
                <a:gd name="connsiteX4" fmla="*/ 72810 w 535666"/>
                <a:gd name="connsiteY4" fmla="*/ 210484 h 642553"/>
                <a:gd name="connsiteX5" fmla="*/ 134921 w 535666"/>
                <a:gd name="connsiteY5" fmla="*/ 200133 h 642553"/>
                <a:gd name="connsiteX6" fmla="*/ 162525 w 535666"/>
                <a:gd name="connsiteY6" fmla="*/ 296748 h 642553"/>
                <a:gd name="connsiteX7" fmla="*/ 269493 w 535666"/>
                <a:gd name="connsiteY7" fmla="*/ 334705 h 642553"/>
                <a:gd name="connsiteX8" fmla="*/ 276394 w 535666"/>
                <a:gd name="connsiteY8" fmla="*/ 207034 h 642553"/>
                <a:gd name="connsiteX9" fmla="*/ 417867 w 535666"/>
                <a:gd name="connsiteY9" fmla="*/ 131121 h 642553"/>
                <a:gd name="connsiteX10" fmla="*/ 535186 w 535666"/>
                <a:gd name="connsiteY10" fmla="*/ 320902 h 642553"/>
                <a:gd name="connsiteX11" fmla="*/ 373010 w 535666"/>
                <a:gd name="connsiteY11" fmla="*/ 431320 h 642553"/>
                <a:gd name="connsiteX12" fmla="*/ 407515 w 535666"/>
                <a:gd name="connsiteY12" fmla="*/ 617651 h 642553"/>
                <a:gd name="connsiteX13" fmla="*/ 110767 w 535666"/>
                <a:gd name="connsiteY13" fmla="*/ 628003 h 642553"/>
                <a:gd name="connsiteX14" fmla="*/ 197031 w 535666"/>
                <a:gd name="connsiteY14" fmla="*/ 500332 h 642553"/>
                <a:gd name="connsiteX15" fmla="*/ 3799 w 535666"/>
                <a:gd name="connsiteY15" fmla="*/ 348507 h 642553"/>
                <a:gd name="connsiteX16" fmla="*/ 65909 w 535666"/>
                <a:gd name="connsiteY16" fmla="*/ 213935 h 642553"/>
                <a:gd name="connsiteX17" fmla="*/ 31404 w 535666"/>
                <a:gd name="connsiteY17" fmla="*/ 138022 h 642553"/>
                <a:gd name="connsiteX18" fmla="*/ 134921 w 535666"/>
                <a:gd name="connsiteY18" fmla="*/ 72462 h 642553"/>
                <a:gd name="connsiteX19" fmla="*/ 207383 w 535666"/>
                <a:gd name="connsiteY19" fmla="*/ 62110 h 642553"/>
                <a:gd name="connsiteX20" fmla="*/ 234987 w 535666"/>
                <a:gd name="connsiteY20" fmla="*/ 0 h 6425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535666" h="642553">
                  <a:moveTo>
                    <a:pt x="234987" y="0"/>
                  </a:moveTo>
                  <a:cubicBezTo>
                    <a:pt x="232687" y="0"/>
                    <a:pt x="210833" y="50033"/>
                    <a:pt x="193580" y="62110"/>
                  </a:cubicBezTo>
                  <a:cubicBezTo>
                    <a:pt x="176327" y="74187"/>
                    <a:pt x="157349" y="60960"/>
                    <a:pt x="131470" y="72462"/>
                  </a:cubicBezTo>
                  <a:cubicBezTo>
                    <a:pt x="105591" y="83964"/>
                    <a:pt x="48082" y="108117"/>
                    <a:pt x="38305" y="131121"/>
                  </a:cubicBezTo>
                  <a:cubicBezTo>
                    <a:pt x="28528" y="154125"/>
                    <a:pt x="56707" y="198982"/>
                    <a:pt x="72810" y="210484"/>
                  </a:cubicBezTo>
                  <a:cubicBezTo>
                    <a:pt x="88913" y="221986"/>
                    <a:pt x="119969" y="185756"/>
                    <a:pt x="134921" y="200133"/>
                  </a:cubicBezTo>
                  <a:cubicBezTo>
                    <a:pt x="149873" y="214510"/>
                    <a:pt x="140096" y="274319"/>
                    <a:pt x="162525" y="296748"/>
                  </a:cubicBezTo>
                  <a:cubicBezTo>
                    <a:pt x="184954" y="319177"/>
                    <a:pt x="250515" y="349657"/>
                    <a:pt x="269493" y="334705"/>
                  </a:cubicBezTo>
                  <a:cubicBezTo>
                    <a:pt x="288471" y="319753"/>
                    <a:pt x="251665" y="240965"/>
                    <a:pt x="276394" y="207034"/>
                  </a:cubicBezTo>
                  <a:cubicBezTo>
                    <a:pt x="301123" y="173103"/>
                    <a:pt x="374735" y="112143"/>
                    <a:pt x="417867" y="131121"/>
                  </a:cubicBezTo>
                  <a:cubicBezTo>
                    <a:pt x="460999" y="150099"/>
                    <a:pt x="542662" y="270869"/>
                    <a:pt x="535186" y="320902"/>
                  </a:cubicBezTo>
                  <a:cubicBezTo>
                    <a:pt x="527710" y="370935"/>
                    <a:pt x="394288" y="381862"/>
                    <a:pt x="373010" y="431320"/>
                  </a:cubicBezTo>
                  <a:cubicBezTo>
                    <a:pt x="351732" y="480778"/>
                    <a:pt x="451222" y="584870"/>
                    <a:pt x="407515" y="617651"/>
                  </a:cubicBezTo>
                  <a:cubicBezTo>
                    <a:pt x="363808" y="650432"/>
                    <a:pt x="145848" y="647556"/>
                    <a:pt x="110767" y="628003"/>
                  </a:cubicBezTo>
                  <a:cubicBezTo>
                    <a:pt x="75686" y="608450"/>
                    <a:pt x="214859" y="546915"/>
                    <a:pt x="197031" y="500332"/>
                  </a:cubicBezTo>
                  <a:cubicBezTo>
                    <a:pt x="179203" y="453749"/>
                    <a:pt x="25653" y="396240"/>
                    <a:pt x="3799" y="348507"/>
                  </a:cubicBezTo>
                  <a:cubicBezTo>
                    <a:pt x="-18055" y="300774"/>
                    <a:pt x="61308" y="249016"/>
                    <a:pt x="65909" y="213935"/>
                  </a:cubicBezTo>
                  <a:cubicBezTo>
                    <a:pt x="70510" y="178854"/>
                    <a:pt x="19902" y="161601"/>
                    <a:pt x="31404" y="138022"/>
                  </a:cubicBezTo>
                  <a:cubicBezTo>
                    <a:pt x="42906" y="114443"/>
                    <a:pt x="105591" y="85114"/>
                    <a:pt x="134921" y="72462"/>
                  </a:cubicBezTo>
                  <a:cubicBezTo>
                    <a:pt x="164251" y="59810"/>
                    <a:pt x="191281" y="71887"/>
                    <a:pt x="207383" y="62110"/>
                  </a:cubicBezTo>
                  <a:cubicBezTo>
                    <a:pt x="223485" y="52333"/>
                    <a:pt x="237287" y="0"/>
                    <a:pt x="234987" y="0"/>
                  </a:cubicBezTo>
                  <a:close/>
                </a:path>
              </a:pathLst>
            </a:custGeom>
            <a:gradFill flip="none" rotWithShape="1">
              <a:gsLst>
                <a:gs pos="0">
                  <a:srgbClr val="780000"/>
                </a:gs>
                <a:gs pos="60000">
                  <a:srgbClr val="C00000"/>
                </a:gs>
                <a:gs pos="100000">
                  <a:srgbClr val="C00000">
                    <a:tint val="23500"/>
                    <a:satMod val="160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3" name="Oval 84">
              <a:extLst>
                <a:ext uri="{FF2B5EF4-FFF2-40B4-BE49-F238E27FC236}">
                  <a16:creationId xmlns:a16="http://schemas.microsoft.com/office/drawing/2014/main" id="{9E88A685-001E-8044-9650-495C44063BE7}"/>
                </a:ext>
              </a:extLst>
            </p:cNvPr>
            <p:cNvSpPr/>
            <p:nvPr/>
          </p:nvSpPr>
          <p:spPr>
            <a:xfrm flipH="1">
              <a:off x="3552654" y="516254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164" name="Oval 84">
              <a:extLst>
                <a:ext uri="{FF2B5EF4-FFF2-40B4-BE49-F238E27FC236}">
                  <a16:creationId xmlns:a16="http://schemas.microsoft.com/office/drawing/2014/main" id="{B7E2FA12-95EC-4245-AC81-FE447448DB46}"/>
                </a:ext>
              </a:extLst>
            </p:cNvPr>
            <p:cNvSpPr/>
            <p:nvPr/>
          </p:nvSpPr>
          <p:spPr>
            <a:xfrm flipH="1">
              <a:off x="3618773" y="524839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</p:grpSp>
      <p:grpSp>
        <p:nvGrpSpPr>
          <p:cNvPr id="165" name="Grupo 164">
            <a:extLst>
              <a:ext uri="{FF2B5EF4-FFF2-40B4-BE49-F238E27FC236}">
                <a16:creationId xmlns:a16="http://schemas.microsoft.com/office/drawing/2014/main" id="{1E9183EA-AFBA-D94C-BBC0-C38956647554}"/>
              </a:ext>
            </a:extLst>
          </p:cNvPr>
          <p:cNvGrpSpPr/>
          <p:nvPr/>
        </p:nvGrpSpPr>
        <p:grpSpPr>
          <a:xfrm>
            <a:off x="2362371" y="1225321"/>
            <a:ext cx="184093" cy="220827"/>
            <a:chOff x="3564469" y="5197645"/>
            <a:chExt cx="184093" cy="220827"/>
          </a:xfrm>
        </p:grpSpPr>
        <p:sp>
          <p:nvSpPr>
            <p:cNvPr id="166" name="Forma libre 165">
              <a:extLst>
                <a:ext uri="{FF2B5EF4-FFF2-40B4-BE49-F238E27FC236}">
                  <a16:creationId xmlns:a16="http://schemas.microsoft.com/office/drawing/2014/main" id="{000EB818-6021-C541-852C-0ACC3942A455}"/>
                </a:ext>
              </a:extLst>
            </p:cNvPr>
            <p:cNvSpPr/>
            <p:nvPr/>
          </p:nvSpPr>
          <p:spPr>
            <a:xfrm>
              <a:off x="3564469" y="5197645"/>
              <a:ext cx="184093" cy="220827"/>
            </a:xfrm>
            <a:custGeom>
              <a:avLst/>
              <a:gdLst>
                <a:gd name="connsiteX0" fmla="*/ 234987 w 535666"/>
                <a:gd name="connsiteY0" fmla="*/ 0 h 642553"/>
                <a:gd name="connsiteX1" fmla="*/ 193580 w 535666"/>
                <a:gd name="connsiteY1" fmla="*/ 62110 h 642553"/>
                <a:gd name="connsiteX2" fmla="*/ 131470 w 535666"/>
                <a:gd name="connsiteY2" fmla="*/ 72462 h 642553"/>
                <a:gd name="connsiteX3" fmla="*/ 38305 w 535666"/>
                <a:gd name="connsiteY3" fmla="*/ 131121 h 642553"/>
                <a:gd name="connsiteX4" fmla="*/ 72810 w 535666"/>
                <a:gd name="connsiteY4" fmla="*/ 210484 h 642553"/>
                <a:gd name="connsiteX5" fmla="*/ 134921 w 535666"/>
                <a:gd name="connsiteY5" fmla="*/ 200133 h 642553"/>
                <a:gd name="connsiteX6" fmla="*/ 162525 w 535666"/>
                <a:gd name="connsiteY6" fmla="*/ 296748 h 642553"/>
                <a:gd name="connsiteX7" fmla="*/ 269493 w 535666"/>
                <a:gd name="connsiteY7" fmla="*/ 334705 h 642553"/>
                <a:gd name="connsiteX8" fmla="*/ 276394 w 535666"/>
                <a:gd name="connsiteY8" fmla="*/ 207034 h 642553"/>
                <a:gd name="connsiteX9" fmla="*/ 417867 w 535666"/>
                <a:gd name="connsiteY9" fmla="*/ 131121 h 642553"/>
                <a:gd name="connsiteX10" fmla="*/ 535186 w 535666"/>
                <a:gd name="connsiteY10" fmla="*/ 320902 h 642553"/>
                <a:gd name="connsiteX11" fmla="*/ 373010 w 535666"/>
                <a:gd name="connsiteY11" fmla="*/ 431320 h 642553"/>
                <a:gd name="connsiteX12" fmla="*/ 407515 w 535666"/>
                <a:gd name="connsiteY12" fmla="*/ 617651 h 642553"/>
                <a:gd name="connsiteX13" fmla="*/ 110767 w 535666"/>
                <a:gd name="connsiteY13" fmla="*/ 628003 h 642553"/>
                <a:gd name="connsiteX14" fmla="*/ 197031 w 535666"/>
                <a:gd name="connsiteY14" fmla="*/ 500332 h 642553"/>
                <a:gd name="connsiteX15" fmla="*/ 3799 w 535666"/>
                <a:gd name="connsiteY15" fmla="*/ 348507 h 642553"/>
                <a:gd name="connsiteX16" fmla="*/ 65909 w 535666"/>
                <a:gd name="connsiteY16" fmla="*/ 213935 h 642553"/>
                <a:gd name="connsiteX17" fmla="*/ 31404 w 535666"/>
                <a:gd name="connsiteY17" fmla="*/ 138022 h 642553"/>
                <a:gd name="connsiteX18" fmla="*/ 134921 w 535666"/>
                <a:gd name="connsiteY18" fmla="*/ 72462 h 642553"/>
                <a:gd name="connsiteX19" fmla="*/ 207383 w 535666"/>
                <a:gd name="connsiteY19" fmla="*/ 62110 h 642553"/>
                <a:gd name="connsiteX20" fmla="*/ 234987 w 535666"/>
                <a:gd name="connsiteY20" fmla="*/ 0 h 6425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535666" h="642553">
                  <a:moveTo>
                    <a:pt x="234987" y="0"/>
                  </a:moveTo>
                  <a:cubicBezTo>
                    <a:pt x="232687" y="0"/>
                    <a:pt x="210833" y="50033"/>
                    <a:pt x="193580" y="62110"/>
                  </a:cubicBezTo>
                  <a:cubicBezTo>
                    <a:pt x="176327" y="74187"/>
                    <a:pt x="157349" y="60960"/>
                    <a:pt x="131470" y="72462"/>
                  </a:cubicBezTo>
                  <a:cubicBezTo>
                    <a:pt x="105591" y="83964"/>
                    <a:pt x="48082" y="108117"/>
                    <a:pt x="38305" y="131121"/>
                  </a:cubicBezTo>
                  <a:cubicBezTo>
                    <a:pt x="28528" y="154125"/>
                    <a:pt x="56707" y="198982"/>
                    <a:pt x="72810" y="210484"/>
                  </a:cubicBezTo>
                  <a:cubicBezTo>
                    <a:pt x="88913" y="221986"/>
                    <a:pt x="119969" y="185756"/>
                    <a:pt x="134921" y="200133"/>
                  </a:cubicBezTo>
                  <a:cubicBezTo>
                    <a:pt x="149873" y="214510"/>
                    <a:pt x="140096" y="274319"/>
                    <a:pt x="162525" y="296748"/>
                  </a:cubicBezTo>
                  <a:cubicBezTo>
                    <a:pt x="184954" y="319177"/>
                    <a:pt x="250515" y="349657"/>
                    <a:pt x="269493" y="334705"/>
                  </a:cubicBezTo>
                  <a:cubicBezTo>
                    <a:pt x="288471" y="319753"/>
                    <a:pt x="251665" y="240965"/>
                    <a:pt x="276394" y="207034"/>
                  </a:cubicBezTo>
                  <a:cubicBezTo>
                    <a:pt x="301123" y="173103"/>
                    <a:pt x="374735" y="112143"/>
                    <a:pt x="417867" y="131121"/>
                  </a:cubicBezTo>
                  <a:cubicBezTo>
                    <a:pt x="460999" y="150099"/>
                    <a:pt x="542662" y="270869"/>
                    <a:pt x="535186" y="320902"/>
                  </a:cubicBezTo>
                  <a:cubicBezTo>
                    <a:pt x="527710" y="370935"/>
                    <a:pt x="394288" y="381862"/>
                    <a:pt x="373010" y="431320"/>
                  </a:cubicBezTo>
                  <a:cubicBezTo>
                    <a:pt x="351732" y="480778"/>
                    <a:pt x="451222" y="584870"/>
                    <a:pt x="407515" y="617651"/>
                  </a:cubicBezTo>
                  <a:cubicBezTo>
                    <a:pt x="363808" y="650432"/>
                    <a:pt x="145848" y="647556"/>
                    <a:pt x="110767" y="628003"/>
                  </a:cubicBezTo>
                  <a:cubicBezTo>
                    <a:pt x="75686" y="608450"/>
                    <a:pt x="214859" y="546915"/>
                    <a:pt x="197031" y="500332"/>
                  </a:cubicBezTo>
                  <a:cubicBezTo>
                    <a:pt x="179203" y="453749"/>
                    <a:pt x="25653" y="396240"/>
                    <a:pt x="3799" y="348507"/>
                  </a:cubicBezTo>
                  <a:cubicBezTo>
                    <a:pt x="-18055" y="300774"/>
                    <a:pt x="61308" y="249016"/>
                    <a:pt x="65909" y="213935"/>
                  </a:cubicBezTo>
                  <a:cubicBezTo>
                    <a:pt x="70510" y="178854"/>
                    <a:pt x="19902" y="161601"/>
                    <a:pt x="31404" y="138022"/>
                  </a:cubicBezTo>
                  <a:cubicBezTo>
                    <a:pt x="42906" y="114443"/>
                    <a:pt x="105591" y="85114"/>
                    <a:pt x="134921" y="72462"/>
                  </a:cubicBezTo>
                  <a:cubicBezTo>
                    <a:pt x="164251" y="59810"/>
                    <a:pt x="191281" y="71887"/>
                    <a:pt x="207383" y="62110"/>
                  </a:cubicBezTo>
                  <a:cubicBezTo>
                    <a:pt x="223485" y="52333"/>
                    <a:pt x="237287" y="0"/>
                    <a:pt x="234987" y="0"/>
                  </a:cubicBezTo>
                  <a:close/>
                </a:path>
              </a:pathLst>
            </a:custGeom>
            <a:gradFill flip="none" rotWithShape="1">
              <a:gsLst>
                <a:gs pos="0">
                  <a:srgbClr val="780000"/>
                </a:gs>
                <a:gs pos="60000">
                  <a:srgbClr val="C00000"/>
                </a:gs>
                <a:gs pos="100000">
                  <a:srgbClr val="C00000">
                    <a:tint val="23500"/>
                    <a:satMod val="160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8" name="Oval 84">
              <a:extLst>
                <a:ext uri="{FF2B5EF4-FFF2-40B4-BE49-F238E27FC236}">
                  <a16:creationId xmlns:a16="http://schemas.microsoft.com/office/drawing/2014/main" id="{85264D03-D6ED-DB42-8DE5-C086B7F4173F}"/>
                </a:ext>
              </a:extLst>
            </p:cNvPr>
            <p:cNvSpPr/>
            <p:nvPr/>
          </p:nvSpPr>
          <p:spPr>
            <a:xfrm flipH="1">
              <a:off x="3618773" y="524839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</p:grpSp>
      <p:grpSp>
        <p:nvGrpSpPr>
          <p:cNvPr id="169" name="Grupo 168">
            <a:extLst>
              <a:ext uri="{FF2B5EF4-FFF2-40B4-BE49-F238E27FC236}">
                <a16:creationId xmlns:a16="http://schemas.microsoft.com/office/drawing/2014/main" id="{4945DD6C-AE3F-FA48-9BB4-AAA3128C832D}"/>
              </a:ext>
            </a:extLst>
          </p:cNvPr>
          <p:cNvGrpSpPr/>
          <p:nvPr/>
        </p:nvGrpSpPr>
        <p:grpSpPr>
          <a:xfrm>
            <a:off x="3041999" y="1059590"/>
            <a:ext cx="184093" cy="220827"/>
            <a:chOff x="3564469" y="5197645"/>
            <a:chExt cx="184093" cy="220827"/>
          </a:xfrm>
        </p:grpSpPr>
        <p:sp>
          <p:nvSpPr>
            <p:cNvPr id="170" name="Forma libre 169">
              <a:extLst>
                <a:ext uri="{FF2B5EF4-FFF2-40B4-BE49-F238E27FC236}">
                  <a16:creationId xmlns:a16="http://schemas.microsoft.com/office/drawing/2014/main" id="{69AFA8D9-5A15-D94A-93BC-CC960AAC0DB2}"/>
                </a:ext>
              </a:extLst>
            </p:cNvPr>
            <p:cNvSpPr/>
            <p:nvPr/>
          </p:nvSpPr>
          <p:spPr>
            <a:xfrm>
              <a:off x="3564469" y="5197645"/>
              <a:ext cx="184093" cy="220827"/>
            </a:xfrm>
            <a:custGeom>
              <a:avLst/>
              <a:gdLst>
                <a:gd name="connsiteX0" fmla="*/ 234987 w 535666"/>
                <a:gd name="connsiteY0" fmla="*/ 0 h 642553"/>
                <a:gd name="connsiteX1" fmla="*/ 193580 w 535666"/>
                <a:gd name="connsiteY1" fmla="*/ 62110 h 642553"/>
                <a:gd name="connsiteX2" fmla="*/ 131470 w 535666"/>
                <a:gd name="connsiteY2" fmla="*/ 72462 h 642553"/>
                <a:gd name="connsiteX3" fmla="*/ 38305 w 535666"/>
                <a:gd name="connsiteY3" fmla="*/ 131121 h 642553"/>
                <a:gd name="connsiteX4" fmla="*/ 72810 w 535666"/>
                <a:gd name="connsiteY4" fmla="*/ 210484 h 642553"/>
                <a:gd name="connsiteX5" fmla="*/ 134921 w 535666"/>
                <a:gd name="connsiteY5" fmla="*/ 200133 h 642553"/>
                <a:gd name="connsiteX6" fmla="*/ 162525 w 535666"/>
                <a:gd name="connsiteY6" fmla="*/ 296748 h 642553"/>
                <a:gd name="connsiteX7" fmla="*/ 269493 w 535666"/>
                <a:gd name="connsiteY7" fmla="*/ 334705 h 642553"/>
                <a:gd name="connsiteX8" fmla="*/ 276394 w 535666"/>
                <a:gd name="connsiteY8" fmla="*/ 207034 h 642553"/>
                <a:gd name="connsiteX9" fmla="*/ 417867 w 535666"/>
                <a:gd name="connsiteY9" fmla="*/ 131121 h 642553"/>
                <a:gd name="connsiteX10" fmla="*/ 535186 w 535666"/>
                <a:gd name="connsiteY10" fmla="*/ 320902 h 642553"/>
                <a:gd name="connsiteX11" fmla="*/ 373010 w 535666"/>
                <a:gd name="connsiteY11" fmla="*/ 431320 h 642553"/>
                <a:gd name="connsiteX12" fmla="*/ 407515 w 535666"/>
                <a:gd name="connsiteY12" fmla="*/ 617651 h 642553"/>
                <a:gd name="connsiteX13" fmla="*/ 110767 w 535666"/>
                <a:gd name="connsiteY13" fmla="*/ 628003 h 642553"/>
                <a:gd name="connsiteX14" fmla="*/ 197031 w 535666"/>
                <a:gd name="connsiteY14" fmla="*/ 500332 h 642553"/>
                <a:gd name="connsiteX15" fmla="*/ 3799 w 535666"/>
                <a:gd name="connsiteY15" fmla="*/ 348507 h 642553"/>
                <a:gd name="connsiteX16" fmla="*/ 65909 w 535666"/>
                <a:gd name="connsiteY16" fmla="*/ 213935 h 642553"/>
                <a:gd name="connsiteX17" fmla="*/ 31404 w 535666"/>
                <a:gd name="connsiteY17" fmla="*/ 138022 h 642553"/>
                <a:gd name="connsiteX18" fmla="*/ 134921 w 535666"/>
                <a:gd name="connsiteY18" fmla="*/ 72462 h 642553"/>
                <a:gd name="connsiteX19" fmla="*/ 207383 w 535666"/>
                <a:gd name="connsiteY19" fmla="*/ 62110 h 642553"/>
                <a:gd name="connsiteX20" fmla="*/ 234987 w 535666"/>
                <a:gd name="connsiteY20" fmla="*/ 0 h 6425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535666" h="642553">
                  <a:moveTo>
                    <a:pt x="234987" y="0"/>
                  </a:moveTo>
                  <a:cubicBezTo>
                    <a:pt x="232687" y="0"/>
                    <a:pt x="210833" y="50033"/>
                    <a:pt x="193580" y="62110"/>
                  </a:cubicBezTo>
                  <a:cubicBezTo>
                    <a:pt x="176327" y="74187"/>
                    <a:pt x="157349" y="60960"/>
                    <a:pt x="131470" y="72462"/>
                  </a:cubicBezTo>
                  <a:cubicBezTo>
                    <a:pt x="105591" y="83964"/>
                    <a:pt x="48082" y="108117"/>
                    <a:pt x="38305" y="131121"/>
                  </a:cubicBezTo>
                  <a:cubicBezTo>
                    <a:pt x="28528" y="154125"/>
                    <a:pt x="56707" y="198982"/>
                    <a:pt x="72810" y="210484"/>
                  </a:cubicBezTo>
                  <a:cubicBezTo>
                    <a:pt x="88913" y="221986"/>
                    <a:pt x="119969" y="185756"/>
                    <a:pt x="134921" y="200133"/>
                  </a:cubicBezTo>
                  <a:cubicBezTo>
                    <a:pt x="149873" y="214510"/>
                    <a:pt x="140096" y="274319"/>
                    <a:pt x="162525" y="296748"/>
                  </a:cubicBezTo>
                  <a:cubicBezTo>
                    <a:pt x="184954" y="319177"/>
                    <a:pt x="250515" y="349657"/>
                    <a:pt x="269493" y="334705"/>
                  </a:cubicBezTo>
                  <a:cubicBezTo>
                    <a:pt x="288471" y="319753"/>
                    <a:pt x="251665" y="240965"/>
                    <a:pt x="276394" y="207034"/>
                  </a:cubicBezTo>
                  <a:cubicBezTo>
                    <a:pt x="301123" y="173103"/>
                    <a:pt x="374735" y="112143"/>
                    <a:pt x="417867" y="131121"/>
                  </a:cubicBezTo>
                  <a:cubicBezTo>
                    <a:pt x="460999" y="150099"/>
                    <a:pt x="542662" y="270869"/>
                    <a:pt x="535186" y="320902"/>
                  </a:cubicBezTo>
                  <a:cubicBezTo>
                    <a:pt x="527710" y="370935"/>
                    <a:pt x="394288" y="381862"/>
                    <a:pt x="373010" y="431320"/>
                  </a:cubicBezTo>
                  <a:cubicBezTo>
                    <a:pt x="351732" y="480778"/>
                    <a:pt x="451222" y="584870"/>
                    <a:pt x="407515" y="617651"/>
                  </a:cubicBezTo>
                  <a:cubicBezTo>
                    <a:pt x="363808" y="650432"/>
                    <a:pt x="145848" y="647556"/>
                    <a:pt x="110767" y="628003"/>
                  </a:cubicBezTo>
                  <a:cubicBezTo>
                    <a:pt x="75686" y="608450"/>
                    <a:pt x="214859" y="546915"/>
                    <a:pt x="197031" y="500332"/>
                  </a:cubicBezTo>
                  <a:cubicBezTo>
                    <a:pt x="179203" y="453749"/>
                    <a:pt x="25653" y="396240"/>
                    <a:pt x="3799" y="348507"/>
                  </a:cubicBezTo>
                  <a:cubicBezTo>
                    <a:pt x="-18055" y="300774"/>
                    <a:pt x="61308" y="249016"/>
                    <a:pt x="65909" y="213935"/>
                  </a:cubicBezTo>
                  <a:cubicBezTo>
                    <a:pt x="70510" y="178854"/>
                    <a:pt x="19902" y="161601"/>
                    <a:pt x="31404" y="138022"/>
                  </a:cubicBezTo>
                  <a:cubicBezTo>
                    <a:pt x="42906" y="114443"/>
                    <a:pt x="105591" y="85114"/>
                    <a:pt x="134921" y="72462"/>
                  </a:cubicBezTo>
                  <a:cubicBezTo>
                    <a:pt x="164251" y="59810"/>
                    <a:pt x="191281" y="71887"/>
                    <a:pt x="207383" y="62110"/>
                  </a:cubicBezTo>
                  <a:cubicBezTo>
                    <a:pt x="223485" y="52333"/>
                    <a:pt x="237287" y="0"/>
                    <a:pt x="234987" y="0"/>
                  </a:cubicBezTo>
                  <a:close/>
                </a:path>
              </a:pathLst>
            </a:custGeom>
            <a:gradFill flip="none" rotWithShape="1">
              <a:gsLst>
                <a:gs pos="0">
                  <a:srgbClr val="780000"/>
                </a:gs>
                <a:gs pos="60000">
                  <a:srgbClr val="C00000"/>
                </a:gs>
                <a:gs pos="100000">
                  <a:srgbClr val="C00000">
                    <a:tint val="23500"/>
                    <a:satMod val="160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72" name="Oval 84">
              <a:extLst>
                <a:ext uri="{FF2B5EF4-FFF2-40B4-BE49-F238E27FC236}">
                  <a16:creationId xmlns:a16="http://schemas.microsoft.com/office/drawing/2014/main" id="{3A689D43-0DB0-B44F-B24C-8841812D0438}"/>
                </a:ext>
              </a:extLst>
            </p:cNvPr>
            <p:cNvSpPr/>
            <p:nvPr/>
          </p:nvSpPr>
          <p:spPr>
            <a:xfrm flipH="1">
              <a:off x="3618773" y="524839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</p:grpSp>
      <p:grpSp>
        <p:nvGrpSpPr>
          <p:cNvPr id="173" name="Grupo 172">
            <a:extLst>
              <a:ext uri="{FF2B5EF4-FFF2-40B4-BE49-F238E27FC236}">
                <a16:creationId xmlns:a16="http://schemas.microsoft.com/office/drawing/2014/main" id="{634689A8-4909-1846-A88B-3F68F8FF0AEA}"/>
              </a:ext>
            </a:extLst>
          </p:cNvPr>
          <p:cNvGrpSpPr/>
          <p:nvPr/>
        </p:nvGrpSpPr>
        <p:grpSpPr>
          <a:xfrm>
            <a:off x="3945631" y="1304047"/>
            <a:ext cx="195908" cy="255927"/>
            <a:chOff x="3552654" y="5162545"/>
            <a:chExt cx="195908" cy="255927"/>
          </a:xfrm>
        </p:grpSpPr>
        <p:sp>
          <p:nvSpPr>
            <p:cNvPr id="174" name="Forma libre 173">
              <a:extLst>
                <a:ext uri="{FF2B5EF4-FFF2-40B4-BE49-F238E27FC236}">
                  <a16:creationId xmlns:a16="http://schemas.microsoft.com/office/drawing/2014/main" id="{9A85FA17-7421-8D45-908D-44A6E0994A05}"/>
                </a:ext>
              </a:extLst>
            </p:cNvPr>
            <p:cNvSpPr/>
            <p:nvPr/>
          </p:nvSpPr>
          <p:spPr>
            <a:xfrm>
              <a:off x="3564469" y="5197645"/>
              <a:ext cx="184093" cy="220827"/>
            </a:xfrm>
            <a:custGeom>
              <a:avLst/>
              <a:gdLst>
                <a:gd name="connsiteX0" fmla="*/ 234987 w 535666"/>
                <a:gd name="connsiteY0" fmla="*/ 0 h 642553"/>
                <a:gd name="connsiteX1" fmla="*/ 193580 w 535666"/>
                <a:gd name="connsiteY1" fmla="*/ 62110 h 642553"/>
                <a:gd name="connsiteX2" fmla="*/ 131470 w 535666"/>
                <a:gd name="connsiteY2" fmla="*/ 72462 h 642553"/>
                <a:gd name="connsiteX3" fmla="*/ 38305 w 535666"/>
                <a:gd name="connsiteY3" fmla="*/ 131121 h 642553"/>
                <a:gd name="connsiteX4" fmla="*/ 72810 w 535666"/>
                <a:gd name="connsiteY4" fmla="*/ 210484 h 642553"/>
                <a:gd name="connsiteX5" fmla="*/ 134921 w 535666"/>
                <a:gd name="connsiteY5" fmla="*/ 200133 h 642553"/>
                <a:gd name="connsiteX6" fmla="*/ 162525 w 535666"/>
                <a:gd name="connsiteY6" fmla="*/ 296748 h 642553"/>
                <a:gd name="connsiteX7" fmla="*/ 269493 w 535666"/>
                <a:gd name="connsiteY7" fmla="*/ 334705 h 642553"/>
                <a:gd name="connsiteX8" fmla="*/ 276394 w 535666"/>
                <a:gd name="connsiteY8" fmla="*/ 207034 h 642553"/>
                <a:gd name="connsiteX9" fmla="*/ 417867 w 535666"/>
                <a:gd name="connsiteY9" fmla="*/ 131121 h 642553"/>
                <a:gd name="connsiteX10" fmla="*/ 535186 w 535666"/>
                <a:gd name="connsiteY10" fmla="*/ 320902 h 642553"/>
                <a:gd name="connsiteX11" fmla="*/ 373010 w 535666"/>
                <a:gd name="connsiteY11" fmla="*/ 431320 h 642553"/>
                <a:gd name="connsiteX12" fmla="*/ 407515 w 535666"/>
                <a:gd name="connsiteY12" fmla="*/ 617651 h 642553"/>
                <a:gd name="connsiteX13" fmla="*/ 110767 w 535666"/>
                <a:gd name="connsiteY13" fmla="*/ 628003 h 642553"/>
                <a:gd name="connsiteX14" fmla="*/ 197031 w 535666"/>
                <a:gd name="connsiteY14" fmla="*/ 500332 h 642553"/>
                <a:gd name="connsiteX15" fmla="*/ 3799 w 535666"/>
                <a:gd name="connsiteY15" fmla="*/ 348507 h 642553"/>
                <a:gd name="connsiteX16" fmla="*/ 65909 w 535666"/>
                <a:gd name="connsiteY16" fmla="*/ 213935 h 642553"/>
                <a:gd name="connsiteX17" fmla="*/ 31404 w 535666"/>
                <a:gd name="connsiteY17" fmla="*/ 138022 h 642553"/>
                <a:gd name="connsiteX18" fmla="*/ 134921 w 535666"/>
                <a:gd name="connsiteY18" fmla="*/ 72462 h 642553"/>
                <a:gd name="connsiteX19" fmla="*/ 207383 w 535666"/>
                <a:gd name="connsiteY19" fmla="*/ 62110 h 642553"/>
                <a:gd name="connsiteX20" fmla="*/ 234987 w 535666"/>
                <a:gd name="connsiteY20" fmla="*/ 0 h 6425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535666" h="642553">
                  <a:moveTo>
                    <a:pt x="234987" y="0"/>
                  </a:moveTo>
                  <a:cubicBezTo>
                    <a:pt x="232687" y="0"/>
                    <a:pt x="210833" y="50033"/>
                    <a:pt x="193580" y="62110"/>
                  </a:cubicBezTo>
                  <a:cubicBezTo>
                    <a:pt x="176327" y="74187"/>
                    <a:pt x="157349" y="60960"/>
                    <a:pt x="131470" y="72462"/>
                  </a:cubicBezTo>
                  <a:cubicBezTo>
                    <a:pt x="105591" y="83964"/>
                    <a:pt x="48082" y="108117"/>
                    <a:pt x="38305" y="131121"/>
                  </a:cubicBezTo>
                  <a:cubicBezTo>
                    <a:pt x="28528" y="154125"/>
                    <a:pt x="56707" y="198982"/>
                    <a:pt x="72810" y="210484"/>
                  </a:cubicBezTo>
                  <a:cubicBezTo>
                    <a:pt x="88913" y="221986"/>
                    <a:pt x="119969" y="185756"/>
                    <a:pt x="134921" y="200133"/>
                  </a:cubicBezTo>
                  <a:cubicBezTo>
                    <a:pt x="149873" y="214510"/>
                    <a:pt x="140096" y="274319"/>
                    <a:pt x="162525" y="296748"/>
                  </a:cubicBezTo>
                  <a:cubicBezTo>
                    <a:pt x="184954" y="319177"/>
                    <a:pt x="250515" y="349657"/>
                    <a:pt x="269493" y="334705"/>
                  </a:cubicBezTo>
                  <a:cubicBezTo>
                    <a:pt x="288471" y="319753"/>
                    <a:pt x="251665" y="240965"/>
                    <a:pt x="276394" y="207034"/>
                  </a:cubicBezTo>
                  <a:cubicBezTo>
                    <a:pt x="301123" y="173103"/>
                    <a:pt x="374735" y="112143"/>
                    <a:pt x="417867" y="131121"/>
                  </a:cubicBezTo>
                  <a:cubicBezTo>
                    <a:pt x="460999" y="150099"/>
                    <a:pt x="542662" y="270869"/>
                    <a:pt x="535186" y="320902"/>
                  </a:cubicBezTo>
                  <a:cubicBezTo>
                    <a:pt x="527710" y="370935"/>
                    <a:pt x="394288" y="381862"/>
                    <a:pt x="373010" y="431320"/>
                  </a:cubicBezTo>
                  <a:cubicBezTo>
                    <a:pt x="351732" y="480778"/>
                    <a:pt x="451222" y="584870"/>
                    <a:pt x="407515" y="617651"/>
                  </a:cubicBezTo>
                  <a:cubicBezTo>
                    <a:pt x="363808" y="650432"/>
                    <a:pt x="145848" y="647556"/>
                    <a:pt x="110767" y="628003"/>
                  </a:cubicBezTo>
                  <a:cubicBezTo>
                    <a:pt x="75686" y="608450"/>
                    <a:pt x="214859" y="546915"/>
                    <a:pt x="197031" y="500332"/>
                  </a:cubicBezTo>
                  <a:cubicBezTo>
                    <a:pt x="179203" y="453749"/>
                    <a:pt x="25653" y="396240"/>
                    <a:pt x="3799" y="348507"/>
                  </a:cubicBezTo>
                  <a:cubicBezTo>
                    <a:pt x="-18055" y="300774"/>
                    <a:pt x="61308" y="249016"/>
                    <a:pt x="65909" y="213935"/>
                  </a:cubicBezTo>
                  <a:cubicBezTo>
                    <a:pt x="70510" y="178854"/>
                    <a:pt x="19902" y="161601"/>
                    <a:pt x="31404" y="138022"/>
                  </a:cubicBezTo>
                  <a:cubicBezTo>
                    <a:pt x="42906" y="114443"/>
                    <a:pt x="105591" y="85114"/>
                    <a:pt x="134921" y="72462"/>
                  </a:cubicBezTo>
                  <a:cubicBezTo>
                    <a:pt x="164251" y="59810"/>
                    <a:pt x="191281" y="71887"/>
                    <a:pt x="207383" y="62110"/>
                  </a:cubicBezTo>
                  <a:cubicBezTo>
                    <a:pt x="223485" y="52333"/>
                    <a:pt x="237287" y="0"/>
                    <a:pt x="234987" y="0"/>
                  </a:cubicBezTo>
                  <a:close/>
                </a:path>
              </a:pathLst>
            </a:custGeom>
            <a:gradFill flip="none" rotWithShape="1">
              <a:gsLst>
                <a:gs pos="0">
                  <a:srgbClr val="780000"/>
                </a:gs>
                <a:gs pos="60000">
                  <a:srgbClr val="C00000"/>
                </a:gs>
                <a:gs pos="100000">
                  <a:srgbClr val="C00000">
                    <a:tint val="23500"/>
                    <a:satMod val="160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75" name="Oval 84">
              <a:extLst>
                <a:ext uri="{FF2B5EF4-FFF2-40B4-BE49-F238E27FC236}">
                  <a16:creationId xmlns:a16="http://schemas.microsoft.com/office/drawing/2014/main" id="{4D2EB8DE-A5DB-C444-95F6-36CAAC814C3E}"/>
                </a:ext>
              </a:extLst>
            </p:cNvPr>
            <p:cNvSpPr/>
            <p:nvPr/>
          </p:nvSpPr>
          <p:spPr>
            <a:xfrm flipH="1">
              <a:off x="3552654" y="516254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176" name="Oval 84">
              <a:extLst>
                <a:ext uri="{FF2B5EF4-FFF2-40B4-BE49-F238E27FC236}">
                  <a16:creationId xmlns:a16="http://schemas.microsoft.com/office/drawing/2014/main" id="{D91D20A4-CCF4-E146-9B9F-E1CD4C497FD6}"/>
                </a:ext>
              </a:extLst>
            </p:cNvPr>
            <p:cNvSpPr/>
            <p:nvPr/>
          </p:nvSpPr>
          <p:spPr>
            <a:xfrm flipH="1">
              <a:off x="3618773" y="524839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</p:grpSp>
      <p:sp>
        <p:nvSpPr>
          <p:cNvPr id="37" name="Forma libre 36">
            <a:extLst>
              <a:ext uri="{FF2B5EF4-FFF2-40B4-BE49-F238E27FC236}">
                <a16:creationId xmlns:a16="http://schemas.microsoft.com/office/drawing/2014/main" id="{6212F60E-0F52-5148-892B-B93DEDF052A8}"/>
              </a:ext>
            </a:extLst>
          </p:cNvPr>
          <p:cNvSpPr/>
          <p:nvPr/>
        </p:nvSpPr>
        <p:spPr>
          <a:xfrm>
            <a:off x="2719389" y="3592454"/>
            <a:ext cx="621102" cy="133829"/>
          </a:xfrm>
          <a:custGeom>
            <a:avLst/>
            <a:gdLst>
              <a:gd name="connsiteX0" fmla="*/ 0 w 621102"/>
              <a:gd name="connsiteY0" fmla="*/ 133829 h 133829"/>
              <a:gd name="connsiteX1" fmla="*/ 200133 w 621102"/>
              <a:gd name="connsiteY1" fmla="*/ 2707 h 133829"/>
              <a:gd name="connsiteX2" fmla="*/ 621102 w 621102"/>
              <a:gd name="connsiteY2" fmla="*/ 57917 h 1338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21102" h="133829">
                <a:moveTo>
                  <a:pt x="0" y="133829"/>
                </a:moveTo>
                <a:cubicBezTo>
                  <a:pt x="48308" y="74594"/>
                  <a:pt x="96616" y="15359"/>
                  <a:pt x="200133" y="2707"/>
                </a:cubicBezTo>
                <a:cubicBezTo>
                  <a:pt x="303650" y="-9945"/>
                  <a:pt x="462376" y="23986"/>
                  <a:pt x="621102" y="57917"/>
                </a:cubicBezTo>
              </a:path>
            </a:pathLst>
          </a:custGeom>
          <a:noFill/>
          <a:ln w="3175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39" name="Conector recto de flecha 38">
            <a:extLst>
              <a:ext uri="{FF2B5EF4-FFF2-40B4-BE49-F238E27FC236}">
                <a16:creationId xmlns:a16="http://schemas.microsoft.com/office/drawing/2014/main" id="{C2AD16E9-3E96-2249-B643-95A7CE1D3161}"/>
              </a:ext>
            </a:extLst>
          </p:cNvPr>
          <p:cNvCxnSpPr/>
          <p:nvPr/>
        </p:nvCxnSpPr>
        <p:spPr>
          <a:xfrm>
            <a:off x="3874227" y="3277648"/>
            <a:ext cx="677627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CuadroTexto 198">
            <a:extLst>
              <a:ext uri="{FF2B5EF4-FFF2-40B4-BE49-F238E27FC236}">
                <a16:creationId xmlns:a16="http://schemas.microsoft.com/office/drawing/2014/main" id="{E3DB7A25-99DC-EC45-96CF-F00FF3D37D75}"/>
              </a:ext>
            </a:extLst>
          </p:cNvPr>
          <p:cNvSpPr txBox="1"/>
          <p:nvPr/>
        </p:nvSpPr>
        <p:spPr>
          <a:xfrm>
            <a:off x="4070366" y="1445827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200" name="CuadroTexto 199">
            <a:extLst>
              <a:ext uri="{FF2B5EF4-FFF2-40B4-BE49-F238E27FC236}">
                <a16:creationId xmlns:a16="http://schemas.microsoft.com/office/drawing/2014/main" id="{67B1571B-5B21-764F-A6AA-23CF6F24F7F4}"/>
              </a:ext>
            </a:extLst>
          </p:cNvPr>
          <p:cNvSpPr txBox="1"/>
          <p:nvPr/>
        </p:nvSpPr>
        <p:spPr>
          <a:xfrm>
            <a:off x="3136103" y="1153247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201" name="CuadroTexto 200">
            <a:extLst>
              <a:ext uri="{FF2B5EF4-FFF2-40B4-BE49-F238E27FC236}">
                <a16:creationId xmlns:a16="http://schemas.microsoft.com/office/drawing/2014/main" id="{9CACC8AA-2CC2-B548-A1EE-281E2BF607EF}"/>
              </a:ext>
            </a:extLst>
          </p:cNvPr>
          <p:cNvSpPr txBox="1"/>
          <p:nvPr/>
        </p:nvSpPr>
        <p:spPr>
          <a:xfrm>
            <a:off x="2444757" y="1298535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202" name="CuadroTexto 201">
            <a:extLst>
              <a:ext uri="{FF2B5EF4-FFF2-40B4-BE49-F238E27FC236}">
                <a16:creationId xmlns:a16="http://schemas.microsoft.com/office/drawing/2014/main" id="{113BA99C-760C-0B49-9FD5-58F58AC8B815}"/>
              </a:ext>
            </a:extLst>
          </p:cNvPr>
          <p:cNvSpPr txBox="1"/>
          <p:nvPr/>
        </p:nvSpPr>
        <p:spPr>
          <a:xfrm>
            <a:off x="1625582" y="1385109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cxnSp>
        <p:nvCxnSpPr>
          <p:cNvPr id="203" name="Conector recto de flecha 202">
            <a:extLst>
              <a:ext uri="{FF2B5EF4-FFF2-40B4-BE49-F238E27FC236}">
                <a16:creationId xmlns:a16="http://schemas.microsoft.com/office/drawing/2014/main" id="{8B56287C-5C9F-9247-9508-A552FEE1E24C}"/>
              </a:ext>
            </a:extLst>
          </p:cNvPr>
          <p:cNvCxnSpPr>
            <a:cxnSpLocks/>
          </p:cNvCxnSpPr>
          <p:nvPr/>
        </p:nvCxnSpPr>
        <p:spPr>
          <a:xfrm flipH="1">
            <a:off x="2302721" y="1455578"/>
            <a:ext cx="90403" cy="369708"/>
          </a:xfrm>
          <a:prstGeom prst="straightConnector1">
            <a:avLst/>
          </a:prstGeom>
          <a:ln w="3175">
            <a:solidFill>
              <a:schemeClr val="tx1"/>
            </a:solidFill>
            <a:prstDash val="lgDash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Conector recto de flecha 204">
            <a:extLst>
              <a:ext uri="{FF2B5EF4-FFF2-40B4-BE49-F238E27FC236}">
                <a16:creationId xmlns:a16="http://schemas.microsoft.com/office/drawing/2014/main" id="{70184C0A-C814-FA47-B884-7604BFFAE956}"/>
              </a:ext>
            </a:extLst>
          </p:cNvPr>
          <p:cNvCxnSpPr>
            <a:cxnSpLocks/>
            <a:stCxn id="117" idx="0"/>
          </p:cNvCxnSpPr>
          <p:nvPr/>
        </p:nvCxnSpPr>
        <p:spPr>
          <a:xfrm flipH="1">
            <a:off x="2275193" y="1888566"/>
            <a:ext cx="3886" cy="265867"/>
          </a:xfrm>
          <a:prstGeom prst="straightConnector1">
            <a:avLst/>
          </a:prstGeom>
          <a:ln w="3175">
            <a:solidFill>
              <a:schemeClr val="tx1"/>
            </a:solidFill>
            <a:prstDash val="lgDash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CuadroTexto 120">
            <a:extLst>
              <a:ext uri="{FF2B5EF4-FFF2-40B4-BE49-F238E27FC236}">
                <a16:creationId xmlns:a16="http://schemas.microsoft.com/office/drawing/2014/main" id="{8E00F819-5224-A543-90DA-C12E85E3186D}"/>
              </a:ext>
            </a:extLst>
          </p:cNvPr>
          <p:cNvSpPr txBox="1"/>
          <p:nvPr/>
        </p:nvSpPr>
        <p:spPr>
          <a:xfrm>
            <a:off x="4393857" y="1889207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6" name="Forma libre 5">
            <a:extLst>
              <a:ext uri="{FF2B5EF4-FFF2-40B4-BE49-F238E27FC236}">
                <a16:creationId xmlns:a16="http://schemas.microsoft.com/office/drawing/2014/main" id="{9924AAB6-84A8-C141-8C44-DE77DD872107}"/>
              </a:ext>
            </a:extLst>
          </p:cNvPr>
          <p:cNvSpPr/>
          <p:nvPr/>
        </p:nvSpPr>
        <p:spPr>
          <a:xfrm>
            <a:off x="4290782" y="1977481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152" name="Grupo 151">
            <a:extLst>
              <a:ext uri="{FF2B5EF4-FFF2-40B4-BE49-F238E27FC236}">
                <a16:creationId xmlns:a16="http://schemas.microsoft.com/office/drawing/2014/main" id="{818F5449-AAD0-3447-9CC2-DC322F7E3385}"/>
              </a:ext>
            </a:extLst>
          </p:cNvPr>
          <p:cNvGrpSpPr/>
          <p:nvPr/>
        </p:nvGrpSpPr>
        <p:grpSpPr>
          <a:xfrm rot="15550455">
            <a:off x="3794117" y="2643465"/>
            <a:ext cx="114758" cy="152400"/>
            <a:chOff x="3021023" y="4132290"/>
            <a:chExt cx="205948" cy="358859"/>
          </a:xfrm>
        </p:grpSpPr>
        <p:sp>
          <p:nvSpPr>
            <p:cNvPr id="159" name="Forma libre 158">
              <a:extLst>
                <a:ext uri="{FF2B5EF4-FFF2-40B4-BE49-F238E27FC236}">
                  <a16:creationId xmlns:a16="http://schemas.microsoft.com/office/drawing/2014/main" id="{FFB819A1-767B-764E-AFC1-9B9D2423D0FD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00FDFF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0" name="Forma libre 159">
              <a:extLst>
                <a:ext uri="{FF2B5EF4-FFF2-40B4-BE49-F238E27FC236}">
                  <a16:creationId xmlns:a16="http://schemas.microsoft.com/office/drawing/2014/main" id="{3DD3B4D2-81E7-1644-87F7-5076634C53C1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00FD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153" name="Grupo 152">
            <a:extLst>
              <a:ext uri="{FF2B5EF4-FFF2-40B4-BE49-F238E27FC236}">
                <a16:creationId xmlns:a16="http://schemas.microsoft.com/office/drawing/2014/main" id="{BC10D47B-434D-AE4A-8E18-8F82A378EF11}"/>
              </a:ext>
            </a:extLst>
          </p:cNvPr>
          <p:cNvGrpSpPr/>
          <p:nvPr/>
        </p:nvGrpSpPr>
        <p:grpSpPr>
          <a:xfrm rot="20667263">
            <a:off x="3707023" y="2304181"/>
            <a:ext cx="205948" cy="358859"/>
            <a:chOff x="3021023" y="4132290"/>
            <a:chExt cx="205948" cy="358859"/>
          </a:xfrm>
        </p:grpSpPr>
        <p:sp>
          <p:nvSpPr>
            <p:cNvPr id="157" name="Forma libre 156">
              <a:extLst>
                <a:ext uri="{FF2B5EF4-FFF2-40B4-BE49-F238E27FC236}">
                  <a16:creationId xmlns:a16="http://schemas.microsoft.com/office/drawing/2014/main" id="{D13A4027-0840-634E-B9E6-97ACB77E7478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C0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58" name="Forma libre 157">
              <a:extLst>
                <a:ext uri="{FF2B5EF4-FFF2-40B4-BE49-F238E27FC236}">
                  <a16:creationId xmlns:a16="http://schemas.microsoft.com/office/drawing/2014/main" id="{6FB8CAD4-EE40-1E4A-B154-FBD9DDA6B931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30" name="Grupo 29">
            <a:extLst>
              <a:ext uri="{FF2B5EF4-FFF2-40B4-BE49-F238E27FC236}">
                <a16:creationId xmlns:a16="http://schemas.microsoft.com/office/drawing/2014/main" id="{02BF0F11-43E5-2D44-A2B9-795BF5515601}"/>
              </a:ext>
            </a:extLst>
          </p:cNvPr>
          <p:cNvGrpSpPr/>
          <p:nvPr/>
        </p:nvGrpSpPr>
        <p:grpSpPr>
          <a:xfrm>
            <a:off x="3326620" y="2396765"/>
            <a:ext cx="1030393" cy="242498"/>
            <a:chOff x="3245881" y="2431599"/>
            <a:chExt cx="1030393" cy="242498"/>
          </a:xfrm>
        </p:grpSpPr>
        <p:sp>
          <p:nvSpPr>
            <p:cNvPr id="27" name="Elipse 26">
              <a:extLst>
                <a:ext uri="{FF2B5EF4-FFF2-40B4-BE49-F238E27FC236}">
                  <a16:creationId xmlns:a16="http://schemas.microsoft.com/office/drawing/2014/main" id="{ABCCA7CD-E663-8347-A04A-851A0706F80D}"/>
                </a:ext>
              </a:extLst>
            </p:cNvPr>
            <p:cNvSpPr/>
            <p:nvPr/>
          </p:nvSpPr>
          <p:spPr>
            <a:xfrm>
              <a:off x="3629228" y="2431599"/>
              <a:ext cx="85411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8" name="Elipse 147">
              <a:extLst>
                <a:ext uri="{FF2B5EF4-FFF2-40B4-BE49-F238E27FC236}">
                  <a16:creationId xmlns:a16="http://schemas.microsoft.com/office/drawing/2014/main" id="{060F3FAA-B590-C947-B3DD-1F66256E1BC0}"/>
                </a:ext>
              </a:extLst>
            </p:cNvPr>
            <p:cNvSpPr/>
            <p:nvPr/>
          </p:nvSpPr>
          <p:spPr>
            <a:xfrm>
              <a:off x="3765559" y="2431599"/>
              <a:ext cx="61984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7" name="Elipse 146">
              <a:extLst>
                <a:ext uri="{FF2B5EF4-FFF2-40B4-BE49-F238E27FC236}">
                  <a16:creationId xmlns:a16="http://schemas.microsoft.com/office/drawing/2014/main" id="{D51D95F1-9238-1F4E-A5C2-3BEC93664407}"/>
                </a:ext>
              </a:extLst>
            </p:cNvPr>
            <p:cNvSpPr/>
            <p:nvPr/>
          </p:nvSpPr>
          <p:spPr>
            <a:xfrm>
              <a:off x="3711139" y="2431599"/>
              <a:ext cx="85411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8" name="Rectángulo redondeado 27">
              <a:extLst>
                <a:ext uri="{FF2B5EF4-FFF2-40B4-BE49-F238E27FC236}">
                  <a16:creationId xmlns:a16="http://schemas.microsoft.com/office/drawing/2014/main" id="{2B0A54B8-E3DF-A54B-BE95-CF8E49CBE546}"/>
                </a:ext>
              </a:extLst>
            </p:cNvPr>
            <p:cNvSpPr/>
            <p:nvPr/>
          </p:nvSpPr>
          <p:spPr>
            <a:xfrm>
              <a:off x="3522325" y="2431599"/>
              <a:ext cx="99627" cy="187822"/>
            </a:xfrm>
            <a:prstGeom prst="round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9" name="CuadroTexto 148">
              <a:extLst>
                <a:ext uri="{FF2B5EF4-FFF2-40B4-BE49-F238E27FC236}">
                  <a16:creationId xmlns:a16="http://schemas.microsoft.com/office/drawing/2014/main" id="{6673F0B4-46CA-ED4B-8F51-5EC74BF8E1AE}"/>
                </a:ext>
              </a:extLst>
            </p:cNvPr>
            <p:cNvSpPr txBox="1"/>
            <p:nvPr/>
          </p:nvSpPr>
          <p:spPr>
            <a:xfrm>
              <a:off x="3245881" y="2502707"/>
              <a:ext cx="34176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 err="1"/>
                <a:t>EpsH</a:t>
              </a:r>
              <a:endParaRPr lang="es-ES" sz="500" dirty="0"/>
            </a:p>
          </p:txBody>
        </p:sp>
        <p:sp>
          <p:nvSpPr>
            <p:cNvPr id="150" name="CuadroTexto 149">
              <a:extLst>
                <a:ext uri="{FF2B5EF4-FFF2-40B4-BE49-F238E27FC236}">
                  <a16:creationId xmlns:a16="http://schemas.microsoft.com/office/drawing/2014/main" id="{8E93C3E9-DAAD-D246-A3AA-6F7007E8B419}"/>
                </a:ext>
              </a:extLst>
            </p:cNvPr>
            <p:cNvSpPr txBox="1"/>
            <p:nvPr/>
          </p:nvSpPr>
          <p:spPr>
            <a:xfrm>
              <a:off x="3761389" y="2504820"/>
              <a:ext cx="51488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 err="1"/>
                <a:t>Sec</a:t>
              </a:r>
              <a:r>
                <a:rPr lang="es-ES" sz="500" dirty="0"/>
                <a:t> </a:t>
              </a:r>
              <a:r>
                <a:rPr lang="es-ES" sz="500" dirty="0" err="1"/>
                <a:t>system</a:t>
              </a:r>
              <a:endParaRPr lang="es-ES" sz="500" dirty="0"/>
            </a:p>
          </p:txBody>
        </p:sp>
      </p:grpSp>
      <p:grpSp>
        <p:nvGrpSpPr>
          <p:cNvPr id="34" name="Grupo 33">
            <a:extLst>
              <a:ext uri="{FF2B5EF4-FFF2-40B4-BE49-F238E27FC236}">
                <a16:creationId xmlns:a16="http://schemas.microsoft.com/office/drawing/2014/main" id="{81EFD80E-B38F-C643-9E8E-279FC804D094}"/>
              </a:ext>
            </a:extLst>
          </p:cNvPr>
          <p:cNvGrpSpPr/>
          <p:nvPr/>
        </p:nvGrpSpPr>
        <p:grpSpPr>
          <a:xfrm>
            <a:off x="2168093" y="2409926"/>
            <a:ext cx="231480" cy="256180"/>
            <a:chOff x="2087354" y="2444760"/>
            <a:chExt cx="231480" cy="256180"/>
          </a:xfrm>
        </p:grpSpPr>
        <p:grpSp>
          <p:nvGrpSpPr>
            <p:cNvPr id="33" name="Grupo 32">
              <a:extLst>
                <a:ext uri="{FF2B5EF4-FFF2-40B4-BE49-F238E27FC236}">
                  <a16:creationId xmlns:a16="http://schemas.microsoft.com/office/drawing/2014/main" id="{AA93CDA5-0C81-AA48-9F48-3F00B383390A}"/>
                </a:ext>
              </a:extLst>
            </p:cNvPr>
            <p:cNvGrpSpPr/>
            <p:nvPr/>
          </p:nvGrpSpPr>
          <p:grpSpPr>
            <a:xfrm>
              <a:off x="2087354" y="2444760"/>
              <a:ext cx="231480" cy="161640"/>
              <a:chOff x="2089080" y="2444760"/>
              <a:chExt cx="231480" cy="161640"/>
            </a:xfrm>
          </p:grpSpPr>
          <p:sp>
            <p:nvSpPr>
              <p:cNvPr id="118" name="Rounded Rectangle 131"/>
              <p:cNvSpPr/>
              <p:nvPr/>
            </p:nvSpPr>
            <p:spPr>
              <a:xfrm>
                <a:off x="2089080" y="2444760"/>
                <a:ext cx="117000" cy="161640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119" name="Rounded Rectangle 132"/>
              <p:cNvSpPr/>
              <p:nvPr/>
            </p:nvSpPr>
            <p:spPr>
              <a:xfrm>
                <a:off x="2203560" y="2444760"/>
                <a:ext cx="117000" cy="161640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  <p:grpSp>
          <p:nvGrpSpPr>
            <p:cNvPr id="32" name="Grupo 31">
              <a:extLst>
                <a:ext uri="{FF2B5EF4-FFF2-40B4-BE49-F238E27FC236}">
                  <a16:creationId xmlns:a16="http://schemas.microsoft.com/office/drawing/2014/main" id="{CD451D43-0FF9-5748-8934-DD0D6BCBAB6C}"/>
                </a:ext>
              </a:extLst>
            </p:cNvPr>
            <p:cNvGrpSpPr/>
            <p:nvPr/>
          </p:nvGrpSpPr>
          <p:grpSpPr>
            <a:xfrm>
              <a:off x="2087354" y="2614271"/>
              <a:ext cx="231480" cy="86669"/>
              <a:chOff x="2085629" y="2614271"/>
              <a:chExt cx="231480" cy="86669"/>
            </a:xfrm>
          </p:grpSpPr>
          <p:sp>
            <p:nvSpPr>
              <p:cNvPr id="181" name="Rounded Rectangle 131">
                <a:extLst>
                  <a:ext uri="{FF2B5EF4-FFF2-40B4-BE49-F238E27FC236}">
                    <a16:creationId xmlns:a16="http://schemas.microsoft.com/office/drawing/2014/main" id="{7A6A7CAE-A7ED-744B-AD0C-5E04E34AE410}"/>
                  </a:ext>
                </a:extLst>
              </p:cNvPr>
              <p:cNvSpPr/>
              <p:nvPr/>
            </p:nvSpPr>
            <p:spPr>
              <a:xfrm>
                <a:off x="2085629" y="2614271"/>
                <a:ext cx="117000" cy="86669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182" name="Rounded Rectangle 132">
                <a:extLst>
                  <a:ext uri="{FF2B5EF4-FFF2-40B4-BE49-F238E27FC236}">
                    <a16:creationId xmlns:a16="http://schemas.microsoft.com/office/drawing/2014/main" id="{ACA57F96-3CA4-5D46-8841-AD188396B909}"/>
                  </a:ext>
                </a:extLst>
              </p:cNvPr>
              <p:cNvSpPr/>
              <p:nvPr/>
            </p:nvSpPr>
            <p:spPr>
              <a:xfrm>
                <a:off x="2200109" y="2614271"/>
                <a:ext cx="117000" cy="86669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</p:grpSp>
      <p:sp>
        <p:nvSpPr>
          <p:cNvPr id="35" name="CuadroTexto 34">
            <a:extLst>
              <a:ext uri="{FF2B5EF4-FFF2-40B4-BE49-F238E27FC236}">
                <a16:creationId xmlns:a16="http://schemas.microsoft.com/office/drawing/2014/main" id="{9BFDC853-3E9E-FC4A-AD07-C0AE5D262C65}"/>
              </a:ext>
            </a:extLst>
          </p:cNvPr>
          <p:cNvSpPr txBox="1"/>
          <p:nvPr/>
        </p:nvSpPr>
        <p:spPr>
          <a:xfrm>
            <a:off x="1909698" y="2468006"/>
            <a:ext cx="3369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B</a:t>
            </a:r>
            <a:endParaRPr lang="es-ES" sz="500" dirty="0"/>
          </a:p>
        </p:txBody>
      </p:sp>
      <p:sp>
        <p:nvSpPr>
          <p:cNvPr id="183" name="CuadroTexto 182">
            <a:extLst>
              <a:ext uri="{FF2B5EF4-FFF2-40B4-BE49-F238E27FC236}">
                <a16:creationId xmlns:a16="http://schemas.microsoft.com/office/drawing/2014/main" id="{6B2B6A9B-6D6A-5044-B5A5-D848EE716A50}"/>
              </a:ext>
            </a:extLst>
          </p:cNvPr>
          <p:cNvSpPr txBox="1"/>
          <p:nvPr/>
        </p:nvSpPr>
        <p:spPr>
          <a:xfrm>
            <a:off x="1906492" y="2564633"/>
            <a:ext cx="3401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C</a:t>
            </a:r>
            <a:endParaRPr lang="es-ES" sz="500" dirty="0"/>
          </a:p>
        </p:txBody>
      </p:sp>
      <p:sp>
        <p:nvSpPr>
          <p:cNvPr id="36" name="Elipse 35">
            <a:extLst>
              <a:ext uri="{FF2B5EF4-FFF2-40B4-BE49-F238E27FC236}">
                <a16:creationId xmlns:a16="http://schemas.microsoft.com/office/drawing/2014/main" id="{8ABDDA74-900A-7D42-8400-935C8637812B}"/>
              </a:ext>
            </a:extLst>
          </p:cNvPr>
          <p:cNvSpPr/>
          <p:nvPr/>
        </p:nvSpPr>
        <p:spPr>
          <a:xfrm>
            <a:off x="1774797" y="2247934"/>
            <a:ext cx="168040" cy="93541"/>
          </a:xfrm>
          <a:prstGeom prst="ellipse">
            <a:avLst/>
          </a:prstGeom>
          <a:solidFill>
            <a:srgbClr val="FF7E79"/>
          </a:solidFill>
          <a:ln w="12700">
            <a:solidFill>
              <a:srgbClr val="B41A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4" name="CuadroTexto 183">
            <a:extLst>
              <a:ext uri="{FF2B5EF4-FFF2-40B4-BE49-F238E27FC236}">
                <a16:creationId xmlns:a16="http://schemas.microsoft.com/office/drawing/2014/main" id="{B8DB51D9-2E38-6C49-A6E1-D1200B7C8E3E}"/>
              </a:ext>
            </a:extLst>
          </p:cNvPr>
          <p:cNvSpPr txBox="1"/>
          <p:nvPr/>
        </p:nvSpPr>
        <p:spPr>
          <a:xfrm>
            <a:off x="1498934" y="2204373"/>
            <a:ext cx="3369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A</a:t>
            </a:r>
            <a:endParaRPr lang="es-ES" sz="500" dirty="0"/>
          </a:p>
        </p:txBody>
      </p:sp>
      <p:grpSp>
        <p:nvGrpSpPr>
          <p:cNvPr id="192" name="Grupo 191">
            <a:extLst>
              <a:ext uri="{FF2B5EF4-FFF2-40B4-BE49-F238E27FC236}">
                <a16:creationId xmlns:a16="http://schemas.microsoft.com/office/drawing/2014/main" id="{DAFD7B6F-3960-3F46-8A5A-614B4F8F6F80}"/>
              </a:ext>
            </a:extLst>
          </p:cNvPr>
          <p:cNvGrpSpPr/>
          <p:nvPr/>
        </p:nvGrpSpPr>
        <p:grpSpPr>
          <a:xfrm rot="18457452">
            <a:off x="3888818" y="2234867"/>
            <a:ext cx="131554" cy="154346"/>
            <a:chOff x="4747546" y="4151030"/>
            <a:chExt cx="406143" cy="476509"/>
          </a:xfrm>
        </p:grpSpPr>
        <p:sp>
          <p:nvSpPr>
            <p:cNvPr id="188" name="Franja diagonal 187">
              <a:extLst>
                <a:ext uri="{FF2B5EF4-FFF2-40B4-BE49-F238E27FC236}">
                  <a16:creationId xmlns:a16="http://schemas.microsoft.com/office/drawing/2014/main" id="{0C9F73CF-E638-0842-9EB9-1C92FB5ADF91}"/>
                </a:ext>
              </a:extLst>
            </p:cNvPr>
            <p:cNvSpPr/>
            <p:nvPr/>
          </p:nvSpPr>
          <p:spPr>
            <a:xfrm rot="17876278">
              <a:off x="4754448" y="4144128"/>
              <a:ext cx="238950" cy="252753"/>
            </a:xfrm>
            <a:prstGeom prst="diagStripe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solidFill>
                  <a:schemeClr val="tx1"/>
                </a:solidFill>
              </a:endParaRPr>
            </a:p>
          </p:txBody>
        </p:sp>
        <p:sp>
          <p:nvSpPr>
            <p:cNvPr id="189" name="Franja diagonal 188">
              <a:extLst>
                <a:ext uri="{FF2B5EF4-FFF2-40B4-BE49-F238E27FC236}">
                  <a16:creationId xmlns:a16="http://schemas.microsoft.com/office/drawing/2014/main" id="{D2DA11D9-CCAF-0446-ADB4-3F2A89E19F58}"/>
                </a:ext>
              </a:extLst>
            </p:cNvPr>
            <p:cNvSpPr/>
            <p:nvPr/>
          </p:nvSpPr>
          <p:spPr>
            <a:xfrm rot="3723722" flipH="1">
              <a:off x="4907838" y="4144129"/>
              <a:ext cx="238950" cy="252753"/>
            </a:xfrm>
            <a:prstGeom prst="diagStripe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solidFill>
                  <a:schemeClr val="tx1"/>
                </a:solidFill>
              </a:endParaRPr>
            </a:p>
          </p:txBody>
        </p:sp>
        <p:sp>
          <p:nvSpPr>
            <p:cNvPr id="190" name="Elipse 189">
              <a:extLst>
                <a:ext uri="{FF2B5EF4-FFF2-40B4-BE49-F238E27FC236}">
                  <a16:creationId xmlns:a16="http://schemas.microsoft.com/office/drawing/2014/main" id="{5D9F47A2-94CD-2042-B529-4F4B13BF0698}"/>
                </a:ext>
              </a:extLst>
            </p:cNvPr>
            <p:cNvSpPr/>
            <p:nvPr/>
          </p:nvSpPr>
          <p:spPr>
            <a:xfrm rot="1495849">
              <a:off x="4816988" y="4428693"/>
              <a:ext cx="113868" cy="198842"/>
            </a:xfrm>
            <a:prstGeom prst="ellipse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91" name="Elipse 190">
              <a:extLst>
                <a:ext uri="{FF2B5EF4-FFF2-40B4-BE49-F238E27FC236}">
                  <a16:creationId xmlns:a16="http://schemas.microsoft.com/office/drawing/2014/main" id="{605E7F5F-B51A-1F45-8732-E717A1F793EF}"/>
                </a:ext>
              </a:extLst>
            </p:cNvPr>
            <p:cNvSpPr/>
            <p:nvPr/>
          </p:nvSpPr>
          <p:spPr>
            <a:xfrm rot="20104151" flipH="1">
              <a:off x="4971222" y="4428694"/>
              <a:ext cx="113868" cy="198845"/>
            </a:xfrm>
            <a:prstGeom prst="ellipse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154" name="Grupo 153">
            <a:extLst>
              <a:ext uri="{FF2B5EF4-FFF2-40B4-BE49-F238E27FC236}">
                <a16:creationId xmlns:a16="http://schemas.microsoft.com/office/drawing/2014/main" id="{21C22A39-04DB-724C-BCA5-18F758313B39}"/>
              </a:ext>
            </a:extLst>
          </p:cNvPr>
          <p:cNvGrpSpPr/>
          <p:nvPr/>
        </p:nvGrpSpPr>
        <p:grpSpPr>
          <a:xfrm rot="955898">
            <a:off x="3877951" y="2124516"/>
            <a:ext cx="114758" cy="152400"/>
            <a:chOff x="3021023" y="4132290"/>
            <a:chExt cx="205948" cy="358859"/>
          </a:xfrm>
        </p:grpSpPr>
        <p:sp>
          <p:nvSpPr>
            <p:cNvPr id="155" name="Forma libre 154">
              <a:extLst>
                <a:ext uri="{FF2B5EF4-FFF2-40B4-BE49-F238E27FC236}">
                  <a16:creationId xmlns:a16="http://schemas.microsoft.com/office/drawing/2014/main" id="{3CD6C746-6BDC-C649-95CB-BBCF005C9283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0070C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56" name="Forma libre 155">
              <a:extLst>
                <a:ext uri="{FF2B5EF4-FFF2-40B4-BE49-F238E27FC236}">
                  <a16:creationId xmlns:a16="http://schemas.microsoft.com/office/drawing/2014/main" id="{09097864-5C2F-534F-8C1A-643BC751CB01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cxnSp>
        <p:nvCxnSpPr>
          <p:cNvPr id="193" name="Conector recto de flecha 192">
            <a:extLst>
              <a:ext uri="{FF2B5EF4-FFF2-40B4-BE49-F238E27FC236}">
                <a16:creationId xmlns:a16="http://schemas.microsoft.com/office/drawing/2014/main" id="{45FF8F0D-9D2B-7B4A-96F1-CAA52399BA20}"/>
              </a:ext>
            </a:extLst>
          </p:cNvPr>
          <p:cNvCxnSpPr>
            <a:cxnSpLocks/>
          </p:cNvCxnSpPr>
          <p:nvPr/>
        </p:nvCxnSpPr>
        <p:spPr>
          <a:xfrm flipH="1">
            <a:off x="4510007" y="2125983"/>
            <a:ext cx="392624" cy="0"/>
          </a:xfrm>
          <a:prstGeom prst="straightConnector1">
            <a:avLst/>
          </a:prstGeom>
          <a:ln w="3175">
            <a:solidFill>
              <a:schemeClr val="tx1"/>
            </a:solidFill>
            <a:prstDash val="lgDash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Oval 84">
            <a:extLst>
              <a:ext uri="{FF2B5EF4-FFF2-40B4-BE49-F238E27FC236}">
                <a16:creationId xmlns:a16="http://schemas.microsoft.com/office/drawing/2014/main" id="{B5C3E58C-53AB-5D49-A7C5-AECBC1793293}"/>
              </a:ext>
            </a:extLst>
          </p:cNvPr>
          <p:cNvSpPr/>
          <p:nvPr/>
        </p:nvSpPr>
        <p:spPr>
          <a:xfrm flipH="1">
            <a:off x="2247297" y="2188704"/>
            <a:ext cx="58616" cy="48177"/>
          </a:xfrm>
          <a:prstGeom prst="ellipse">
            <a:avLst/>
          </a:prstGeom>
          <a:solidFill>
            <a:schemeClr val="accent4"/>
          </a:solidFill>
          <a:ln w="12700">
            <a:solidFill>
              <a:srgbClr val="1D315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16200" rIns="90000" bIns="162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208" name="Oval 84">
            <a:extLst>
              <a:ext uri="{FF2B5EF4-FFF2-40B4-BE49-F238E27FC236}">
                <a16:creationId xmlns:a16="http://schemas.microsoft.com/office/drawing/2014/main" id="{77F1B0CC-CE7B-BB4D-B555-A684CAFADD4D}"/>
              </a:ext>
            </a:extLst>
          </p:cNvPr>
          <p:cNvSpPr/>
          <p:nvPr/>
        </p:nvSpPr>
        <p:spPr>
          <a:xfrm flipH="1">
            <a:off x="1780390" y="2223108"/>
            <a:ext cx="58616" cy="48177"/>
          </a:xfrm>
          <a:prstGeom prst="ellipse">
            <a:avLst/>
          </a:prstGeom>
          <a:solidFill>
            <a:schemeClr val="accent4"/>
          </a:solidFill>
          <a:ln w="12700">
            <a:solidFill>
              <a:srgbClr val="1D315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16200" rIns="90000" bIns="162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209" name="Forma libre 208">
            <a:extLst>
              <a:ext uri="{FF2B5EF4-FFF2-40B4-BE49-F238E27FC236}">
                <a16:creationId xmlns:a16="http://schemas.microsoft.com/office/drawing/2014/main" id="{9FE7293A-BD81-AC4E-824B-74035ADD518D}"/>
              </a:ext>
            </a:extLst>
          </p:cNvPr>
          <p:cNvSpPr/>
          <p:nvPr/>
        </p:nvSpPr>
        <p:spPr>
          <a:xfrm rot="905009" flipH="1">
            <a:off x="1840992" y="2142981"/>
            <a:ext cx="380473" cy="126014"/>
          </a:xfrm>
          <a:custGeom>
            <a:avLst/>
            <a:gdLst>
              <a:gd name="connsiteX0" fmla="*/ 0 w 386464"/>
              <a:gd name="connsiteY0" fmla="*/ 8695 h 126014"/>
              <a:gd name="connsiteX1" fmla="*/ 213935 w 386464"/>
              <a:gd name="connsiteY1" fmla="*/ 12146 h 126014"/>
              <a:gd name="connsiteX2" fmla="*/ 386464 w 386464"/>
              <a:gd name="connsiteY2" fmla="*/ 126014 h 1260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86464" h="126014">
                <a:moveTo>
                  <a:pt x="0" y="8695"/>
                </a:moveTo>
                <a:cubicBezTo>
                  <a:pt x="74762" y="644"/>
                  <a:pt x="149524" y="-7407"/>
                  <a:pt x="213935" y="12146"/>
                </a:cubicBezTo>
                <a:cubicBezTo>
                  <a:pt x="278346" y="31699"/>
                  <a:pt x="332405" y="78856"/>
                  <a:pt x="386464" y="126014"/>
                </a:cubicBezTo>
              </a:path>
            </a:pathLst>
          </a:custGeom>
          <a:noFill/>
          <a:ln w="0">
            <a:solidFill>
              <a:schemeClr val="tx1"/>
            </a:solidFill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0" name="Forma libre 209">
            <a:extLst>
              <a:ext uri="{FF2B5EF4-FFF2-40B4-BE49-F238E27FC236}">
                <a16:creationId xmlns:a16="http://schemas.microsoft.com/office/drawing/2014/main" id="{1D9C9C02-27B1-414E-8634-0245714AC7DA}"/>
              </a:ext>
            </a:extLst>
          </p:cNvPr>
          <p:cNvSpPr/>
          <p:nvPr/>
        </p:nvSpPr>
        <p:spPr>
          <a:xfrm rot="408609">
            <a:off x="1948649" y="2293018"/>
            <a:ext cx="342573" cy="100138"/>
          </a:xfrm>
          <a:custGeom>
            <a:avLst/>
            <a:gdLst>
              <a:gd name="connsiteX0" fmla="*/ 0 w 386464"/>
              <a:gd name="connsiteY0" fmla="*/ 8695 h 126014"/>
              <a:gd name="connsiteX1" fmla="*/ 213935 w 386464"/>
              <a:gd name="connsiteY1" fmla="*/ 12146 h 126014"/>
              <a:gd name="connsiteX2" fmla="*/ 386464 w 386464"/>
              <a:gd name="connsiteY2" fmla="*/ 126014 h 1260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86464" h="126014">
                <a:moveTo>
                  <a:pt x="0" y="8695"/>
                </a:moveTo>
                <a:cubicBezTo>
                  <a:pt x="74762" y="644"/>
                  <a:pt x="149524" y="-7407"/>
                  <a:pt x="213935" y="12146"/>
                </a:cubicBezTo>
                <a:cubicBezTo>
                  <a:pt x="278346" y="31699"/>
                  <a:pt x="332405" y="78856"/>
                  <a:pt x="386464" y="126014"/>
                </a:cubicBezTo>
              </a:path>
            </a:pathLst>
          </a:custGeom>
          <a:noFill/>
          <a:ln w="0">
            <a:solidFill>
              <a:schemeClr val="tx1"/>
            </a:solidFill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212" name="Conector recto de flecha 211">
            <a:extLst>
              <a:ext uri="{FF2B5EF4-FFF2-40B4-BE49-F238E27FC236}">
                <a16:creationId xmlns:a16="http://schemas.microsoft.com/office/drawing/2014/main" id="{78B2A45D-74CA-3545-B03A-640CFB775CCF}"/>
              </a:ext>
            </a:extLst>
          </p:cNvPr>
          <p:cNvCxnSpPr>
            <a:cxnSpLocks/>
          </p:cNvCxnSpPr>
          <p:nvPr/>
        </p:nvCxnSpPr>
        <p:spPr>
          <a:xfrm flipH="1">
            <a:off x="2277089" y="2561667"/>
            <a:ext cx="3886" cy="265867"/>
          </a:xfrm>
          <a:prstGeom prst="straightConnector1">
            <a:avLst/>
          </a:prstGeom>
          <a:ln w="3175">
            <a:solidFill>
              <a:schemeClr val="tx1"/>
            </a:solidFill>
            <a:prstDash val="soli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Oval 84">
            <a:extLst>
              <a:ext uri="{FF2B5EF4-FFF2-40B4-BE49-F238E27FC236}">
                <a16:creationId xmlns:a16="http://schemas.microsoft.com/office/drawing/2014/main" id="{C3C2D509-4AA7-7544-BA9B-4908DE880E8B}"/>
              </a:ext>
            </a:extLst>
          </p:cNvPr>
          <p:cNvSpPr/>
          <p:nvPr/>
        </p:nvSpPr>
        <p:spPr>
          <a:xfrm flipH="1">
            <a:off x="2254768" y="2863212"/>
            <a:ext cx="58616" cy="48177"/>
          </a:xfrm>
          <a:prstGeom prst="ellipse">
            <a:avLst/>
          </a:prstGeom>
          <a:solidFill>
            <a:schemeClr val="accent4"/>
          </a:solidFill>
          <a:ln w="12700">
            <a:solidFill>
              <a:srgbClr val="1D315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16200" rIns="90000" bIns="162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117" name="Magnetic Disk 130"/>
          <p:cNvSpPr/>
          <p:nvPr/>
        </p:nvSpPr>
        <p:spPr>
          <a:xfrm>
            <a:off x="2185659" y="1828326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chemeClr val="accent6">
                  <a:lumMod val="50000"/>
                  <a:tint val="66000"/>
                  <a:satMod val="160000"/>
                </a:schemeClr>
              </a:gs>
              <a:gs pos="50000">
                <a:schemeClr val="accent6">
                  <a:lumMod val="50000"/>
                  <a:tint val="44500"/>
                  <a:satMod val="160000"/>
                </a:schemeClr>
              </a:gs>
              <a:gs pos="100000">
                <a:schemeClr val="accent6">
                  <a:lumMod val="50000"/>
                  <a:tint val="23500"/>
                  <a:satMod val="160000"/>
                </a:schemeClr>
              </a:gs>
            </a:gsLst>
            <a:lin ang="13500000" scaled="1"/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185" name="Magnetic Disk 130">
            <a:extLst>
              <a:ext uri="{FF2B5EF4-FFF2-40B4-BE49-F238E27FC236}">
                <a16:creationId xmlns:a16="http://schemas.microsoft.com/office/drawing/2014/main" id="{B6DA3857-4818-4745-B666-D9BDE7CD207E}"/>
              </a:ext>
            </a:extLst>
          </p:cNvPr>
          <p:cNvSpPr/>
          <p:nvPr/>
        </p:nvSpPr>
        <p:spPr>
          <a:xfrm>
            <a:off x="2669492" y="1824068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rgbClr val="929000">
                  <a:tint val="66000"/>
                  <a:satMod val="160000"/>
                </a:srgbClr>
              </a:gs>
              <a:gs pos="50000">
                <a:srgbClr val="929000">
                  <a:tint val="44500"/>
                  <a:satMod val="160000"/>
                </a:srgbClr>
              </a:gs>
              <a:gs pos="100000">
                <a:srgbClr val="929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grpSp>
        <p:nvGrpSpPr>
          <p:cNvPr id="5" name="Grupo 151">
            <a:extLst>
              <a:ext uri="{FF2B5EF4-FFF2-40B4-BE49-F238E27FC236}">
                <a16:creationId xmlns:a16="http://schemas.microsoft.com/office/drawing/2014/main" id="{5D83D7AB-5961-0037-12F5-0301036D6F06}"/>
              </a:ext>
            </a:extLst>
          </p:cNvPr>
          <p:cNvGrpSpPr/>
          <p:nvPr/>
        </p:nvGrpSpPr>
        <p:grpSpPr>
          <a:xfrm rot="17016916">
            <a:off x="4961683" y="2280303"/>
            <a:ext cx="146029" cy="246092"/>
            <a:chOff x="3021023" y="4132290"/>
            <a:chExt cx="205948" cy="358859"/>
          </a:xfrm>
        </p:grpSpPr>
        <p:sp>
          <p:nvSpPr>
            <p:cNvPr id="10" name="Forma libre 158">
              <a:extLst>
                <a:ext uri="{FF2B5EF4-FFF2-40B4-BE49-F238E27FC236}">
                  <a16:creationId xmlns:a16="http://schemas.microsoft.com/office/drawing/2014/main" id="{7C8ED2B2-A7E1-B497-C43B-D9573D4B53F0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00FDFF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0" name="Forma libre 159">
              <a:extLst>
                <a:ext uri="{FF2B5EF4-FFF2-40B4-BE49-F238E27FC236}">
                  <a16:creationId xmlns:a16="http://schemas.microsoft.com/office/drawing/2014/main" id="{0B00263F-7892-B793-4688-E924900F7AC2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00FD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21" name="Grupo 152">
            <a:extLst>
              <a:ext uri="{FF2B5EF4-FFF2-40B4-BE49-F238E27FC236}">
                <a16:creationId xmlns:a16="http://schemas.microsoft.com/office/drawing/2014/main" id="{D7089DEB-E13D-6F49-1C8E-092641EC8984}"/>
              </a:ext>
            </a:extLst>
          </p:cNvPr>
          <p:cNvGrpSpPr/>
          <p:nvPr/>
        </p:nvGrpSpPr>
        <p:grpSpPr>
          <a:xfrm rot="1809763">
            <a:off x="4985634" y="1986464"/>
            <a:ext cx="205948" cy="358859"/>
            <a:chOff x="3021023" y="4132290"/>
            <a:chExt cx="205948" cy="358859"/>
          </a:xfrm>
        </p:grpSpPr>
        <p:sp>
          <p:nvSpPr>
            <p:cNvPr id="25" name="Forma libre 156">
              <a:extLst>
                <a:ext uri="{FF2B5EF4-FFF2-40B4-BE49-F238E27FC236}">
                  <a16:creationId xmlns:a16="http://schemas.microsoft.com/office/drawing/2014/main" id="{318FC99A-0F85-564F-EF9B-593F8DC6B492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C0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1" name="Forma libre 157">
              <a:extLst>
                <a:ext uri="{FF2B5EF4-FFF2-40B4-BE49-F238E27FC236}">
                  <a16:creationId xmlns:a16="http://schemas.microsoft.com/office/drawing/2014/main" id="{3623E61F-7C4D-C176-D064-F667991FC205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38" name="Grupo 29">
            <a:extLst>
              <a:ext uri="{FF2B5EF4-FFF2-40B4-BE49-F238E27FC236}">
                <a16:creationId xmlns:a16="http://schemas.microsoft.com/office/drawing/2014/main" id="{9F925F29-E3F6-2942-6218-18E97132450F}"/>
              </a:ext>
            </a:extLst>
          </p:cNvPr>
          <p:cNvGrpSpPr/>
          <p:nvPr/>
        </p:nvGrpSpPr>
        <p:grpSpPr>
          <a:xfrm>
            <a:off x="4605230" y="2394182"/>
            <a:ext cx="1030393" cy="242498"/>
            <a:chOff x="3245881" y="2431599"/>
            <a:chExt cx="1030393" cy="242498"/>
          </a:xfrm>
        </p:grpSpPr>
        <p:sp>
          <p:nvSpPr>
            <p:cNvPr id="40" name="Elipse 26">
              <a:extLst>
                <a:ext uri="{FF2B5EF4-FFF2-40B4-BE49-F238E27FC236}">
                  <a16:creationId xmlns:a16="http://schemas.microsoft.com/office/drawing/2014/main" id="{BE1E8D9F-7791-B98A-D13E-C4C6EFC4B520}"/>
                </a:ext>
              </a:extLst>
            </p:cNvPr>
            <p:cNvSpPr/>
            <p:nvPr/>
          </p:nvSpPr>
          <p:spPr>
            <a:xfrm>
              <a:off x="3629228" y="2431599"/>
              <a:ext cx="85411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1" name="Elipse 147">
              <a:extLst>
                <a:ext uri="{FF2B5EF4-FFF2-40B4-BE49-F238E27FC236}">
                  <a16:creationId xmlns:a16="http://schemas.microsoft.com/office/drawing/2014/main" id="{E54433C0-4503-6C54-835D-5DDC6CE9F4CC}"/>
                </a:ext>
              </a:extLst>
            </p:cNvPr>
            <p:cNvSpPr/>
            <p:nvPr/>
          </p:nvSpPr>
          <p:spPr>
            <a:xfrm>
              <a:off x="3765559" y="2431599"/>
              <a:ext cx="61984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5" name="Elipse 146">
              <a:extLst>
                <a:ext uri="{FF2B5EF4-FFF2-40B4-BE49-F238E27FC236}">
                  <a16:creationId xmlns:a16="http://schemas.microsoft.com/office/drawing/2014/main" id="{3E1C1115-879C-DD93-63FD-581A58F293BE}"/>
                </a:ext>
              </a:extLst>
            </p:cNvPr>
            <p:cNvSpPr/>
            <p:nvPr/>
          </p:nvSpPr>
          <p:spPr>
            <a:xfrm>
              <a:off x="3711139" y="2431599"/>
              <a:ext cx="85411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22" name="Rectángulo redondeado 27">
              <a:extLst>
                <a:ext uri="{FF2B5EF4-FFF2-40B4-BE49-F238E27FC236}">
                  <a16:creationId xmlns:a16="http://schemas.microsoft.com/office/drawing/2014/main" id="{059B6D84-1985-9660-7C74-E32F0FFACA4D}"/>
                </a:ext>
              </a:extLst>
            </p:cNvPr>
            <p:cNvSpPr/>
            <p:nvPr/>
          </p:nvSpPr>
          <p:spPr>
            <a:xfrm>
              <a:off x="3522325" y="2431599"/>
              <a:ext cx="99627" cy="187822"/>
            </a:xfrm>
            <a:prstGeom prst="round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23" name="CuadroTexto 148">
              <a:extLst>
                <a:ext uri="{FF2B5EF4-FFF2-40B4-BE49-F238E27FC236}">
                  <a16:creationId xmlns:a16="http://schemas.microsoft.com/office/drawing/2014/main" id="{F86C89F4-1075-0AE0-3BA7-808F43EACAC7}"/>
                </a:ext>
              </a:extLst>
            </p:cNvPr>
            <p:cNvSpPr txBox="1"/>
            <p:nvPr/>
          </p:nvSpPr>
          <p:spPr>
            <a:xfrm>
              <a:off x="3245881" y="2502707"/>
              <a:ext cx="34176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 err="1"/>
                <a:t>EpsH</a:t>
              </a:r>
              <a:endParaRPr lang="es-ES" sz="500" dirty="0"/>
            </a:p>
          </p:txBody>
        </p:sp>
        <p:sp>
          <p:nvSpPr>
            <p:cNvPr id="130" name="CuadroTexto 149">
              <a:extLst>
                <a:ext uri="{FF2B5EF4-FFF2-40B4-BE49-F238E27FC236}">
                  <a16:creationId xmlns:a16="http://schemas.microsoft.com/office/drawing/2014/main" id="{B3CCADC2-8966-0BC1-6AD6-CAB35599823B}"/>
                </a:ext>
              </a:extLst>
            </p:cNvPr>
            <p:cNvSpPr txBox="1"/>
            <p:nvPr/>
          </p:nvSpPr>
          <p:spPr>
            <a:xfrm>
              <a:off x="3761389" y="2504820"/>
              <a:ext cx="51488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 err="1"/>
                <a:t>Sec</a:t>
              </a:r>
              <a:r>
                <a:rPr lang="es-ES" sz="500" dirty="0"/>
                <a:t> </a:t>
              </a:r>
              <a:r>
                <a:rPr lang="es-ES" sz="500" dirty="0" err="1"/>
                <a:t>system</a:t>
              </a:r>
              <a:endParaRPr lang="es-ES" sz="500" dirty="0"/>
            </a:p>
          </p:txBody>
        </p:sp>
      </p:grpSp>
      <p:grpSp>
        <p:nvGrpSpPr>
          <p:cNvPr id="131" name="Grupo 191">
            <a:extLst>
              <a:ext uri="{FF2B5EF4-FFF2-40B4-BE49-F238E27FC236}">
                <a16:creationId xmlns:a16="http://schemas.microsoft.com/office/drawing/2014/main" id="{7E5B3545-9C1F-524D-2BD5-523D4718F535}"/>
              </a:ext>
            </a:extLst>
          </p:cNvPr>
          <p:cNvGrpSpPr/>
          <p:nvPr/>
        </p:nvGrpSpPr>
        <p:grpSpPr>
          <a:xfrm rot="4142925">
            <a:off x="4743808" y="2221950"/>
            <a:ext cx="131554" cy="154346"/>
            <a:chOff x="4747546" y="4151030"/>
            <a:chExt cx="406143" cy="476509"/>
          </a:xfrm>
        </p:grpSpPr>
        <p:sp>
          <p:nvSpPr>
            <p:cNvPr id="132" name="Franja diagonal 187">
              <a:extLst>
                <a:ext uri="{FF2B5EF4-FFF2-40B4-BE49-F238E27FC236}">
                  <a16:creationId xmlns:a16="http://schemas.microsoft.com/office/drawing/2014/main" id="{4C5262DF-CD3E-65F0-6471-C61D87769539}"/>
                </a:ext>
              </a:extLst>
            </p:cNvPr>
            <p:cNvSpPr/>
            <p:nvPr/>
          </p:nvSpPr>
          <p:spPr>
            <a:xfrm rot="17876278">
              <a:off x="4754448" y="4144128"/>
              <a:ext cx="238950" cy="252753"/>
            </a:xfrm>
            <a:prstGeom prst="diagStripe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solidFill>
                  <a:schemeClr val="tx1"/>
                </a:solidFill>
              </a:endParaRPr>
            </a:p>
          </p:txBody>
        </p:sp>
        <p:sp>
          <p:nvSpPr>
            <p:cNvPr id="139" name="Franja diagonal 188">
              <a:extLst>
                <a:ext uri="{FF2B5EF4-FFF2-40B4-BE49-F238E27FC236}">
                  <a16:creationId xmlns:a16="http://schemas.microsoft.com/office/drawing/2014/main" id="{807152D6-8D6D-421C-5C82-D3C544C07D6B}"/>
                </a:ext>
              </a:extLst>
            </p:cNvPr>
            <p:cNvSpPr/>
            <p:nvPr/>
          </p:nvSpPr>
          <p:spPr>
            <a:xfrm rot="3723722" flipH="1">
              <a:off x="4907838" y="4144129"/>
              <a:ext cx="238950" cy="252753"/>
            </a:xfrm>
            <a:prstGeom prst="diagStripe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solidFill>
                  <a:schemeClr val="tx1"/>
                </a:solidFill>
              </a:endParaRPr>
            </a:p>
          </p:txBody>
        </p:sp>
        <p:sp>
          <p:nvSpPr>
            <p:cNvPr id="151" name="Elipse 189">
              <a:extLst>
                <a:ext uri="{FF2B5EF4-FFF2-40B4-BE49-F238E27FC236}">
                  <a16:creationId xmlns:a16="http://schemas.microsoft.com/office/drawing/2014/main" id="{87B3CCAC-0234-C0F9-0322-E22670386F4E}"/>
                </a:ext>
              </a:extLst>
            </p:cNvPr>
            <p:cNvSpPr/>
            <p:nvPr/>
          </p:nvSpPr>
          <p:spPr>
            <a:xfrm rot="1495849">
              <a:off x="4816988" y="4428693"/>
              <a:ext cx="113868" cy="198842"/>
            </a:xfrm>
            <a:prstGeom prst="ellipse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7" name="Elipse 190">
              <a:extLst>
                <a:ext uri="{FF2B5EF4-FFF2-40B4-BE49-F238E27FC236}">
                  <a16:creationId xmlns:a16="http://schemas.microsoft.com/office/drawing/2014/main" id="{225DAC5E-DB9B-969E-A921-91D5E5D33CD6}"/>
                </a:ext>
              </a:extLst>
            </p:cNvPr>
            <p:cNvSpPr/>
            <p:nvPr/>
          </p:nvSpPr>
          <p:spPr>
            <a:xfrm rot="20104151" flipH="1">
              <a:off x="4971222" y="4428694"/>
              <a:ext cx="113868" cy="198845"/>
            </a:xfrm>
            <a:prstGeom prst="ellipse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cxnSp>
        <p:nvCxnSpPr>
          <p:cNvPr id="179" name="Conector recto de flecha 192">
            <a:extLst>
              <a:ext uri="{FF2B5EF4-FFF2-40B4-BE49-F238E27FC236}">
                <a16:creationId xmlns:a16="http://schemas.microsoft.com/office/drawing/2014/main" id="{723ED870-7D89-EB5F-8F39-7E72D7069578}"/>
              </a:ext>
            </a:extLst>
          </p:cNvPr>
          <p:cNvCxnSpPr>
            <a:cxnSpLocks/>
          </p:cNvCxnSpPr>
          <p:nvPr/>
        </p:nvCxnSpPr>
        <p:spPr>
          <a:xfrm>
            <a:off x="4033504" y="2392037"/>
            <a:ext cx="755473" cy="0"/>
          </a:xfrm>
          <a:prstGeom prst="straightConnector1">
            <a:avLst/>
          </a:prstGeom>
          <a:ln w="3175">
            <a:solidFill>
              <a:schemeClr val="tx1"/>
            </a:solidFill>
            <a:prstDash val="lgDash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Forma libre 36">
            <a:extLst>
              <a:ext uri="{FF2B5EF4-FFF2-40B4-BE49-F238E27FC236}">
                <a16:creationId xmlns:a16="http://schemas.microsoft.com/office/drawing/2014/main" id="{20F8295C-6AC9-DD5F-3AB3-CE5B7DBC373B}"/>
              </a:ext>
            </a:extLst>
          </p:cNvPr>
          <p:cNvSpPr/>
          <p:nvPr/>
        </p:nvSpPr>
        <p:spPr>
          <a:xfrm rot="14040046">
            <a:off x="3774787" y="1802342"/>
            <a:ext cx="547279" cy="153645"/>
          </a:xfrm>
          <a:custGeom>
            <a:avLst/>
            <a:gdLst>
              <a:gd name="connsiteX0" fmla="*/ 0 w 621102"/>
              <a:gd name="connsiteY0" fmla="*/ 133829 h 133829"/>
              <a:gd name="connsiteX1" fmla="*/ 200133 w 621102"/>
              <a:gd name="connsiteY1" fmla="*/ 2707 h 133829"/>
              <a:gd name="connsiteX2" fmla="*/ 621102 w 621102"/>
              <a:gd name="connsiteY2" fmla="*/ 57917 h 1338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21102" h="133829">
                <a:moveTo>
                  <a:pt x="0" y="133829"/>
                </a:moveTo>
                <a:cubicBezTo>
                  <a:pt x="48308" y="74594"/>
                  <a:pt x="96616" y="15359"/>
                  <a:pt x="200133" y="2707"/>
                </a:cubicBezTo>
                <a:cubicBezTo>
                  <a:pt x="303650" y="-9945"/>
                  <a:pt x="462376" y="23986"/>
                  <a:pt x="621102" y="57917"/>
                </a:cubicBezTo>
              </a:path>
            </a:pathLst>
          </a:custGeom>
          <a:noFill/>
          <a:ln w="3175">
            <a:solidFill>
              <a:schemeClr val="tx1"/>
            </a:solidFill>
            <a:prstDash val="lgDash"/>
            <a:headEnd type="none" w="med" len="med"/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4" name="Forma libre 36">
            <a:extLst>
              <a:ext uri="{FF2B5EF4-FFF2-40B4-BE49-F238E27FC236}">
                <a16:creationId xmlns:a16="http://schemas.microsoft.com/office/drawing/2014/main" id="{970C1372-2C6C-2FF4-9189-C087E43637EB}"/>
              </a:ext>
            </a:extLst>
          </p:cNvPr>
          <p:cNvSpPr/>
          <p:nvPr/>
        </p:nvSpPr>
        <p:spPr>
          <a:xfrm rot="11527082" flipV="1">
            <a:off x="3951780" y="2788531"/>
            <a:ext cx="717722" cy="170159"/>
          </a:xfrm>
          <a:custGeom>
            <a:avLst/>
            <a:gdLst>
              <a:gd name="connsiteX0" fmla="*/ 0 w 621102"/>
              <a:gd name="connsiteY0" fmla="*/ 133829 h 133829"/>
              <a:gd name="connsiteX1" fmla="*/ 200133 w 621102"/>
              <a:gd name="connsiteY1" fmla="*/ 2707 h 133829"/>
              <a:gd name="connsiteX2" fmla="*/ 621102 w 621102"/>
              <a:gd name="connsiteY2" fmla="*/ 57917 h 1338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21102" h="133829">
                <a:moveTo>
                  <a:pt x="0" y="133829"/>
                </a:moveTo>
                <a:cubicBezTo>
                  <a:pt x="48308" y="74594"/>
                  <a:pt x="96616" y="15359"/>
                  <a:pt x="200133" y="2707"/>
                </a:cubicBezTo>
                <a:cubicBezTo>
                  <a:pt x="303650" y="-9945"/>
                  <a:pt x="462376" y="23986"/>
                  <a:pt x="621102" y="57917"/>
                </a:cubicBezTo>
              </a:path>
            </a:pathLst>
          </a:custGeom>
          <a:noFill/>
          <a:ln w="3175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3602360E-BF26-8F6E-79E3-74B19AD55E4E}"/>
              </a:ext>
            </a:extLst>
          </p:cNvPr>
          <p:cNvSpPr txBox="1"/>
          <p:nvPr/>
        </p:nvSpPr>
        <p:spPr>
          <a:xfrm>
            <a:off x="4805267" y="924732"/>
            <a:ext cx="11592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Extracellular space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6086258E-695A-DE8B-9B35-26E7BE91846C}"/>
              </a:ext>
            </a:extLst>
          </p:cNvPr>
          <p:cNvSpPr txBox="1"/>
          <p:nvPr/>
        </p:nvSpPr>
        <p:spPr>
          <a:xfrm>
            <a:off x="5315022" y="2089688"/>
            <a:ext cx="6976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Periplasm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92F25D17-8AF9-D6B9-7C81-BF245795EA90}"/>
              </a:ext>
            </a:extLst>
          </p:cNvPr>
          <p:cNvSpPr txBox="1"/>
          <p:nvPr/>
        </p:nvSpPr>
        <p:spPr>
          <a:xfrm>
            <a:off x="5279755" y="2851689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Cytoplasm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3719CAD3-BBB6-A197-0FB5-1161B7C7E05F}"/>
              </a:ext>
            </a:extLst>
          </p:cNvPr>
          <p:cNvSpPr txBox="1"/>
          <p:nvPr/>
        </p:nvSpPr>
        <p:spPr>
          <a:xfrm>
            <a:off x="5677300" y="1691900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OM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C47C1EE2-BC24-41D0-7C2A-D14FB43ED1E6}"/>
              </a:ext>
            </a:extLst>
          </p:cNvPr>
          <p:cNvSpPr txBox="1"/>
          <p:nvPr/>
        </p:nvSpPr>
        <p:spPr>
          <a:xfrm>
            <a:off x="5677300" y="2459066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PM</a:t>
            </a:r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EBAFD840-3135-214F-FBB7-A14AAD781657}"/>
              </a:ext>
            </a:extLst>
          </p:cNvPr>
          <p:cNvSpPr/>
          <p:nvPr/>
        </p:nvSpPr>
        <p:spPr>
          <a:xfrm>
            <a:off x="960895" y="878237"/>
            <a:ext cx="5047281" cy="3006671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221" name="Rectangle 6">
            <a:extLst>
              <a:ext uri="{FF2B5EF4-FFF2-40B4-BE49-F238E27FC236}">
                <a16:creationId xmlns:a16="http://schemas.microsoft.com/office/drawing/2014/main" id="{4FBC9248-3BB5-C37C-5D37-5B413C41798E}"/>
              </a:ext>
            </a:extLst>
          </p:cNvPr>
          <p:cNvSpPr/>
          <p:nvPr/>
        </p:nvSpPr>
        <p:spPr>
          <a:xfrm>
            <a:off x="957698" y="4030953"/>
            <a:ext cx="5055644" cy="1112215"/>
          </a:xfrm>
          <a:prstGeom prst="rect">
            <a:avLst/>
          </a:prstGeom>
          <a:gradFill rotWithShape="0">
            <a:gsLst>
              <a:gs pos="0">
                <a:srgbClr val="E0E5F6"/>
              </a:gs>
              <a:gs pos="100000">
                <a:schemeClr val="accent5">
                  <a:lumMod val="40000"/>
                  <a:lumOff val="60000"/>
                </a:schemeClr>
              </a:gs>
            </a:gsLst>
            <a:lin ang="27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222" name="Rectangle 7">
            <a:extLst>
              <a:ext uri="{FF2B5EF4-FFF2-40B4-BE49-F238E27FC236}">
                <a16:creationId xmlns:a16="http://schemas.microsoft.com/office/drawing/2014/main" id="{BA5054F1-651F-0AE6-A2DD-EAFB1DCC8A2B}"/>
              </a:ext>
            </a:extLst>
          </p:cNvPr>
          <p:cNvSpPr/>
          <p:nvPr/>
        </p:nvSpPr>
        <p:spPr>
          <a:xfrm>
            <a:off x="957698" y="5630072"/>
            <a:ext cx="5055644" cy="1397671"/>
          </a:xfrm>
          <a:prstGeom prst="rect">
            <a:avLst/>
          </a:prstGeom>
          <a:gradFill rotWithShape="0">
            <a:gsLst>
              <a:gs pos="0">
                <a:srgbClr val="E2F0D9"/>
              </a:gs>
              <a:gs pos="100000">
                <a:schemeClr val="accent6">
                  <a:lumMod val="40000"/>
                  <a:lumOff val="60000"/>
                </a:schemeClr>
              </a:gs>
            </a:gsLst>
            <a:lin ang="27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223" name="Rectangle 8">
            <a:extLst>
              <a:ext uri="{FF2B5EF4-FFF2-40B4-BE49-F238E27FC236}">
                <a16:creationId xmlns:a16="http://schemas.microsoft.com/office/drawing/2014/main" id="{C92E94B2-4BB2-DC7A-9FB5-03481B3E06C1}"/>
              </a:ext>
            </a:extLst>
          </p:cNvPr>
          <p:cNvSpPr/>
          <p:nvPr/>
        </p:nvSpPr>
        <p:spPr>
          <a:xfrm>
            <a:off x="957698" y="5046513"/>
            <a:ext cx="5055644" cy="585720"/>
          </a:xfrm>
          <a:prstGeom prst="rect">
            <a:avLst/>
          </a:prstGeom>
          <a:gradFill rotWithShape="0">
            <a:gsLst>
              <a:gs pos="0">
                <a:schemeClr val="bg1"/>
              </a:gs>
              <a:gs pos="100000">
                <a:srgbClr val="FBE5D6"/>
              </a:gs>
            </a:gsLst>
            <a:lin ang="27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 dirty="0">
              <a:solidFill>
                <a:schemeClr val="lt1"/>
              </a:solidFill>
              <a:latin typeface="Calibri"/>
            </a:endParaRPr>
          </a:p>
        </p:txBody>
      </p:sp>
      <p:cxnSp>
        <p:nvCxnSpPr>
          <p:cNvPr id="224" name="Conector recto 214">
            <a:extLst>
              <a:ext uri="{FF2B5EF4-FFF2-40B4-BE49-F238E27FC236}">
                <a16:creationId xmlns:a16="http://schemas.microsoft.com/office/drawing/2014/main" id="{A5B1AAF7-0DEF-A8DA-40D1-EBC6530A2C76}"/>
              </a:ext>
            </a:extLst>
          </p:cNvPr>
          <p:cNvCxnSpPr/>
          <p:nvPr/>
        </p:nvCxnSpPr>
        <p:spPr>
          <a:xfrm>
            <a:off x="972456" y="5045913"/>
            <a:ext cx="5017910" cy="0"/>
          </a:xfrm>
          <a:prstGeom prst="line">
            <a:avLst/>
          </a:prstGeom>
          <a:ln w="76200" cmpd="thickThin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Conector recto 215">
            <a:extLst>
              <a:ext uri="{FF2B5EF4-FFF2-40B4-BE49-F238E27FC236}">
                <a16:creationId xmlns:a16="http://schemas.microsoft.com/office/drawing/2014/main" id="{F09DEE3F-A076-DC0F-84DE-756B7298AE8F}"/>
              </a:ext>
            </a:extLst>
          </p:cNvPr>
          <p:cNvCxnSpPr/>
          <p:nvPr/>
        </p:nvCxnSpPr>
        <p:spPr>
          <a:xfrm>
            <a:off x="972456" y="5617769"/>
            <a:ext cx="5017910" cy="0"/>
          </a:xfrm>
          <a:prstGeom prst="line">
            <a:avLst/>
          </a:prstGeom>
          <a:ln w="76200" cmpd="dbl">
            <a:solidFill>
              <a:schemeClr val="accent4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5" name="Grupo 23">
            <a:extLst>
              <a:ext uri="{FF2B5EF4-FFF2-40B4-BE49-F238E27FC236}">
                <a16:creationId xmlns:a16="http://schemas.microsoft.com/office/drawing/2014/main" id="{BAF9E46F-06D9-24E8-44EA-1CDE7E75585B}"/>
              </a:ext>
            </a:extLst>
          </p:cNvPr>
          <p:cNvGrpSpPr/>
          <p:nvPr/>
        </p:nvGrpSpPr>
        <p:grpSpPr>
          <a:xfrm>
            <a:off x="3628661" y="6215395"/>
            <a:ext cx="306071" cy="499332"/>
            <a:chOff x="2297505" y="4099104"/>
            <a:chExt cx="306071" cy="499332"/>
          </a:xfrm>
        </p:grpSpPr>
        <p:grpSp>
          <p:nvGrpSpPr>
            <p:cNvPr id="266" name="Grupo 22">
              <a:extLst>
                <a:ext uri="{FF2B5EF4-FFF2-40B4-BE49-F238E27FC236}">
                  <a16:creationId xmlns:a16="http://schemas.microsoft.com/office/drawing/2014/main" id="{83E1A6B7-3974-B519-6385-24AFD4FA6850}"/>
                </a:ext>
              </a:extLst>
            </p:cNvPr>
            <p:cNvGrpSpPr/>
            <p:nvPr/>
          </p:nvGrpSpPr>
          <p:grpSpPr>
            <a:xfrm>
              <a:off x="2297505" y="4239577"/>
              <a:ext cx="205948" cy="358859"/>
              <a:chOff x="3021023" y="4132290"/>
              <a:chExt cx="205948" cy="358859"/>
            </a:xfrm>
          </p:grpSpPr>
          <p:sp>
            <p:nvSpPr>
              <p:cNvPr id="270" name="Forma libre 18">
                <a:extLst>
                  <a:ext uri="{FF2B5EF4-FFF2-40B4-BE49-F238E27FC236}">
                    <a16:creationId xmlns:a16="http://schemas.microsoft.com/office/drawing/2014/main" id="{D07F30BC-AAFE-53F7-E5BA-495A4E9A9AE9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C0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271" name="Forma libre 21">
                <a:extLst>
                  <a:ext uri="{FF2B5EF4-FFF2-40B4-BE49-F238E27FC236}">
                    <a16:creationId xmlns:a16="http://schemas.microsoft.com/office/drawing/2014/main" id="{D01DF3EF-EF70-8FBB-AACB-E8FAC1A18D21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267" name="Grupo 132">
              <a:extLst>
                <a:ext uri="{FF2B5EF4-FFF2-40B4-BE49-F238E27FC236}">
                  <a16:creationId xmlns:a16="http://schemas.microsoft.com/office/drawing/2014/main" id="{D291DC5B-FCD0-61E2-DB11-54C43AF09634}"/>
                </a:ext>
              </a:extLst>
            </p:cNvPr>
            <p:cNvGrpSpPr/>
            <p:nvPr/>
          </p:nvGrpSpPr>
          <p:grpSpPr>
            <a:xfrm>
              <a:off x="2488818" y="4099104"/>
              <a:ext cx="114758" cy="152400"/>
              <a:chOff x="3021023" y="4132290"/>
              <a:chExt cx="205948" cy="358859"/>
            </a:xfrm>
          </p:grpSpPr>
          <p:sp>
            <p:nvSpPr>
              <p:cNvPr id="268" name="Forma libre 133">
                <a:extLst>
                  <a:ext uri="{FF2B5EF4-FFF2-40B4-BE49-F238E27FC236}">
                    <a16:creationId xmlns:a16="http://schemas.microsoft.com/office/drawing/2014/main" id="{43F49508-E56D-E687-E7CD-832885F2A2CF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0070C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269" name="Forma libre 134">
                <a:extLst>
                  <a:ext uri="{FF2B5EF4-FFF2-40B4-BE49-F238E27FC236}">
                    <a16:creationId xmlns:a16="http://schemas.microsoft.com/office/drawing/2014/main" id="{BDAAE785-A6EE-55AB-C5A9-3F230EF65E66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grpSp>
        <p:nvGrpSpPr>
          <p:cNvPr id="272" name="Grupo 17">
            <a:extLst>
              <a:ext uri="{FF2B5EF4-FFF2-40B4-BE49-F238E27FC236}">
                <a16:creationId xmlns:a16="http://schemas.microsoft.com/office/drawing/2014/main" id="{F3294D40-EA78-8F27-04BA-6A8F2261B8CE}"/>
              </a:ext>
            </a:extLst>
          </p:cNvPr>
          <p:cNvGrpSpPr/>
          <p:nvPr/>
        </p:nvGrpSpPr>
        <p:grpSpPr>
          <a:xfrm>
            <a:off x="3231922" y="6543481"/>
            <a:ext cx="655321" cy="310465"/>
            <a:chOff x="1869721" y="4434816"/>
            <a:chExt cx="835035" cy="395606"/>
          </a:xfrm>
        </p:grpSpPr>
        <p:grpSp>
          <p:nvGrpSpPr>
            <p:cNvPr id="273" name="Grupo 16">
              <a:extLst>
                <a:ext uri="{FF2B5EF4-FFF2-40B4-BE49-F238E27FC236}">
                  <a16:creationId xmlns:a16="http://schemas.microsoft.com/office/drawing/2014/main" id="{3ABD96D1-A6A1-649E-2763-D560E8F36C2B}"/>
                </a:ext>
              </a:extLst>
            </p:cNvPr>
            <p:cNvGrpSpPr/>
            <p:nvPr/>
          </p:nvGrpSpPr>
          <p:grpSpPr>
            <a:xfrm rot="20543507">
              <a:off x="1869721" y="4797956"/>
              <a:ext cx="432139" cy="32466"/>
              <a:chOff x="1849246" y="4735547"/>
              <a:chExt cx="432139" cy="32466"/>
            </a:xfrm>
          </p:grpSpPr>
          <p:sp>
            <p:nvSpPr>
              <p:cNvPr id="281" name="Forma libre 149">
                <a:extLst>
                  <a:ext uri="{FF2B5EF4-FFF2-40B4-BE49-F238E27FC236}">
                    <a16:creationId xmlns:a16="http://schemas.microsoft.com/office/drawing/2014/main" id="{3C244968-B0F0-651D-7D96-6633064AC6D6}"/>
                  </a:ext>
                </a:extLst>
              </p:cNvPr>
              <p:cNvSpPr/>
              <p:nvPr/>
            </p:nvSpPr>
            <p:spPr>
              <a:xfrm>
                <a:off x="1849246" y="4736777"/>
                <a:ext cx="217668" cy="31236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2" name="Forma libre 150">
                <a:extLst>
                  <a:ext uri="{FF2B5EF4-FFF2-40B4-BE49-F238E27FC236}">
                    <a16:creationId xmlns:a16="http://schemas.microsoft.com/office/drawing/2014/main" id="{70F364C7-12E9-2351-50C4-A92FDEEC017F}"/>
                  </a:ext>
                </a:extLst>
              </p:cNvPr>
              <p:cNvSpPr/>
              <p:nvPr/>
            </p:nvSpPr>
            <p:spPr>
              <a:xfrm>
                <a:off x="2063717" y="4735547"/>
                <a:ext cx="217668" cy="31236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74" name="Grupo 15">
              <a:extLst>
                <a:ext uri="{FF2B5EF4-FFF2-40B4-BE49-F238E27FC236}">
                  <a16:creationId xmlns:a16="http://schemas.microsoft.com/office/drawing/2014/main" id="{BD91206A-5ABF-AAFA-0396-A498405D6DEC}"/>
                </a:ext>
              </a:extLst>
            </p:cNvPr>
            <p:cNvGrpSpPr/>
            <p:nvPr/>
          </p:nvGrpSpPr>
          <p:grpSpPr>
            <a:xfrm>
              <a:off x="2335809" y="4543813"/>
              <a:ext cx="368947" cy="236552"/>
              <a:chOff x="3539379" y="4188715"/>
              <a:chExt cx="368947" cy="236552"/>
            </a:xfrm>
          </p:grpSpPr>
          <p:sp>
            <p:nvSpPr>
              <p:cNvPr id="278" name="Forma libre 146">
                <a:extLst>
                  <a:ext uri="{FF2B5EF4-FFF2-40B4-BE49-F238E27FC236}">
                    <a16:creationId xmlns:a16="http://schemas.microsoft.com/office/drawing/2014/main" id="{BCBE799A-2665-7A25-22A1-12AAD2661506}"/>
                  </a:ext>
                </a:extLst>
              </p:cNvPr>
              <p:cNvSpPr/>
              <p:nvPr/>
            </p:nvSpPr>
            <p:spPr>
              <a:xfrm rot="18409375">
                <a:off x="3446163" y="4300815"/>
                <a:ext cx="217668" cy="31236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9" name="Forma libre 147">
                <a:extLst>
                  <a:ext uri="{FF2B5EF4-FFF2-40B4-BE49-F238E27FC236}">
                    <a16:creationId xmlns:a16="http://schemas.microsoft.com/office/drawing/2014/main" id="{0F6ABB4D-6DE3-179F-AAA0-1ED4C56FD2AB}"/>
                  </a:ext>
                </a:extLst>
              </p:cNvPr>
              <p:cNvSpPr/>
              <p:nvPr/>
            </p:nvSpPr>
            <p:spPr>
              <a:xfrm rot="20444268" flipV="1">
                <a:off x="3540884" y="4219888"/>
                <a:ext cx="217668" cy="45719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0" name="Forma libre 148">
                <a:extLst>
                  <a:ext uri="{FF2B5EF4-FFF2-40B4-BE49-F238E27FC236}">
                    <a16:creationId xmlns:a16="http://schemas.microsoft.com/office/drawing/2014/main" id="{554D5718-4E9C-5C8C-430E-D4FEF8FC9277}"/>
                  </a:ext>
                </a:extLst>
              </p:cNvPr>
              <p:cNvSpPr/>
              <p:nvPr/>
            </p:nvSpPr>
            <p:spPr>
              <a:xfrm>
                <a:off x="3690658" y="4188715"/>
                <a:ext cx="217668" cy="31236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75" name="Grupo 14">
              <a:extLst>
                <a:ext uri="{FF2B5EF4-FFF2-40B4-BE49-F238E27FC236}">
                  <a16:creationId xmlns:a16="http://schemas.microsoft.com/office/drawing/2014/main" id="{5F6B235F-756E-819D-2D76-EFEC50598021}"/>
                </a:ext>
              </a:extLst>
            </p:cNvPr>
            <p:cNvGrpSpPr/>
            <p:nvPr/>
          </p:nvGrpSpPr>
          <p:grpSpPr>
            <a:xfrm rot="21011966">
              <a:off x="2332135" y="4434816"/>
              <a:ext cx="192907" cy="208024"/>
              <a:chOff x="2399355" y="4434815"/>
              <a:chExt cx="216810" cy="233801"/>
            </a:xfrm>
            <a:solidFill>
              <a:schemeClr val="accent6">
                <a:lumMod val="75000"/>
              </a:schemeClr>
            </a:solidFill>
          </p:grpSpPr>
          <p:sp>
            <p:nvSpPr>
              <p:cNvPr id="276" name="Elipse 13">
                <a:extLst>
                  <a:ext uri="{FF2B5EF4-FFF2-40B4-BE49-F238E27FC236}">
                    <a16:creationId xmlns:a16="http://schemas.microsoft.com/office/drawing/2014/main" id="{7192CC17-3749-8F21-BACA-0CB9B469A18E}"/>
                  </a:ext>
                </a:extLst>
              </p:cNvPr>
              <p:cNvSpPr/>
              <p:nvPr/>
            </p:nvSpPr>
            <p:spPr>
              <a:xfrm>
                <a:off x="2418847" y="4582352"/>
                <a:ext cx="184729" cy="86264"/>
              </a:xfrm>
              <a:prstGeom prst="ellipse">
                <a:avLst/>
              </a:prstGeom>
              <a:grpFill/>
              <a:ln w="19050"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277" name="Elipse 123">
                <a:extLst>
                  <a:ext uri="{FF2B5EF4-FFF2-40B4-BE49-F238E27FC236}">
                    <a16:creationId xmlns:a16="http://schemas.microsoft.com/office/drawing/2014/main" id="{F3356BAC-F989-8749-34E4-9C7BA24BC11E}"/>
                  </a:ext>
                </a:extLst>
              </p:cNvPr>
              <p:cNvSpPr/>
              <p:nvPr/>
            </p:nvSpPr>
            <p:spPr>
              <a:xfrm>
                <a:off x="2399355" y="4434815"/>
                <a:ext cx="216810" cy="144348"/>
              </a:xfrm>
              <a:prstGeom prst="ellipse">
                <a:avLst/>
              </a:prstGeom>
              <a:grpFill/>
              <a:ln w="19050"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grpSp>
        <p:nvGrpSpPr>
          <p:cNvPr id="283" name="Grupo 28">
            <a:extLst>
              <a:ext uri="{FF2B5EF4-FFF2-40B4-BE49-F238E27FC236}">
                <a16:creationId xmlns:a16="http://schemas.microsoft.com/office/drawing/2014/main" id="{891B3E3A-29C2-FF4E-6F4A-C341192EC431}"/>
              </a:ext>
            </a:extLst>
          </p:cNvPr>
          <p:cNvGrpSpPr/>
          <p:nvPr/>
        </p:nvGrpSpPr>
        <p:grpSpPr>
          <a:xfrm>
            <a:off x="4577661" y="6222959"/>
            <a:ext cx="481779" cy="423731"/>
            <a:chOff x="3657484" y="2834955"/>
            <a:chExt cx="481779" cy="423731"/>
          </a:xfrm>
        </p:grpSpPr>
        <p:grpSp>
          <p:nvGrpSpPr>
            <p:cNvPr id="284" name="Grupo 135">
              <a:extLst>
                <a:ext uri="{FF2B5EF4-FFF2-40B4-BE49-F238E27FC236}">
                  <a16:creationId xmlns:a16="http://schemas.microsoft.com/office/drawing/2014/main" id="{5DE33AF5-1AA2-06A3-267D-7975ECCEF8EB}"/>
                </a:ext>
              </a:extLst>
            </p:cNvPr>
            <p:cNvGrpSpPr/>
            <p:nvPr/>
          </p:nvGrpSpPr>
          <p:grpSpPr>
            <a:xfrm rot="12974753">
              <a:off x="4024505" y="3106286"/>
              <a:ext cx="114758" cy="152400"/>
              <a:chOff x="3021023" y="4132290"/>
              <a:chExt cx="205948" cy="358859"/>
            </a:xfrm>
          </p:grpSpPr>
          <p:sp>
            <p:nvSpPr>
              <p:cNvPr id="291" name="Forma libre 136">
                <a:extLst>
                  <a:ext uri="{FF2B5EF4-FFF2-40B4-BE49-F238E27FC236}">
                    <a16:creationId xmlns:a16="http://schemas.microsoft.com/office/drawing/2014/main" id="{40D602A1-444A-D886-8947-FFE690A24279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00FDFF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292" name="Forma libre 137">
                <a:extLst>
                  <a:ext uri="{FF2B5EF4-FFF2-40B4-BE49-F238E27FC236}">
                    <a16:creationId xmlns:a16="http://schemas.microsoft.com/office/drawing/2014/main" id="{97B534E8-2797-3AD9-973E-723DFB47A03D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00FD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285" name="Grupo 139">
              <a:extLst>
                <a:ext uri="{FF2B5EF4-FFF2-40B4-BE49-F238E27FC236}">
                  <a16:creationId xmlns:a16="http://schemas.microsoft.com/office/drawing/2014/main" id="{421A112F-54AC-F5AC-1F23-C999E9B0DC45}"/>
                </a:ext>
              </a:extLst>
            </p:cNvPr>
            <p:cNvGrpSpPr/>
            <p:nvPr/>
          </p:nvGrpSpPr>
          <p:grpSpPr>
            <a:xfrm rot="16598938">
              <a:off x="3733940" y="2917027"/>
              <a:ext cx="205948" cy="358859"/>
              <a:chOff x="3021023" y="4132290"/>
              <a:chExt cx="205948" cy="358859"/>
            </a:xfrm>
          </p:grpSpPr>
          <p:sp>
            <p:nvSpPr>
              <p:cNvPr id="289" name="Forma libre 143">
                <a:extLst>
                  <a:ext uri="{FF2B5EF4-FFF2-40B4-BE49-F238E27FC236}">
                    <a16:creationId xmlns:a16="http://schemas.microsoft.com/office/drawing/2014/main" id="{29275CB2-B137-78E7-E8C8-5BA10EEF6C97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C0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290" name="Forma libre 144">
                <a:extLst>
                  <a:ext uri="{FF2B5EF4-FFF2-40B4-BE49-F238E27FC236}">
                    <a16:creationId xmlns:a16="http://schemas.microsoft.com/office/drawing/2014/main" id="{BC2E1AA8-B8B8-47CA-6DD7-9C015B8B927F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286" name="Grupo 140">
              <a:extLst>
                <a:ext uri="{FF2B5EF4-FFF2-40B4-BE49-F238E27FC236}">
                  <a16:creationId xmlns:a16="http://schemas.microsoft.com/office/drawing/2014/main" id="{A986C377-302A-8CE3-D53E-CDB7AC7D0C27}"/>
                </a:ext>
              </a:extLst>
            </p:cNvPr>
            <p:cNvGrpSpPr/>
            <p:nvPr/>
          </p:nvGrpSpPr>
          <p:grpSpPr>
            <a:xfrm rot="19980196">
              <a:off x="3662833" y="2834955"/>
              <a:ext cx="114758" cy="152400"/>
              <a:chOff x="3021023" y="4132290"/>
              <a:chExt cx="205948" cy="358859"/>
            </a:xfrm>
          </p:grpSpPr>
          <p:sp>
            <p:nvSpPr>
              <p:cNvPr id="287" name="Forma libre 141">
                <a:extLst>
                  <a:ext uri="{FF2B5EF4-FFF2-40B4-BE49-F238E27FC236}">
                    <a16:creationId xmlns:a16="http://schemas.microsoft.com/office/drawing/2014/main" id="{43DC66D8-9E0A-E750-256D-FFC7376B3E71}"/>
                  </a:ext>
                </a:extLst>
              </p:cNvPr>
              <p:cNvSpPr/>
              <p:nvPr/>
            </p:nvSpPr>
            <p:spPr>
              <a:xfrm>
                <a:off x="3021023" y="4132290"/>
                <a:ext cx="205948" cy="358859"/>
              </a:xfrm>
              <a:custGeom>
                <a:avLst/>
                <a:gdLst>
                  <a:gd name="connsiteX0" fmla="*/ 5815 w 205948"/>
                  <a:gd name="connsiteY0" fmla="*/ 358859 h 358859"/>
                  <a:gd name="connsiteX1" fmla="*/ 2365 w 205948"/>
                  <a:gd name="connsiteY1" fmla="*/ 234638 h 358859"/>
                  <a:gd name="connsiteX2" fmla="*/ 36870 w 205948"/>
                  <a:gd name="connsiteY2" fmla="*/ 200133 h 358859"/>
                  <a:gd name="connsiteX3" fmla="*/ 74827 w 205948"/>
                  <a:gd name="connsiteY3" fmla="*/ 175979 h 358859"/>
                  <a:gd name="connsiteX4" fmla="*/ 171442 w 205948"/>
                  <a:gd name="connsiteY4" fmla="*/ 117319 h 358859"/>
                  <a:gd name="connsiteX5" fmla="*/ 116233 w 205948"/>
                  <a:gd name="connsiteY5" fmla="*/ 62110 h 358859"/>
                  <a:gd name="connsiteX6" fmla="*/ 205948 w 205948"/>
                  <a:gd name="connsiteY6" fmla="*/ 0 h 358859"/>
                  <a:gd name="connsiteX7" fmla="*/ 205948 w 205948"/>
                  <a:gd name="connsiteY7" fmla="*/ 0 h 358859"/>
                  <a:gd name="connsiteX8" fmla="*/ 205948 w 205948"/>
                  <a:gd name="connsiteY8" fmla="*/ 0 h 3588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05948" h="358859">
                    <a:moveTo>
                      <a:pt x="5815" y="358859"/>
                    </a:moveTo>
                    <a:cubicBezTo>
                      <a:pt x="1502" y="309975"/>
                      <a:pt x="-2811" y="261092"/>
                      <a:pt x="2365" y="234638"/>
                    </a:cubicBezTo>
                    <a:cubicBezTo>
                      <a:pt x="7541" y="208184"/>
                      <a:pt x="24793" y="209909"/>
                      <a:pt x="36870" y="200133"/>
                    </a:cubicBezTo>
                    <a:cubicBezTo>
                      <a:pt x="48947" y="190357"/>
                      <a:pt x="74827" y="175979"/>
                      <a:pt x="74827" y="175979"/>
                    </a:cubicBezTo>
                    <a:cubicBezTo>
                      <a:pt x="97256" y="162177"/>
                      <a:pt x="164541" y="136297"/>
                      <a:pt x="171442" y="117319"/>
                    </a:cubicBezTo>
                    <a:cubicBezTo>
                      <a:pt x="178343" y="98341"/>
                      <a:pt x="110482" y="81663"/>
                      <a:pt x="116233" y="62110"/>
                    </a:cubicBezTo>
                    <a:cubicBezTo>
                      <a:pt x="121984" y="42557"/>
                      <a:pt x="205948" y="0"/>
                      <a:pt x="205948" y="0"/>
                    </a:cubicBezTo>
                    <a:lnTo>
                      <a:pt x="205948" y="0"/>
                    </a:lnTo>
                    <a:lnTo>
                      <a:pt x="205948" y="0"/>
                    </a:lnTo>
                  </a:path>
                </a:pathLst>
              </a:custGeom>
              <a:noFill/>
              <a:ln w="38100">
                <a:solidFill>
                  <a:srgbClr val="0070C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288" name="Forma libre 142">
                <a:extLst>
                  <a:ext uri="{FF2B5EF4-FFF2-40B4-BE49-F238E27FC236}">
                    <a16:creationId xmlns:a16="http://schemas.microsoft.com/office/drawing/2014/main" id="{952F6C3F-F1A7-E575-6F31-F3F1E97BB227}"/>
                  </a:ext>
                </a:extLst>
              </p:cNvPr>
              <p:cNvSpPr/>
              <p:nvPr/>
            </p:nvSpPr>
            <p:spPr>
              <a:xfrm>
                <a:off x="3021023" y="4144217"/>
                <a:ext cx="191313" cy="320903"/>
              </a:xfrm>
              <a:custGeom>
                <a:avLst/>
                <a:gdLst>
                  <a:gd name="connsiteX0" fmla="*/ 18782 w 191313"/>
                  <a:gd name="connsiteY0" fmla="*/ 320903 h 320903"/>
                  <a:gd name="connsiteX1" fmla="*/ 1529 w 191313"/>
                  <a:gd name="connsiteY1" fmla="*/ 238089 h 320903"/>
                  <a:gd name="connsiteX2" fmla="*/ 53288 w 191313"/>
                  <a:gd name="connsiteY2" fmla="*/ 169078 h 320903"/>
                  <a:gd name="connsiteX3" fmla="*/ 122299 w 191313"/>
                  <a:gd name="connsiteY3" fmla="*/ 141473 h 320903"/>
                  <a:gd name="connsiteX4" fmla="*/ 191310 w 191313"/>
                  <a:gd name="connsiteY4" fmla="*/ 96616 h 320903"/>
                  <a:gd name="connsiteX5" fmla="*/ 125750 w 191313"/>
                  <a:gd name="connsiteY5" fmla="*/ 55209 h 320903"/>
                  <a:gd name="connsiteX6" fmla="*/ 167156 w 191313"/>
                  <a:gd name="connsiteY6" fmla="*/ 0 h 3209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1313" h="320903">
                    <a:moveTo>
                      <a:pt x="18782" y="320903"/>
                    </a:moveTo>
                    <a:cubicBezTo>
                      <a:pt x="7280" y="292148"/>
                      <a:pt x="-4222" y="263393"/>
                      <a:pt x="1529" y="238089"/>
                    </a:cubicBezTo>
                    <a:cubicBezTo>
                      <a:pt x="7280" y="212785"/>
                      <a:pt x="33160" y="185181"/>
                      <a:pt x="53288" y="169078"/>
                    </a:cubicBezTo>
                    <a:cubicBezTo>
                      <a:pt x="73416" y="152975"/>
                      <a:pt x="99295" y="153550"/>
                      <a:pt x="122299" y="141473"/>
                    </a:cubicBezTo>
                    <a:cubicBezTo>
                      <a:pt x="145303" y="129396"/>
                      <a:pt x="190735" y="110993"/>
                      <a:pt x="191310" y="96616"/>
                    </a:cubicBezTo>
                    <a:cubicBezTo>
                      <a:pt x="191885" y="82239"/>
                      <a:pt x="129776" y="71312"/>
                      <a:pt x="125750" y="55209"/>
                    </a:cubicBezTo>
                    <a:cubicBezTo>
                      <a:pt x="121724" y="39106"/>
                      <a:pt x="144440" y="19553"/>
                      <a:pt x="167156" y="0"/>
                    </a:cubicBezTo>
                  </a:path>
                </a:pathLst>
              </a:custGeom>
              <a:no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sp>
        <p:nvSpPr>
          <p:cNvPr id="293" name="CuadroTexto 25">
            <a:extLst>
              <a:ext uri="{FF2B5EF4-FFF2-40B4-BE49-F238E27FC236}">
                <a16:creationId xmlns:a16="http://schemas.microsoft.com/office/drawing/2014/main" id="{2B5A3E6F-B673-DA37-6B32-AEA1411683D5}"/>
              </a:ext>
            </a:extLst>
          </p:cNvPr>
          <p:cNvSpPr txBox="1"/>
          <p:nvPr/>
        </p:nvSpPr>
        <p:spPr>
          <a:xfrm>
            <a:off x="4792373" y="6598102"/>
            <a:ext cx="562975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/>
              <a:t>PEP-CTERM</a:t>
            </a:r>
          </a:p>
        </p:txBody>
      </p:sp>
      <p:sp>
        <p:nvSpPr>
          <p:cNvPr id="294" name="CuadroTexto 145">
            <a:extLst>
              <a:ext uri="{FF2B5EF4-FFF2-40B4-BE49-F238E27FC236}">
                <a16:creationId xmlns:a16="http://schemas.microsoft.com/office/drawing/2014/main" id="{8515EC96-90A5-7F4D-5DF0-580A2C8AF79F}"/>
              </a:ext>
            </a:extLst>
          </p:cNvPr>
          <p:cNvSpPr txBox="1"/>
          <p:nvPr/>
        </p:nvSpPr>
        <p:spPr>
          <a:xfrm>
            <a:off x="4608742" y="6214520"/>
            <a:ext cx="58862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Signal</a:t>
            </a:r>
            <a:r>
              <a:rPr lang="es-ES" sz="500" dirty="0"/>
              <a:t> </a:t>
            </a:r>
            <a:r>
              <a:rPr lang="es-ES" sz="500" dirty="0" err="1"/>
              <a:t>peptide</a:t>
            </a:r>
            <a:endParaRPr lang="es-ES" sz="500" dirty="0"/>
          </a:p>
        </p:txBody>
      </p:sp>
      <p:sp>
        <p:nvSpPr>
          <p:cNvPr id="296" name="Forma libre 161">
            <a:extLst>
              <a:ext uri="{FF2B5EF4-FFF2-40B4-BE49-F238E27FC236}">
                <a16:creationId xmlns:a16="http://schemas.microsoft.com/office/drawing/2014/main" id="{739A13D9-1599-4E17-ADD6-C7440E5E8990}"/>
              </a:ext>
            </a:extLst>
          </p:cNvPr>
          <p:cNvSpPr/>
          <p:nvPr/>
        </p:nvSpPr>
        <p:spPr>
          <a:xfrm>
            <a:off x="1550961" y="4428496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99" name="Grupo 164">
            <a:extLst>
              <a:ext uri="{FF2B5EF4-FFF2-40B4-BE49-F238E27FC236}">
                <a16:creationId xmlns:a16="http://schemas.microsoft.com/office/drawing/2014/main" id="{58EA62C5-4A3B-27E8-C1E8-4F1415409E6F}"/>
              </a:ext>
            </a:extLst>
          </p:cNvPr>
          <p:cNvGrpSpPr/>
          <p:nvPr/>
        </p:nvGrpSpPr>
        <p:grpSpPr>
          <a:xfrm>
            <a:off x="2362371" y="4366268"/>
            <a:ext cx="184093" cy="220827"/>
            <a:chOff x="3564469" y="5197645"/>
            <a:chExt cx="184093" cy="220827"/>
          </a:xfrm>
        </p:grpSpPr>
        <p:sp>
          <p:nvSpPr>
            <p:cNvPr id="300" name="Forma libre 165">
              <a:extLst>
                <a:ext uri="{FF2B5EF4-FFF2-40B4-BE49-F238E27FC236}">
                  <a16:creationId xmlns:a16="http://schemas.microsoft.com/office/drawing/2014/main" id="{0097CA87-E2B7-D680-E241-A1B974D4AC1C}"/>
                </a:ext>
              </a:extLst>
            </p:cNvPr>
            <p:cNvSpPr/>
            <p:nvPr/>
          </p:nvSpPr>
          <p:spPr>
            <a:xfrm>
              <a:off x="3564469" y="5197645"/>
              <a:ext cx="184093" cy="220827"/>
            </a:xfrm>
            <a:custGeom>
              <a:avLst/>
              <a:gdLst>
                <a:gd name="connsiteX0" fmla="*/ 234987 w 535666"/>
                <a:gd name="connsiteY0" fmla="*/ 0 h 642553"/>
                <a:gd name="connsiteX1" fmla="*/ 193580 w 535666"/>
                <a:gd name="connsiteY1" fmla="*/ 62110 h 642553"/>
                <a:gd name="connsiteX2" fmla="*/ 131470 w 535666"/>
                <a:gd name="connsiteY2" fmla="*/ 72462 h 642553"/>
                <a:gd name="connsiteX3" fmla="*/ 38305 w 535666"/>
                <a:gd name="connsiteY3" fmla="*/ 131121 h 642553"/>
                <a:gd name="connsiteX4" fmla="*/ 72810 w 535666"/>
                <a:gd name="connsiteY4" fmla="*/ 210484 h 642553"/>
                <a:gd name="connsiteX5" fmla="*/ 134921 w 535666"/>
                <a:gd name="connsiteY5" fmla="*/ 200133 h 642553"/>
                <a:gd name="connsiteX6" fmla="*/ 162525 w 535666"/>
                <a:gd name="connsiteY6" fmla="*/ 296748 h 642553"/>
                <a:gd name="connsiteX7" fmla="*/ 269493 w 535666"/>
                <a:gd name="connsiteY7" fmla="*/ 334705 h 642553"/>
                <a:gd name="connsiteX8" fmla="*/ 276394 w 535666"/>
                <a:gd name="connsiteY8" fmla="*/ 207034 h 642553"/>
                <a:gd name="connsiteX9" fmla="*/ 417867 w 535666"/>
                <a:gd name="connsiteY9" fmla="*/ 131121 h 642553"/>
                <a:gd name="connsiteX10" fmla="*/ 535186 w 535666"/>
                <a:gd name="connsiteY10" fmla="*/ 320902 h 642553"/>
                <a:gd name="connsiteX11" fmla="*/ 373010 w 535666"/>
                <a:gd name="connsiteY11" fmla="*/ 431320 h 642553"/>
                <a:gd name="connsiteX12" fmla="*/ 407515 w 535666"/>
                <a:gd name="connsiteY12" fmla="*/ 617651 h 642553"/>
                <a:gd name="connsiteX13" fmla="*/ 110767 w 535666"/>
                <a:gd name="connsiteY13" fmla="*/ 628003 h 642553"/>
                <a:gd name="connsiteX14" fmla="*/ 197031 w 535666"/>
                <a:gd name="connsiteY14" fmla="*/ 500332 h 642553"/>
                <a:gd name="connsiteX15" fmla="*/ 3799 w 535666"/>
                <a:gd name="connsiteY15" fmla="*/ 348507 h 642553"/>
                <a:gd name="connsiteX16" fmla="*/ 65909 w 535666"/>
                <a:gd name="connsiteY16" fmla="*/ 213935 h 642553"/>
                <a:gd name="connsiteX17" fmla="*/ 31404 w 535666"/>
                <a:gd name="connsiteY17" fmla="*/ 138022 h 642553"/>
                <a:gd name="connsiteX18" fmla="*/ 134921 w 535666"/>
                <a:gd name="connsiteY18" fmla="*/ 72462 h 642553"/>
                <a:gd name="connsiteX19" fmla="*/ 207383 w 535666"/>
                <a:gd name="connsiteY19" fmla="*/ 62110 h 642553"/>
                <a:gd name="connsiteX20" fmla="*/ 234987 w 535666"/>
                <a:gd name="connsiteY20" fmla="*/ 0 h 6425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535666" h="642553">
                  <a:moveTo>
                    <a:pt x="234987" y="0"/>
                  </a:moveTo>
                  <a:cubicBezTo>
                    <a:pt x="232687" y="0"/>
                    <a:pt x="210833" y="50033"/>
                    <a:pt x="193580" y="62110"/>
                  </a:cubicBezTo>
                  <a:cubicBezTo>
                    <a:pt x="176327" y="74187"/>
                    <a:pt x="157349" y="60960"/>
                    <a:pt x="131470" y="72462"/>
                  </a:cubicBezTo>
                  <a:cubicBezTo>
                    <a:pt x="105591" y="83964"/>
                    <a:pt x="48082" y="108117"/>
                    <a:pt x="38305" y="131121"/>
                  </a:cubicBezTo>
                  <a:cubicBezTo>
                    <a:pt x="28528" y="154125"/>
                    <a:pt x="56707" y="198982"/>
                    <a:pt x="72810" y="210484"/>
                  </a:cubicBezTo>
                  <a:cubicBezTo>
                    <a:pt x="88913" y="221986"/>
                    <a:pt x="119969" y="185756"/>
                    <a:pt x="134921" y="200133"/>
                  </a:cubicBezTo>
                  <a:cubicBezTo>
                    <a:pt x="149873" y="214510"/>
                    <a:pt x="140096" y="274319"/>
                    <a:pt x="162525" y="296748"/>
                  </a:cubicBezTo>
                  <a:cubicBezTo>
                    <a:pt x="184954" y="319177"/>
                    <a:pt x="250515" y="349657"/>
                    <a:pt x="269493" y="334705"/>
                  </a:cubicBezTo>
                  <a:cubicBezTo>
                    <a:pt x="288471" y="319753"/>
                    <a:pt x="251665" y="240965"/>
                    <a:pt x="276394" y="207034"/>
                  </a:cubicBezTo>
                  <a:cubicBezTo>
                    <a:pt x="301123" y="173103"/>
                    <a:pt x="374735" y="112143"/>
                    <a:pt x="417867" y="131121"/>
                  </a:cubicBezTo>
                  <a:cubicBezTo>
                    <a:pt x="460999" y="150099"/>
                    <a:pt x="542662" y="270869"/>
                    <a:pt x="535186" y="320902"/>
                  </a:cubicBezTo>
                  <a:cubicBezTo>
                    <a:pt x="527710" y="370935"/>
                    <a:pt x="394288" y="381862"/>
                    <a:pt x="373010" y="431320"/>
                  </a:cubicBezTo>
                  <a:cubicBezTo>
                    <a:pt x="351732" y="480778"/>
                    <a:pt x="451222" y="584870"/>
                    <a:pt x="407515" y="617651"/>
                  </a:cubicBezTo>
                  <a:cubicBezTo>
                    <a:pt x="363808" y="650432"/>
                    <a:pt x="145848" y="647556"/>
                    <a:pt x="110767" y="628003"/>
                  </a:cubicBezTo>
                  <a:cubicBezTo>
                    <a:pt x="75686" y="608450"/>
                    <a:pt x="214859" y="546915"/>
                    <a:pt x="197031" y="500332"/>
                  </a:cubicBezTo>
                  <a:cubicBezTo>
                    <a:pt x="179203" y="453749"/>
                    <a:pt x="25653" y="396240"/>
                    <a:pt x="3799" y="348507"/>
                  </a:cubicBezTo>
                  <a:cubicBezTo>
                    <a:pt x="-18055" y="300774"/>
                    <a:pt x="61308" y="249016"/>
                    <a:pt x="65909" y="213935"/>
                  </a:cubicBezTo>
                  <a:cubicBezTo>
                    <a:pt x="70510" y="178854"/>
                    <a:pt x="19902" y="161601"/>
                    <a:pt x="31404" y="138022"/>
                  </a:cubicBezTo>
                  <a:cubicBezTo>
                    <a:pt x="42906" y="114443"/>
                    <a:pt x="105591" y="85114"/>
                    <a:pt x="134921" y="72462"/>
                  </a:cubicBezTo>
                  <a:cubicBezTo>
                    <a:pt x="164251" y="59810"/>
                    <a:pt x="191281" y="71887"/>
                    <a:pt x="207383" y="62110"/>
                  </a:cubicBezTo>
                  <a:cubicBezTo>
                    <a:pt x="223485" y="52333"/>
                    <a:pt x="237287" y="0"/>
                    <a:pt x="234987" y="0"/>
                  </a:cubicBezTo>
                  <a:close/>
                </a:path>
              </a:pathLst>
            </a:custGeom>
            <a:gradFill flip="none" rotWithShape="1">
              <a:gsLst>
                <a:gs pos="0">
                  <a:srgbClr val="780000"/>
                </a:gs>
                <a:gs pos="60000">
                  <a:srgbClr val="C00000"/>
                </a:gs>
                <a:gs pos="100000">
                  <a:srgbClr val="C00000">
                    <a:tint val="23500"/>
                    <a:satMod val="160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01" name="Oval 84">
              <a:extLst>
                <a:ext uri="{FF2B5EF4-FFF2-40B4-BE49-F238E27FC236}">
                  <a16:creationId xmlns:a16="http://schemas.microsoft.com/office/drawing/2014/main" id="{576547EE-6F8B-1BA4-8D59-1BFF5EC1255D}"/>
                </a:ext>
              </a:extLst>
            </p:cNvPr>
            <p:cNvSpPr/>
            <p:nvPr/>
          </p:nvSpPr>
          <p:spPr>
            <a:xfrm flipH="1">
              <a:off x="3618773" y="524839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</p:grpSp>
      <p:sp>
        <p:nvSpPr>
          <p:cNvPr id="303" name="Forma libre 169">
            <a:extLst>
              <a:ext uri="{FF2B5EF4-FFF2-40B4-BE49-F238E27FC236}">
                <a16:creationId xmlns:a16="http://schemas.microsoft.com/office/drawing/2014/main" id="{0E555C5F-EC0E-B29E-A826-015F82C48725}"/>
              </a:ext>
            </a:extLst>
          </p:cNvPr>
          <p:cNvSpPr/>
          <p:nvPr/>
        </p:nvSpPr>
        <p:spPr>
          <a:xfrm>
            <a:off x="3041999" y="4200537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6" name="Forma libre 173">
            <a:extLst>
              <a:ext uri="{FF2B5EF4-FFF2-40B4-BE49-F238E27FC236}">
                <a16:creationId xmlns:a16="http://schemas.microsoft.com/office/drawing/2014/main" id="{2989890C-EA31-268C-11F5-562426F4302B}"/>
              </a:ext>
            </a:extLst>
          </p:cNvPr>
          <p:cNvSpPr/>
          <p:nvPr/>
        </p:nvSpPr>
        <p:spPr>
          <a:xfrm>
            <a:off x="3957446" y="4480094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310" name="Conector recto de flecha 38">
            <a:extLst>
              <a:ext uri="{FF2B5EF4-FFF2-40B4-BE49-F238E27FC236}">
                <a16:creationId xmlns:a16="http://schemas.microsoft.com/office/drawing/2014/main" id="{9B93BD79-ECCF-2427-9B6C-B24C577B7CF1}"/>
              </a:ext>
            </a:extLst>
          </p:cNvPr>
          <p:cNvCxnSpPr/>
          <p:nvPr/>
        </p:nvCxnSpPr>
        <p:spPr>
          <a:xfrm>
            <a:off x="3874227" y="6418595"/>
            <a:ext cx="677627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1" name="CuadroTexto 198">
            <a:extLst>
              <a:ext uri="{FF2B5EF4-FFF2-40B4-BE49-F238E27FC236}">
                <a16:creationId xmlns:a16="http://schemas.microsoft.com/office/drawing/2014/main" id="{5AF7E076-8E11-C084-A5A0-5979BC683605}"/>
              </a:ext>
            </a:extLst>
          </p:cNvPr>
          <p:cNvSpPr txBox="1"/>
          <p:nvPr/>
        </p:nvSpPr>
        <p:spPr>
          <a:xfrm>
            <a:off x="4070366" y="4586774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312" name="CuadroTexto 199">
            <a:extLst>
              <a:ext uri="{FF2B5EF4-FFF2-40B4-BE49-F238E27FC236}">
                <a16:creationId xmlns:a16="http://schemas.microsoft.com/office/drawing/2014/main" id="{1A6267DC-965F-5CE5-B7A8-FF1530AD8D6F}"/>
              </a:ext>
            </a:extLst>
          </p:cNvPr>
          <p:cNvSpPr txBox="1"/>
          <p:nvPr/>
        </p:nvSpPr>
        <p:spPr>
          <a:xfrm>
            <a:off x="3136103" y="4294194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313" name="CuadroTexto 200">
            <a:extLst>
              <a:ext uri="{FF2B5EF4-FFF2-40B4-BE49-F238E27FC236}">
                <a16:creationId xmlns:a16="http://schemas.microsoft.com/office/drawing/2014/main" id="{CF6C4D8F-8CC2-BF5C-41D9-58A106A13A11}"/>
              </a:ext>
            </a:extLst>
          </p:cNvPr>
          <p:cNvSpPr txBox="1"/>
          <p:nvPr/>
        </p:nvSpPr>
        <p:spPr>
          <a:xfrm>
            <a:off x="2444757" y="4439482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314" name="CuadroTexto 201">
            <a:extLst>
              <a:ext uri="{FF2B5EF4-FFF2-40B4-BE49-F238E27FC236}">
                <a16:creationId xmlns:a16="http://schemas.microsoft.com/office/drawing/2014/main" id="{83D882CA-6221-BB15-7898-DB45A31C3236}"/>
              </a:ext>
            </a:extLst>
          </p:cNvPr>
          <p:cNvSpPr txBox="1"/>
          <p:nvPr/>
        </p:nvSpPr>
        <p:spPr>
          <a:xfrm>
            <a:off x="1625582" y="4526056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cxnSp>
        <p:nvCxnSpPr>
          <p:cNvPr id="315" name="Conector recto de flecha 202">
            <a:extLst>
              <a:ext uri="{FF2B5EF4-FFF2-40B4-BE49-F238E27FC236}">
                <a16:creationId xmlns:a16="http://schemas.microsoft.com/office/drawing/2014/main" id="{243EC877-DA3A-3AC9-522B-CE6A867110B6}"/>
              </a:ext>
            </a:extLst>
          </p:cNvPr>
          <p:cNvCxnSpPr>
            <a:cxnSpLocks/>
          </p:cNvCxnSpPr>
          <p:nvPr/>
        </p:nvCxnSpPr>
        <p:spPr>
          <a:xfrm flipH="1">
            <a:off x="2302721" y="4596525"/>
            <a:ext cx="90403" cy="369708"/>
          </a:xfrm>
          <a:prstGeom prst="straightConnector1">
            <a:avLst/>
          </a:prstGeom>
          <a:ln w="3175">
            <a:solidFill>
              <a:schemeClr val="tx1"/>
            </a:solidFill>
            <a:prstDash val="lgDash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Conector recto de flecha 204">
            <a:extLst>
              <a:ext uri="{FF2B5EF4-FFF2-40B4-BE49-F238E27FC236}">
                <a16:creationId xmlns:a16="http://schemas.microsoft.com/office/drawing/2014/main" id="{368873F4-C113-5785-5986-7BE52685995B}"/>
              </a:ext>
            </a:extLst>
          </p:cNvPr>
          <p:cNvCxnSpPr>
            <a:cxnSpLocks/>
            <a:stCxn id="358" idx="0"/>
          </p:cNvCxnSpPr>
          <p:nvPr/>
        </p:nvCxnSpPr>
        <p:spPr>
          <a:xfrm flipH="1">
            <a:off x="2275193" y="5029513"/>
            <a:ext cx="3886" cy="265867"/>
          </a:xfrm>
          <a:prstGeom prst="straightConnector1">
            <a:avLst/>
          </a:prstGeom>
          <a:ln w="3175">
            <a:solidFill>
              <a:schemeClr val="tx1"/>
            </a:solidFill>
            <a:prstDash val="lgDash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7" name="CuadroTexto 120">
            <a:extLst>
              <a:ext uri="{FF2B5EF4-FFF2-40B4-BE49-F238E27FC236}">
                <a16:creationId xmlns:a16="http://schemas.microsoft.com/office/drawing/2014/main" id="{49578F66-2574-ADA7-02F0-5CDFC6F50308}"/>
              </a:ext>
            </a:extLst>
          </p:cNvPr>
          <p:cNvSpPr txBox="1"/>
          <p:nvPr/>
        </p:nvSpPr>
        <p:spPr>
          <a:xfrm>
            <a:off x="4223035" y="5321556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318" name="Forma libre 5">
            <a:extLst>
              <a:ext uri="{FF2B5EF4-FFF2-40B4-BE49-F238E27FC236}">
                <a16:creationId xmlns:a16="http://schemas.microsoft.com/office/drawing/2014/main" id="{A29D63FF-591F-1A1D-155B-6DA9C415BE6C}"/>
              </a:ext>
            </a:extLst>
          </p:cNvPr>
          <p:cNvSpPr/>
          <p:nvPr/>
        </p:nvSpPr>
        <p:spPr>
          <a:xfrm>
            <a:off x="4290782" y="5118428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319" name="Grupo 151">
            <a:extLst>
              <a:ext uri="{FF2B5EF4-FFF2-40B4-BE49-F238E27FC236}">
                <a16:creationId xmlns:a16="http://schemas.microsoft.com/office/drawing/2014/main" id="{9C6F03FC-A5E7-8C57-C5BE-D49C72B58215}"/>
              </a:ext>
            </a:extLst>
          </p:cNvPr>
          <p:cNvGrpSpPr/>
          <p:nvPr/>
        </p:nvGrpSpPr>
        <p:grpSpPr>
          <a:xfrm rot="15550455">
            <a:off x="3794117" y="5784412"/>
            <a:ext cx="114758" cy="152400"/>
            <a:chOff x="3021023" y="4132290"/>
            <a:chExt cx="205948" cy="358859"/>
          </a:xfrm>
        </p:grpSpPr>
        <p:sp>
          <p:nvSpPr>
            <p:cNvPr id="320" name="Forma libre 158">
              <a:extLst>
                <a:ext uri="{FF2B5EF4-FFF2-40B4-BE49-F238E27FC236}">
                  <a16:creationId xmlns:a16="http://schemas.microsoft.com/office/drawing/2014/main" id="{D713A3BC-E670-F1F7-D4DE-9556887F8FF3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00FDFF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21" name="Forma libre 159">
              <a:extLst>
                <a:ext uri="{FF2B5EF4-FFF2-40B4-BE49-F238E27FC236}">
                  <a16:creationId xmlns:a16="http://schemas.microsoft.com/office/drawing/2014/main" id="{D50534C6-EE97-D4E2-8E7B-092A98394A45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00FD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322" name="Grupo 152">
            <a:extLst>
              <a:ext uri="{FF2B5EF4-FFF2-40B4-BE49-F238E27FC236}">
                <a16:creationId xmlns:a16="http://schemas.microsoft.com/office/drawing/2014/main" id="{E0A52097-B4E2-36EB-CD24-104A53B82DB8}"/>
              </a:ext>
            </a:extLst>
          </p:cNvPr>
          <p:cNvGrpSpPr/>
          <p:nvPr/>
        </p:nvGrpSpPr>
        <p:grpSpPr>
          <a:xfrm rot="20667263">
            <a:off x="3707023" y="5445128"/>
            <a:ext cx="205948" cy="358859"/>
            <a:chOff x="3021023" y="4132290"/>
            <a:chExt cx="205948" cy="358859"/>
          </a:xfrm>
        </p:grpSpPr>
        <p:sp>
          <p:nvSpPr>
            <p:cNvPr id="323" name="Forma libre 156">
              <a:extLst>
                <a:ext uri="{FF2B5EF4-FFF2-40B4-BE49-F238E27FC236}">
                  <a16:creationId xmlns:a16="http://schemas.microsoft.com/office/drawing/2014/main" id="{B59319F6-4B6C-65D5-BFF7-DADEF3E59C72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C0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24" name="Forma libre 157">
              <a:extLst>
                <a:ext uri="{FF2B5EF4-FFF2-40B4-BE49-F238E27FC236}">
                  <a16:creationId xmlns:a16="http://schemas.microsoft.com/office/drawing/2014/main" id="{311779B7-A179-F8C4-EC31-07CD88303082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325" name="Grupo 29">
            <a:extLst>
              <a:ext uri="{FF2B5EF4-FFF2-40B4-BE49-F238E27FC236}">
                <a16:creationId xmlns:a16="http://schemas.microsoft.com/office/drawing/2014/main" id="{87C8ADF8-C223-4E20-3647-C712C31BCECA}"/>
              </a:ext>
            </a:extLst>
          </p:cNvPr>
          <p:cNvGrpSpPr/>
          <p:nvPr/>
        </p:nvGrpSpPr>
        <p:grpSpPr>
          <a:xfrm>
            <a:off x="3326620" y="5537712"/>
            <a:ext cx="1030393" cy="236059"/>
            <a:chOff x="3245881" y="2431599"/>
            <a:chExt cx="1030393" cy="236059"/>
          </a:xfrm>
        </p:grpSpPr>
        <p:sp>
          <p:nvSpPr>
            <p:cNvPr id="326" name="Elipse 26">
              <a:extLst>
                <a:ext uri="{FF2B5EF4-FFF2-40B4-BE49-F238E27FC236}">
                  <a16:creationId xmlns:a16="http://schemas.microsoft.com/office/drawing/2014/main" id="{D60285EE-8C74-C400-2800-F528DC21AC81}"/>
                </a:ext>
              </a:extLst>
            </p:cNvPr>
            <p:cNvSpPr/>
            <p:nvPr/>
          </p:nvSpPr>
          <p:spPr>
            <a:xfrm>
              <a:off x="3629228" y="2431599"/>
              <a:ext cx="85411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27" name="Elipse 147">
              <a:extLst>
                <a:ext uri="{FF2B5EF4-FFF2-40B4-BE49-F238E27FC236}">
                  <a16:creationId xmlns:a16="http://schemas.microsoft.com/office/drawing/2014/main" id="{A55F8C23-2D92-62E4-9B91-7AC6DAE7E894}"/>
                </a:ext>
              </a:extLst>
            </p:cNvPr>
            <p:cNvSpPr/>
            <p:nvPr/>
          </p:nvSpPr>
          <p:spPr>
            <a:xfrm>
              <a:off x="3765559" y="2431599"/>
              <a:ext cx="61984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28" name="Elipse 146">
              <a:extLst>
                <a:ext uri="{FF2B5EF4-FFF2-40B4-BE49-F238E27FC236}">
                  <a16:creationId xmlns:a16="http://schemas.microsoft.com/office/drawing/2014/main" id="{0512D987-359C-2E08-C088-935C72994343}"/>
                </a:ext>
              </a:extLst>
            </p:cNvPr>
            <p:cNvSpPr/>
            <p:nvPr/>
          </p:nvSpPr>
          <p:spPr>
            <a:xfrm>
              <a:off x="3711139" y="2431599"/>
              <a:ext cx="85411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29" name="Rectángulo redondeado 27">
              <a:extLst>
                <a:ext uri="{FF2B5EF4-FFF2-40B4-BE49-F238E27FC236}">
                  <a16:creationId xmlns:a16="http://schemas.microsoft.com/office/drawing/2014/main" id="{F69080EF-0672-62BF-04D9-874D2C1B8C4B}"/>
                </a:ext>
              </a:extLst>
            </p:cNvPr>
            <p:cNvSpPr/>
            <p:nvPr/>
          </p:nvSpPr>
          <p:spPr>
            <a:xfrm>
              <a:off x="3522325" y="2431599"/>
              <a:ext cx="99627" cy="187822"/>
            </a:xfrm>
            <a:prstGeom prst="round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30" name="CuadroTexto 148">
              <a:extLst>
                <a:ext uri="{FF2B5EF4-FFF2-40B4-BE49-F238E27FC236}">
                  <a16:creationId xmlns:a16="http://schemas.microsoft.com/office/drawing/2014/main" id="{1550F4A2-5FD1-78FC-7EE8-D140CAACAE24}"/>
                </a:ext>
              </a:extLst>
            </p:cNvPr>
            <p:cNvSpPr txBox="1"/>
            <p:nvPr/>
          </p:nvSpPr>
          <p:spPr>
            <a:xfrm>
              <a:off x="3245881" y="2496268"/>
              <a:ext cx="34176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 err="1"/>
                <a:t>EpsH</a:t>
              </a:r>
              <a:endParaRPr lang="es-ES" sz="500" dirty="0"/>
            </a:p>
          </p:txBody>
        </p:sp>
        <p:sp>
          <p:nvSpPr>
            <p:cNvPr id="331" name="CuadroTexto 149">
              <a:extLst>
                <a:ext uri="{FF2B5EF4-FFF2-40B4-BE49-F238E27FC236}">
                  <a16:creationId xmlns:a16="http://schemas.microsoft.com/office/drawing/2014/main" id="{062A2422-9722-0BB0-26EB-C7F71E5A3635}"/>
                </a:ext>
              </a:extLst>
            </p:cNvPr>
            <p:cNvSpPr txBox="1"/>
            <p:nvPr/>
          </p:nvSpPr>
          <p:spPr>
            <a:xfrm>
              <a:off x="3761389" y="2498381"/>
              <a:ext cx="51488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 err="1"/>
                <a:t>Sec</a:t>
              </a:r>
              <a:r>
                <a:rPr lang="es-ES" sz="500" dirty="0"/>
                <a:t> </a:t>
              </a:r>
              <a:r>
                <a:rPr lang="es-ES" sz="500" dirty="0" err="1"/>
                <a:t>system</a:t>
              </a:r>
              <a:endParaRPr lang="es-ES" sz="500" dirty="0"/>
            </a:p>
          </p:txBody>
        </p:sp>
      </p:grpSp>
      <p:grpSp>
        <p:nvGrpSpPr>
          <p:cNvPr id="332" name="Grupo 33">
            <a:extLst>
              <a:ext uri="{FF2B5EF4-FFF2-40B4-BE49-F238E27FC236}">
                <a16:creationId xmlns:a16="http://schemas.microsoft.com/office/drawing/2014/main" id="{ECA0707C-925E-A630-2900-842102D2D779}"/>
              </a:ext>
            </a:extLst>
          </p:cNvPr>
          <p:cNvGrpSpPr/>
          <p:nvPr/>
        </p:nvGrpSpPr>
        <p:grpSpPr>
          <a:xfrm>
            <a:off x="2168093" y="5550873"/>
            <a:ext cx="231480" cy="256180"/>
            <a:chOff x="2087354" y="2444760"/>
            <a:chExt cx="231480" cy="256180"/>
          </a:xfrm>
        </p:grpSpPr>
        <p:grpSp>
          <p:nvGrpSpPr>
            <p:cNvPr id="333" name="Grupo 32">
              <a:extLst>
                <a:ext uri="{FF2B5EF4-FFF2-40B4-BE49-F238E27FC236}">
                  <a16:creationId xmlns:a16="http://schemas.microsoft.com/office/drawing/2014/main" id="{27F1A417-090C-BED9-64B3-8E5327F45140}"/>
                </a:ext>
              </a:extLst>
            </p:cNvPr>
            <p:cNvGrpSpPr/>
            <p:nvPr/>
          </p:nvGrpSpPr>
          <p:grpSpPr>
            <a:xfrm>
              <a:off x="2087354" y="2444760"/>
              <a:ext cx="231480" cy="161640"/>
              <a:chOff x="2089080" y="2444760"/>
              <a:chExt cx="231480" cy="161640"/>
            </a:xfrm>
          </p:grpSpPr>
          <p:sp>
            <p:nvSpPr>
              <p:cNvPr id="337" name="Rounded Rectangle 131">
                <a:extLst>
                  <a:ext uri="{FF2B5EF4-FFF2-40B4-BE49-F238E27FC236}">
                    <a16:creationId xmlns:a16="http://schemas.microsoft.com/office/drawing/2014/main" id="{4D29AB83-388A-0686-15C9-831A5B3B860C}"/>
                  </a:ext>
                </a:extLst>
              </p:cNvPr>
              <p:cNvSpPr/>
              <p:nvPr/>
            </p:nvSpPr>
            <p:spPr>
              <a:xfrm>
                <a:off x="2089080" y="2444760"/>
                <a:ext cx="117000" cy="161640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338" name="Rounded Rectangle 132">
                <a:extLst>
                  <a:ext uri="{FF2B5EF4-FFF2-40B4-BE49-F238E27FC236}">
                    <a16:creationId xmlns:a16="http://schemas.microsoft.com/office/drawing/2014/main" id="{C8CBAE15-C558-DBD1-660A-3B166E9A11B2}"/>
                  </a:ext>
                </a:extLst>
              </p:cNvPr>
              <p:cNvSpPr/>
              <p:nvPr/>
            </p:nvSpPr>
            <p:spPr>
              <a:xfrm>
                <a:off x="2203560" y="2444760"/>
                <a:ext cx="117000" cy="161640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  <p:grpSp>
          <p:nvGrpSpPr>
            <p:cNvPr id="334" name="Grupo 31">
              <a:extLst>
                <a:ext uri="{FF2B5EF4-FFF2-40B4-BE49-F238E27FC236}">
                  <a16:creationId xmlns:a16="http://schemas.microsoft.com/office/drawing/2014/main" id="{8B89EDAE-C3E9-DDA3-FD93-43A9D255B4D7}"/>
                </a:ext>
              </a:extLst>
            </p:cNvPr>
            <p:cNvGrpSpPr/>
            <p:nvPr/>
          </p:nvGrpSpPr>
          <p:grpSpPr>
            <a:xfrm>
              <a:off x="2087354" y="2614271"/>
              <a:ext cx="231480" cy="86669"/>
              <a:chOff x="2085629" y="2614271"/>
              <a:chExt cx="231480" cy="86669"/>
            </a:xfrm>
          </p:grpSpPr>
          <p:sp>
            <p:nvSpPr>
              <p:cNvPr id="335" name="Rounded Rectangle 131">
                <a:extLst>
                  <a:ext uri="{FF2B5EF4-FFF2-40B4-BE49-F238E27FC236}">
                    <a16:creationId xmlns:a16="http://schemas.microsoft.com/office/drawing/2014/main" id="{A14F3ABB-ECC9-0995-7343-511545C4C848}"/>
                  </a:ext>
                </a:extLst>
              </p:cNvPr>
              <p:cNvSpPr/>
              <p:nvPr/>
            </p:nvSpPr>
            <p:spPr>
              <a:xfrm>
                <a:off x="2085629" y="2614271"/>
                <a:ext cx="117000" cy="86669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336" name="Rounded Rectangle 132">
                <a:extLst>
                  <a:ext uri="{FF2B5EF4-FFF2-40B4-BE49-F238E27FC236}">
                    <a16:creationId xmlns:a16="http://schemas.microsoft.com/office/drawing/2014/main" id="{A21409B3-5570-A322-128E-C6C5EF108CB1}"/>
                  </a:ext>
                </a:extLst>
              </p:cNvPr>
              <p:cNvSpPr/>
              <p:nvPr/>
            </p:nvSpPr>
            <p:spPr>
              <a:xfrm>
                <a:off x="2200109" y="2614271"/>
                <a:ext cx="117000" cy="86669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</p:grpSp>
      <p:sp>
        <p:nvSpPr>
          <p:cNvPr id="339" name="CuadroTexto 34">
            <a:extLst>
              <a:ext uri="{FF2B5EF4-FFF2-40B4-BE49-F238E27FC236}">
                <a16:creationId xmlns:a16="http://schemas.microsoft.com/office/drawing/2014/main" id="{61405431-C9A5-3DAD-48FA-DB452A0178BC}"/>
              </a:ext>
            </a:extLst>
          </p:cNvPr>
          <p:cNvSpPr txBox="1"/>
          <p:nvPr/>
        </p:nvSpPr>
        <p:spPr>
          <a:xfrm>
            <a:off x="1909698" y="5608530"/>
            <a:ext cx="3369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B</a:t>
            </a:r>
            <a:endParaRPr lang="es-ES" sz="500" dirty="0"/>
          </a:p>
        </p:txBody>
      </p:sp>
      <p:sp>
        <p:nvSpPr>
          <p:cNvPr id="340" name="CuadroTexto 182">
            <a:extLst>
              <a:ext uri="{FF2B5EF4-FFF2-40B4-BE49-F238E27FC236}">
                <a16:creationId xmlns:a16="http://schemas.microsoft.com/office/drawing/2014/main" id="{575FC129-E4D2-D910-C821-E24BF3B542C9}"/>
              </a:ext>
            </a:extLst>
          </p:cNvPr>
          <p:cNvSpPr txBox="1"/>
          <p:nvPr/>
        </p:nvSpPr>
        <p:spPr>
          <a:xfrm>
            <a:off x="1906492" y="5705157"/>
            <a:ext cx="3401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C</a:t>
            </a:r>
            <a:endParaRPr lang="es-ES" sz="500" dirty="0"/>
          </a:p>
        </p:txBody>
      </p:sp>
      <p:sp>
        <p:nvSpPr>
          <p:cNvPr id="341" name="Elipse 35">
            <a:extLst>
              <a:ext uri="{FF2B5EF4-FFF2-40B4-BE49-F238E27FC236}">
                <a16:creationId xmlns:a16="http://schemas.microsoft.com/office/drawing/2014/main" id="{9524FCA3-1185-6F96-1ED1-817B6A1ECD59}"/>
              </a:ext>
            </a:extLst>
          </p:cNvPr>
          <p:cNvSpPr/>
          <p:nvPr/>
        </p:nvSpPr>
        <p:spPr>
          <a:xfrm>
            <a:off x="1774797" y="5388881"/>
            <a:ext cx="168040" cy="93541"/>
          </a:xfrm>
          <a:prstGeom prst="ellipse">
            <a:avLst/>
          </a:prstGeom>
          <a:solidFill>
            <a:srgbClr val="FF7E79"/>
          </a:solidFill>
          <a:ln w="12700">
            <a:solidFill>
              <a:srgbClr val="B41A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2" name="CuadroTexto 183">
            <a:extLst>
              <a:ext uri="{FF2B5EF4-FFF2-40B4-BE49-F238E27FC236}">
                <a16:creationId xmlns:a16="http://schemas.microsoft.com/office/drawing/2014/main" id="{A87522F9-8C9A-BF7D-B264-ACF42C765C12}"/>
              </a:ext>
            </a:extLst>
          </p:cNvPr>
          <p:cNvSpPr txBox="1"/>
          <p:nvPr/>
        </p:nvSpPr>
        <p:spPr>
          <a:xfrm>
            <a:off x="1498934" y="5345320"/>
            <a:ext cx="3369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A</a:t>
            </a:r>
            <a:endParaRPr lang="es-ES" sz="500" dirty="0"/>
          </a:p>
        </p:txBody>
      </p:sp>
      <p:grpSp>
        <p:nvGrpSpPr>
          <p:cNvPr id="343" name="Grupo 191">
            <a:extLst>
              <a:ext uri="{FF2B5EF4-FFF2-40B4-BE49-F238E27FC236}">
                <a16:creationId xmlns:a16="http://schemas.microsoft.com/office/drawing/2014/main" id="{FE3E538D-44FC-F6DD-D994-48C140FB4249}"/>
              </a:ext>
            </a:extLst>
          </p:cNvPr>
          <p:cNvGrpSpPr/>
          <p:nvPr/>
        </p:nvGrpSpPr>
        <p:grpSpPr>
          <a:xfrm rot="18457452">
            <a:off x="3888818" y="5375814"/>
            <a:ext cx="131554" cy="154346"/>
            <a:chOff x="4747546" y="4151030"/>
            <a:chExt cx="406143" cy="476509"/>
          </a:xfrm>
        </p:grpSpPr>
        <p:sp>
          <p:nvSpPr>
            <p:cNvPr id="344" name="Franja diagonal 187">
              <a:extLst>
                <a:ext uri="{FF2B5EF4-FFF2-40B4-BE49-F238E27FC236}">
                  <a16:creationId xmlns:a16="http://schemas.microsoft.com/office/drawing/2014/main" id="{2E1A00AA-D83E-2667-F872-C1A702FFA54A}"/>
                </a:ext>
              </a:extLst>
            </p:cNvPr>
            <p:cNvSpPr/>
            <p:nvPr/>
          </p:nvSpPr>
          <p:spPr>
            <a:xfrm rot="17876278">
              <a:off x="4754448" y="4144128"/>
              <a:ext cx="238950" cy="252753"/>
            </a:xfrm>
            <a:prstGeom prst="diagStripe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solidFill>
                  <a:schemeClr val="tx1"/>
                </a:solidFill>
              </a:endParaRPr>
            </a:p>
          </p:txBody>
        </p:sp>
        <p:sp>
          <p:nvSpPr>
            <p:cNvPr id="345" name="Franja diagonal 188">
              <a:extLst>
                <a:ext uri="{FF2B5EF4-FFF2-40B4-BE49-F238E27FC236}">
                  <a16:creationId xmlns:a16="http://schemas.microsoft.com/office/drawing/2014/main" id="{7C3AC0BE-88AD-8F8C-B97D-753E4FE4CDFC}"/>
                </a:ext>
              </a:extLst>
            </p:cNvPr>
            <p:cNvSpPr/>
            <p:nvPr/>
          </p:nvSpPr>
          <p:spPr>
            <a:xfrm rot="3723722" flipH="1">
              <a:off x="4907838" y="4144129"/>
              <a:ext cx="238950" cy="252753"/>
            </a:xfrm>
            <a:prstGeom prst="diagStripe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solidFill>
                  <a:schemeClr val="tx1"/>
                </a:solidFill>
              </a:endParaRPr>
            </a:p>
          </p:txBody>
        </p:sp>
        <p:sp>
          <p:nvSpPr>
            <p:cNvPr id="346" name="Elipse 189">
              <a:extLst>
                <a:ext uri="{FF2B5EF4-FFF2-40B4-BE49-F238E27FC236}">
                  <a16:creationId xmlns:a16="http://schemas.microsoft.com/office/drawing/2014/main" id="{319DABAD-B90E-B844-A9E7-544504E6EC68}"/>
                </a:ext>
              </a:extLst>
            </p:cNvPr>
            <p:cNvSpPr/>
            <p:nvPr/>
          </p:nvSpPr>
          <p:spPr>
            <a:xfrm rot="1495849">
              <a:off x="4816988" y="4428693"/>
              <a:ext cx="113868" cy="198842"/>
            </a:xfrm>
            <a:prstGeom prst="ellipse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47" name="Elipse 190">
              <a:extLst>
                <a:ext uri="{FF2B5EF4-FFF2-40B4-BE49-F238E27FC236}">
                  <a16:creationId xmlns:a16="http://schemas.microsoft.com/office/drawing/2014/main" id="{0FF69984-150A-8F26-D33E-5833EA25D9C2}"/>
                </a:ext>
              </a:extLst>
            </p:cNvPr>
            <p:cNvSpPr/>
            <p:nvPr/>
          </p:nvSpPr>
          <p:spPr>
            <a:xfrm rot="20104151" flipH="1">
              <a:off x="4971222" y="4428694"/>
              <a:ext cx="113868" cy="198845"/>
            </a:xfrm>
            <a:prstGeom prst="ellipse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348" name="Grupo 153">
            <a:extLst>
              <a:ext uri="{FF2B5EF4-FFF2-40B4-BE49-F238E27FC236}">
                <a16:creationId xmlns:a16="http://schemas.microsoft.com/office/drawing/2014/main" id="{1EA56A87-7E49-1B4F-D694-47D4CB2349E3}"/>
              </a:ext>
            </a:extLst>
          </p:cNvPr>
          <p:cNvGrpSpPr/>
          <p:nvPr/>
        </p:nvGrpSpPr>
        <p:grpSpPr>
          <a:xfrm rot="955898">
            <a:off x="3877951" y="5265463"/>
            <a:ext cx="114758" cy="152400"/>
            <a:chOff x="3021023" y="4132290"/>
            <a:chExt cx="205948" cy="358859"/>
          </a:xfrm>
        </p:grpSpPr>
        <p:sp>
          <p:nvSpPr>
            <p:cNvPr id="349" name="Forma libre 154">
              <a:extLst>
                <a:ext uri="{FF2B5EF4-FFF2-40B4-BE49-F238E27FC236}">
                  <a16:creationId xmlns:a16="http://schemas.microsoft.com/office/drawing/2014/main" id="{251A1F51-9493-0F1B-7D97-90860362661C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0070C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50" name="Forma libre 155">
              <a:extLst>
                <a:ext uri="{FF2B5EF4-FFF2-40B4-BE49-F238E27FC236}">
                  <a16:creationId xmlns:a16="http://schemas.microsoft.com/office/drawing/2014/main" id="{F158401D-9AFB-75FE-2774-206362ECEC1C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cxnSp>
        <p:nvCxnSpPr>
          <p:cNvPr id="351" name="Conector recto de flecha 192">
            <a:extLst>
              <a:ext uri="{FF2B5EF4-FFF2-40B4-BE49-F238E27FC236}">
                <a16:creationId xmlns:a16="http://schemas.microsoft.com/office/drawing/2014/main" id="{3408F061-9422-7F8E-B244-05DD207C6DF5}"/>
              </a:ext>
            </a:extLst>
          </p:cNvPr>
          <p:cNvCxnSpPr>
            <a:cxnSpLocks/>
          </p:cNvCxnSpPr>
          <p:nvPr/>
        </p:nvCxnSpPr>
        <p:spPr>
          <a:xfrm flipH="1">
            <a:off x="4510007" y="5266930"/>
            <a:ext cx="392624" cy="0"/>
          </a:xfrm>
          <a:prstGeom prst="straightConnector1">
            <a:avLst/>
          </a:prstGeom>
          <a:ln w="3175">
            <a:solidFill>
              <a:schemeClr val="tx1"/>
            </a:solidFill>
            <a:prstDash val="lgDash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2" name="Oval 84">
            <a:extLst>
              <a:ext uri="{FF2B5EF4-FFF2-40B4-BE49-F238E27FC236}">
                <a16:creationId xmlns:a16="http://schemas.microsoft.com/office/drawing/2014/main" id="{089AC1F4-4955-4559-F196-E3DD2551F648}"/>
              </a:ext>
            </a:extLst>
          </p:cNvPr>
          <p:cNvSpPr/>
          <p:nvPr/>
        </p:nvSpPr>
        <p:spPr>
          <a:xfrm flipH="1">
            <a:off x="2247297" y="5329651"/>
            <a:ext cx="58616" cy="48177"/>
          </a:xfrm>
          <a:prstGeom prst="ellipse">
            <a:avLst/>
          </a:prstGeom>
          <a:solidFill>
            <a:schemeClr val="accent4"/>
          </a:solidFill>
          <a:ln w="12700">
            <a:solidFill>
              <a:srgbClr val="1D315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16200" rIns="90000" bIns="162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353" name="Oval 84">
            <a:extLst>
              <a:ext uri="{FF2B5EF4-FFF2-40B4-BE49-F238E27FC236}">
                <a16:creationId xmlns:a16="http://schemas.microsoft.com/office/drawing/2014/main" id="{9651D322-46FC-0D7E-8E86-F9B3B4F21049}"/>
              </a:ext>
            </a:extLst>
          </p:cNvPr>
          <p:cNvSpPr/>
          <p:nvPr/>
        </p:nvSpPr>
        <p:spPr>
          <a:xfrm flipH="1">
            <a:off x="1780390" y="5364055"/>
            <a:ext cx="58616" cy="48177"/>
          </a:xfrm>
          <a:prstGeom prst="ellipse">
            <a:avLst/>
          </a:prstGeom>
          <a:solidFill>
            <a:schemeClr val="accent4"/>
          </a:solidFill>
          <a:ln w="12700">
            <a:solidFill>
              <a:srgbClr val="1D315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16200" rIns="90000" bIns="162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354" name="Forma libre 208">
            <a:extLst>
              <a:ext uri="{FF2B5EF4-FFF2-40B4-BE49-F238E27FC236}">
                <a16:creationId xmlns:a16="http://schemas.microsoft.com/office/drawing/2014/main" id="{8A7E6690-99DA-651D-21B6-0C860A0FD9FD}"/>
              </a:ext>
            </a:extLst>
          </p:cNvPr>
          <p:cNvSpPr/>
          <p:nvPr/>
        </p:nvSpPr>
        <p:spPr>
          <a:xfrm rot="905009" flipH="1">
            <a:off x="1840992" y="5283928"/>
            <a:ext cx="380473" cy="126014"/>
          </a:xfrm>
          <a:custGeom>
            <a:avLst/>
            <a:gdLst>
              <a:gd name="connsiteX0" fmla="*/ 0 w 386464"/>
              <a:gd name="connsiteY0" fmla="*/ 8695 h 126014"/>
              <a:gd name="connsiteX1" fmla="*/ 213935 w 386464"/>
              <a:gd name="connsiteY1" fmla="*/ 12146 h 126014"/>
              <a:gd name="connsiteX2" fmla="*/ 386464 w 386464"/>
              <a:gd name="connsiteY2" fmla="*/ 126014 h 1260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86464" h="126014">
                <a:moveTo>
                  <a:pt x="0" y="8695"/>
                </a:moveTo>
                <a:cubicBezTo>
                  <a:pt x="74762" y="644"/>
                  <a:pt x="149524" y="-7407"/>
                  <a:pt x="213935" y="12146"/>
                </a:cubicBezTo>
                <a:cubicBezTo>
                  <a:pt x="278346" y="31699"/>
                  <a:pt x="332405" y="78856"/>
                  <a:pt x="386464" y="126014"/>
                </a:cubicBezTo>
              </a:path>
            </a:pathLst>
          </a:custGeom>
          <a:noFill/>
          <a:ln w="0">
            <a:solidFill>
              <a:schemeClr val="tx1"/>
            </a:solidFill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5" name="Forma libre 209">
            <a:extLst>
              <a:ext uri="{FF2B5EF4-FFF2-40B4-BE49-F238E27FC236}">
                <a16:creationId xmlns:a16="http://schemas.microsoft.com/office/drawing/2014/main" id="{3B077D7B-D1F0-BD95-2F8A-14F488557B2E}"/>
              </a:ext>
            </a:extLst>
          </p:cNvPr>
          <p:cNvSpPr/>
          <p:nvPr/>
        </p:nvSpPr>
        <p:spPr>
          <a:xfrm rot="408609">
            <a:off x="1948649" y="5433965"/>
            <a:ext cx="342573" cy="100138"/>
          </a:xfrm>
          <a:custGeom>
            <a:avLst/>
            <a:gdLst>
              <a:gd name="connsiteX0" fmla="*/ 0 w 386464"/>
              <a:gd name="connsiteY0" fmla="*/ 8695 h 126014"/>
              <a:gd name="connsiteX1" fmla="*/ 213935 w 386464"/>
              <a:gd name="connsiteY1" fmla="*/ 12146 h 126014"/>
              <a:gd name="connsiteX2" fmla="*/ 386464 w 386464"/>
              <a:gd name="connsiteY2" fmla="*/ 126014 h 1260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86464" h="126014">
                <a:moveTo>
                  <a:pt x="0" y="8695"/>
                </a:moveTo>
                <a:cubicBezTo>
                  <a:pt x="74762" y="644"/>
                  <a:pt x="149524" y="-7407"/>
                  <a:pt x="213935" y="12146"/>
                </a:cubicBezTo>
                <a:cubicBezTo>
                  <a:pt x="278346" y="31699"/>
                  <a:pt x="332405" y="78856"/>
                  <a:pt x="386464" y="126014"/>
                </a:cubicBezTo>
              </a:path>
            </a:pathLst>
          </a:custGeom>
          <a:noFill/>
          <a:ln w="0">
            <a:solidFill>
              <a:schemeClr val="tx1"/>
            </a:solidFill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356" name="Conector recto de flecha 211">
            <a:extLst>
              <a:ext uri="{FF2B5EF4-FFF2-40B4-BE49-F238E27FC236}">
                <a16:creationId xmlns:a16="http://schemas.microsoft.com/office/drawing/2014/main" id="{5A0D48FE-917F-C2C8-8F6B-105937724CC2}"/>
              </a:ext>
            </a:extLst>
          </p:cNvPr>
          <p:cNvCxnSpPr>
            <a:cxnSpLocks/>
          </p:cNvCxnSpPr>
          <p:nvPr/>
        </p:nvCxnSpPr>
        <p:spPr>
          <a:xfrm flipH="1">
            <a:off x="2277089" y="5714646"/>
            <a:ext cx="3886" cy="265867"/>
          </a:xfrm>
          <a:prstGeom prst="straightConnector1">
            <a:avLst/>
          </a:prstGeom>
          <a:ln w="3175">
            <a:solidFill>
              <a:schemeClr val="tx1"/>
            </a:solidFill>
            <a:prstDash val="soli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7" name="Oval 84">
            <a:extLst>
              <a:ext uri="{FF2B5EF4-FFF2-40B4-BE49-F238E27FC236}">
                <a16:creationId xmlns:a16="http://schemas.microsoft.com/office/drawing/2014/main" id="{5A2CEE7A-F1C4-3BA2-F11F-4EBEB564EA5B}"/>
              </a:ext>
            </a:extLst>
          </p:cNvPr>
          <p:cNvSpPr/>
          <p:nvPr/>
        </p:nvSpPr>
        <p:spPr>
          <a:xfrm flipH="1">
            <a:off x="2254768" y="6004159"/>
            <a:ext cx="58616" cy="48177"/>
          </a:xfrm>
          <a:prstGeom prst="ellipse">
            <a:avLst/>
          </a:prstGeom>
          <a:solidFill>
            <a:schemeClr val="accent4"/>
          </a:solidFill>
          <a:ln w="12700">
            <a:solidFill>
              <a:srgbClr val="1D315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16200" rIns="90000" bIns="162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358" name="Magnetic Disk 130">
            <a:extLst>
              <a:ext uri="{FF2B5EF4-FFF2-40B4-BE49-F238E27FC236}">
                <a16:creationId xmlns:a16="http://schemas.microsoft.com/office/drawing/2014/main" id="{5FBF11EC-9989-BE25-C304-C11FDA210642}"/>
              </a:ext>
            </a:extLst>
          </p:cNvPr>
          <p:cNvSpPr/>
          <p:nvPr/>
        </p:nvSpPr>
        <p:spPr>
          <a:xfrm>
            <a:off x="2185659" y="4969273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chemeClr val="accent6">
                  <a:lumMod val="50000"/>
                  <a:tint val="66000"/>
                  <a:satMod val="160000"/>
                </a:schemeClr>
              </a:gs>
              <a:gs pos="50000">
                <a:schemeClr val="accent6">
                  <a:lumMod val="50000"/>
                  <a:tint val="44500"/>
                  <a:satMod val="160000"/>
                </a:schemeClr>
              </a:gs>
              <a:gs pos="100000">
                <a:schemeClr val="accent6">
                  <a:lumMod val="50000"/>
                  <a:tint val="23500"/>
                  <a:satMod val="160000"/>
                </a:schemeClr>
              </a:gs>
            </a:gsLst>
            <a:lin ang="13500000" scaled="1"/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359" name="Magnetic Disk 130">
            <a:extLst>
              <a:ext uri="{FF2B5EF4-FFF2-40B4-BE49-F238E27FC236}">
                <a16:creationId xmlns:a16="http://schemas.microsoft.com/office/drawing/2014/main" id="{7B0DEB83-59A1-5F20-BDEB-74EACBE28C44}"/>
              </a:ext>
            </a:extLst>
          </p:cNvPr>
          <p:cNvSpPr/>
          <p:nvPr/>
        </p:nvSpPr>
        <p:spPr>
          <a:xfrm>
            <a:off x="2669492" y="4969273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rgbClr val="929000">
                  <a:tint val="66000"/>
                  <a:satMod val="160000"/>
                </a:srgbClr>
              </a:gs>
              <a:gs pos="50000">
                <a:srgbClr val="929000">
                  <a:tint val="44500"/>
                  <a:satMod val="160000"/>
                </a:srgbClr>
              </a:gs>
              <a:gs pos="100000">
                <a:srgbClr val="929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grpSp>
        <p:nvGrpSpPr>
          <p:cNvPr id="360" name="Grupo 151">
            <a:extLst>
              <a:ext uri="{FF2B5EF4-FFF2-40B4-BE49-F238E27FC236}">
                <a16:creationId xmlns:a16="http://schemas.microsoft.com/office/drawing/2014/main" id="{06224716-9B61-3054-A2D4-55E873D9D010}"/>
              </a:ext>
            </a:extLst>
          </p:cNvPr>
          <p:cNvGrpSpPr/>
          <p:nvPr/>
        </p:nvGrpSpPr>
        <p:grpSpPr>
          <a:xfrm rot="17016916">
            <a:off x="4961683" y="5421250"/>
            <a:ext cx="146029" cy="246092"/>
            <a:chOff x="3021023" y="4132290"/>
            <a:chExt cx="205948" cy="358859"/>
          </a:xfrm>
        </p:grpSpPr>
        <p:sp>
          <p:nvSpPr>
            <p:cNvPr id="361" name="Forma libre 158">
              <a:extLst>
                <a:ext uri="{FF2B5EF4-FFF2-40B4-BE49-F238E27FC236}">
                  <a16:creationId xmlns:a16="http://schemas.microsoft.com/office/drawing/2014/main" id="{3965C478-D99C-498A-87CB-9D96A622EAC5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00FDFF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62" name="Forma libre 159">
              <a:extLst>
                <a:ext uri="{FF2B5EF4-FFF2-40B4-BE49-F238E27FC236}">
                  <a16:creationId xmlns:a16="http://schemas.microsoft.com/office/drawing/2014/main" id="{D81CC482-F21D-52EB-17A7-26F1035EACA8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00FD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363" name="Grupo 152">
            <a:extLst>
              <a:ext uri="{FF2B5EF4-FFF2-40B4-BE49-F238E27FC236}">
                <a16:creationId xmlns:a16="http://schemas.microsoft.com/office/drawing/2014/main" id="{A9A87C52-1270-0095-7C03-41EB12AC544D}"/>
              </a:ext>
            </a:extLst>
          </p:cNvPr>
          <p:cNvGrpSpPr/>
          <p:nvPr/>
        </p:nvGrpSpPr>
        <p:grpSpPr>
          <a:xfrm rot="1809763">
            <a:off x="4985634" y="5127411"/>
            <a:ext cx="205948" cy="358859"/>
            <a:chOff x="3021023" y="4132290"/>
            <a:chExt cx="205948" cy="358859"/>
          </a:xfrm>
        </p:grpSpPr>
        <p:sp>
          <p:nvSpPr>
            <p:cNvPr id="364" name="Forma libre 156">
              <a:extLst>
                <a:ext uri="{FF2B5EF4-FFF2-40B4-BE49-F238E27FC236}">
                  <a16:creationId xmlns:a16="http://schemas.microsoft.com/office/drawing/2014/main" id="{B726846A-AA60-F0F4-907B-6BF004C15C23}"/>
                </a:ext>
              </a:extLst>
            </p:cNvPr>
            <p:cNvSpPr/>
            <p:nvPr/>
          </p:nvSpPr>
          <p:spPr>
            <a:xfrm>
              <a:off x="3021023" y="4132290"/>
              <a:ext cx="205948" cy="358859"/>
            </a:xfrm>
            <a:custGeom>
              <a:avLst/>
              <a:gdLst>
                <a:gd name="connsiteX0" fmla="*/ 5815 w 205948"/>
                <a:gd name="connsiteY0" fmla="*/ 358859 h 358859"/>
                <a:gd name="connsiteX1" fmla="*/ 2365 w 205948"/>
                <a:gd name="connsiteY1" fmla="*/ 234638 h 358859"/>
                <a:gd name="connsiteX2" fmla="*/ 36870 w 205948"/>
                <a:gd name="connsiteY2" fmla="*/ 200133 h 358859"/>
                <a:gd name="connsiteX3" fmla="*/ 74827 w 205948"/>
                <a:gd name="connsiteY3" fmla="*/ 175979 h 358859"/>
                <a:gd name="connsiteX4" fmla="*/ 171442 w 205948"/>
                <a:gd name="connsiteY4" fmla="*/ 117319 h 358859"/>
                <a:gd name="connsiteX5" fmla="*/ 116233 w 205948"/>
                <a:gd name="connsiteY5" fmla="*/ 62110 h 358859"/>
                <a:gd name="connsiteX6" fmla="*/ 205948 w 205948"/>
                <a:gd name="connsiteY6" fmla="*/ 0 h 358859"/>
                <a:gd name="connsiteX7" fmla="*/ 205948 w 205948"/>
                <a:gd name="connsiteY7" fmla="*/ 0 h 358859"/>
                <a:gd name="connsiteX8" fmla="*/ 205948 w 205948"/>
                <a:gd name="connsiteY8" fmla="*/ 0 h 3588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05948" h="358859">
                  <a:moveTo>
                    <a:pt x="5815" y="358859"/>
                  </a:moveTo>
                  <a:cubicBezTo>
                    <a:pt x="1502" y="309975"/>
                    <a:pt x="-2811" y="261092"/>
                    <a:pt x="2365" y="234638"/>
                  </a:cubicBezTo>
                  <a:cubicBezTo>
                    <a:pt x="7541" y="208184"/>
                    <a:pt x="24793" y="209909"/>
                    <a:pt x="36870" y="200133"/>
                  </a:cubicBezTo>
                  <a:cubicBezTo>
                    <a:pt x="48947" y="190357"/>
                    <a:pt x="74827" y="175979"/>
                    <a:pt x="74827" y="175979"/>
                  </a:cubicBezTo>
                  <a:cubicBezTo>
                    <a:pt x="97256" y="162177"/>
                    <a:pt x="164541" y="136297"/>
                    <a:pt x="171442" y="117319"/>
                  </a:cubicBezTo>
                  <a:cubicBezTo>
                    <a:pt x="178343" y="98341"/>
                    <a:pt x="110482" y="81663"/>
                    <a:pt x="116233" y="62110"/>
                  </a:cubicBezTo>
                  <a:cubicBezTo>
                    <a:pt x="121984" y="42557"/>
                    <a:pt x="205948" y="0"/>
                    <a:pt x="205948" y="0"/>
                  </a:cubicBezTo>
                  <a:lnTo>
                    <a:pt x="205948" y="0"/>
                  </a:lnTo>
                  <a:lnTo>
                    <a:pt x="205948" y="0"/>
                  </a:lnTo>
                </a:path>
              </a:pathLst>
            </a:custGeom>
            <a:noFill/>
            <a:ln w="38100">
              <a:solidFill>
                <a:srgbClr val="C0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65" name="Forma libre 157">
              <a:extLst>
                <a:ext uri="{FF2B5EF4-FFF2-40B4-BE49-F238E27FC236}">
                  <a16:creationId xmlns:a16="http://schemas.microsoft.com/office/drawing/2014/main" id="{DE7DFABD-011D-FB80-5509-CF384D6BBF85}"/>
                </a:ext>
              </a:extLst>
            </p:cNvPr>
            <p:cNvSpPr/>
            <p:nvPr/>
          </p:nvSpPr>
          <p:spPr>
            <a:xfrm>
              <a:off x="3021023" y="4144217"/>
              <a:ext cx="191313" cy="320903"/>
            </a:xfrm>
            <a:custGeom>
              <a:avLst/>
              <a:gdLst>
                <a:gd name="connsiteX0" fmla="*/ 18782 w 191313"/>
                <a:gd name="connsiteY0" fmla="*/ 320903 h 320903"/>
                <a:gd name="connsiteX1" fmla="*/ 1529 w 191313"/>
                <a:gd name="connsiteY1" fmla="*/ 238089 h 320903"/>
                <a:gd name="connsiteX2" fmla="*/ 53288 w 191313"/>
                <a:gd name="connsiteY2" fmla="*/ 169078 h 320903"/>
                <a:gd name="connsiteX3" fmla="*/ 122299 w 191313"/>
                <a:gd name="connsiteY3" fmla="*/ 141473 h 320903"/>
                <a:gd name="connsiteX4" fmla="*/ 191310 w 191313"/>
                <a:gd name="connsiteY4" fmla="*/ 96616 h 320903"/>
                <a:gd name="connsiteX5" fmla="*/ 125750 w 191313"/>
                <a:gd name="connsiteY5" fmla="*/ 55209 h 320903"/>
                <a:gd name="connsiteX6" fmla="*/ 167156 w 191313"/>
                <a:gd name="connsiteY6" fmla="*/ 0 h 320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1313" h="320903">
                  <a:moveTo>
                    <a:pt x="18782" y="320903"/>
                  </a:moveTo>
                  <a:cubicBezTo>
                    <a:pt x="7280" y="292148"/>
                    <a:pt x="-4222" y="263393"/>
                    <a:pt x="1529" y="238089"/>
                  </a:cubicBezTo>
                  <a:cubicBezTo>
                    <a:pt x="7280" y="212785"/>
                    <a:pt x="33160" y="185181"/>
                    <a:pt x="53288" y="169078"/>
                  </a:cubicBezTo>
                  <a:cubicBezTo>
                    <a:pt x="73416" y="152975"/>
                    <a:pt x="99295" y="153550"/>
                    <a:pt x="122299" y="141473"/>
                  </a:cubicBezTo>
                  <a:cubicBezTo>
                    <a:pt x="145303" y="129396"/>
                    <a:pt x="190735" y="110993"/>
                    <a:pt x="191310" y="96616"/>
                  </a:cubicBezTo>
                  <a:cubicBezTo>
                    <a:pt x="191885" y="82239"/>
                    <a:pt x="129776" y="71312"/>
                    <a:pt x="125750" y="55209"/>
                  </a:cubicBezTo>
                  <a:cubicBezTo>
                    <a:pt x="121724" y="39106"/>
                    <a:pt x="144440" y="19553"/>
                    <a:pt x="167156" y="0"/>
                  </a:cubicBezTo>
                </a:path>
              </a:pathLst>
            </a:custGeom>
            <a:noFill/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366" name="Grupo 29">
            <a:extLst>
              <a:ext uri="{FF2B5EF4-FFF2-40B4-BE49-F238E27FC236}">
                <a16:creationId xmlns:a16="http://schemas.microsoft.com/office/drawing/2014/main" id="{436782D7-CD92-3301-6911-8B01BE44AE49}"/>
              </a:ext>
            </a:extLst>
          </p:cNvPr>
          <p:cNvGrpSpPr/>
          <p:nvPr/>
        </p:nvGrpSpPr>
        <p:grpSpPr>
          <a:xfrm>
            <a:off x="4605230" y="5535129"/>
            <a:ext cx="1030393" cy="236059"/>
            <a:chOff x="3245881" y="2431599"/>
            <a:chExt cx="1030393" cy="236059"/>
          </a:xfrm>
        </p:grpSpPr>
        <p:sp>
          <p:nvSpPr>
            <p:cNvPr id="367" name="Elipse 26">
              <a:extLst>
                <a:ext uri="{FF2B5EF4-FFF2-40B4-BE49-F238E27FC236}">
                  <a16:creationId xmlns:a16="http://schemas.microsoft.com/office/drawing/2014/main" id="{18BECA76-EF53-482B-CF83-76C61ACD121C}"/>
                </a:ext>
              </a:extLst>
            </p:cNvPr>
            <p:cNvSpPr/>
            <p:nvPr/>
          </p:nvSpPr>
          <p:spPr>
            <a:xfrm>
              <a:off x="3629228" y="2431599"/>
              <a:ext cx="85411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68" name="Elipse 147">
              <a:extLst>
                <a:ext uri="{FF2B5EF4-FFF2-40B4-BE49-F238E27FC236}">
                  <a16:creationId xmlns:a16="http://schemas.microsoft.com/office/drawing/2014/main" id="{E8B25191-4B9E-AAB2-C36B-E1C68F3C9862}"/>
                </a:ext>
              </a:extLst>
            </p:cNvPr>
            <p:cNvSpPr/>
            <p:nvPr/>
          </p:nvSpPr>
          <p:spPr>
            <a:xfrm>
              <a:off x="3765559" y="2431599"/>
              <a:ext cx="61984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69" name="Elipse 146">
              <a:extLst>
                <a:ext uri="{FF2B5EF4-FFF2-40B4-BE49-F238E27FC236}">
                  <a16:creationId xmlns:a16="http://schemas.microsoft.com/office/drawing/2014/main" id="{BBA00703-B165-E5B2-34E8-CDFF4A656C14}"/>
                </a:ext>
              </a:extLst>
            </p:cNvPr>
            <p:cNvSpPr/>
            <p:nvPr/>
          </p:nvSpPr>
          <p:spPr>
            <a:xfrm>
              <a:off x="3711139" y="2431599"/>
              <a:ext cx="85411" cy="187822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127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70" name="Rectángulo redondeado 27">
              <a:extLst>
                <a:ext uri="{FF2B5EF4-FFF2-40B4-BE49-F238E27FC236}">
                  <a16:creationId xmlns:a16="http://schemas.microsoft.com/office/drawing/2014/main" id="{F23AE2D0-5B7A-8F2A-21E2-5A6CA2A890D3}"/>
                </a:ext>
              </a:extLst>
            </p:cNvPr>
            <p:cNvSpPr/>
            <p:nvPr/>
          </p:nvSpPr>
          <p:spPr>
            <a:xfrm>
              <a:off x="3522325" y="2431599"/>
              <a:ext cx="99627" cy="187822"/>
            </a:xfrm>
            <a:prstGeom prst="round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71" name="CuadroTexto 148">
              <a:extLst>
                <a:ext uri="{FF2B5EF4-FFF2-40B4-BE49-F238E27FC236}">
                  <a16:creationId xmlns:a16="http://schemas.microsoft.com/office/drawing/2014/main" id="{7FA5F65F-1856-966E-E441-C41527F10F27}"/>
                </a:ext>
              </a:extLst>
            </p:cNvPr>
            <p:cNvSpPr txBox="1"/>
            <p:nvPr/>
          </p:nvSpPr>
          <p:spPr>
            <a:xfrm>
              <a:off x="3245881" y="2496268"/>
              <a:ext cx="34176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 err="1"/>
                <a:t>EpsH</a:t>
              </a:r>
              <a:endParaRPr lang="es-ES" sz="500" dirty="0"/>
            </a:p>
          </p:txBody>
        </p:sp>
        <p:sp>
          <p:nvSpPr>
            <p:cNvPr id="372" name="CuadroTexto 149">
              <a:extLst>
                <a:ext uri="{FF2B5EF4-FFF2-40B4-BE49-F238E27FC236}">
                  <a16:creationId xmlns:a16="http://schemas.microsoft.com/office/drawing/2014/main" id="{AC2AE11A-266A-5213-7366-5BA319197138}"/>
                </a:ext>
              </a:extLst>
            </p:cNvPr>
            <p:cNvSpPr txBox="1"/>
            <p:nvPr/>
          </p:nvSpPr>
          <p:spPr>
            <a:xfrm>
              <a:off x="3761389" y="2498381"/>
              <a:ext cx="51488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 err="1"/>
                <a:t>Sec</a:t>
              </a:r>
              <a:r>
                <a:rPr lang="es-ES" sz="500" dirty="0"/>
                <a:t> </a:t>
              </a:r>
              <a:r>
                <a:rPr lang="es-ES" sz="500" dirty="0" err="1"/>
                <a:t>system</a:t>
              </a:r>
              <a:endParaRPr lang="es-ES" sz="500" dirty="0"/>
            </a:p>
          </p:txBody>
        </p:sp>
      </p:grpSp>
      <p:grpSp>
        <p:nvGrpSpPr>
          <p:cNvPr id="373" name="Grupo 191">
            <a:extLst>
              <a:ext uri="{FF2B5EF4-FFF2-40B4-BE49-F238E27FC236}">
                <a16:creationId xmlns:a16="http://schemas.microsoft.com/office/drawing/2014/main" id="{CD6F3C35-31EB-B91E-E7D1-75398A9C78E8}"/>
              </a:ext>
            </a:extLst>
          </p:cNvPr>
          <p:cNvGrpSpPr/>
          <p:nvPr/>
        </p:nvGrpSpPr>
        <p:grpSpPr>
          <a:xfrm rot="4142925">
            <a:off x="4743808" y="5362897"/>
            <a:ext cx="131554" cy="154346"/>
            <a:chOff x="4747546" y="4151030"/>
            <a:chExt cx="406143" cy="476509"/>
          </a:xfrm>
        </p:grpSpPr>
        <p:sp>
          <p:nvSpPr>
            <p:cNvPr id="374" name="Franja diagonal 187">
              <a:extLst>
                <a:ext uri="{FF2B5EF4-FFF2-40B4-BE49-F238E27FC236}">
                  <a16:creationId xmlns:a16="http://schemas.microsoft.com/office/drawing/2014/main" id="{73547B99-C2E3-7724-A792-A1F61C7F8BD9}"/>
                </a:ext>
              </a:extLst>
            </p:cNvPr>
            <p:cNvSpPr/>
            <p:nvPr/>
          </p:nvSpPr>
          <p:spPr>
            <a:xfrm rot="17876278">
              <a:off x="4754448" y="4144128"/>
              <a:ext cx="238950" cy="252753"/>
            </a:xfrm>
            <a:prstGeom prst="diagStripe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solidFill>
                  <a:schemeClr val="tx1"/>
                </a:solidFill>
              </a:endParaRPr>
            </a:p>
          </p:txBody>
        </p:sp>
        <p:sp>
          <p:nvSpPr>
            <p:cNvPr id="375" name="Franja diagonal 188">
              <a:extLst>
                <a:ext uri="{FF2B5EF4-FFF2-40B4-BE49-F238E27FC236}">
                  <a16:creationId xmlns:a16="http://schemas.microsoft.com/office/drawing/2014/main" id="{D94DF68F-E6C3-AF1E-2E3F-322D34DFFC07}"/>
                </a:ext>
              </a:extLst>
            </p:cNvPr>
            <p:cNvSpPr/>
            <p:nvPr/>
          </p:nvSpPr>
          <p:spPr>
            <a:xfrm rot="3723722" flipH="1">
              <a:off x="4907838" y="4144129"/>
              <a:ext cx="238950" cy="252753"/>
            </a:xfrm>
            <a:prstGeom prst="diagStripe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solidFill>
                  <a:schemeClr val="tx1"/>
                </a:solidFill>
              </a:endParaRPr>
            </a:p>
          </p:txBody>
        </p:sp>
        <p:sp>
          <p:nvSpPr>
            <p:cNvPr id="376" name="Elipse 189">
              <a:extLst>
                <a:ext uri="{FF2B5EF4-FFF2-40B4-BE49-F238E27FC236}">
                  <a16:creationId xmlns:a16="http://schemas.microsoft.com/office/drawing/2014/main" id="{9C6682DF-10D3-476A-92A8-6F17BD00BC9B}"/>
                </a:ext>
              </a:extLst>
            </p:cNvPr>
            <p:cNvSpPr/>
            <p:nvPr/>
          </p:nvSpPr>
          <p:spPr>
            <a:xfrm rot="1495849">
              <a:off x="4816988" y="4428693"/>
              <a:ext cx="113868" cy="198842"/>
            </a:xfrm>
            <a:prstGeom prst="ellipse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77" name="Elipse 190">
              <a:extLst>
                <a:ext uri="{FF2B5EF4-FFF2-40B4-BE49-F238E27FC236}">
                  <a16:creationId xmlns:a16="http://schemas.microsoft.com/office/drawing/2014/main" id="{1B723BE5-7155-9BA2-5094-65881664E243}"/>
                </a:ext>
              </a:extLst>
            </p:cNvPr>
            <p:cNvSpPr/>
            <p:nvPr/>
          </p:nvSpPr>
          <p:spPr>
            <a:xfrm rot="20104151" flipH="1">
              <a:off x="4971222" y="4428694"/>
              <a:ext cx="113868" cy="198845"/>
            </a:xfrm>
            <a:prstGeom prst="ellipse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cxnSp>
        <p:nvCxnSpPr>
          <p:cNvPr id="378" name="Conector recto de flecha 192">
            <a:extLst>
              <a:ext uri="{FF2B5EF4-FFF2-40B4-BE49-F238E27FC236}">
                <a16:creationId xmlns:a16="http://schemas.microsoft.com/office/drawing/2014/main" id="{8F771A0D-4AB0-7ECB-78F4-5A24C8FDDD7C}"/>
              </a:ext>
            </a:extLst>
          </p:cNvPr>
          <p:cNvCxnSpPr>
            <a:cxnSpLocks/>
          </p:cNvCxnSpPr>
          <p:nvPr/>
        </p:nvCxnSpPr>
        <p:spPr>
          <a:xfrm>
            <a:off x="4033504" y="5532984"/>
            <a:ext cx="755473" cy="0"/>
          </a:xfrm>
          <a:prstGeom prst="straightConnector1">
            <a:avLst/>
          </a:prstGeom>
          <a:ln w="3175">
            <a:solidFill>
              <a:schemeClr val="tx1"/>
            </a:solidFill>
            <a:prstDash val="lgDash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9" name="Forma libre 36">
            <a:extLst>
              <a:ext uri="{FF2B5EF4-FFF2-40B4-BE49-F238E27FC236}">
                <a16:creationId xmlns:a16="http://schemas.microsoft.com/office/drawing/2014/main" id="{451F899E-284C-058C-994D-C5964AB81AE6}"/>
              </a:ext>
            </a:extLst>
          </p:cNvPr>
          <p:cNvSpPr/>
          <p:nvPr/>
        </p:nvSpPr>
        <p:spPr>
          <a:xfrm rot="14040046">
            <a:off x="3774787" y="4943289"/>
            <a:ext cx="547279" cy="153645"/>
          </a:xfrm>
          <a:custGeom>
            <a:avLst/>
            <a:gdLst>
              <a:gd name="connsiteX0" fmla="*/ 0 w 621102"/>
              <a:gd name="connsiteY0" fmla="*/ 133829 h 133829"/>
              <a:gd name="connsiteX1" fmla="*/ 200133 w 621102"/>
              <a:gd name="connsiteY1" fmla="*/ 2707 h 133829"/>
              <a:gd name="connsiteX2" fmla="*/ 621102 w 621102"/>
              <a:gd name="connsiteY2" fmla="*/ 57917 h 1338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21102" h="133829">
                <a:moveTo>
                  <a:pt x="0" y="133829"/>
                </a:moveTo>
                <a:cubicBezTo>
                  <a:pt x="48308" y="74594"/>
                  <a:pt x="96616" y="15359"/>
                  <a:pt x="200133" y="2707"/>
                </a:cubicBezTo>
                <a:cubicBezTo>
                  <a:pt x="303650" y="-9945"/>
                  <a:pt x="462376" y="23986"/>
                  <a:pt x="621102" y="57917"/>
                </a:cubicBezTo>
              </a:path>
            </a:pathLst>
          </a:custGeom>
          <a:noFill/>
          <a:ln w="3175">
            <a:solidFill>
              <a:schemeClr val="tx1"/>
            </a:solidFill>
            <a:prstDash val="lgDash"/>
            <a:headEnd type="none" w="med" len="med"/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0" name="Oval 84">
            <a:extLst>
              <a:ext uri="{FF2B5EF4-FFF2-40B4-BE49-F238E27FC236}">
                <a16:creationId xmlns:a16="http://schemas.microsoft.com/office/drawing/2014/main" id="{7724D27C-BC65-33D5-0560-D1E01B446FF8}"/>
              </a:ext>
            </a:extLst>
          </p:cNvPr>
          <p:cNvSpPr/>
          <p:nvPr/>
        </p:nvSpPr>
        <p:spPr>
          <a:xfrm flipH="1">
            <a:off x="1877524" y="4271995"/>
            <a:ext cx="58616" cy="48177"/>
          </a:xfrm>
          <a:prstGeom prst="ellipse">
            <a:avLst/>
          </a:prstGeom>
          <a:solidFill>
            <a:schemeClr val="accent4"/>
          </a:solidFill>
          <a:ln w="12700">
            <a:solidFill>
              <a:srgbClr val="1D315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16200" rIns="90000" bIns="162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381" name="Forma libre 36">
            <a:extLst>
              <a:ext uri="{FF2B5EF4-FFF2-40B4-BE49-F238E27FC236}">
                <a16:creationId xmlns:a16="http://schemas.microsoft.com/office/drawing/2014/main" id="{6AA1919E-1CF1-6FCF-B6F9-33AB82C8DA3B}"/>
              </a:ext>
            </a:extLst>
          </p:cNvPr>
          <p:cNvSpPr/>
          <p:nvPr/>
        </p:nvSpPr>
        <p:spPr>
          <a:xfrm rot="11527082" flipV="1">
            <a:off x="3951780" y="5929478"/>
            <a:ext cx="717722" cy="170159"/>
          </a:xfrm>
          <a:custGeom>
            <a:avLst/>
            <a:gdLst>
              <a:gd name="connsiteX0" fmla="*/ 0 w 621102"/>
              <a:gd name="connsiteY0" fmla="*/ 133829 h 133829"/>
              <a:gd name="connsiteX1" fmla="*/ 200133 w 621102"/>
              <a:gd name="connsiteY1" fmla="*/ 2707 h 133829"/>
              <a:gd name="connsiteX2" fmla="*/ 621102 w 621102"/>
              <a:gd name="connsiteY2" fmla="*/ 57917 h 1338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21102" h="133829">
                <a:moveTo>
                  <a:pt x="0" y="133829"/>
                </a:moveTo>
                <a:cubicBezTo>
                  <a:pt x="48308" y="74594"/>
                  <a:pt x="96616" y="15359"/>
                  <a:pt x="200133" y="2707"/>
                </a:cubicBezTo>
                <a:cubicBezTo>
                  <a:pt x="303650" y="-9945"/>
                  <a:pt x="462376" y="23986"/>
                  <a:pt x="621102" y="57917"/>
                </a:cubicBezTo>
              </a:path>
            </a:pathLst>
          </a:custGeom>
          <a:noFill/>
          <a:ln w="3175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2" name="TextBox 381">
            <a:extLst>
              <a:ext uri="{FF2B5EF4-FFF2-40B4-BE49-F238E27FC236}">
                <a16:creationId xmlns:a16="http://schemas.microsoft.com/office/drawing/2014/main" id="{A1E4A91F-BBEC-C0C1-E6EF-BA4DA2FDD5AB}"/>
              </a:ext>
            </a:extLst>
          </p:cNvPr>
          <p:cNvSpPr txBox="1"/>
          <p:nvPr/>
        </p:nvSpPr>
        <p:spPr>
          <a:xfrm>
            <a:off x="4805267" y="4065679"/>
            <a:ext cx="11592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Extracellular space</a:t>
            </a:r>
          </a:p>
        </p:txBody>
      </p:sp>
      <p:sp>
        <p:nvSpPr>
          <p:cNvPr id="383" name="TextBox 382">
            <a:extLst>
              <a:ext uri="{FF2B5EF4-FFF2-40B4-BE49-F238E27FC236}">
                <a16:creationId xmlns:a16="http://schemas.microsoft.com/office/drawing/2014/main" id="{7AC50423-5890-581D-8564-FCAEEB321544}"/>
              </a:ext>
            </a:extLst>
          </p:cNvPr>
          <p:cNvSpPr txBox="1"/>
          <p:nvPr/>
        </p:nvSpPr>
        <p:spPr>
          <a:xfrm>
            <a:off x="5315022" y="5230635"/>
            <a:ext cx="6976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Periplasm</a:t>
            </a:r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47F99C16-3CAB-4B27-C395-C7538E90553D}"/>
              </a:ext>
            </a:extLst>
          </p:cNvPr>
          <p:cNvSpPr txBox="1"/>
          <p:nvPr/>
        </p:nvSpPr>
        <p:spPr>
          <a:xfrm>
            <a:off x="5279755" y="5992636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Cytoplasm</a:t>
            </a:r>
          </a:p>
        </p:txBody>
      </p:sp>
      <p:sp>
        <p:nvSpPr>
          <p:cNvPr id="385" name="TextBox 384">
            <a:extLst>
              <a:ext uri="{FF2B5EF4-FFF2-40B4-BE49-F238E27FC236}">
                <a16:creationId xmlns:a16="http://schemas.microsoft.com/office/drawing/2014/main" id="{E53AFD76-C1F6-A5E4-60C7-131F928ED622}"/>
              </a:ext>
            </a:extLst>
          </p:cNvPr>
          <p:cNvSpPr txBox="1"/>
          <p:nvPr/>
        </p:nvSpPr>
        <p:spPr>
          <a:xfrm>
            <a:off x="5677300" y="4832847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OM</a:t>
            </a:r>
          </a:p>
        </p:txBody>
      </p:sp>
      <p:sp>
        <p:nvSpPr>
          <p:cNvPr id="386" name="TextBox 385">
            <a:extLst>
              <a:ext uri="{FF2B5EF4-FFF2-40B4-BE49-F238E27FC236}">
                <a16:creationId xmlns:a16="http://schemas.microsoft.com/office/drawing/2014/main" id="{F0EFD519-1ADB-EB18-E922-BBFF63BA0E16}"/>
              </a:ext>
            </a:extLst>
          </p:cNvPr>
          <p:cNvSpPr txBox="1"/>
          <p:nvPr/>
        </p:nvSpPr>
        <p:spPr>
          <a:xfrm>
            <a:off x="5677300" y="560001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900" dirty="0"/>
              <a:t>PM</a:t>
            </a:r>
          </a:p>
        </p:txBody>
      </p:sp>
      <p:sp>
        <p:nvSpPr>
          <p:cNvPr id="387" name="Rectangle 386">
            <a:extLst>
              <a:ext uri="{FF2B5EF4-FFF2-40B4-BE49-F238E27FC236}">
                <a16:creationId xmlns:a16="http://schemas.microsoft.com/office/drawing/2014/main" id="{2A8492C9-9B59-3C0F-0F96-F3FCFDCACCC4}"/>
              </a:ext>
            </a:extLst>
          </p:cNvPr>
          <p:cNvSpPr/>
          <p:nvPr/>
        </p:nvSpPr>
        <p:spPr>
          <a:xfrm>
            <a:off x="960895" y="4019184"/>
            <a:ext cx="5047281" cy="3006671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388" name="TextBox 387">
            <a:extLst>
              <a:ext uri="{FF2B5EF4-FFF2-40B4-BE49-F238E27FC236}">
                <a16:creationId xmlns:a16="http://schemas.microsoft.com/office/drawing/2014/main" id="{FD9CC0D8-87A7-16D9-299C-BF4BAC2DF83F}"/>
              </a:ext>
            </a:extLst>
          </p:cNvPr>
          <p:cNvSpPr txBox="1"/>
          <p:nvPr/>
        </p:nvSpPr>
        <p:spPr>
          <a:xfrm>
            <a:off x="940838" y="859417"/>
            <a:ext cx="13484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>
                <a:solidFill>
                  <a:srgbClr val="C00000"/>
                </a:solidFill>
              </a:rPr>
              <a:t>Zinc sufficiency</a:t>
            </a:r>
          </a:p>
        </p:txBody>
      </p:sp>
      <p:sp>
        <p:nvSpPr>
          <p:cNvPr id="389" name="TextBox 388">
            <a:extLst>
              <a:ext uri="{FF2B5EF4-FFF2-40B4-BE49-F238E27FC236}">
                <a16:creationId xmlns:a16="http://schemas.microsoft.com/office/drawing/2014/main" id="{A5A1C56D-E180-2D6B-C603-B7B4D3E217E2}"/>
              </a:ext>
            </a:extLst>
          </p:cNvPr>
          <p:cNvSpPr txBox="1"/>
          <p:nvPr/>
        </p:nvSpPr>
        <p:spPr>
          <a:xfrm>
            <a:off x="940838" y="3989477"/>
            <a:ext cx="1124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>
                <a:solidFill>
                  <a:srgbClr val="C00000"/>
                </a:solidFill>
              </a:rPr>
              <a:t>Zinc scarcity</a:t>
            </a:r>
          </a:p>
        </p:txBody>
      </p:sp>
      <p:grpSp>
        <p:nvGrpSpPr>
          <p:cNvPr id="66" name="Group 77"/>
          <p:cNvGrpSpPr/>
          <p:nvPr/>
        </p:nvGrpSpPr>
        <p:grpSpPr>
          <a:xfrm>
            <a:off x="1574786" y="5965510"/>
            <a:ext cx="183942" cy="177054"/>
            <a:chOff x="1833120" y="4998600"/>
            <a:chExt cx="384480" cy="370080"/>
          </a:xfrm>
          <a:solidFill>
            <a:srgbClr val="9437FF"/>
          </a:solidFill>
        </p:grpSpPr>
        <p:grpSp>
          <p:nvGrpSpPr>
            <p:cNvPr id="67" name="Group 65"/>
            <p:cNvGrpSpPr/>
            <p:nvPr/>
          </p:nvGrpSpPr>
          <p:grpSpPr>
            <a:xfrm>
              <a:off x="1833120" y="4998600"/>
              <a:ext cx="239760" cy="367200"/>
              <a:chOff x="1833120" y="4998600"/>
              <a:chExt cx="239760" cy="367200"/>
            </a:xfrm>
            <a:grpFill/>
          </p:grpSpPr>
          <p:sp>
            <p:nvSpPr>
              <p:cNvPr id="68" name="Oval 53"/>
              <p:cNvSpPr/>
              <p:nvPr/>
            </p:nvSpPr>
            <p:spPr>
              <a:xfrm rot="19234800">
                <a:off x="1834560" y="5242320"/>
                <a:ext cx="186480" cy="72360"/>
              </a:xfrm>
              <a:prstGeom prst="ellipse">
                <a:avLst/>
              </a:prstGeom>
              <a:grpFill/>
              <a:ln>
                <a:solidFill>
                  <a:srgbClr val="1D3155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6480" rIns="90000" bIns="64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69" name="Oval 56"/>
              <p:cNvSpPr/>
              <p:nvPr/>
            </p:nvSpPr>
            <p:spPr>
              <a:xfrm rot="17726400">
                <a:off x="1906920" y="5061960"/>
                <a:ext cx="186480" cy="72360"/>
              </a:xfrm>
              <a:prstGeom prst="ellipse">
                <a:avLst/>
              </a:prstGeom>
              <a:grpFill/>
              <a:ln>
                <a:solidFill>
                  <a:srgbClr val="1D3155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6480" rIns="90000" bIns="64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70" name="Freeform 64"/>
              <p:cNvSpPr/>
              <p:nvPr/>
            </p:nvSpPr>
            <p:spPr>
              <a:xfrm>
                <a:off x="1967040" y="5186880"/>
                <a:ext cx="29520" cy="28080"/>
              </a:xfrm>
              <a:custGeom>
                <a:avLst/>
                <a:gdLst>
                  <a:gd name="textAreaLeft" fmla="*/ 0 w 29520"/>
                  <a:gd name="textAreaRight" fmla="*/ 29880 w 29520"/>
                  <a:gd name="textAreaTop" fmla="*/ 0 h 28080"/>
                  <a:gd name="textAreaBottom" fmla="*/ 28440 h 28080"/>
                </a:gdLst>
                <a:ahLst/>
                <a:cxnLst/>
                <a:rect l="textAreaLeft" t="textAreaTop" r="textAreaRight" b="textAreaBottom"/>
                <a:pathLst>
                  <a:path w="60407" h="57150">
                    <a:moveTo>
                      <a:pt x="0" y="0"/>
                    </a:moveTo>
                    <a:cubicBezTo>
                      <a:pt x="47763" y="6823"/>
                      <a:pt x="30251" y="1617"/>
                      <a:pt x="53975" y="9525"/>
                    </a:cubicBezTo>
                    <a:cubicBezTo>
                      <a:pt x="56092" y="12700"/>
                      <a:pt x="59785" y="15272"/>
                      <a:pt x="60325" y="19050"/>
                    </a:cubicBezTo>
                    <a:cubicBezTo>
                      <a:pt x="60942" y="23370"/>
                      <a:pt x="57931" y="27457"/>
                      <a:pt x="57150" y="31750"/>
                    </a:cubicBezTo>
                    <a:cubicBezTo>
                      <a:pt x="53825" y="50036"/>
                      <a:pt x="53975" y="47197"/>
                      <a:pt x="53975" y="57150"/>
                    </a:cubicBezTo>
                  </a:path>
                </a:pathLst>
              </a:custGeom>
              <a:grpFill/>
              <a:ln>
                <a:solidFill>
                  <a:srgbClr val="1D3155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-16560" rIns="90000" bIns="-1656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  <p:grpSp>
          <p:nvGrpSpPr>
            <p:cNvPr id="71" name="Group 66"/>
            <p:cNvGrpSpPr/>
            <p:nvPr/>
          </p:nvGrpSpPr>
          <p:grpSpPr>
            <a:xfrm>
              <a:off x="1977480" y="5001480"/>
              <a:ext cx="240120" cy="367200"/>
              <a:chOff x="1977480" y="5001480"/>
              <a:chExt cx="240120" cy="367200"/>
            </a:xfrm>
            <a:grpFill/>
          </p:grpSpPr>
          <p:sp>
            <p:nvSpPr>
              <p:cNvPr id="72" name="Oval 67"/>
              <p:cNvSpPr/>
              <p:nvPr/>
            </p:nvSpPr>
            <p:spPr>
              <a:xfrm rot="2365200" flipH="1">
                <a:off x="2028960" y="5245200"/>
                <a:ext cx="186480" cy="72360"/>
              </a:xfrm>
              <a:prstGeom prst="ellipse">
                <a:avLst/>
              </a:prstGeom>
              <a:grpFill/>
              <a:ln>
                <a:solidFill>
                  <a:srgbClr val="1D3155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6480" rIns="90000" bIns="64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73" name="Oval 68"/>
              <p:cNvSpPr/>
              <p:nvPr/>
            </p:nvSpPr>
            <p:spPr>
              <a:xfrm rot="3873600" flipH="1">
                <a:off x="1956960" y="5064840"/>
                <a:ext cx="186480" cy="72360"/>
              </a:xfrm>
              <a:prstGeom prst="ellipse">
                <a:avLst/>
              </a:prstGeom>
              <a:grpFill/>
              <a:ln>
                <a:solidFill>
                  <a:srgbClr val="1D3155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6480" rIns="90000" bIns="64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74" name="Freeform 69"/>
              <p:cNvSpPr/>
              <p:nvPr/>
            </p:nvSpPr>
            <p:spPr>
              <a:xfrm flipH="1">
                <a:off x="2053800" y="5189760"/>
                <a:ext cx="29520" cy="28080"/>
              </a:xfrm>
              <a:custGeom>
                <a:avLst/>
                <a:gdLst>
                  <a:gd name="textAreaLeft" fmla="*/ 360 w 29520"/>
                  <a:gd name="textAreaRight" fmla="*/ 30240 w 29520"/>
                  <a:gd name="textAreaTop" fmla="*/ 0 h 28080"/>
                  <a:gd name="textAreaBottom" fmla="*/ 28440 h 28080"/>
                </a:gdLst>
                <a:ahLst/>
                <a:cxnLst/>
                <a:rect l="textAreaLeft" t="textAreaTop" r="textAreaRight" b="textAreaBottom"/>
                <a:pathLst>
                  <a:path w="60407" h="57150">
                    <a:moveTo>
                      <a:pt x="0" y="0"/>
                    </a:moveTo>
                    <a:cubicBezTo>
                      <a:pt x="47763" y="6823"/>
                      <a:pt x="30251" y="1617"/>
                      <a:pt x="53975" y="9525"/>
                    </a:cubicBezTo>
                    <a:cubicBezTo>
                      <a:pt x="56092" y="12700"/>
                      <a:pt x="59785" y="15272"/>
                      <a:pt x="60325" y="19050"/>
                    </a:cubicBezTo>
                    <a:cubicBezTo>
                      <a:pt x="60942" y="23370"/>
                      <a:pt x="57931" y="27457"/>
                      <a:pt x="57150" y="31750"/>
                    </a:cubicBezTo>
                    <a:cubicBezTo>
                      <a:pt x="53825" y="50036"/>
                      <a:pt x="53975" y="47197"/>
                      <a:pt x="53975" y="57150"/>
                    </a:cubicBezTo>
                  </a:path>
                </a:pathLst>
              </a:custGeom>
              <a:grpFill/>
              <a:ln>
                <a:solidFill>
                  <a:srgbClr val="1D3155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-16560" rIns="90000" bIns="-1656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</p:grpSp>
      <p:sp>
        <p:nvSpPr>
          <p:cNvPr id="86" name="Flecha derecha 86"/>
          <p:cNvSpPr/>
          <p:nvPr/>
        </p:nvSpPr>
        <p:spPr>
          <a:xfrm>
            <a:off x="1958338" y="6433609"/>
            <a:ext cx="447388" cy="166019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C0000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s-ES_tradnl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87" name="CuadroTexto 87"/>
          <p:cNvSpPr/>
          <p:nvPr/>
        </p:nvSpPr>
        <p:spPr>
          <a:xfrm>
            <a:off x="1941010" y="6505432"/>
            <a:ext cx="537766" cy="198601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s-ES_tradnl" sz="700" b="0" i="1" strike="noStrike" spc="-1" dirty="0" err="1">
                <a:solidFill>
                  <a:srgbClr val="000000"/>
                </a:solidFill>
                <a:latin typeface="Arial"/>
              </a:rPr>
              <a:t>zepA</a:t>
            </a:r>
            <a:endParaRPr lang="es-ES" sz="7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Conector recto 88"/>
          <p:cNvSpPr/>
          <p:nvPr/>
        </p:nvSpPr>
        <p:spPr>
          <a:xfrm flipH="1" flipV="1">
            <a:off x="1234992" y="6513052"/>
            <a:ext cx="723100" cy="3443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/>
        </p:style>
        <p:txBody>
          <a:bodyPr lIns="90000" tIns="-39960" rIns="90000" bIns="-39960" anchor="t" anchorCtr="1">
            <a:noAutofit/>
          </a:bodyPr>
          <a:lstStyle/>
          <a:p>
            <a:endParaRPr lang="es-E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Flecha derecha 107"/>
          <p:cNvSpPr/>
          <p:nvPr/>
        </p:nvSpPr>
        <p:spPr>
          <a:xfrm>
            <a:off x="1729111" y="6433609"/>
            <a:ext cx="222341" cy="166019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6666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s-ES_tradnl" sz="1800" b="0" strike="noStrike" spc="-1">
              <a:solidFill>
                <a:schemeClr val="lt1"/>
              </a:solidFill>
              <a:latin typeface="Calibri"/>
            </a:endParaRPr>
          </a:p>
        </p:txBody>
      </p:sp>
      <p:grpSp>
        <p:nvGrpSpPr>
          <p:cNvPr id="617" name="Group 616">
            <a:extLst>
              <a:ext uri="{FF2B5EF4-FFF2-40B4-BE49-F238E27FC236}">
                <a16:creationId xmlns:a16="http://schemas.microsoft.com/office/drawing/2014/main" id="{130F1A8C-43C8-7C04-A1E9-83A7911EE88E}"/>
              </a:ext>
            </a:extLst>
          </p:cNvPr>
          <p:cNvGrpSpPr/>
          <p:nvPr/>
        </p:nvGrpSpPr>
        <p:grpSpPr>
          <a:xfrm>
            <a:off x="1877121" y="6321425"/>
            <a:ext cx="326329" cy="210718"/>
            <a:chOff x="365821" y="6197600"/>
            <a:chExt cx="326329" cy="210718"/>
          </a:xfrm>
        </p:grpSpPr>
        <p:sp>
          <p:nvSpPr>
            <p:cNvPr id="92" name="Conector recto de flecha 90"/>
            <p:cNvSpPr/>
            <p:nvPr/>
          </p:nvSpPr>
          <p:spPr>
            <a:xfrm>
              <a:off x="365821" y="6210080"/>
              <a:ext cx="326329" cy="0"/>
            </a:xfrm>
            <a:custGeom>
              <a:avLst/>
              <a:gdLst/>
              <a:ahLst/>
              <a:cxnLst/>
              <a:rect l="l" t="t" r="r" b="b"/>
              <a:pathLst>
                <a:path w="21600" h="21600">
                  <a:moveTo>
                    <a:pt x="0" y="0"/>
                  </a:moveTo>
                  <a:lnTo>
                    <a:pt x="21600" y="2160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round/>
              <a:tailEnd type="triangl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-44280" rIns="90000" bIns="-44280" anchor="t">
              <a:noAutofit/>
            </a:bodyPr>
            <a:lstStyle/>
            <a:p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Conector recto 108"/>
            <p:cNvSpPr/>
            <p:nvPr/>
          </p:nvSpPr>
          <p:spPr>
            <a:xfrm flipV="1">
              <a:off x="384871" y="6197600"/>
              <a:ext cx="0" cy="210718"/>
            </a:xfrm>
            <a:prstGeom prst="line">
              <a:avLst/>
            </a:prstGeom>
            <a:ln w="44450">
              <a:solidFill>
                <a:srgbClr val="000000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45000" rIns="90000" bIns="45000" anchor="t" anchorCtr="1">
              <a:noAutofit/>
            </a:bodyPr>
            <a:lstStyle/>
            <a:p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4" name="Flecha derecha 111"/>
          <p:cNvSpPr/>
          <p:nvPr/>
        </p:nvSpPr>
        <p:spPr>
          <a:xfrm>
            <a:off x="1235238" y="6430166"/>
            <a:ext cx="358845" cy="166019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accent4">
              <a:lumMod val="60000"/>
              <a:lumOff val="40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s-ES_tradnl" sz="1800" b="0" strike="noStrike" spc="-1">
              <a:solidFill>
                <a:schemeClr val="lt1"/>
              </a:solidFill>
              <a:latin typeface="Calibri"/>
            </a:endParaRPr>
          </a:p>
        </p:txBody>
      </p:sp>
      <p:grpSp>
        <p:nvGrpSpPr>
          <p:cNvPr id="95" name="Agrupar 122"/>
          <p:cNvGrpSpPr/>
          <p:nvPr/>
        </p:nvGrpSpPr>
        <p:grpSpPr>
          <a:xfrm>
            <a:off x="1362149" y="6345312"/>
            <a:ext cx="172659" cy="128388"/>
            <a:chOff x="1541520" y="6750720"/>
            <a:chExt cx="252720" cy="187920"/>
          </a:xfrm>
        </p:grpSpPr>
        <p:sp>
          <p:nvSpPr>
            <p:cNvPr id="96" name="Conector recto 123"/>
            <p:cNvSpPr/>
            <p:nvPr/>
          </p:nvSpPr>
          <p:spPr>
            <a:xfrm flipV="1">
              <a:off x="1544400" y="6750720"/>
              <a:ext cx="1440" cy="187920"/>
            </a:xfrm>
            <a:prstGeom prst="line">
              <a:avLst/>
            </a:prstGeom>
            <a:ln w="9525">
              <a:solidFill>
                <a:srgbClr val="000000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45000" rIns="90000" bIns="45000" anchor="t" anchorCtr="1">
              <a:noAutofit/>
            </a:bodyPr>
            <a:lstStyle/>
            <a:p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Conector recto de flecha 124"/>
            <p:cNvSpPr/>
            <p:nvPr/>
          </p:nvSpPr>
          <p:spPr>
            <a:xfrm>
              <a:off x="1541520" y="6757200"/>
              <a:ext cx="252720" cy="720"/>
            </a:xfrm>
            <a:custGeom>
              <a:avLst/>
              <a:gdLst/>
              <a:ahLst/>
              <a:cxnLst/>
              <a:rect l="l" t="t" r="r" b="b"/>
              <a:pathLst>
                <a:path w="21600" h="21600">
                  <a:moveTo>
                    <a:pt x="0" y="0"/>
                  </a:moveTo>
                  <a:lnTo>
                    <a:pt x="21600" y="2160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round/>
              <a:tailEnd type="triangl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-44280" rIns="90000" bIns="-44280" anchor="t">
              <a:noAutofit/>
            </a:bodyPr>
            <a:lstStyle/>
            <a:p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8" name="Agrupar 152"/>
          <p:cNvGrpSpPr/>
          <p:nvPr/>
        </p:nvGrpSpPr>
        <p:grpSpPr>
          <a:xfrm>
            <a:off x="1883569" y="6718915"/>
            <a:ext cx="561510" cy="31236"/>
            <a:chOff x="2304720" y="7297560"/>
            <a:chExt cx="821880" cy="45720"/>
          </a:xfrm>
          <a:effectLst/>
        </p:grpSpPr>
        <p:sp>
          <p:nvSpPr>
            <p:cNvPr id="99" name="Forma libre 140"/>
            <p:cNvSpPr/>
            <p:nvPr/>
          </p:nvSpPr>
          <p:spPr>
            <a:xfrm>
              <a:off x="2304720" y="7301520"/>
              <a:ext cx="276840" cy="41760"/>
            </a:xfrm>
            <a:custGeom>
              <a:avLst/>
              <a:gdLst>
                <a:gd name="textAreaLeft" fmla="*/ 0 w 276840"/>
                <a:gd name="textAreaRight" fmla="*/ 277200 w 276840"/>
                <a:gd name="textAreaTop" fmla="*/ 0 h 41760"/>
                <a:gd name="textAreaBottom" fmla="*/ 42120 h 41760"/>
              </a:gdLst>
              <a:ahLst/>
              <a:cxnLst/>
              <a:rect l="textAreaLeft" t="textAreaTop" r="textAreaRight" b="textAreaBottom"/>
              <a:pathLst>
                <a:path w="336550" h="77381">
                  <a:moveTo>
                    <a:pt x="0" y="39049"/>
                  </a:moveTo>
                  <a:cubicBezTo>
                    <a:pt x="15081" y="17088"/>
                    <a:pt x="30163" y="-4872"/>
                    <a:pt x="50800" y="949"/>
                  </a:cubicBezTo>
                  <a:cubicBezTo>
                    <a:pt x="71437" y="6770"/>
                    <a:pt x="100013" y="73974"/>
                    <a:pt x="123825" y="73974"/>
                  </a:cubicBezTo>
                  <a:cubicBezTo>
                    <a:pt x="147637" y="73974"/>
                    <a:pt x="168275" y="420"/>
                    <a:pt x="193675" y="949"/>
                  </a:cubicBezTo>
                  <a:cubicBezTo>
                    <a:pt x="219075" y="1478"/>
                    <a:pt x="252413" y="72916"/>
                    <a:pt x="276225" y="77149"/>
                  </a:cubicBezTo>
                  <a:cubicBezTo>
                    <a:pt x="300037" y="81382"/>
                    <a:pt x="336550" y="26349"/>
                    <a:pt x="336550" y="26349"/>
                  </a:cubicBezTo>
                </a:path>
              </a:pathLst>
            </a:custGeom>
            <a:noFill/>
            <a:ln w="57150">
              <a:solidFill>
                <a:srgbClr val="C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-2880" rIns="90000" bIns="-288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Forma libre 141"/>
            <p:cNvSpPr/>
            <p:nvPr/>
          </p:nvSpPr>
          <p:spPr>
            <a:xfrm>
              <a:off x="2577240" y="7299720"/>
              <a:ext cx="276840" cy="41760"/>
            </a:xfrm>
            <a:custGeom>
              <a:avLst/>
              <a:gdLst>
                <a:gd name="textAreaLeft" fmla="*/ 0 w 276840"/>
                <a:gd name="textAreaRight" fmla="*/ 277200 w 276840"/>
                <a:gd name="textAreaTop" fmla="*/ 0 h 41760"/>
                <a:gd name="textAreaBottom" fmla="*/ 42120 h 41760"/>
              </a:gdLst>
              <a:ahLst/>
              <a:cxnLst/>
              <a:rect l="textAreaLeft" t="textAreaTop" r="textAreaRight" b="textAreaBottom"/>
              <a:pathLst>
                <a:path w="336550" h="77381">
                  <a:moveTo>
                    <a:pt x="0" y="39049"/>
                  </a:moveTo>
                  <a:cubicBezTo>
                    <a:pt x="15081" y="17088"/>
                    <a:pt x="30163" y="-4872"/>
                    <a:pt x="50800" y="949"/>
                  </a:cubicBezTo>
                  <a:cubicBezTo>
                    <a:pt x="71437" y="6770"/>
                    <a:pt x="100013" y="73974"/>
                    <a:pt x="123825" y="73974"/>
                  </a:cubicBezTo>
                  <a:cubicBezTo>
                    <a:pt x="147637" y="73974"/>
                    <a:pt x="168275" y="420"/>
                    <a:pt x="193675" y="949"/>
                  </a:cubicBezTo>
                  <a:cubicBezTo>
                    <a:pt x="219075" y="1478"/>
                    <a:pt x="252413" y="72916"/>
                    <a:pt x="276225" y="77149"/>
                  </a:cubicBezTo>
                  <a:cubicBezTo>
                    <a:pt x="300037" y="81382"/>
                    <a:pt x="336550" y="26349"/>
                    <a:pt x="336550" y="26349"/>
                  </a:cubicBezTo>
                </a:path>
              </a:pathLst>
            </a:custGeom>
            <a:noFill/>
            <a:ln w="57150">
              <a:solidFill>
                <a:srgbClr val="C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-2880" rIns="90000" bIns="-288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Forma libre 142"/>
            <p:cNvSpPr/>
            <p:nvPr/>
          </p:nvSpPr>
          <p:spPr>
            <a:xfrm>
              <a:off x="2849760" y="7297560"/>
              <a:ext cx="276840" cy="41760"/>
            </a:xfrm>
            <a:custGeom>
              <a:avLst/>
              <a:gdLst>
                <a:gd name="textAreaLeft" fmla="*/ 0 w 276840"/>
                <a:gd name="textAreaRight" fmla="*/ 277200 w 276840"/>
                <a:gd name="textAreaTop" fmla="*/ 0 h 41760"/>
                <a:gd name="textAreaBottom" fmla="*/ 42120 h 41760"/>
              </a:gdLst>
              <a:ahLst/>
              <a:cxnLst/>
              <a:rect l="textAreaLeft" t="textAreaTop" r="textAreaRight" b="textAreaBottom"/>
              <a:pathLst>
                <a:path w="336550" h="77381">
                  <a:moveTo>
                    <a:pt x="0" y="39049"/>
                  </a:moveTo>
                  <a:cubicBezTo>
                    <a:pt x="15081" y="17088"/>
                    <a:pt x="30163" y="-4872"/>
                    <a:pt x="50800" y="949"/>
                  </a:cubicBezTo>
                  <a:cubicBezTo>
                    <a:pt x="71437" y="6770"/>
                    <a:pt x="100013" y="73974"/>
                    <a:pt x="123825" y="73974"/>
                  </a:cubicBezTo>
                  <a:cubicBezTo>
                    <a:pt x="147637" y="73974"/>
                    <a:pt x="168275" y="420"/>
                    <a:pt x="193675" y="949"/>
                  </a:cubicBezTo>
                  <a:cubicBezTo>
                    <a:pt x="219075" y="1478"/>
                    <a:pt x="252413" y="72916"/>
                    <a:pt x="276225" y="77149"/>
                  </a:cubicBezTo>
                  <a:cubicBezTo>
                    <a:pt x="300037" y="81382"/>
                    <a:pt x="336550" y="26349"/>
                    <a:pt x="336550" y="26349"/>
                  </a:cubicBezTo>
                </a:path>
              </a:pathLst>
            </a:custGeom>
            <a:noFill/>
            <a:ln w="57150">
              <a:solidFill>
                <a:srgbClr val="C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-2880" rIns="90000" bIns="-288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2" name="Agrupar 151"/>
          <p:cNvGrpSpPr/>
          <p:nvPr/>
        </p:nvGrpSpPr>
        <p:grpSpPr>
          <a:xfrm>
            <a:off x="1361658" y="6823199"/>
            <a:ext cx="1072599" cy="35171"/>
            <a:chOff x="1540800" y="7450200"/>
            <a:chExt cx="1569960" cy="51480"/>
          </a:xfrm>
        </p:grpSpPr>
        <p:grpSp>
          <p:nvGrpSpPr>
            <p:cNvPr id="103" name="Agrupar 145"/>
            <p:cNvGrpSpPr/>
            <p:nvPr/>
          </p:nvGrpSpPr>
          <p:grpSpPr>
            <a:xfrm>
              <a:off x="1540800" y="7454160"/>
              <a:ext cx="632520" cy="47520"/>
              <a:chOff x="1540800" y="7454160"/>
              <a:chExt cx="632520" cy="47520"/>
            </a:xfrm>
          </p:grpSpPr>
          <p:sp>
            <p:nvSpPr>
              <p:cNvPr id="104" name="Forma libre 149"/>
              <p:cNvSpPr/>
              <p:nvPr/>
            </p:nvSpPr>
            <p:spPr>
              <a:xfrm>
                <a:off x="1540800" y="7455960"/>
                <a:ext cx="318600" cy="45720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Forma libre 150"/>
              <p:cNvSpPr/>
              <p:nvPr/>
            </p:nvSpPr>
            <p:spPr>
              <a:xfrm>
                <a:off x="1854720" y="7454160"/>
                <a:ext cx="318600" cy="45720"/>
              </a:xfrm>
              <a:custGeom>
                <a:avLst/>
                <a:gdLst>
                  <a:gd name="textAreaLeft" fmla="*/ 0 w 318600"/>
                  <a:gd name="textAreaRight" fmla="*/ 318960 w 318600"/>
                  <a:gd name="textAreaTop" fmla="*/ 0 h 45720"/>
                  <a:gd name="textAreaBottom" fmla="*/ 46080 h 45720"/>
                </a:gdLst>
                <a:ahLst/>
                <a:cxnLst/>
                <a:rect l="textAreaLeft" t="textAreaTop" r="textAreaRight" b="textAreaBottom"/>
                <a:pathLst>
                  <a:path w="336550" h="77381">
                    <a:moveTo>
                      <a:pt x="0" y="39049"/>
                    </a:moveTo>
                    <a:cubicBezTo>
                      <a:pt x="15081" y="17088"/>
                      <a:pt x="30163" y="-4872"/>
                      <a:pt x="50800" y="949"/>
                    </a:cubicBezTo>
                    <a:cubicBezTo>
                      <a:pt x="71437" y="6770"/>
                      <a:pt x="100013" y="73974"/>
                      <a:pt x="123825" y="73974"/>
                    </a:cubicBezTo>
                    <a:cubicBezTo>
                      <a:pt x="147637" y="73974"/>
                      <a:pt x="168275" y="420"/>
                      <a:pt x="193675" y="949"/>
                    </a:cubicBezTo>
                    <a:cubicBezTo>
                      <a:pt x="219075" y="1478"/>
                      <a:pt x="252413" y="72916"/>
                      <a:pt x="276225" y="77149"/>
                    </a:cubicBezTo>
                    <a:cubicBezTo>
                      <a:pt x="300037" y="81382"/>
                      <a:pt x="336550" y="26349"/>
                      <a:pt x="336550" y="26349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/>
            </p:style>
            <p:txBody>
              <a:bodyPr lIns="90000" tIns="1080" rIns="90000" bIns="108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s-ES" sz="1800" b="0" strike="noStrike" spc="-1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06" name="Forma libre 146"/>
            <p:cNvSpPr/>
            <p:nvPr/>
          </p:nvSpPr>
          <p:spPr>
            <a:xfrm>
              <a:off x="2164680" y="7454160"/>
              <a:ext cx="318600" cy="45720"/>
            </a:xfrm>
            <a:custGeom>
              <a:avLst/>
              <a:gdLst>
                <a:gd name="textAreaLeft" fmla="*/ 0 w 318600"/>
                <a:gd name="textAreaRight" fmla="*/ 318960 w 318600"/>
                <a:gd name="textAreaTop" fmla="*/ 0 h 45720"/>
                <a:gd name="textAreaBottom" fmla="*/ 46080 h 45720"/>
              </a:gdLst>
              <a:ahLst/>
              <a:cxnLst/>
              <a:rect l="textAreaLeft" t="textAreaTop" r="textAreaRight" b="textAreaBottom"/>
              <a:pathLst>
                <a:path w="336550" h="77381">
                  <a:moveTo>
                    <a:pt x="0" y="39049"/>
                  </a:moveTo>
                  <a:cubicBezTo>
                    <a:pt x="15081" y="17088"/>
                    <a:pt x="30163" y="-4872"/>
                    <a:pt x="50800" y="949"/>
                  </a:cubicBezTo>
                  <a:cubicBezTo>
                    <a:pt x="71437" y="6770"/>
                    <a:pt x="100013" y="73974"/>
                    <a:pt x="123825" y="73974"/>
                  </a:cubicBezTo>
                  <a:cubicBezTo>
                    <a:pt x="147637" y="73974"/>
                    <a:pt x="168275" y="420"/>
                    <a:pt x="193675" y="949"/>
                  </a:cubicBezTo>
                  <a:cubicBezTo>
                    <a:pt x="219075" y="1478"/>
                    <a:pt x="252413" y="72916"/>
                    <a:pt x="276225" y="77149"/>
                  </a:cubicBezTo>
                  <a:cubicBezTo>
                    <a:pt x="300037" y="81382"/>
                    <a:pt x="336550" y="26349"/>
                    <a:pt x="336550" y="26349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1080" rIns="90000" bIns="108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Forma libre 147"/>
            <p:cNvSpPr/>
            <p:nvPr/>
          </p:nvSpPr>
          <p:spPr>
            <a:xfrm>
              <a:off x="2478600" y="7452360"/>
              <a:ext cx="318600" cy="45720"/>
            </a:xfrm>
            <a:custGeom>
              <a:avLst/>
              <a:gdLst>
                <a:gd name="textAreaLeft" fmla="*/ 0 w 318600"/>
                <a:gd name="textAreaRight" fmla="*/ 318960 w 318600"/>
                <a:gd name="textAreaTop" fmla="*/ 0 h 45720"/>
                <a:gd name="textAreaBottom" fmla="*/ 46080 h 45720"/>
              </a:gdLst>
              <a:ahLst/>
              <a:cxnLst/>
              <a:rect l="textAreaLeft" t="textAreaTop" r="textAreaRight" b="textAreaBottom"/>
              <a:pathLst>
                <a:path w="336550" h="77381">
                  <a:moveTo>
                    <a:pt x="0" y="39049"/>
                  </a:moveTo>
                  <a:cubicBezTo>
                    <a:pt x="15081" y="17088"/>
                    <a:pt x="30163" y="-4872"/>
                    <a:pt x="50800" y="949"/>
                  </a:cubicBezTo>
                  <a:cubicBezTo>
                    <a:pt x="71437" y="6770"/>
                    <a:pt x="100013" y="73974"/>
                    <a:pt x="123825" y="73974"/>
                  </a:cubicBezTo>
                  <a:cubicBezTo>
                    <a:pt x="147637" y="73974"/>
                    <a:pt x="168275" y="420"/>
                    <a:pt x="193675" y="949"/>
                  </a:cubicBezTo>
                  <a:cubicBezTo>
                    <a:pt x="219075" y="1478"/>
                    <a:pt x="252413" y="72916"/>
                    <a:pt x="276225" y="77149"/>
                  </a:cubicBezTo>
                  <a:cubicBezTo>
                    <a:pt x="300037" y="81382"/>
                    <a:pt x="336550" y="26349"/>
                    <a:pt x="336550" y="26349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1080" rIns="90000" bIns="108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Forma libre 148"/>
            <p:cNvSpPr/>
            <p:nvPr/>
          </p:nvSpPr>
          <p:spPr>
            <a:xfrm>
              <a:off x="2792160" y="7450200"/>
              <a:ext cx="318600" cy="45720"/>
            </a:xfrm>
            <a:custGeom>
              <a:avLst/>
              <a:gdLst>
                <a:gd name="textAreaLeft" fmla="*/ 0 w 318600"/>
                <a:gd name="textAreaRight" fmla="*/ 318960 w 318600"/>
                <a:gd name="textAreaTop" fmla="*/ 0 h 45720"/>
                <a:gd name="textAreaBottom" fmla="*/ 46080 h 45720"/>
              </a:gdLst>
              <a:ahLst/>
              <a:cxnLst/>
              <a:rect l="textAreaLeft" t="textAreaTop" r="textAreaRight" b="textAreaBottom"/>
              <a:pathLst>
                <a:path w="336550" h="77381">
                  <a:moveTo>
                    <a:pt x="0" y="39049"/>
                  </a:moveTo>
                  <a:cubicBezTo>
                    <a:pt x="15081" y="17088"/>
                    <a:pt x="30163" y="-4872"/>
                    <a:pt x="50800" y="949"/>
                  </a:cubicBezTo>
                  <a:cubicBezTo>
                    <a:pt x="71437" y="6770"/>
                    <a:pt x="100013" y="73974"/>
                    <a:pt x="123825" y="73974"/>
                  </a:cubicBezTo>
                  <a:cubicBezTo>
                    <a:pt x="147637" y="73974"/>
                    <a:pt x="168275" y="420"/>
                    <a:pt x="193675" y="949"/>
                  </a:cubicBezTo>
                  <a:cubicBezTo>
                    <a:pt x="219075" y="1478"/>
                    <a:pt x="252413" y="72916"/>
                    <a:pt x="276225" y="77149"/>
                  </a:cubicBezTo>
                  <a:cubicBezTo>
                    <a:pt x="300037" y="81382"/>
                    <a:pt x="336550" y="26349"/>
                    <a:pt x="336550" y="26349"/>
                  </a:cubicBezTo>
                </a:path>
              </a:pathLst>
            </a:cu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/>
          </p:style>
          <p:txBody>
            <a:bodyPr lIns="90000" tIns="1080" rIns="90000" bIns="108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s-ES" sz="1800" b="0" strike="noStrike" spc="-1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9" name="Conector recto 153"/>
          <p:cNvSpPr/>
          <p:nvPr/>
        </p:nvSpPr>
        <p:spPr>
          <a:xfrm>
            <a:off x="1361904" y="6473699"/>
            <a:ext cx="246" cy="380736"/>
          </a:xfrm>
          <a:prstGeom prst="line">
            <a:avLst/>
          </a:prstGeom>
          <a:ln w="6350">
            <a:solidFill>
              <a:srgbClr val="000000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/>
        </p:style>
        <p:txBody>
          <a:bodyPr lIns="90000" tIns="45000" rIns="90000" bIns="45000" anchor="t" anchorCtr="1">
            <a:noAutofit/>
          </a:bodyPr>
          <a:lstStyle/>
          <a:p>
            <a:endParaRPr lang="es-E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Conector recto 155"/>
          <p:cNvSpPr/>
          <p:nvPr/>
        </p:nvSpPr>
        <p:spPr>
          <a:xfrm>
            <a:off x="1883323" y="6480832"/>
            <a:ext cx="246" cy="255054"/>
          </a:xfrm>
          <a:prstGeom prst="line">
            <a:avLst/>
          </a:prstGeom>
          <a:ln w="6350">
            <a:solidFill>
              <a:srgbClr val="000000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/>
        </p:style>
        <p:txBody>
          <a:bodyPr lIns="90000" tIns="45000" rIns="90000" bIns="45000" anchor="t" anchorCtr="1">
            <a:noAutofit/>
          </a:bodyPr>
          <a:lstStyle/>
          <a:p>
            <a:endParaRPr lang="es-E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CuadroTexto 157"/>
          <p:cNvSpPr/>
          <p:nvPr/>
        </p:nvSpPr>
        <p:spPr>
          <a:xfrm>
            <a:off x="2394412" y="6649556"/>
            <a:ext cx="532732" cy="198602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s-ES_tradnl" sz="700" b="0" strike="noStrike" spc="-1" dirty="0">
                <a:solidFill>
                  <a:srgbClr val="000000"/>
                </a:solidFill>
                <a:latin typeface="Arial"/>
              </a:rPr>
              <a:t>1.1 Kb</a:t>
            </a:r>
            <a:endParaRPr lang="es-ES" sz="7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CuadroTexto 158"/>
          <p:cNvSpPr/>
          <p:nvPr/>
        </p:nvSpPr>
        <p:spPr>
          <a:xfrm>
            <a:off x="2394412" y="6760727"/>
            <a:ext cx="501103" cy="198602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s-ES_tradnl" sz="700" b="0" strike="noStrike" spc="-1" dirty="0">
                <a:solidFill>
                  <a:srgbClr val="000000"/>
                </a:solidFill>
                <a:latin typeface="Arial"/>
              </a:rPr>
              <a:t>2.1 Kb</a:t>
            </a:r>
            <a:endParaRPr lang="es-ES" sz="7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Conector recto 159"/>
          <p:cNvSpPr/>
          <p:nvPr/>
        </p:nvSpPr>
        <p:spPr>
          <a:xfrm>
            <a:off x="1907672" y="6468780"/>
            <a:ext cx="246" cy="255054"/>
          </a:xfrm>
          <a:prstGeom prst="line">
            <a:avLst/>
          </a:prstGeom>
          <a:ln w="6350">
            <a:solidFill>
              <a:srgbClr val="000000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/>
        </p:style>
        <p:txBody>
          <a:bodyPr lIns="90000" tIns="45000" rIns="90000" bIns="45000" anchor="t" anchorCtr="1">
            <a:noAutofit/>
          </a:bodyPr>
          <a:lstStyle/>
          <a:p>
            <a:endParaRPr lang="es-E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4A91698E-01B3-0145-B933-725C3375CE49}"/>
              </a:ext>
            </a:extLst>
          </p:cNvPr>
          <p:cNvSpPr txBox="1"/>
          <p:nvPr/>
        </p:nvSpPr>
        <p:spPr>
          <a:xfrm>
            <a:off x="1119251" y="5960482"/>
            <a:ext cx="5084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/>
              <a:t>Apo-Zur</a:t>
            </a:r>
            <a:endParaRPr lang="es-ES" sz="700" dirty="0"/>
          </a:p>
        </p:txBody>
      </p:sp>
      <p:sp>
        <p:nvSpPr>
          <p:cNvPr id="427" name="Forma libre 161">
            <a:extLst>
              <a:ext uri="{FF2B5EF4-FFF2-40B4-BE49-F238E27FC236}">
                <a16:creationId xmlns:a16="http://schemas.microsoft.com/office/drawing/2014/main" id="{7B23C2F6-2465-F6F3-0F4E-D48FAE8BFE7C}"/>
              </a:ext>
            </a:extLst>
          </p:cNvPr>
          <p:cNvSpPr/>
          <p:nvPr/>
        </p:nvSpPr>
        <p:spPr>
          <a:xfrm>
            <a:off x="1986390" y="4580896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1" name="Forma libre 165">
            <a:extLst>
              <a:ext uri="{FF2B5EF4-FFF2-40B4-BE49-F238E27FC236}">
                <a16:creationId xmlns:a16="http://schemas.microsoft.com/office/drawing/2014/main" id="{2112EE91-EB81-2931-3C6D-376064A308E9}"/>
              </a:ext>
            </a:extLst>
          </p:cNvPr>
          <p:cNvSpPr/>
          <p:nvPr/>
        </p:nvSpPr>
        <p:spPr>
          <a:xfrm>
            <a:off x="2797800" y="4518668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4" name="Forma libre 169">
            <a:extLst>
              <a:ext uri="{FF2B5EF4-FFF2-40B4-BE49-F238E27FC236}">
                <a16:creationId xmlns:a16="http://schemas.microsoft.com/office/drawing/2014/main" id="{B22C6C74-E776-AF44-7494-4AB420D57AA8}"/>
              </a:ext>
            </a:extLst>
          </p:cNvPr>
          <p:cNvSpPr/>
          <p:nvPr/>
        </p:nvSpPr>
        <p:spPr>
          <a:xfrm>
            <a:off x="3477428" y="4352937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436" name="Grupo 172">
            <a:extLst>
              <a:ext uri="{FF2B5EF4-FFF2-40B4-BE49-F238E27FC236}">
                <a16:creationId xmlns:a16="http://schemas.microsoft.com/office/drawing/2014/main" id="{4F99A89C-B760-7998-DE2E-0110898EEF18}"/>
              </a:ext>
            </a:extLst>
          </p:cNvPr>
          <p:cNvGrpSpPr/>
          <p:nvPr/>
        </p:nvGrpSpPr>
        <p:grpSpPr>
          <a:xfrm>
            <a:off x="4381060" y="4597394"/>
            <a:ext cx="195908" cy="255927"/>
            <a:chOff x="3552654" y="5162545"/>
            <a:chExt cx="195908" cy="255927"/>
          </a:xfrm>
        </p:grpSpPr>
        <p:sp>
          <p:nvSpPr>
            <p:cNvPr id="437" name="Forma libre 173">
              <a:extLst>
                <a:ext uri="{FF2B5EF4-FFF2-40B4-BE49-F238E27FC236}">
                  <a16:creationId xmlns:a16="http://schemas.microsoft.com/office/drawing/2014/main" id="{BFDA7572-3434-4413-8805-BA2668F304FB}"/>
                </a:ext>
              </a:extLst>
            </p:cNvPr>
            <p:cNvSpPr/>
            <p:nvPr/>
          </p:nvSpPr>
          <p:spPr>
            <a:xfrm>
              <a:off x="3564469" y="5197645"/>
              <a:ext cx="184093" cy="220827"/>
            </a:xfrm>
            <a:custGeom>
              <a:avLst/>
              <a:gdLst>
                <a:gd name="connsiteX0" fmla="*/ 234987 w 535666"/>
                <a:gd name="connsiteY0" fmla="*/ 0 h 642553"/>
                <a:gd name="connsiteX1" fmla="*/ 193580 w 535666"/>
                <a:gd name="connsiteY1" fmla="*/ 62110 h 642553"/>
                <a:gd name="connsiteX2" fmla="*/ 131470 w 535666"/>
                <a:gd name="connsiteY2" fmla="*/ 72462 h 642553"/>
                <a:gd name="connsiteX3" fmla="*/ 38305 w 535666"/>
                <a:gd name="connsiteY3" fmla="*/ 131121 h 642553"/>
                <a:gd name="connsiteX4" fmla="*/ 72810 w 535666"/>
                <a:gd name="connsiteY4" fmla="*/ 210484 h 642553"/>
                <a:gd name="connsiteX5" fmla="*/ 134921 w 535666"/>
                <a:gd name="connsiteY5" fmla="*/ 200133 h 642553"/>
                <a:gd name="connsiteX6" fmla="*/ 162525 w 535666"/>
                <a:gd name="connsiteY6" fmla="*/ 296748 h 642553"/>
                <a:gd name="connsiteX7" fmla="*/ 269493 w 535666"/>
                <a:gd name="connsiteY7" fmla="*/ 334705 h 642553"/>
                <a:gd name="connsiteX8" fmla="*/ 276394 w 535666"/>
                <a:gd name="connsiteY8" fmla="*/ 207034 h 642553"/>
                <a:gd name="connsiteX9" fmla="*/ 417867 w 535666"/>
                <a:gd name="connsiteY9" fmla="*/ 131121 h 642553"/>
                <a:gd name="connsiteX10" fmla="*/ 535186 w 535666"/>
                <a:gd name="connsiteY10" fmla="*/ 320902 h 642553"/>
                <a:gd name="connsiteX11" fmla="*/ 373010 w 535666"/>
                <a:gd name="connsiteY11" fmla="*/ 431320 h 642553"/>
                <a:gd name="connsiteX12" fmla="*/ 407515 w 535666"/>
                <a:gd name="connsiteY12" fmla="*/ 617651 h 642553"/>
                <a:gd name="connsiteX13" fmla="*/ 110767 w 535666"/>
                <a:gd name="connsiteY13" fmla="*/ 628003 h 642553"/>
                <a:gd name="connsiteX14" fmla="*/ 197031 w 535666"/>
                <a:gd name="connsiteY14" fmla="*/ 500332 h 642553"/>
                <a:gd name="connsiteX15" fmla="*/ 3799 w 535666"/>
                <a:gd name="connsiteY15" fmla="*/ 348507 h 642553"/>
                <a:gd name="connsiteX16" fmla="*/ 65909 w 535666"/>
                <a:gd name="connsiteY16" fmla="*/ 213935 h 642553"/>
                <a:gd name="connsiteX17" fmla="*/ 31404 w 535666"/>
                <a:gd name="connsiteY17" fmla="*/ 138022 h 642553"/>
                <a:gd name="connsiteX18" fmla="*/ 134921 w 535666"/>
                <a:gd name="connsiteY18" fmla="*/ 72462 h 642553"/>
                <a:gd name="connsiteX19" fmla="*/ 207383 w 535666"/>
                <a:gd name="connsiteY19" fmla="*/ 62110 h 642553"/>
                <a:gd name="connsiteX20" fmla="*/ 234987 w 535666"/>
                <a:gd name="connsiteY20" fmla="*/ 0 h 6425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535666" h="642553">
                  <a:moveTo>
                    <a:pt x="234987" y="0"/>
                  </a:moveTo>
                  <a:cubicBezTo>
                    <a:pt x="232687" y="0"/>
                    <a:pt x="210833" y="50033"/>
                    <a:pt x="193580" y="62110"/>
                  </a:cubicBezTo>
                  <a:cubicBezTo>
                    <a:pt x="176327" y="74187"/>
                    <a:pt x="157349" y="60960"/>
                    <a:pt x="131470" y="72462"/>
                  </a:cubicBezTo>
                  <a:cubicBezTo>
                    <a:pt x="105591" y="83964"/>
                    <a:pt x="48082" y="108117"/>
                    <a:pt x="38305" y="131121"/>
                  </a:cubicBezTo>
                  <a:cubicBezTo>
                    <a:pt x="28528" y="154125"/>
                    <a:pt x="56707" y="198982"/>
                    <a:pt x="72810" y="210484"/>
                  </a:cubicBezTo>
                  <a:cubicBezTo>
                    <a:pt x="88913" y="221986"/>
                    <a:pt x="119969" y="185756"/>
                    <a:pt x="134921" y="200133"/>
                  </a:cubicBezTo>
                  <a:cubicBezTo>
                    <a:pt x="149873" y="214510"/>
                    <a:pt x="140096" y="274319"/>
                    <a:pt x="162525" y="296748"/>
                  </a:cubicBezTo>
                  <a:cubicBezTo>
                    <a:pt x="184954" y="319177"/>
                    <a:pt x="250515" y="349657"/>
                    <a:pt x="269493" y="334705"/>
                  </a:cubicBezTo>
                  <a:cubicBezTo>
                    <a:pt x="288471" y="319753"/>
                    <a:pt x="251665" y="240965"/>
                    <a:pt x="276394" y="207034"/>
                  </a:cubicBezTo>
                  <a:cubicBezTo>
                    <a:pt x="301123" y="173103"/>
                    <a:pt x="374735" y="112143"/>
                    <a:pt x="417867" y="131121"/>
                  </a:cubicBezTo>
                  <a:cubicBezTo>
                    <a:pt x="460999" y="150099"/>
                    <a:pt x="542662" y="270869"/>
                    <a:pt x="535186" y="320902"/>
                  </a:cubicBezTo>
                  <a:cubicBezTo>
                    <a:pt x="527710" y="370935"/>
                    <a:pt x="394288" y="381862"/>
                    <a:pt x="373010" y="431320"/>
                  </a:cubicBezTo>
                  <a:cubicBezTo>
                    <a:pt x="351732" y="480778"/>
                    <a:pt x="451222" y="584870"/>
                    <a:pt x="407515" y="617651"/>
                  </a:cubicBezTo>
                  <a:cubicBezTo>
                    <a:pt x="363808" y="650432"/>
                    <a:pt x="145848" y="647556"/>
                    <a:pt x="110767" y="628003"/>
                  </a:cubicBezTo>
                  <a:cubicBezTo>
                    <a:pt x="75686" y="608450"/>
                    <a:pt x="214859" y="546915"/>
                    <a:pt x="197031" y="500332"/>
                  </a:cubicBezTo>
                  <a:cubicBezTo>
                    <a:pt x="179203" y="453749"/>
                    <a:pt x="25653" y="396240"/>
                    <a:pt x="3799" y="348507"/>
                  </a:cubicBezTo>
                  <a:cubicBezTo>
                    <a:pt x="-18055" y="300774"/>
                    <a:pt x="61308" y="249016"/>
                    <a:pt x="65909" y="213935"/>
                  </a:cubicBezTo>
                  <a:cubicBezTo>
                    <a:pt x="70510" y="178854"/>
                    <a:pt x="19902" y="161601"/>
                    <a:pt x="31404" y="138022"/>
                  </a:cubicBezTo>
                  <a:cubicBezTo>
                    <a:pt x="42906" y="114443"/>
                    <a:pt x="105591" y="85114"/>
                    <a:pt x="134921" y="72462"/>
                  </a:cubicBezTo>
                  <a:cubicBezTo>
                    <a:pt x="164251" y="59810"/>
                    <a:pt x="191281" y="71887"/>
                    <a:pt x="207383" y="62110"/>
                  </a:cubicBezTo>
                  <a:cubicBezTo>
                    <a:pt x="223485" y="52333"/>
                    <a:pt x="237287" y="0"/>
                    <a:pt x="234987" y="0"/>
                  </a:cubicBezTo>
                  <a:close/>
                </a:path>
              </a:pathLst>
            </a:custGeom>
            <a:gradFill flip="none" rotWithShape="1">
              <a:gsLst>
                <a:gs pos="0">
                  <a:srgbClr val="780000"/>
                </a:gs>
                <a:gs pos="60000">
                  <a:srgbClr val="C00000"/>
                </a:gs>
                <a:gs pos="100000">
                  <a:srgbClr val="C00000">
                    <a:tint val="23500"/>
                    <a:satMod val="160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38" name="Oval 84">
              <a:extLst>
                <a:ext uri="{FF2B5EF4-FFF2-40B4-BE49-F238E27FC236}">
                  <a16:creationId xmlns:a16="http://schemas.microsoft.com/office/drawing/2014/main" id="{B165078B-AECE-3748-2D5D-C310DA0617DF}"/>
                </a:ext>
              </a:extLst>
            </p:cNvPr>
            <p:cNvSpPr/>
            <p:nvPr/>
          </p:nvSpPr>
          <p:spPr>
            <a:xfrm flipH="1">
              <a:off x="3552654" y="516254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439" name="Oval 84">
              <a:extLst>
                <a:ext uri="{FF2B5EF4-FFF2-40B4-BE49-F238E27FC236}">
                  <a16:creationId xmlns:a16="http://schemas.microsoft.com/office/drawing/2014/main" id="{713BA349-5882-3833-CE5B-6540459267D1}"/>
                </a:ext>
              </a:extLst>
            </p:cNvPr>
            <p:cNvSpPr/>
            <p:nvPr/>
          </p:nvSpPr>
          <p:spPr>
            <a:xfrm flipH="1">
              <a:off x="3618773" y="524839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</p:grpSp>
      <p:sp>
        <p:nvSpPr>
          <p:cNvPr id="440" name="CuadroTexto 198">
            <a:extLst>
              <a:ext uri="{FF2B5EF4-FFF2-40B4-BE49-F238E27FC236}">
                <a16:creationId xmlns:a16="http://schemas.microsoft.com/office/drawing/2014/main" id="{C1EA1A62-9A15-CEC5-20F2-361F7FA805DF}"/>
              </a:ext>
            </a:extLst>
          </p:cNvPr>
          <p:cNvSpPr txBox="1"/>
          <p:nvPr/>
        </p:nvSpPr>
        <p:spPr>
          <a:xfrm>
            <a:off x="4505795" y="4739174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441" name="CuadroTexto 199">
            <a:extLst>
              <a:ext uri="{FF2B5EF4-FFF2-40B4-BE49-F238E27FC236}">
                <a16:creationId xmlns:a16="http://schemas.microsoft.com/office/drawing/2014/main" id="{853BC067-5B02-F4EB-02C6-13E52F1B52C1}"/>
              </a:ext>
            </a:extLst>
          </p:cNvPr>
          <p:cNvSpPr txBox="1"/>
          <p:nvPr/>
        </p:nvSpPr>
        <p:spPr>
          <a:xfrm>
            <a:off x="3571532" y="4446594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442" name="CuadroTexto 200">
            <a:extLst>
              <a:ext uri="{FF2B5EF4-FFF2-40B4-BE49-F238E27FC236}">
                <a16:creationId xmlns:a16="http://schemas.microsoft.com/office/drawing/2014/main" id="{E2CEE4D7-9B02-BF75-0D44-D9278E3367B9}"/>
              </a:ext>
            </a:extLst>
          </p:cNvPr>
          <p:cNvSpPr txBox="1"/>
          <p:nvPr/>
        </p:nvSpPr>
        <p:spPr>
          <a:xfrm>
            <a:off x="2880186" y="4591882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443" name="CuadroTexto 201">
            <a:extLst>
              <a:ext uri="{FF2B5EF4-FFF2-40B4-BE49-F238E27FC236}">
                <a16:creationId xmlns:a16="http://schemas.microsoft.com/office/drawing/2014/main" id="{E697DD00-E5FD-EB49-F107-1FE09A79A3F4}"/>
              </a:ext>
            </a:extLst>
          </p:cNvPr>
          <p:cNvSpPr txBox="1"/>
          <p:nvPr/>
        </p:nvSpPr>
        <p:spPr>
          <a:xfrm>
            <a:off x="1895911" y="4754656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463" name="Forma libre 161">
            <a:extLst>
              <a:ext uri="{FF2B5EF4-FFF2-40B4-BE49-F238E27FC236}">
                <a16:creationId xmlns:a16="http://schemas.microsoft.com/office/drawing/2014/main" id="{33FA1195-4F07-4A10-0684-05CBA027F13D}"/>
              </a:ext>
            </a:extLst>
          </p:cNvPr>
          <p:cNvSpPr/>
          <p:nvPr/>
        </p:nvSpPr>
        <p:spPr>
          <a:xfrm>
            <a:off x="3309973" y="4645613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67" name="Forma libre 165">
            <a:extLst>
              <a:ext uri="{FF2B5EF4-FFF2-40B4-BE49-F238E27FC236}">
                <a16:creationId xmlns:a16="http://schemas.microsoft.com/office/drawing/2014/main" id="{EDDD380C-3731-7A1C-EC2E-60FBF7A442B6}"/>
              </a:ext>
            </a:extLst>
          </p:cNvPr>
          <p:cNvSpPr/>
          <p:nvPr/>
        </p:nvSpPr>
        <p:spPr>
          <a:xfrm>
            <a:off x="5173569" y="4689857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70" name="Forma libre 169">
            <a:extLst>
              <a:ext uri="{FF2B5EF4-FFF2-40B4-BE49-F238E27FC236}">
                <a16:creationId xmlns:a16="http://schemas.microsoft.com/office/drawing/2014/main" id="{4EFEAD5D-9D44-21E1-87B5-33372916FD16}"/>
              </a:ext>
            </a:extLst>
          </p:cNvPr>
          <p:cNvSpPr/>
          <p:nvPr/>
        </p:nvSpPr>
        <p:spPr>
          <a:xfrm>
            <a:off x="4801011" y="4417654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73" name="Forma libre 173">
            <a:extLst>
              <a:ext uri="{FF2B5EF4-FFF2-40B4-BE49-F238E27FC236}">
                <a16:creationId xmlns:a16="http://schemas.microsoft.com/office/drawing/2014/main" id="{57A70C1F-C1AE-273D-43BA-46F4119385CA}"/>
              </a:ext>
            </a:extLst>
          </p:cNvPr>
          <p:cNvSpPr/>
          <p:nvPr/>
        </p:nvSpPr>
        <p:spPr>
          <a:xfrm>
            <a:off x="5390781" y="4440428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76" name="CuadroTexto 198">
            <a:extLst>
              <a:ext uri="{FF2B5EF4-FFF2-40B4-BE49-F238E27FC236}">
                <a16:creationId xmlns:a16="http://schemas.microsoft.com/office/drawing/2014/main" id="{10AA7997-F585-ED7D-FF7F-62ABFEA1BE2F}"/>
              </a:ext>
            </a:extLst>
          </p:cNvPr>
          <p:cNvSpPr txBox="1"/>
          <p:nvPr/>
        </p:nvSpPr>
        <p:spPr>
          <a:xfrm>
            <a:off x="5503701" y="4547108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477" name="CuadroTexto 199">
            <a:extLst>
              <a:ext uri="{FF2B5EF4-FFF2-40B4-BE49-F238E27FC236}">
                <a16:creationId xmlns:a16="http://schemas.microsoft.com/office/drawing/2014/main" id="{C0C05B00-3F12-7B85-416C-AD5E77F1CCA7}"/>
              </a:ext>
            </a:extLst>
          </p:cNvPr>
          <p:cNvSpPr txBox="1"/>
          <p:nvPr/>
        </p:nvSpPr>
        <p:spPr>
          <a:xfrm>
            <a:off x="4895115" y="4511311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478" name="CuadroTexto 200">
            <a:extLst>
              <a:ext uri="{FF2B5EF4-FFF2-40B4-BE49-F238E27FC236}">
                <a16:creationId xmlns:a16="http://schemas.microsoft.com/office/drawing/2014/main" id="{7CB8CDD6-92F3-F1EA-703C-3954BCC6513E}"/>
              </a:ext>
            </a:extLst>
          </p:cNvPr>
          <p:cNvSpPr txBox="1"/>
          <p:nvPr/>
        </p:nvSpPr>
        <p:spPr>
          <a:xfrm>
            <a:off x="5262219" y="4769334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479" name="CuadroTexto 201">
            <a:extLst>
              <a:ext uri="{FF2B5EF4-FFF2-40B4-BE49-F238E27FC236}">
                <a16:creationId xmlns:a16="http://schemas.microsoft.com/office/drawing/2014/main" id="{24D458DD-0A5B-FDB8-FC02-3E01AB6C5FF5}"/>
              </a:ext>
            </a:extLst>
          </p:cNvPr>
          <p:cNvSpPr txBox="1"/>
          <p:nvPr/>
        </p:nvSpPr>
        <p:spPr>
          <a:xfrm>
            <a:off x="3384594" y="4743173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sp>
        <p:nvSpPr>
          <p:cNvPr id="480" name="Oval 84">
            <a:extLst>
              <a:ext uri="{FF2B5EF4-FFF2-40B4-BE49-F238E27FC236}">
                <a16:creationId xmlns:a16="http://schemas.microsoft.com/office/drawing/2014/main" id="{4575DCAA-A083-F3E6-B596-083F5A9E8722}"/>
              </a:ext>
            </a:extLst>
          </p:cNvPr>
          <p:cNvSpPr/>
          <p:nvPr/>
        </p:nvSpPr>
        <p:spPr>
          <a:xfrm flipH="1">
            <a:off x="3630124" y="4153885"/>
            <a:ext cx="58616" cy="48177"/>
          </a:xfrm>
          <a:prstGeom prst="ellipse">
            <a:avLst/>
          </a:prstGeom>
          <a:solidFill>
            <a:schemeClr val="accent4"/>
          </a:solidFill>
          <a:ln w="12700">
            <a:solidFill>
              <a:srgbClr val="1D315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16200" rIns="90000" bIns="162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481" name="Oval 84">
            <a:extLst>
              <a:ext uri="{FF2B5EF4-FFF2-40B4-BE49-F238E27FC236}">
                <a16:creationId xmlns:a16="http://schemas.microsoft.com/office/drawing/2014/main" id="{F9BD1D51-B184-6ACB-CE36-7F20F7B010AF}"/>
              </a:ext>
            </a:extLst>
          </p:cNvPr>
          <p:cNvSpPr/>
          <p:nvPr/>
        </p:nvSpPr>
        <p:spPr>
          <a:xfrm flipH="1">
            <a:off x="5245564" y="4313905"/>
            <a:ext cx="58616" cy="48177"/>
          </a:xfrm>
          <a:prstGeom prst="ellipse">
            <a:avLst/>
          </a:prstGeom>
          <a:solidFill>
            <a:schemeClr val="accent4"/>
          </a:solidFill>
          <a:ln w="12700">
            <a:solidFill>
              <a:srgbClr val="1D315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16200" rIns="90000" bIns="162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482" name="Forma libre 161">
            <a:extLst>
              <a:ext uri="{FF2B5EF4-FFF2-40B4-BE49-F238E27FC236}">
                <a16:creationId xmlns:a16="http://schemas.microsoft.com/office/drawing/2014/main" id="{37ECF86F-EF08-453A-B842-154AAF56F7AC}"/>
              </a:ext>
            </a:extLst>
          </p:cNvPr>
          <p:cNvSpPr/>
          <p:nvPr/>
        </p:nvSpPr>
        <p:spPr>
          <a:xfrm>
            <a:off x="1093761" y="4683766"/>
            <a:ext cx="184093" cy="220827"/>
          </a:xfrm>
          <a:custGeom>
            <a:avLst/>
            <a:gdLst>
              <a:gd name="connsiteX0" fmla="*/ 234987 w 535666"/>
              <a:gd name="connsiteY0" fmla="*/ 0 h 642553"/>
              <a:gd name="connsiteX1" fmla="*/ 193580 w 535666"/>
              <a:gd name="connsiteY1" fmla="*/ 62110 h 642553"/>
              <a:gd name="connsiteX2" fmla="*/ 131470 w 535666"/>
              <a:gd name="connsiteY2" fmla="*/ 72462 h 642553"/>
              <a:gd name="connsiteX3" fmla="*/ 38305 w 535666"/>
              <a:gd name="connsiteY3" fmla="*/ 131121 h 642553"/>
              <a:gd name="connsiteX4" fmla="*/ 72810 w 535666"/>
              <a:gd name="connsiteY4" fmla="*/ 210484 h 642553"/>
              <a:gd name="connsiteX5" fmla="*/ 134921 w 535666"/>
              <a:gd name="connsiteY5" fmla="*/ 200133 h 642553"/>
              <a:gd name="connsiteX6" fmla="*/ 162525 w 535666"/>
              <a:gd name="connsiteY6" fmla="*/ 296748 h 642553"/>
              <a:gd name="connsiteX7" fmla="*/ 269493 w 535666"/>
              <a:gd name="connsiteY7" fmla="*/ 334705 h 642553"/>
              <a:gd name="connsiteX8" fmla="*/ 276394 w 535666"/>
              <a:gd name="connsiteY8" fmla="*/ 207034 h 642553"/>
              <a:gd name="connsiteX9" fmla="*/ 417867 w 535666"/>
              <a:gd name="connsiteY9" fmla="*/ 131121 h 642553"/>
              <a:gd name="connsiteX10" fmla="*/ 535186 w 535666"/>
              <a:gd name="connsiteY10" fmla="*/ 320902 h 642553"/>
              <a:gd name="connsiteX11" fmla="*/ 373010 w 535666"/>
              <a:gd name="connsiteY11" fmla="*/ 431320 h 642553"/>
              <a:gd name="connsiteX12" fmla="*/ 407515 w 535666"/>
              <a:gd name="connsiteY12" fmla="*/ 617651 h 642553"/>
              <a:gd name="connsiteX13" fmla="*/ 110767 w 535666"/>
              <a:gd name="connsiteY13" fmla="*/ 628003 h 642553"/>
              <a:gd name="connsiteX14" fmla="*/ 197031 w 535666"/>
              <a:gd name="connsiteY14" fmla="*/ 500332 h 642553"/>
              <a:gd name="connsiteX15" fmla="*/ 3799 w 535666"/>
              <a:gd name="connsiteY15" fmla="*/ 348507 h 642553"/>
              <a:gd name="connsiteX16" fmla="*/ 65909 w 535666"/>
              <a:gd name="connsiteY16" fmla="*/ 213935 h 642553"/>
              <a:gd name="connsiteX17" fmla="*/ 31404 w 535666"/>
              <a:gd name="connsiteY17" fmla="*/ 138022 h 642553"/>
              <a:gd name="connsiteX18" fmla="*/ 134921 w 535666"/>
              <a:gd name="connsiteY18" fmla="*/ 72462 h 642553"/>
              <a:gd name="connsiteX19" fmla="*/ 207383 w 535666"/>
              <a:gd name="connsiteY19" fmla="*/ 62110 h 642553"/>
              <a:gd name="connsiteX20" fmla="*/ 234987 w 535666"/>
              <a:gd name="connsiteY20" fmla="*/ 0 h 642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35666" h="642553">
                <a:moveTo>
                  <a:pt x="234987" y="0"/>
                </a:moveTo>
                <a:cubicBezTo>
                  <a:pt x="232687" y="0"/>
                  <a:pt x="210833" y="50033"/>
                  <a:pt x="193580" y="62110"/>
                </a:cubicBezTo>
                <a:cubicBezTo>
                  <a:pt x="176327" y="74187"/>
                  <a:pt x="157349" y="60960"/>
                  <a:pt x="131470" y="72462"/>
                </a:cubicBezTo>
                <a:cubicBezTo>
                  <a:pt x="105591" y="83964"/>
                  <a:pt x="48082" y="108117"/>
                  <a:pt x="38305" y="131121"/>
                </a:cubicBezTo>
                <a:cubicBezTo>
                  <a:pt x="28528" y="154125"/>
                  <a:pt x="56707" y="198982"/>
                  <a:pt x="72810" y="210484"/>
                </a:cubicBezTo>
                <a:cubicBezTo>
                  <a:pt x="88913" y="221986"/>
                  <a:pt x="119969" y="185756"/>
                  <a:pt x="134921" y="200133"/>
                </a:cubicBezTo>
                <a:cubicBezTo>
                  <a:pt x="149873" y="214510"/>
                  <a:pt x="140096" y="274319"/>
                  <a:pt x="162525" y="296748"/>
                </a:cubicBezTo>
                <a:cubicBezTo>
                  <a:pt x="184954" y="319177"/>
                  <a:pt x="250515" y="349657"/>
                  <a:pt x="269493" y="334705"/>
                </a:cubicBezTo>
                <a:cubicBezTo>
                  <a:pt x="288471" y="319753"/>
                  <a:pt x="251665" y="240965"/>
                  <a:pt x="276394" y="207034"/>
                </a:cubicBezTo>
                <a:cubicBezTo>
                  <a:pt x="301123" y="173103"/>
                  <a:pt x="374735" y="112143"/>
                  <a:pt x="417867" y="131121"/>
                </a:cubicBezTo>
                <a:cubicBezTo>
                  <a:pt x="460999" y="150099"/>
                  <a:pt x="542662" y="270869"/>
                  <a:pt x="535186" y="320902"/>
                </a:cubicBezTo>
                <a:cubicBezTo>
                  <a:pt x="527710" y="370935"/>
                  <a:pt x="394288" y="381862"/>
                  <a:pt x="373010" y="431320"/>
                </a:cubicBezTo>
                <a:cubicBezTo>
                  <a:pt x="351732" y="480778"/>
                  <a:pt x="451222" y="584870"/>
                  <a:pt x="407515" y="617651"/>
                </a:cubicBezTo>
                <a:cubicBezTo>
                  <a:pt x="363808" y="650432"/>
                  <a:pt x="145848" y="647556"/>
                  <a:pt x="110767" y="628003"/>
                </a:cubicBezTo>
                <a:cubicBezTo>
                  <a:pt x="75686" y="608450"/>
                  <a:pt x="214859" y="546915"/>
                  <a:pt x="197031" y="500332"/>
                </a:cubicBezTo>
                <a:cubicBezTo>
                  <a:pt x="179203" y="453749"/>
                  <a:pt x="25653" y="396240"/>
                  <a:pt x="3799" y="348507"/>
                </a:cubicBezTo>
                <a:cubicBezTo>
                  <a:pt x="-18055" y="300774"/>
                  <a:pt x="61308" y="249016"/>
                  <a:pt x="65909" y="213935"/>
                </a:cubicBezTo>
                <a:cubicBezTo>
                  <a:pt x="70510" y="178854"/>
                  <a:pt x="19902" y="161601"/>
                  <a:pt x="31404" y="138022"/>
                </a:cubicBezTo>
                <a:cubicBezTo>
                  <a:pt x="42906" y="114443"/>
                  <a:pt x="105591" y="85114"/>
                  <a:pt x="134921" y="72462"/>
                </a:cubicBezTo>
                <a:cubicBezTo>
                  <a:pt x="164251" y="59810"/>
                  <a:pt x="191281" y="71887"/>
                  <a:pt x="207383" y="62110"/>
                </a:cubicBezTo>
                <a:cubicBezTo>
                  <a:pt x="223485" y="52333"/>
                  <a:pt x="237287" y="0"/>
                  <a:pt x="234987" y="0"/>
                </a:cubicBezTo>
                <a:close/>
              </a:path>
            </a:pathLst>
          </a:custGeom>
          <a:gradFill flip="none" rotWithShape="1">
            <a:gsLst>
              <a:gs pos="0">
                <a:srgbClr val="780000"/>
              </a:gs>
              <a:gs pos="60000">
                <a:srgbClr val="C00000"/>
              </a:gs>
              <a:gs pos="100000">
                <a:srgbClr val="C00000">
                  <a:tint val="23500"/>
                  <a:satMod val="160000"/>
                </a:srgbClr>
              </a:gs>
            </a:gsLst>
            <a:path path="circle">
              <a:fillToRect l="100000" t="100000"/>
            </a:path>
            <a:tileRect r="-100000" b="-100000"/>
          </a:gra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83" name="CuadroTexto 201">
            <a:extLst>
              <a:ext uri="{FF2B5EF4-FFF2-40B4-BE49-F238E27FC236}">
                <a16:creationId xmlns:a16="http://schemas.microsoft.com/office/drawing/2014/main" id="{4D3D99D1-561D-6AF4-A43A-035E0DB30A29}"/>
              </a:ext>
            </a:extLst>
          </p:cNvPr>
          <p:cNvSpPr txBox="1"/>
          <p:nvPr/>
        </p:nvSpPr>
        <p:spPr>
          <a:xfrm>
            <a:off x="1168382" y="4781326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ZepA</a:t>
            </a:r>
            <a:endParaRPr lang="es-ES" sz="600" dirty="0"/>
          </a:p>
        </p:txBody>
      </p:sp>
      <p:grpSp>
        <p:nvGrpSpPr>
          <p:cNvPr id="581" name="Group 580">
            <a:extLst>
              <a:ext uri="{FF2B5EF4-FFF2-40B4-BE49-F238E27FC236}">
                <a16:creationId xmlns:a16="http://schemas.microsoft.com/office/drawing/2014/main" id="{24B91215-59CF-5BB1-815B-4FC5E5CD8069}"/>
              </a:ext>
            </a:extLst>
          </p:cNvPr>
          <p:cNvGrpSpPr/>
          <p:nvPr/>
        </p:nvGrpSpPr>
        <p:grpSpPr>
          <a:xfrm>
            <a:off x="1163657" y="978654"/>
            <a:ext cx="4654656" cy="746002"/>
            <a:chOff x="1163657" y="64260"/>
            <a:chExt cx="4654656" cy="746002"/>
          </a:xfrm>
        </p:grpSpPr>
        <p:sp>
          <p:nvSpPr>
            <p:cNvPr id="484" name="Oval 84">
              <a:extLst>
                <a:ext uri="{FF2B5EF4-FFF2-40B4-BE49-F238E27FC236}">
                  <a16:creationId xmlns:a16="http://schemas.microsoft.com/office/drawing/2014/main" id="{BEBE724A-9CB6-B724-FC5C-69763DC67931}"/>
                </a:ext>
              </a:extLst>
            </p:cNvPr>
            <p:cNvSpPr/>
            <p:nvPr/>
          </p:nvSpPr>
          <p:spPr>
            <a:xfrm flipH="1">
              <a:off x="1989819" y="328949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486" name="Oval 84">
              <a:extLst>
                <a:ext uri="{FF2B5EF4-FFF2-40B4-BE49-F238E27FC236}">
                  <a16:creationId xmlns:a16="http://schemas.microsoft.com/office/drawing/2014/main" id="{3E03480E-46BC-2FD8-DCF0-370DCE7790A2}"/>
                </a:ext>
              </a:extLst>
            </p:cNvPr>
            <p:cNvSpPr/>
            <p:nvPr/>
          </p:nvSpPr>
          <p:spPr>
            <a:xfrm flipH="1">
              <a:off x="2182324" y="425202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491" name="Oval 84">
              <a:extLst>
                <a:ext uri="{FF2B5EF4-FFF2-40B4-BE49-F238E27FC236}">
                  <a16:creationId xmlns:a16="http://schemas.microsoft.com/office/drawing/2014/main" id="{D19ABC3A-57CC-E1DC-31C3-E9CC421862AD}"/>
                </a:ext>
              </a:extLst>
            </p:cNvPr>
            <p:cNvSpPr/>
            <p:nvPr/>
          </p:nvSpPr>
          <p:spPr>
            <a:xfrm flipH="1">
              <a:off x="2639521" y="112383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493" name="Oval 84">
              <a:extLst>
                <a:ext uri="{FF2B5EF4-FFF2-40B4-BE49-F238E27FC236}">
                  <a16:creationId xmlns:a16="http://schemas.microsoft.com/office/drawing/2014/main" id="{B6BC507B-0795-B063-233B-0F11836E639F}"/>
                </a:ext>
              </a:extLst>
            </p:cNvPr>
            <p:cNvSpPr/>
            <p:nvPr/>
          </p:nvSpPr>
          <p:spPr>
            <a:xfrm flipH="1">
              <a:off x="2840047" y="216657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499" name="Oval 84">
              <a:extLst>
                <a:ext uri="{FF2B5EF4-FFF2-40B4-BE49-F238E27FC236}">
                  <a16:creationId xmlns:a16="http://schemas.microsoft.com/office/drawing/2014/main" id="{E609E646-3A20-822B-2EEA-705CB6A6BE13}"/>
                </a:ext>
              </a:extLst>
            </p:cNvPr>
            <p:cNvSpPr/>
            <p:nvPr/>
          </p:nvSpPr>
          <p:spPr>
            <a:xfrm flipH="1">
              <a:off x="3393497" y="200616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02" name="Oval 84">
              <a:extLst>
                <a:ext uri="{FF2B5EF4-FFF2-40B4-BE49-F238E27FC236}">
                  <a16:creationId xmlns:a16="http://schemas.microsoft.com/office/drawing/2014/main" id="{234BB625-1237-A520-DB01-A01364767121}"/>
                </a:ext>
              </a:extLst>
            </p:cNvPr>
            <p:cNvSpPr/>
            <p:nvPr/>
          </p:nvSpPr>
          <p:spPr>
            <a:xfrm flipH="1">
              <a:off x="3650169" y="280826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03" name="Oval 84">
              <a:extLst>
                <a:ext uri="{FF2B5EF4-FFF2-40B4-BE49-F238E27FC236}">
                  <a16:creationId xmlns:a16="http://schemas.microsoft.com/office/drawing/2014/main" id="{DC622926-2C83-5378-9CA1-3B5E926E971C}"/>
                </a:ext>
              </a:extLst>
            </p:cNvPr>
            <p:cNvSpPr/>
            <p:nvPr/>
          </p:nvSpPr>
          <p:spPr>
            <a:xfrm flipH="1">
              <a:off x="3746421" y="80301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05" name="Oval 84">
              <a:extLst>
                <a:ext uri="{FF2B5EF4-FFF2-40B4-BE49-F238E27FC236}">
                  <a16:creationId xmlns:a16="http://schemas.microsoft.com/office/drawing/2014/main" id="{EEA87D39-5D38-F598-3027-94422AEC6016}"/>
                </a:ext>
              </a:extLst>
            </p:cNvPr>
            <p:cNvSpPr/>
            <p:nvPr/>
          </p:nvSpPr>
          <p:spPr>
            <a:xfrm flipH="1">
              <a:off x="3946947" y="18457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08" name="Oval 84">
              <a:extLst>
                <a:ext uri="{FF2B5EF4-FFF2-40B4-BE49-F238E27FC236}">
                  <a16:creationId xmlns:a16="http://schemas.microsoft.com/office/drawing/2014/main" id="{3B2A9BC6-22F2-A9F1-B2C5-69E7B5E6B4F6}"/>
                </a:ext>
              </a:extLst>
            </p:cNvPr>
            <p:cNvSpPr/>
            <p:nvPr/>
          </p:nvSpPr>
          <p:spPr>
            <a:xfrm flipH="1">
              <a:off x="4203619" y="26478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09" name="Oval 84">
              <a:extLst>
                <a:ext uri="{FF2B5EF4-FFF2-40B4-BE49-F238E27FC236}">
                  <a16:creationId xmlns:a16="http://schemas.microsoft.com/office/drawing/2014/main" id="{6DE38539-E503-BB8C-9955-30A9BA315782}"/>
                </a:ext>
              </a:extLst>
            </p:cNvPr>
            <p:cNvSpPr/>
            <p:nvPr/>
          </p:nvSpPr>
          <p:spPr>
            <a:xfrm flipH="1">
              <a:off x="4299871" y="64260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14" name="Oval 84">
              <a:extLst>
                <a:ext uri="{FF2B5EF4-FFF2-40B4-BE49-F238E27FC236}">
                  <a16:creationId xmlns:a16="http://schemas.microsoft.com/office/drawing/2014/main" id="{1EEE52CE-41E6-B562-D00D-7095AB21B33D}"/>
                </a:ext>
              </a:extLst>
            </p:cNvPr>
            <p:cNvSpPr/>
            <p:nvPr/>
          </p:nvSpPr>
          <p:spPr>
            <a:xfrm flipH="1">
              <a:off x="4757069" y="248744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16" name="Oval 84">
              <a:extLst>
                <a:ext uri="{FF2B5EF4-FFF2-40B4-BE49-F238E27FC236}">
                  <a16:creationId xmlns:a16="http://schemas.microsoft.com/office/drawing/2014/main" id="{8C8B7342-685F-AB90-85B0-A123CEA44F7A}"/>
                </a:ext>
              </a:extLst>
            </p:cNvPr>
            <p:cNvSpPr/>
            <p:nvPr/>
          </p:nvSpPr>
          <p:spPr>
            <a:xfrm flipH="1">
              <a:off x="4949574" y="344997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20" name="Oval 84">
              <a:extLst>
                <a:ext uri="{FF2B5EF4-FFF2-40B4-BE49-F238E27FC236}">
                  <a16:creationId xmlns:a16="http://schemas.microsoft.com/office/drawing/2014/main" id="{AC10B549-A5BA-533C-751B-AB4EE5A4AD14}"/>
                </a:ext>
              </a:extLst>
            </p:cNvPr>
            <p:cNvSpPr/>
            <p:nvPr/>
          </p:nvSpPr>
          <p:spPr>
            <a:xfrm flipH="1">
              <a:off x="5310519" y="232703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24" name="Oval 84">
              <a:extLst>
                <a:ext uri="{FF2B5EF4-FFF2-40B4-BE49-F238E27FC236}">
                  <a16:creationId xmlns:a16="http://schemas.microsoft.com/office/drawing/2014/main" id="{DA5C518C-BB1D-C42E-FD2C-10FF69EAD5D3}"/>
                </a:ext>
              </a:extLst>
            </p:cNvPr>
            <p:cNvSpPr/>
            <p:nvPr/>
          </p:nvSpPr>
          <p:spPr>
            <a:xfrm flipH="1">
              <a:off x="5759697" y="288852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25" name="Oval 84">
              <a:extLst>
                <a:ext uri="{FF2B5EF4-FFF2-40B4-BE49-F238E27FC236}">
                  <a16:creationId xmlns:a16="http://schemas.microsoft.com/office/drawing/2014/main" id="{C4CE357A-F4B9-8238-34E6-0AD8DCAB11C1}"/>
                </a:ext>
              </a:extLst>
            </p:cNvPr>
            <p:cNvSpPr/>
            <p:nvPr/>
          </p:nvSpPr>
          <p:spPr>
            <a:xfrm flipH="1">
              <a:off x="1195740" y="208634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26" name="Oval 84">
              <a:extLst>
                <a:ext uri="{FF2B5EF4-FFF2-40B4-BE49-F238E27FC236}">
                  <a16:creationId xmlns:a16="http://schemas.microsoft.com/office/drawing/2014/main" id="{04E173E7-71DB-4DF7-3616-F287A3CFA4E4}"/>
                </a:ext>
              </a:extLst>
            </p:cNvPr>
            <p:cNvSpPr/>
            <p:nvPr/>
          </p:nvSpPr>
          <p:spPr>
            <a:xfrm flipH="1">
              <a:off x="1308035" y="312908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31" name="Oval 84">
              <a:extLst>
                <a:ext uri="{FF2B5EF4-FFF2-40B4-BE49-F238E27FC236}">
                  <a16:creationId xmlns:a16="http://schemas.microsoft.com/office/drawing/2014/main" id="{E5CC8D31-6114-36C8-DB92-C23728A3060F}"/>
                </a:ext>
              </a:extLst>
            </p:cNvPr>
            <p:cNvSpPr/>
            <p:nvPr/>
          </p:nvSpPr>
          <p:spPr>
            <a:xfrm flipH="1">
              <a:off x="1749190" y="192593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33" name="Oval 84">
              <a:extLst>
                <a:ext uri="{FF2B5EF4-FFF2-40B4-BE49-F238E27FC236}">
                  <a16:creationId xmlns:a16="http://schemas.microsoft.com/office/drawing/2014/main" id="{03D7D00B-5F69-E30D-92AF-1588D330A3A5}"/>
                </a:ext>
              </a:extLst>
            </p:cNvPr>
            <p:cNvSpPr/>
            <p:nvPr/>
          </p:nvSpPr>
          <p:spPr>
            <a:xfrm flipH="1">
              <a:off x="1957736" y="665832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35" name="Oval 84">
              <a:extLst>
                <a:ext uri="{FF2B5EF4-FFF2-40B4-BE49-F238E27FC236}">
                  <a16:creationId xmlns:a16="http://schemas.microsoft.com/office/drawing/2014/main" id="{1445048C-1DEA-829D-D74F-510B2FD90847}"/>
                </a:ext>
              </a:extLst>
            </p:cNvPr>
            <p:cNvSpPr/>
            <p:nvPr/>
          </p:nvSpPr>
          <p:spPr>
            <a:xfrm flipH="1">
              <a:off x="2150241" y="76208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37" name="Oval 84">
              <a:extLst>
                <a:ext uri="{FF2B5EF4-FFF2-40B4-BE49-F238E27FC236}">
                  <a16:creationId xmlns:a16="http://schemas.microsoft.com/office/drawing/2014/main" id="{9F093B23-1F54-8BE3-DFB3-4F56722C18D4}"/>
                </a:ext>
              </a:extLst>
            </p:cNvPr>
            <p:cNvSpPr/>
            <p:nvPr/>
          </p:nvSpPr>
          <p:spPr>
            <a:xfrm flipH="1">
              <a:off x="2406914" y="721981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41" name="Oval 84">
              <a:extLst>
                <a:ext uri="{FF2B5EF4-FFF2-40B4-BE49-F238E27FC236}">
                  <a16:creationId xmlns:a16="http://schemas.microsoft.com/office/drawing/2014/main" id="{2D937E93-0142-37C8-3583-CCDCB7C2376E}"/>
                </a:ext>
              </a:extLst>
            </p:cNvPr>
            <p:cNvSpPr/>
            <p:nvPr/>
          </p:nvSpPr>
          <p:spPr>
            <a:xfrm flipH="1">
              <a:off x="2703691" y="746044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42" name="Oval 84">
              <a:extLst>
                <a:ext uri="{FF2B5EF4-FFF2-40B4-BE49-F238E27FC236}">
                  <a16:creationId xmlns:a16="http://schemas.microsoft.com/office/drawing/2014/main" id="{CCB30697-3A11-F402-4AF6-DFF92759FDAD}"/>
                </a:ext>
              </a:extLst>
            </p:cNvPr>
            <p:cNvSpPr/>
            <p:nvPr/>
          </p:nvSpPr>
          <p:spPr>
            <a:xfrm flipH="1">
              <a:off x="2807964" y="553540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43" name="Oval 84">
              <a:extLst>
                <a:ext uri="{FF2B5EF4-FFF2-40B4-BE49-F238E27FC236}">
                  <a16:creationId xmlns:a16="http://schemas.microsoft.com/office/drawing/2014/main" id="{8EC79E4A-966F-31B2-6ACC-04986D622C65}"/>
                </a:ext>
              </a:extLst>
            </p:cNvPr>
            <p:cNvSpPr/>
            <p:nvPr/>
          </p:nvSpPr>
          <p:spPr>
            <a:xfrm flipH="1">
              <a:off x="2960364" y="705940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46" name="Oval 84">
              <a:extLst>
                <a:ext uri="{FF2B5EF4-FFF2-40B4-BE49-F238E27FC236}">
                  <a16:creationId xmlns:a16="http://schemas.microsoft.com/office/drawing/2014/main" id="{A2D19D59-64DF-5E33-D2F2-FDD45A1C7318}"/>
                </a:ext>
              </a:extLst>
            </p:cNvPr>
            <p:cNvSpPr/>
            <p:nvPr/>
          </p:nvSpPr>
          <p:spPr>
            <a:xfrm flipH="1">
              <a:off x="3160888" y="43322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47" name="Oval 84">
              <a:extLst>
                <a:ext uri="{FF2B5EF4-FFF2-40B4-BE49-F238E27FC236}">
                  <a16:creationId xmlns:a16="http://schemas.microsoft.com/office/drawing/2014/main" id="{1B31DBD7-8DA6-A315-2706-C63060BC4D9E}"/>
                </a:ext>
              </a:extLst>
            </p:cNvPr>
            <p:cNvSpPr/>
            <p:nvPr/>
          </p:nvSpPr>
          <p:spPr>
            <a:xfrm flipH="1">
              <a:off x="3257141" y="730003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48" name="Oval 84">
              <a:extLst>
                <a:ext uri="{FF2B5EF4-FFF2-40B4-BE49-F238E27FC236}">
                  <a16:creationId xmlns:a16="http://schemas.microsoft.com/office/drawing/2014/main" id="{B8ECFC23-5BC6-1B6A-A0A8-AD0956D11E0D}"/>
                </a:ext>
              </a:extLst>
            </p:cNvPr>
            <p:cNvSpPr/>
            <p:nvPr/>
          </p:nvSpPr>
          <p:spPr>
            <a:xfrm flipH="1">
              <a:off x="3361414" y="537499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49" name="Oval 84">
              <a:extLst>
                <a:ext uri="{FF2B5EF4-FFF2-40B4-BE49-F238E27FC236}">
                  <a16:creationId xmlns:a16="http://schemas.microsoft.com/office/drawing/2014/main" id="{380971C8-4328-392F-D571-BF0377BA4BF9}"/>
                </a:ext>
              </a:extLst>
            </p:cNvPr>
            <p:cNvSpPr/>
            <p:nvPr/>
          </p:nvSpPr>
          <p:spPr>
            <a:xfrm flipH="1">
              <a:off x="3513814" y="689899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61" name="Oval 84">
              <a:extLst>
                <a:ext uri="{FF2B5EF4-FFF2-40B4-BE49-F238E27FC236}">
                  <a16:creationId xmlns:a16="http://schemas.microsoft.com/office/drawing/2014/main" id="{84B924E5-F46C-E129-684A-E082DD98E998}"/>
                </a:ext>
              </a:extLst>
            </p:cNvPr>
            <p:cNvSpPr/>
            <p:nvPr/>
          </p:nvSpPr>
          <p:spPr>
            <a:xfrm flipH="1">
              <a:off x="4620714" y="657817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62" name="Oval 84">
              <a:extLst>
                <a:ext uri="{FF2B5EF4-FFF2-40B4-BE49-F238E27FC236}">
                  <a16:creationId xmlns:a16="http://schemas.microsoft.com/office/drawing/2014/main" id="{6586EE97-B0D5-6D01-95F7-F4F230298C5D}"/>
                </a:ext>
              </a:extLst>
            </p:cNvPr>
            <p:cNvSpPr/>
            <p:nvPr/>
          </p:nvSpPr>
          <p:spPr>
            <a:xfrm flipH="1">
              <a:off x="4528350" y="379257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65" name="Oval 84">
              <a:extLst>
                <a:ext uri="{FF2B5EF4-FFF2-40B4-BE49-F238E27FC236}">
                  <a16:creationId xmlns:a16="http://schemas.microsoft.com/office/drawing/2014/main" id="{ED977DEC-09B2-7851-0AFD-1CFB6931AF96}"/>
                </a:ext>
              </a:extLst>
            </p:cNvPr>
            <p:cNvSpPr/>
            <p:nvPr/>
          </p:nvSpPr>
          <p:spPr>
            <a:xfrm flipH="1">
              <a:off x="4917491" y="730709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67" name="Oval 84">
              <a:extLst>
                <a:ext uri="{FF2B5EF4-FFF2-40B4-BE49-F238E27FC236}">
                  <a16:creationId xmlns:a16="http://schemas.microsoft.com/office/drawing/2014/main" id="{A598754F-9D45-C4EF-EEE1-595B1F5B73B7}"/>
                </a:ext>
              </a:extLst>
            </p:cNvPr>
            <p:cNvSpPr/>
            <p:nvPr/>
          </p:nvSpPr>
          <p:spPr>
            <a:xfrm flipH="1">
              <a:off x="5258505" y="486411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71" name="Oval 84">
              <a:extLst>
                <a:ext uri="{FF2B5EF4-FFF2-40B4-BE49-F238E27FC236}">
                  <a16:creationId xmlns:a16="http://schemas.microsoft.com/office/drawing/2014/main" id="{69A581C8-93CB-EE9A-9144-9C717E63A5B2}"/>
                </a:ext>
              </a:extLst>
            </p:cNvPr>
            <p:cNvSpPr/>
            <p:nvPr/>
          </p:nvSpPr>
          <p:spPr>
            <a:xfrm flipH="1">
              <a:off x="5470941" y="665839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73" name="Oval 84">
              <a:extLst>
                <a:ext uri="{FF2B5EF4-FFF2-40B4-BE49-F238E27FC236}">
                  <a16:creationId xmlns:a16="http://schemas.microsoft.com/office/drawing/2014/main" id="{7BD6A749-17DF-8561-D73C-0E9A6EF5C980}"/>
                </a:ext>
              </a:extLst>
            </p:cNvPr>
            <p:cNvSpPr/>
            <p:nvPr/>
          </p:nvSpPr>
          <p:spPr>
            <a:xfrm flipH="1">
              <a:off x="5727614" y="625735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74" name="Oval 84">
              <a:extLst>
                <a:ext uri="{FF2B5EF4-FFF2-40B4-BE49-F238E27FC236}">
                  <a16:creationId xmlns:a16="http://schemas.microsoft.com/office/drawing/2014/main" id="{98367ED2-B199-B551-0DB4-F7A813554FA2}"/>
                </a:ext>
              </a:extLst>
            </p:cNvPr>
            <p:cNvSpPr/>
            <p:nvPr/>
          </p:nvSpPr>
          <p:spPr>
            <a:xfrm flipH="1">
              <a:off x="1163657" y="545517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75" name="Oval 84">
              <a:extLst>
                <a:ext uri="{FF2B5EF4-FFF2-40B4-BE49-F238E27FC236}">
                  <a16:creationId xmlns:a16="http://schemas.microsoft.com/office/drawing/2014/main" id="{08064840-DBF9-B3A2-C740-410D5F7530C9}"/>
                </a:ext>
              </a:extLst>
            </p:cNvPr>
            <p:cNvSpPr/>
            <p:nvPr/>
          </p:nvSpPr>
          <p:spPr>
            <a:xfrm flipH="1">
              <a:off x="1275952" y="649791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77" name="Oval 84">
              <a:extLst>
                <a:ext uri="{FF2B5EF4-FFF2-40B4-BE49-F238E27FC236}">
                  <a16:creationId xmlns:a16="http://schemas.microsoft.com/office/drawing/2014/main" id="{9FEE0A3C-4C9F-988F-E962-BECE605CC350}"/>
                </a:ext>
              </a:extLst>
            </p:cNvPr>
            <p:cNvSpPr/>
            <p:nvPr/>
          </p:nvSpPr>
          <p:spPr>
            <a:xfrm flipH="1">
              <a:off x="1468457" y="746044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  <p:sp>
          <p:nvSpPr>
            <p:cNvPr id="579" name="Oval 84">
              <a:extLst>
                <a:ext uri="{FF2B5EF4-FFF2-40B4-BE49-F238E27FC236}">
                  <a16:creationId xmlns:a16="http://schemas.microsoft.com/office/drawing/2014/main" id="{DD39B53D-A5AE-DC49-A064-D3838EE58C41}"/>
                </a:ext>
              </a:extLst>
            </p:cNvPr>
            <p:cNvSpPr/>
            <p:nvPr/>
          </p:nvSpPr>
          <p:spPr>
            <a:xfrm flipH="1">
              <a:off x="1725130" y="705940"/>
              <a:ext cx="58616" cy="48177"/>
            </a:xfrm>
            <a:prstGeom prst="ellipse">
              <a:avLst/>
            </a:prstGeom>
            <a:solidFill>
              <a:schemeClr val="accent4"/>
            </a:solidFill>
            <a:ln w="12700">
              <a:solidFill>
                <a:srgbClr val="1D315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16200" rIns="90000" bIns="16200" anchor="ctr">
              <a:noAutofit/>
            </a:bodyPr>
            <a:lstStyle/>
            <a:p>
              <a:pPr algn="ctr">
                <a:lnSpc>
                  <a:spcPct val="100000"/>
                </a:lnSpc>
                <a:buNone/>
              </a:pPr>
              <a:endParaRPr lang="en-ES" sz="1800" b="0" strike="noStrike" spc="-1">
                <a:solidFill>
                  <a:schemeClr val="lt1"/>
                </a:solidFill>
                <a:latin typeface="Calibri"/>
              </a:endParaRPr>
            </a:p>
          </p:txBody>
        </p:sp>
      </p:grpSp>
      <p:sp>
        <p:nvSpPr>
          <p:cNvPr id="582" name="TextBox 581">
            <a:extLst>
              <a:ext uri="{FF2B5EF4-FFF2-40B4-BE49-F238E27FC236}">
                <a16:creationId xmlns:a16="http://schemas.microsoft.com/office/drawing/2014/main" id="{8A30564D-665A-C3DE-F3B1-93ABBEC81037}"/>
              </a:ext>
            </a:extLst>
          </p:cNvPr>
          <p:cNvSpPr txBox="1"/>
          <p:nvPr/>
        </p:nvSpPr>
        <p:spPr>
          <a:xfrm>
            <a:off x="884255" y="7264958"/>
            <a:ext cx="513979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E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. Model for the function of ZepA. </a:t>
            </a:r>
            <a:r>
              <a:rPr lang="en-E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icture shows a theoretical model based on results presented in this manuscript of zinc acquisition mediated by ZepA in </a:t>
            </a:r>
            <a:r>
              <a:rPr lang="en-E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baena</a:t>
            </a:r>
            <a:r>
              <a:rPr lang="en-E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Zinc atoms are depicted as yellow dots. OM stands for outer membrane and PM for plasma membrane. Cilinders on the outer membrane represent Zur-regulated TBDTs All3242 and All4028-4029. Dashed arrows indicate steps that will need to be further investigated.  </a:t>
            </a:r>
            <a:endParaRPr lang="en-E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3" name="Magnetic Disk 130">
            <a:extLst>
              <a:ext uri="{FF2B5EF4-FFF2-40B4-BE49-F238E27FC236}">
                <a16:creationId xmlns:a16="http://schemas.microsoft.com/office/drawing/2014/main" id="{7EA8034E-6063-A86C-1DAA-7E56BA228A2E}"/>
              </a:ext>
            </a:extLst>
          </p:cNvPr>
          <p:cNvSpPr/>
          <p:nvPr/>
        </p:nvSpPr>
        <p:spPr>
          <a:xfrm>
            <a:off x="3111782" y="4969273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chemeClr val="accent6">
                  <a:lumMod val="50000"/>
                  <a:tint val="66000"/>
                  <a:satMod val="160000"/>
                </a:schemeClr>
              </a:gs>
              <a:gs pos="50000">
                <a:schemeClr val="accent6">
                  <a:lumMod val="50000"/>
                  <a:tint val="44500"/>
                  <a:satMod val="160000"/>
                </a:schemeClr>
              </a:gs>
              <a:gs pos="100000">
                <a:schemeClr val="accent6">
                  <a:lumMod val="50000"/>
                  <a:tint val="23500"/>
                  <a:satMod val="160000"/>
                </a:schemeClr>
              </a:gs>
            </a:gsLst>
            <a:lin ang="13500000" scaled="1"/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584" name="Magnetic Disk 130">
            <a:extLst>
              <a:ext uri="{FF2B5EF4-FFF2-40B4-BE49-F238E27FC236}">
                <a16:creationId xmlns:a16="http://schemas.microsoft.com/office/drawing/2014/main" id="{50D8B9E6-B592-E953-8EA7-5E31172BA05A}"/>
              </a:ext>
            </a:extLst>
          </p:cNvPr>
          <p:cNvSpPr/>
          <p:nvPr/>
        </p:nvSpPr>
        <p:spPr>
          <a:xfrm>
            <a:off x="3595615" y="4969273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rgbClr val="929000">
                  <a:tint val="66000"/>
                  <a:satMod val="160000"/>
                </a:srgbClr>
              </a:gs>
              <a:gs pos="50000">
                <a:srgbClr val="929000">
                  <a:tint val="44500"/>
                  <a:satMod val="160000"/>
                </a:srgbClr>
              </a:gs>
              <a:gs pos="100000">
                <a:srgbClr val="929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586" name="Magnetic Disk 130">
            <a:extLst>
              <a:ext uri="{FF2B5EF4-FFF2-40B4-BE49-F238E27FC236}">
                <a16:creationId xmlns:a16="http://schemas.microsoft.com/office/drawing/2014/main" id="{58B0BF7F-2433-1749-32A8-36155D441F91}"/>
              </a:ext>
            </a:extLst>
          </p:cNvPr>
          <p:cNvSpPr/>
          <p:nvPr/>
        </p:nvSpPr>
        <p:spPr>
          <a:xfrm>
            <a:off x="4712656" y="4969273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rgbClr val="929000">
                  <a:tint val="66000"/>
                  <a:satMod val="160000"/>
                </a:srgbClr>
              </a:gs>
              <a:gs pos="50000">
                <a:srgbClr val="929000">
                  <a:tint val="44500"/>
                  <a:satMod val="160000"/>
                </a:srgbClr>
              </a:gs>
              <a:gs pos="100000">
                <a:srgbClr val="929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587" name="Magnetic Disk 130">
            <a:extLst>
              <a:ext uri="{FF2B5EF4-FFF2-40B4-BE49-F238E27FC236}">
                <a16:creationId xmlns:a16="http://schemas.microsoft.com/office/drawing/2014/main" id="{0438F59B-EB60-C4F8-2E35-9C66C70F2B1F}"/>
              </a:ext>
            </a:extLst>
          </p:cNvPr>
          <p:cNvSpPr/>
          <p:nvPr/>
        </p:nvSpPr>
        <p:spPr>
          <a:xfrm>
            <a:off x="5215240" y="4969273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chemeClr val="accent6">
                  <a:lumMod val="50000"/>
                  <a:tint val="66000"/>
                  <a:satMod val="160000"/>
                </a:schemeClr>
              </a:gs>
              <a:gs pos="50000">
                <a:schemeClr val="accent6">
                  <a:lumMod val="50000"/>
                  <a:tint val="44500"/>
                  <a:satMod val="160000"/>
                </a:schemeClr>
              </a:gs>
              <a:gs pos="100000">
                <a:schemeClr val="accent6">
                  <a:lumMod val="50000"/>
                  <a:tint val="23500"/>
                  <a:satMod val="160000"/>
                </a:schemeClr>
              </a:gs>
            </a:gsLst>
            <a:lin ang="13500000" scaled="1"/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589" name="Magnetic Disk 130">
            <a:extLst>
              <a:ext uri="{FF2B5EF4-FFF2-40B4-BE49-F238E27FC236}">
                <a16:creationId xmlns:a16="http://schemas.microsoft.com/office/drawing/2014/main" id="{279B76C8-A9C7-A331-E849-35CC1BD05FF3}"/>
              </a:ext>
            </a:extLst>
          </p:cNvPr>
          <p:cNvSpPr/>
          <p:nvPr/>
        </p:nvSpPr>
        <p:spPr>
          <a:xfrm>
            <a:off x="1197578" y="4969273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chemeClr val="accent6">
                  <a:lumMod val="50000"/>
                  <a:tint val="66000"/>
                  <a:satMod val="160000"/>
                </a:schemeClr>
              </a:gs>
              <a:gs pos="50000">
                <a:schemeClr val="accent6">
                  <a:lumMod val="50000"/>
                  <a:tint val="44500"/>
                  <a:satMod val="160000"/>
                </a:schemeClr>
              </a:gs>
              <a:gs pos="100000">
                <a:schemeClr val="accent6">
                  <a:lumMod val="50000"/>
                  <a:tint val="23500"/>
                  <a:satMod val="160000"/>
                </a:schemeClr>
              </a:gs>
            </a:gsLst>
            <a:lin ang="13500000" scaled="1"/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sp>
        <p:nvSpPr>
          <p:cNvPr id="590" name="Magnetic Disk 130">
            <a:extLst>
              <a:ext uri="{FF2B5EF4-FFF2-40B4-BE49-F238E27FC236}">
                <a16:creationId xmlns:a16="http://schemas.microsoft.com/office/drawing/2014/main" id="{DC40B658-0269-C5EE-C99E-0D523D60ADDA}"/>
              </a:ext>
            </a:extLst>
          </p:cNvPr>
          <p:cNvSpPr/>
          <p:nvPr/>
        </p:nvSpPr>
        <p:spPr>
          <a:xfrm>
            <a:off x="1681411" y="4969273"/>
            <a:ext cx="186840" cy="180720"/>
          </a:xfrm>
          <a:prstGeom prst="flowChartMagneticDisk">
            <a:avLst/>
          </a:prstGeom>
          <a:gradFill flip="none" rotWithShape="1">
            <a:gsLst>
              <a:gs pos="0">
                <a:srgbClr val="929000">
                  <a:tint val="66000"/>
                  <a:satMod val="160000"/>
                </a:srgbClr>
              </a:gs>
              <a:gs pos="50000">
                <a:srgbClr val="929000">
                  <a:tint val="44500"/>
                  <a:satMod val="160000"/>
                </a:srgbClr>
              </a:gs>
              <a:gs pos="100000">
                <a:srgbClr val="929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 w="1270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  <a:buNone/>
            </a:pPr>
            <a:endParaRPr lang="en-ES" sz="1800" b="0" strike="noStrike" spc="-1">
              <a:solidFill>
                <a:schemeClr val="lt1"/>
              </a:solidFill>
              <a:latin typeface="Calibri"/>
            </a:endParaRPr>
          </a:p>
        </p:txBody>
      </p:sp>
      <p:grpSp>
        <p:nvGrpSpPr>
          <p:cNvPr id="591" name="Grupo 33">
            <a:extLst>
              <a:ext uri="{FF2B5EF4-FFF2-40B4-BE49-F238E27FC236}">
                <a16:creationId xmlns:a16="http://schemas.microsoft.com/office/drawing/2014/main" id="{75E984AB-B1A4-8C30-C1C7-35BA191376C0}"/>
              </a:ext>
            </a:extLst>
          </p:cNvPr>
          <p:cNvGrpSpPr/>
          <p:nvPr/>
        </p:nvGrpSpPr>
        <p:grpSpPr>
          <a:xfrm>
            <a:off x="3058292" y="5546294"/>
            <a:ext cx="231480" cy="256180"/>
            <a:chOff x="2087354" y="2444760"/>
            <a:chExt cx="231480" cy="256180"/>
          </a:xfrm>
        </p:grpSpPr>
        <p:grpSp>
          <p:nvGrpSpPr>
            <p:cNvPr id="592" name="Grupo 32">
              <a:extLst>
                <a:ext uri="{FF2B5EF4-FFF2-40B4-BE49-F238E27FC236}">
                  <a16:creationId xmlns:a16="http://schemas.microsoft.com/office/drawing/2014/main" id="{11AAD3CC-1DA6-EE18-6FD7-C734F56D00CB}"/>
                </a:ext>
              </a:extLst>
            </p:cNvPr>
            <p:cNvGrpSpPr/>
            <p:nvPr/>
          </p:nvGrpSpPr>
          <p:grpSpPr>
            <a:xfrm>
              <a:off x="2087354" y="2444760"/>
              <a:ext cx="231480" cy="161640"/>
              <a:chOff x="2089080" y="2444760"/>
              <a:chExt cx="231480" cy="161640"/>
            </a:xfrm>
          </p:grpSpPr>
          <p:sp>
            <p:nvSpPr>
              <p:cNvPr id="596" name="Rounded Rectangle 131">
                <a:extLst>
                  <a:ext uri="{FF2B5EF4-FFF2-40B4-BE49-F238E27FC236}">
                    <a16:creationId xmlns:a16="http://schemas.microsoft.com/office/drawing/2014/main" id="{6DE92124-2CBC-E0A7-ADB4-88AAD3B473FE}"/>
                  </a:ext>
                </a:extLst>
              </p:cNvPr>
              <p:cNvSpPr/>
              <p:nvPr/>
            </p:nvSpPr>
            <p:spPr>
              <a:xfrm>
                <a:off x="2089080" y="2444760"/>
                <a:ext cx="117000" cy="161640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597" name="Rounded Rectangle 132">
                <a:extLst>
                  <a:ext uri="{FF2B5EF4-FFF2-40B4-BE49-F238E27FC236}">
                    <a16:creationId xmlns:a16="http://schemas.microsoft.com/office/drawing/2014/main" id="{D31506F9-0DF6-D8B9-081C-7E31CA88C6EC}"/>
                  </a:ext>
                </a:extLst>
              </p:cNvPr>
              <p:cNvSpPr/>
              <p:nvPr/>
            </p:nvSpPr>
            <p:spPr>
              <a:xfrm>
                <a:off x="2203560" y="2444760"/>
                <a:ext cx="117000" cy="161640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  <p:grpSp>
          <p:nvGrpSpPr>
            <p:cNvPr id="593" name="Grupo 31">
              <a:extLst>
                <a:ext uri="{FF2B5EF4-FFF2-40B4-BE49-F238E27FC236}">
                  <a16:creationId xmlns:a16="http://schemas.microsoft.com/office/drawing/2014/main" id="{0E54E203-8D53-375D-6581-B441CC956B44}"/>
                </a:ext>
              </a:extLst>
            </p:cNvPr>
            <p:cNvGrpSpPr/>
            <p:nvPr/>
          </p:nvGrpSpPr>
          <p:grpSpPr>
            <a:xfrm>
              <a:off x="2087354" y="2614271"/>
              <a:ext cx="231480" cy="86669"/>
              <a:chOff x="2085629" y="2614271"/>
              <a:chExt cx="231480" cy="86669"/>
            </a:xfrm>
          </p:grpSpPr>
          <p:sp>
            <p:nvSpPr>
              <p:cNvPr id="594" name="Rounded Rectangle 131">
                <a:extLst>
                  <a:ext uri="{FF2B5EF4-FFF2-40B4-BE49-F238E27FC236}">
                    <a16:creationId xmlns:a16="http://schemas.microsoft.com/office/drawing/2014/main" id="{8F9D0211-3417-621B-8DF7-A0B5FE0BF077}"/>
                  </a:ext>
                </a:extLst>
              </p:cNvPr>
              <p:cNvSpPr/>
              <p:nvPr/>
            </p:nvSpPr>
            <p:spPr>
              <a:xfrm>
                <a:off x="2085629" y="2614271"/>
                <a:ext cx="117000" cy="86669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595" name="Rounded Rectangle 132">
                <a:extLst>
                  <a:ext uri="{FF2B5EF4-FFF2-40B4-BE49-F238E27FC236}">
                    <a16:creationId xmlns:a16="http://schemas.microsoft.com/office/drawing/2014/main" id="{42241EA9-C7F6-26D7-424D-B48253F04589}"/>
                  </a:ext>
                </a:extLst>
              </p:cNvPr>
              <p:cNvSpPr/>
              <p:nvPr/>
            </p:nvSpPr>
            <p:spPr>
              <a:xfrm>
                <a:off x="2200109" y="2614271"/>
                <a:ext cx="117000" cy="86669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</p:grpSp>
      <p:sp>
        <p:nvSpPr>
          <p:cNvPr id="598" name="CuadroTexto 34">
            <a:extLst>
              <a:ext uri="{FF2B5EF4-FFF2-40B4-BE49-F238E27FC236}">
                <a16:creationId xmlns:a16="http://schemas.microsoft.com/office/drawing/2014/main" id="{227748BD-E9DD-F796-8364-C32722FD642C}"/>
              </a:ext>
            </a:extLst>
          </p:cNvPr>
          <p:cNvSpPr txBox="1"/>
          <p:nvPr/>
        </p:nvSpPr>
        <p:spPr>
          <a:xfrm>
            <a:off x="2799897" y="5609967"/>
            <a:ext cx="3369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B</a:t>
            </a:r>
            <a:endParaRPr lang="es-ES" sz="500" dirty="0"/>
          </a:p>
        </p:txBody>
      </p:sp>
      <p:sp>
        <p:nvSpPr>
          <p:cNvPr id="599" name="CuadroTexto 182">
            <a:extLst>
              <a:ext uri="{FF2B5EF4-FFF2-40B4-BE49-F238E27FC236}">
                <a16:creationId xmlns:a16="http://schemas.microsoft.com/office/drawing/2014/main" id="{8C4CD62B-735E-CCA7-953A-2A185139A029}"/>
              </a:ext>
            </a:extLst>
          </p:cNvPr>
          <p:cNvSpPr txBox="1"/>
          <p:nvPr/>
        </p:nvSpPr>
        <p:spPr>
          <a:xfrm>
            <a:off x="2796691" y="5706594"/>
            <a:ext cx="3401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C</a:t>
            </a:r>
            <a:endParaRPr lang="es-ES" sz="500" dirty="0"/>
          </a:p>
        </p:txBody>
      </p:sp>
      <p:sp>
        <p:nvSpPr>
          <p:cNvPr id="600" name="Elipse 35">
            <a:extLst>
              <a:ext uri="{FF2B5EF4-FFF2-40B4-BE49-F238E27FC236}">
                <a16:creationId xmlns:a16="http://schemas.microsoft.com/office/drawing/2014/main" id="{A687D348-814A-64DC-0378-F5AD40F498FC}"/>
              </a:ext>
            </a:extLst>
          </p:cNvPr>
          <p:cNvSpPr/>
          <p:nvPr/>
        </p:nvSpPr>
        <p:spPr>
          <a:xfrm>
            <a:off x="3029971" y="5274417"/>
            <a:ext cx="168040" cy="93541"/>
          </a:xfrm>
          <a:prstGeom prst="ellipse">
            <a:avLst/>
          </a:prstGeom>
          <a:solidFill>
            <a:srgbClr val="FF7E79"/>
          </a:solidFill>
          <a:ln w="12700">
            <a:solidFill>
              <a:srgbClr val="B41A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01" name="CuadroTexto 183">
            <a:extLst>
              <a:ext uri="{FF2B5EF4-FFF2-40B4-BE49-F238E27FC236}">
                <a16:creationId xmlns:a16="http://schemas.microsoft.com/office/drawing/2014/main" id="{2833C5BD-5877-F42B-F0E8-F9FBC4678E32}"/>
              </a:ext>
            </a:extLst>
          </p:cNvPr>
          <p:cNvSpPr txBox="1"/>
          <p:nvPr/>
        </p:nvSpPr>
        <p:spPr>
          <a:xfrm>
            <a:off x="2754108" y="5230856"/>
            <a:ext cx="3369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A</a:t>
            </a:r>
            <a:endParaRPr lang="es-ES" sz="500" dirty="0"/>
          </a:p>
        </p:txBody>
      </p:sp>
      <p:grpSp>
        <p:nvGrpSpPr>
          <p:cNvPr id="602" name="Grupo 33">
            <a:extLst>
              <a:ext uri="{FF2B5EF4-FFF2-40B4-BE49-F238E27FC236}">
                <a16:creationId xmlns:a16="http://schemas.microsoft.com/office/drawing/2014/main" id="{E7D2FAA6-AC82-183B-B23F-43BA3E3919EB}"/>
              </a:ext>
            </a:extLst>
          </p:cNvPr>
          <p:cNvGrpSpPr/>
          <p:nvPr/>
        </p:nvGrpSpPr>
        <p:grpSpPr>
          <a:xfrm>
            <a:off x="1232762" y="5557413"/>
            <a:ext cx="231480" cy="256180"/>
            <a:chOff x="2087354" y="2444760"/>
            <a:chExt cx="231480" cy="256180"/>
          </a:xfrm>
        </p:grpSpPr>
        <p:grpSp>
          <p:nvGrpSpPr>
            <p:cNvPr id="603" name="Grupo 32">
              <a:extLst>
                <a:ext uri="{FF2B5EF4-FFF2-40B4-BE49-F238E27FC236}">
                  <a16:creationId xmlns:a16="http://schemas.microsoft.com/office/drawing/2014/main" id="{D12A7EDC-AE3C-F433-6A61-2152E5D3F0D4}"/>
                </a:ext>
              </a:extLst>
            </p:cNvPr>
            <p:cNvGrpSpPr/>
            <p:nvPr/>
          </p:nvGrpSpPr>
          <p:grpSpPr>
            <a:xfrm>
              <a:off x="2087354" y="2444760"/>
              <a:ext cx="231480" cy="161640"/>
              <a:chOff x="2089080" y="2444760"/>
              <a:chExt cx="231480" cy="161640"/>
            </a:xfrm>
          </p:grpSpPr>
          <p:sp>
            <p:nvSpPr>
              <p:cNvPr id="607" name="Rounded Rectangle 131">
                <a:extLst>
                  <a:ext uri="{FF2B5EF4-FFF2-40B4-BE49-F238E27FC236}">
                    <a16:creationId xmlns:a16="http://schemas.microsoft.com/office/drawing/2014/main" id="{F0262A8A-27E3-AD26-A77C-951563929AF8}"/>
                  </a:ext>
                </a:extLst>
              </p:cNvPr>
              <p:cNvSpPr/>
              <p:nvPr/>
            </p:nvSpPr>
            <p:spPr>
              <a:xfrm>
                <a:off x="2089080" y="2444760"/>
                <a:ext cx="117000" cy="161640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608" name="Rounded Rectangle 132">
                <a:extLst>
                  <a:ext uri="{FF2B5EF4-FFF2-40B4-BE49-F238E27FC236}">
                    <a16:creationId xmlns:a16="http://schemas.microsoft.com/office/drawing/2014/main" id="{59937211-9EBB-8B7C-6F65-75C5702A2ED9}"/>
                  </a:ext>
                </a:extLst>
              </p:cNvPr>
              <p:cNvSpPr/>
              <p:nvPr/>
            </p:nvSpPr>
            <p:spPr>
              <a:xfrm>
                <a:off x="2203560" y="2444760"/>
                <a:ext cx="117000" cy="161640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  <p:grpSp>
          <p:nvGrpSpPr>
            <p:cNvPr id="604" name="Grupo 31">
              <a:extLst>
                <a:ext uri="{FF2B5EF4-FFF2-40B4-BE49-F238E27FC236}">
                  <a16:creationId xmlns:a16="http://schemas.microsoft.com/office/drawing/2014/main" id="{1261E28E-8825-8F23-FC6F-AC34FCEA9492}"/>
                </a:ext>
              </a:extLst>
            </p:cNvPr>
            <p:cNvGrpSpPr/>
            <p:nvPr/>
          </p:nvGrpSpPr>
          <p:grpSpPr>
            <a:xfrm>
              <a:off x="2087354" y="2614271"/>
              <a:ext cx="231480" cy="86669"/>
              <a:chOff x="2085629" y="2614271"/>
              <a:chExt cx="231480" cy="86669"/>
            </a:xfrm>
          </p:grpSpPr>
          <p:sp>
            <p:nvSpPr>
              <p:cNvPr id="605" name="Rounded Rectangle 131">
                <a:extLst>
                  <a:ext uri="{FF2B5EF4-FFF2-40B4-BE49-F238E27FC236}">
                    <a16:creationId xmlns:a16="http://schemas.microsoft.com/office/drawing/2014/main" id="{4DC85911-E8F3-90AE-A895-ABADF4429DA9}"/>
                  </a:ext>
                </a:extLst>
              </p:cNvPr>
              <p:cNvSpPr/>
              <p:nvPr/>
            </p:nvSpPr>
            <p:spPr>
              <a:xfrm>
                <a:off x="2085629" y="2614271"/>
                <a:ext cx="117000" cy="86669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  <p:sp>
            <p:nvSpPr>
              <p:cNvPr id="606" name="Rounded Rectangle 132">
                <a:extLst>
                  <a:ext uri="{FF2B5EF4-FFF2-40B4-BE49-F238E27FC236}">
                    <a16:creationId xmlns:a16="http://schemas.microsoft.com/office/drawing/2014/main" id="{8CC6402C-EC3F-6488-5F8B-D1448F609B55}"/>
                  </a:ext>
                </a:extLst>
              </p:cNvPr>
              <p:cNvSpPr/>
              <p:nvPr/>
            </p:nvSpPr>
            <p:spPr>
              <a:xfrm>
                <a:off x="2200109" y="2614271"/>
                <a:ext cx="117000" cy="86669"/>
              </a:xfrm>
              <a:prstGeom prst="roundRect">
                <a:avLst>
                  <a:gd name="adj" fmla="val 16667"/>
                </a:avLst>
              </a:prstGeom>
              <a:solidFill>
                <a:srgbClr val="FF7E79"/>
              </a:solidFill>
              <a:ln w="12700">
                <a:solidFill>
                  <a:srgbClr val="B41A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  <p:txBody>
              <a:bodyPr lIns="90000" tIns="45000" rIns="90000" bIns="45000" anchor="ctr">
                <a:noAutofit/>
              </a:bodyPr>
              <a:lstStyle/>
              <a:p>
                <a:pPr algn="ctr">
                  <a:lnSpc>
                    <a:spcPct val="100000"/>
                  </a:lnSpc>
                  <a:buNone/>
                </a:pPr>
                <a:endParaRPr lang="en-ES" sz="1800" b="0" strike="noStrike" spc="-1">
                  <a:solidFill>
                    <a:schemeClr val="lt1"/>
                  </a:solidFill>
                  <a:latin typeface="Calibri"/>
                </a:endParaRPr>
              </a:p>
            </p:txBody>
          </p:sp>
        </p:grpSp>
      </p:grpSp>
      <p:sp>
        <p:nvSpPr>
          <p:cNvPr id="609" name="CuadroTexto 34">
            <a:extLst>
              <a:ext uri="{FF2B5EF4-FFF2-40B4-BE49-F238E27FC236}">
                <a16:creationId xmlns:a16="http://schemas.microsoft.com/office/drawing/2014/main" id="{96E5937A-ACAB-914B-2B2F-A7FF78F3A7D0}"/>
              </a:ext>
            </a:extLst>
          </p:cNvPr>
          <p:cNvSpPr txBox="1"/>
          <p:nvPr/>
        </p:nvSpPr>
        <p:spPr>
          <a:xfrm>
            <a:off x="974367" y="5609054"/>
            <a:ext cx="3369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B</a:t>
            </a:r>
            <a:endParaRPr lang="es-ES" sz="500" dirty="0"/>
          </a:p>
        </p:txBody>
      </p:sp>
      <p:sp>
        <p:nvSpPr>
          <p:cNvPr id="610" name="CuadroTexto 182">
            <a:extLst>
              <a:ext uri="{FF2B5EF4-FFF2-40B4-BE49-F238E27FC236}">
                <a16:creationId xmlns:a16="http://schemas.microsoft.com/office/drawing/2014/main" id="{56710EF9-D397-7ECA-1B68-7E26C5DD70FD}"/>
              </a:ext>
            </a:extLst>
          </p:cNvPr>
          <p:cNvSpPr txBox="1"/>
          <p:nvPr/>
        </p:nvSpPr>
        <p:spPr>
          <a:xfrm>
            <a:off x="971161" y="5705681"/>
            <a:ext cx="3401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C</a:t>
            </a:r>
            <a:endParaRPr lang="es-ES" sz="500" dirty="0"/>
          </a:p>
        </p:txBody>
      </p:sp>
      <p:sp>
        <p:nvSpPr>
          <p:cNvPr id="611" name="Elipse 35">
            <a:extLst>
              <a:ext uri="{FF2B5EF4-FFF2-40B4-BE49-F238E27FC236}">
                <a16:creationId xmlns:a16="http://schemas.microsoft.com/office/drawing/2014/main" id="{F59F34DD-0DCE-CDF9-A0D5-6B649D16273C}"/>
              </a:ext>
            </a:extLst>
          </p:cNvPr>
          <p:cNvSpPr/>
          <p:nvPr/>
        </p:nvSpPr>
        <p:spPr>
          <a:xfrm>
            <a:off x="1220139" y="5238443"/>
            <a:ext cx="168040" cy="93541"/>
          </a:xfrm>
          <a:prstGeom prst="ellipse">
            <a:avLst/>
          </a:prstGeom>
          <a:solidFill>
            <a:srgbClr val="FF7E79"/>
          </a:solidFill>
          <a:ln w="12700">
            <a:solidFill>
              <a:srgbClr val="B41A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12" name="CuadroTexto 183">
            <a:extLst>
              <a:ext uri="{FF2B5EF4-FFF2-40B4-BE49-F238E27FC236}">
                <a16:creationId xmlns:a16="http://schemas.microsoft.com/office/drawing/2014/main" id="{37EB4D07-59E3-8ABA-74E0-7A0FC904BA08}"/>
              </a:ext>
            </a:extLst>
          </p:cNvPr>
          <p:cNvSpPr txBox="1"/>
          <p:nvPr/>
        </p:nvSpPr>
        <p:spPr>
          <a:xfrm>
            <a:off x="944276" y="5194882"/>
            <a:ext cx="3369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 err="1"/>
              <a:t>ZnuA</a:t>
            </a:r>
            <a:endParaRPr lang="es-ES" sz="500" dirty="0"/>
          </a:p>
        </p:txBody>
      </p:sp>
      <p:cxnSp>
        <p:nvCxnSpPr>
          <p:cNvPr id="613" name="Conector recto de flecha 38">
            <a:extLst>
              <a:ext uri="{FF2B5EF4-FFF2-40B4-BE49-F238E27FC236}">
                <a16:creationId xmlns:a16="http://schemas.microsoft.com/office/drawing/2014/main" id="{A72AE461-FA6A-4240-A269-4F98E321875C}"/>
              </a:ext>
            </a:extLst>
          </p:cNvPr>
          <p:cNvCxnSpPr/>
          <p:nvPr/>
        </p:nvCxnSpPr>
        <p:spPr>
          <a:xfrm>
            <a:off x="2758058" y="6751300"/>
            <a:ext cx="677627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4" name="Conector recto de flecha 38">
            <a:extLst>
              <a:ext uri="{FF2B5EF4-FFF2-40B4-BE49-F238E27FC236}">
                <a16:creationId xmlns:a16="http://schemas.microsoft.com/office/drawing/2014/main" id="{2D824497-ED4B-1083-7747-8F52A48ABDF3}"/>
              </a:ext>
            </a:extLst>
          </p:cNvPr>
          <p:cNvCxnSpPr>
            <a:cxnSpLocks/>
          </p:cNvCxnSpPr>
          <p:nvPr/>
        </p:nvCxnSpPr>
        <p:spPr>
          <a:xfrm>
            <a:off x="2755912" y="6865064"/>
            <a:ext cx="425170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65</TotalTime>
  <Words>152</Words>
  <Application>Microsoft Macintosh PowerPoint</Application>
  <PresentationFormat>A4 Paper (210x297 mm)</PresentationFormat>
  <Paragraphs>6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Ignacio Luque</dc:creator>
  <dc:description/>
  <cp:lastModifiedBy>Ignacio Luque</cp:lastModifiedBy>
  <cp:revision>32</cp:revision>
  <cp:lastPrinted>2023-12-18T09:20:13Z</cp:lastPrinted>
  <dcterms:created xsi:type="dcterms:W3CDTF">2023-12-14T21:24:45Z</dcterms:created>
  <dcterms:modified xsi:type="dcterms:W3CDTF">2023-12-29T16:03:08Z</dcterms:modified>
  <dc:language>es-E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A4 Paper (210x297 mm)</vt:lpwstr>
  </property>
  <property fmtid="{D5CDD505-2E9C-101B-9397-08002B2CF9AE}" pid="3" name="Slides">
    <vt:i4>1</vt:i4>
  </property>
</Properties>
</file>